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74" r:id="rId2"/>
    <p:sldId id="272" r:id="rId3"/>
    <p:sldId id="273" r:id="rId4"/>
    <p:sldId id="266" r:id="rId5"/>
    <p:sldId id="271" r:id="rId6"/>
    <p:sldId id="267" r:id="rId7"/>
    <p:sldId id="265" r:id="rId8"/>
  </p:sldIdLst>
  <p:sldSz cx="9906000" cy="6858000" type="A4"/>
  <p:notesSz cx="9942513" cy="68119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5A5A5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74" autoAdjust="0"/>
    <p:restoredTop sz="86590" autoAdjust="0"/>
  </p:normalViewPr>
  <p:slideViewPr>
    <p:cSldViewPr snapToGrid="0">
      <p:cViewPr varScale="1">
        <p:scale>
          <a:sx n="72" d="100"/>
          <a:sy n="72" d="100"/>
        </p:scale>
        <p:origin x="869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1\Profiles\rfahey\Desktop\5-Aza%20cisplatin%20ex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1\Profiles\rfahey\Documents\Radka%20research\Publications\my%20papers\2submitted\AZA%20paper\data%20used\Figure%202_Glycan%20data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1\Profiles\rfahey\Desktop\Migration%20and%20proliferation_source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1\Profiles\rfahey\Desktop\Migration%20and%20proliferation_source%20dat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IE" sz="1800" dirty="0" smtClean="0"/>
              <a:t>Cisplatin sensitivity</a:t>
            </a:r>
            <a:r>
              <a:rPr lang="en-IE" sz="1800" baseline="0" dirty="0" smtClean="0"/>
              <a:t> in 5-AZA-dC treated cells</a:t>
            </a:r>
            <a:endParaRPr lang="en-IE" sz="18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K$5</c:f>
              <c:strCache>
                <c:ptCount val="1"/>
                <c:pt idx="0">
                  <c:v>A278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C$9,Sheet1!$E$9,Sheet1!$G$9,Sheet1!$I$9)</c:f>
                <c:numCache>
                  <c:formatCode>General</c:formatCode>
                  <c:ptCount val="4"/>
                  <c:pt idx="0">
                    <c:v>0.47258156262526352</c:v>
                  </c:pt>
                  <c:pt idx="1">
                    <c:v>7.0882531933709378</c:v>
                  </c:pt>
                  <c:pt idx="2">
                    <c:v>4.4500936319737479</c:v>
                  </c:pt>
                  <c:pt idx="3">
                    <c:v>2.0033305601755611</c:v>
                  </c:pt>
                </c:numCache>
              </c:numRef>
            </c:plus>
            <c:minus>
              <c:numRef>
                <c:f>(Sheet1!$C$9,Sheet1!$E$9,Sheet1!$G$9,Sheet1!$I$9)</c:f>
                <c:numCache>
                  <c:formatCode>General</c:formatCode>
                  <c:ptCount val="4"/>
                  <c:pt idx="0">
                    <c:v>0.47258156262526352</c:v>
                  </c:pt>
                  <c:pt idx="1">
                    <c:v>7.0882531933709378</c:v>
                  </c:pt>
                  <c:pt idx="2">
                    <c:v>4.4500936319737479</c:v>
                  </c:pt>
                  <c:pt idx="3">
                    <c:v>2.00333056017556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4:$O$4</c:f>
              <c:strCache>
                <c:ptCount val="2"/>
                <c:pt idx="0">
                  <c:v>1 uM cisplatin</c:v>
                </c:pt>
                <c:pt idx="1">
                  <c:v>1 uM 5-AZA-dC + 1 uM cis</c:v>
                </c:pt>
              </c:strCache>
            </c:strRef>
          </c:cat>
          <c:val>
            <c:numRef>
              <c:f>Sheet1!$N$5:$O$5</c:f>
              <c:numCache>
                <c:formatCode>0.00</c:formatCode>
                <c:ptCount val="2"/>
                <c:pt idx="0">
                  <c:v>80.87</c:v>
                </c:pt>
                <c:pt idx="1">
                  <c:v>89.0333333333333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964-462C-9368-D3FCEB28E765}"/>
            </c:ext>
          </c:extLst>
        </c:ser>
        <c:ser>
          <c:idx val="1"/>
          <c:order val="1"/>
          <c:tx>
            <c:strRef>
              <c:f>Sheet1!$K$6</c:f>
              <c:strCache>
                <c:ptCount val="1"/>
                <c:pt idx="0">
                  <c:v>A2780cis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C$18,Sheet1!$E$18,Sheet1!$G$18,Sheet1!$I$18)</c:f>
                <c:numCache>
                  <c:formatCode>General</c:formatCode>
                  <c:ptCount val="4"/>
                  <c:pt idx="0">
                    <c:v>0.95393920141694055</c:v>
                  </c:pt>
                  <c:pt idx="1">
                    <c:v>1.6041612554021298</c:v>
                  </c:pt>
                  <c:pt idx="2">
                    <c:v>1.6000000000000014</c:v>
                  </c:pt>
                  <c:pt idx="3">
                    <c:v>3.5161532010612597</c:v>
                  </c:pt>
                </c:numCache>
              </c:numRef>
            </c:plus>
            <c:minus>
              <c:numRef>
                <c:f>(Sheet1!$C$18,Sheet1!$E$18,Sheet1!$G$18,Sheet1!$I$18)</c:f>
                <c:numCache>
                  <c:formatCode>General</c:formatCode>
                  <c:ptCount val="4"/>
                  <c:pt idx="0">
                    <c:v>0.95393920141694055</c:v>
                  </c:pt>
                  <c:pt idx="1">
                    <c:v>1.6041612554021298</c:v>
                  </c:pt>
                  <c:pt idx="2">
                    <c:v>1.6000000000000014</c:v>
                  </c:pt>
                  <c:pt idx="3">
                    <c:v>3.51615320106125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4:$O$4</c:f>
              <c:strCache>
                <c:ptCount val="2"/>
                <c:pt idx="0">
                  <c:v>1 uM cisplatin</c:v>
                </c:pt>
                <c:pt idx="1">
                  <c:v>1 uM 5-AZA-dC + 1 uM cis</c:v>
                </c:pt>
              </c:strCache>
            </c:strRef>
          </c:cat>
          <c:val>
            <c:numRef>
              <c:f>Sheet1!$N$6:$O$6</c:f>
              <c:numCache>
                <c:formatCode>0.00</c:formatCode>
                <c:ptCount val="2"/>
                <c:pt idx="0">
                  <c:v>97.199999999999989</c:v>
                </c:pt>
                <c:pt idx="1">
                  <c:v>84.0666666666666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964-462C-9368-D3FCEB28E7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408448"/>
        <c:axId val="294633824"/>
      </c:barChart>
      <c:catAx>
        <c:axId val="22408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reatm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4633824"/>
        <c:crosses val="autoZero"/>
        <c:auto val="1"/>
        <c:lblAlgn val="ctr"/>
        <c:lblOffset val="100"/>
        <c:noMultiLvlLbl val="0"/>
      </c:catAx>
      <c:valAx>
        <c:axId val="294633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Viabil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408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IE" sz="1800"/>
              <a:t>Glycan peaks which differ in chemoresistanc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Figure 2_Glycan data2.xlsx]chemoresistant GPs'!$F$11</c:f>
              <c:strCache>
                <c:ptCount val="1"/>
                <c:pt idx="0">
                  <c:v>GP1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Figure 2_Glycan data2.xlsx]chemoresistant GPs'!$G$15:$J$15</c:f>
                <c:numCache>
                  <c:formatCode>General</c:formatCode>
                  <c:ptCount val="4"/>
                  <c:pt idx="0">
                    <c:v>0.44482206180299355</c:v>
                  </c:pt>
                  <c:pt idx="1">
                    <c:v>0.6658828725834598</c:v>
                  </c:pt>
                  <c:pt idx="2">
                    <c:v>0.30274877073543688</c:v>
                  </c:pt>
                  <c:pt idx="3">
                    <c:v>0.57463812470020914</c:v>
                  </c:pt>
                </c:numCache>
              </c:numRef>
            </c:plus>
            <c:minus>
              <c:numRef>
                <c:f>'[Figure 2_Glycan data2.xlsx]chemoresistant GPs'!$G$16:$J$16</c:f>
                <c:numCache>
                  <c:formatCode>General</c:formatCode>
                  <c:ptCount val="4"/>
                  <c:pt idx="0">
                    <c:v>0.4779818685543073</c:v>
                  </c:pt>
                  <c:pt idx="1">
                    <c:v>0.49812603370486941</c:v>
                  </c:pt>
                  <c:pt idx="2">
                    <c:v>0.51058715458209647</c:v>
                  </c:pt>
                  <c:pt idx="3">
                    <c:v>0.671823961985160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igure 2_Glycan data2.xlsx]chemoresistant GPs'!$G$10:$J$10</c:f>
              <c:strCache>
                <c:ptCount val="4"/>
                <c:pt idx="0">
                  <c:v>A2780</c:v>
                </c:pt>
                <c:pt idx="1">
                  <c:v>A2780cis</c:v>
                </c:pt>
                <c:pt idx="2">
                  <c:v>PEO1</c:v>
                </c:pt>
                <c:pt idx="3">
                  <c:v>PEO4</c:v>
                </c:pt>
              </c:strCache>
            </c:strRef>
          </c:cat>
          <c:val>
            <c:numRef>
              <c:f>'[Figure 2_Glycan data2.xlsx]chemoresistant GPs'!$G$11:$J$11</c:f>
              <c:numCache>
                <c:formatCode>0.00</c:formatCode>
                <c:ptCount val="4"/>
                <c:pt idx="0">
                  <c:v>1.06</c:v>
                </c:pt>
                <c:pt idx="1">
                  <c:v>2.27</c:v>
                </c:pt>
                <c:pt idx="2">
                  <c:v>0.94750000000000012</c:v>
                </c:pt>
                <c:pt idx="3">
                  <c:v>1.5038461538461543</c:v>
                </c:pt>
              </c:numCache>
            </c:numRef>
          </c:val>
        </c:ser>
        <c:ser>
          <c:idx val="1"/>
          <c:order val="1"/>
          <c:tx>
            <c:strRef>
              <c:f>'[Figure 2_Glycan data2.xlsx]chemoresistant GPs'!$F$12</c:f>
              <c:strCache>
                <c:ptCount val="1"/>
                <c:pt idx="0">
                  <c:v>GP14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Figure 2_Glycan data2.xlsx]chemoresistant GPs'!$G$16:$J$16</c:f>
                <c:numCache>
                  <c:formatCode>General</c:formatCode>
                  <c:ptCount val="4"/>
                  <c:pt idx="0">
                    <c:v>0.4779818685543073</c:v>
                  </c:pt>
                  <c:pt idx="1">
                    <c:v>0.49812603370486941</c:v>
                  </c:pt>
                  <c:pt idx="2">
                    <c:v>0.51058715458209647</c:v>
                  </c:pt>
                  <c:pt idx="3">
                    <c:v>0.67182396198516026</c:v>
                  </c:pt>
                </c:numCache>
              </c:numRef>
            </c:plus>
            <c:minus>
              <c:numRef>
                <c:f>'[Figure 2_Glycan data2.xlsx]chemoresistant GPs'!$G$16:$J$16</c:f>
                <c:numCache>
                  <c:formatCode>General</c:formatCode>
                  <c:ptCount val="4"/>
                  <c:pt idx="0">
                    <c:v>0.4779818685543073</c:v>
                  </c:pt>
                  <c:pt idx="1">
                    <c:v>0.49812603370486941</c:v>
                  </c:pt>
                  <c:pt idx="2">
                    <c:v>0.51058715458209647</c:v>
                  </c:pt>
                  <c:pt idx="3">
                    <c:v>0.671823961985160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igure 2_Glycan data2.xlsx]chemoresistant GPs'!$G$10:$J$10</c:f>
              <c:strCache>
                <c:ptCount val="4"/>
                <c:pt idx="0">
                  <c:v>A2780</c:v>
                </c:pt>
                <c:pt idx="1">
                  <c:v>A2780cis</c:v>
                </c:pt>
                <c:pt idx="2">
                  <c:v>PEO1</c:v>
                </c:pt>
                <c:pt idx="3">
                  <c:v>PEO4</c:v>
                </c:pt>
              </c:strCache>
            </c:strRef>
          </c:cat>
          <c:val>
            <c:numRef>
              <c:f>'[Figure 2_Glycan data2.xlsx]chemoresistant GPs'!$G$12:$J$12</c:f>
              <c:numCache>
                <c:formatCode>0.00</c:formatCode>
                <c:ptCount val="4"/>
                <c:pt idx="0">
                  <c:v>2.29</c:v>
                </c:pt>
                <c:pt idx="1">
                  <c:v>2.3125</c:v>
                </c:pt>
                <c:pt idx="2">
                  <c:v>1.6841666666666668</c:v>
                </c:pt>
                <c:pt idx="3">
                  <c:v>2.4915384615384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7804296"/>
        <c:axId val="437807824"/>
      </c:barChart>
      <c:catAx>
        <c:axId val="437804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807824"/>
        <c:crosses val="autoZero"/>
        <c:auto val="1"/>
        <c:lblAlgn val="ctr"/>
        <c:lblOffset val="100"/>
        <c:noMultiLvlLbl val="0"/>
      </c:catAx>
      <c:valAx>
        <c:axId val="437807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IE" sz="1400" dirty="0" smtClean="0"/>
                  <a:t>% peak areas</a:t>
                </a:r>
                <a:endParaRPr lang="en-IE" sz="14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8042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0258333333333333"/>
          <c:y val="4.107619634421852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3.3333333333333333E-2"/>
          <c:y val="0.19432888597258677"/>
          <c:w val="0.93888888888888888"/>
          <c:h val="0.754745188101487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2780cis proliferation data'!$E$3</c:f>
              <c:strCache>
                <c:ptCount val="1"/>
                <c:pt idx="0">
                  <c:v>Migration % relative to control</c:v>
                </c:pt>
              </c:strCache>
            </c:strRef>
          </c:tx>
          <c:spPr>
            <a:solidFill>
              <a:schemeClr val="accent1">
                <a:alpha val="85000"/>
              </a:schemeClr>
            </a:solidFill>
            <a:ln w="9525" cap="flat" cmpd="sng" algn="ctr">
              <a:solidFill>
                <a:schemeClr val="lt1">
                  <a:alpha val="50000"/>
                </a:schemeClr>
              </a:solidFill>
              <a:round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lt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dk1">
                          <a:lumMod val="50000"/>
                          <a:lumOff val="50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A2780cis proliferation data'!$E$9</c:f>
                <c:numCache>
                  <c:formatCode>General</c:formatCode>
                  <c:ptCount val="1"/>
                  <c:pt idx="0">
                    <c:v>15.172905830087529</c:v>
                  </c:pt>
                </c:numCache>
              </c:numRef>
            </c:plus>
            <c:minus>
              <c:numRef>
                <c:f>'A2780cis proliferation data'!$E$9</c:f>
                <c:numCache>
                  <c:formatCode>General</c:formatCode>
                  <c:ptCount val="1"/>
                  <c:pt idx="0">
                    <c:v>15.172905830087529</c:v>
                  </c:pt>
                </c:numCache>
              </c:numRef>
            </c:minus>
            <c:spPr>
              <a:noFill/>
              <a:ln w="15875">
                <a:solidFill>
                  <a:schemeClr val="dk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2780cis proliferation data'!$D$3</c:f>
              <c:strCache>
                <c:ptCount val="1"/>
                <c:pt idx="0">
                  <c:v>1uM 5-AZA-dC treated</c:v>
                </c:pt>
              </c:strCache>
            </c:strRef>
          </c:cat>
          <c:val>
            <c:numRef>
              <c:f>'A2780cis proliferation data'!$E$8</c:f>
              <c:numCache>
                <c:formatCode>0.00</c:formatCode>
                <c:ptCount val="1"/>
                <c:pt idx="0">
                  <c:v>-13.35861154027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5D3-4EA5-BD36-6E70413633F2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axId val="437804688"/>
        <c:axId val="437801160"/>
      </c:barChart>
      <c:catAx>
        <c:axId val="437804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801160"/>
        <c:crosses val="autoZero"/>
        <c:auto val="1"/>
        <c:lblAlgn val="ctr"/>
        <c:lblOffset val="100"/>
        <c:noMultiLvlLbl val="0"/>
      </c:catAx>
      <c:valAx>
        <c:axId val="437801160"/>
        <c:scaling>
          <c:orientation val="minMax"/>
        </c:scaling>
        <c:delete val="1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crossAx val="43780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4976377952755907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2780cis proliferation data'!$K$3</c:f>
              <c:strCache>
                <c:ptCount val="1"/>
                <c:pt idx="0">
                  <c:v>Proliferation % relative to control</c:v>
                </c:pt>
              </c:strCache>
            </c:strRef>
          </c:tx>
          <c:spPr>
            <a:solidFill>
              <a:schemeClr val="accent1">
                <a:alpha val="85000"/>
              </a:schemeClr>
            </a:solidFill>
            <a:ln w="9525" cap="flat" cmpd="sng" algn="ctr">
              <a:solidFill>
                <a:schemeClr val="lt1">
                  <a:alpha val="50000"/>
                </a:schemeClr>
              </a:solidFill>
              <a:round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lt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dk1">
                          <a:lumMod val="50000"/>
                          <a:lumOff val="50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A2780cis proliferation data'!$K$9</c:f>
                <c:numCache>
                  <c:formatCode>General</c:formatCode>
                  <c:ptCount val="1"/>
                  <c:pt idx="0">
                    <c:v>3.8680765551119385</c:v>
                  </c:pt>
                </c:numCache>
              </c:numRef>
            </c:plus>
            <c:minus>
              <c:numRef>
                <c:f>'A2780cis proliferation data'!$K$9</c:f>
                <c:numCache>
                  <c:formatCode>General</c:formatCode>
                  <c:ptCount val="1"/>
                  <c:pt idx="0">
                    <c:v>3.8680765551119385</c:v>
                  </c:pt>
                </c:numCache>
              </c:numRef>
            </c:minus>
            <c:spPr>
              <a:noFill/>
              <a:ln w="9525">
                <a:solidFill>
                  <a:schemeClr val="dk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2780cis proliferation data'!$J$3</c:f>
              <c:strCache>
                <c:ptCount val="1"/>
                <c:pt idx="0">
                  <c:v>1uM 5-AZA-dC treated</c:v>
                </c:pt>
              </c:strCache>
            </c:strRef>
          </c:cat>
          <c:val>
            <c:numRef>
              <c:f>'A2780cis proliferation data'!$K$8</c:f>
              <c:numCache>
                <c:formatCode>0.00</c:formatCode>
                <c:ptCount val="1"/>
                <c:pt idx="0">
                  <c:v>4.20949342693663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0A3-420C-B7E8-613451B14699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axId val="437802336"/>
        <c:axId val="437802728"/>
      </c:barChart>
      <c:catAx>
        <c:axId val="437802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802728"/>
        <c:crosses val="autoZero"/>
        <c:auto val="1"/>
        <c:lblAlgn val="ctr"/>
        <c:lblOffset val="100"/>
        <c:noMultiLvlLbl val="0"/>
      </c:catAx>
      <c:valAx>
        <c:axId val="437802728"/>
        <c:scaling>
          <c:orientation val="minMax"/>
        </c:scaling>
        <c:delete val="1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crossAx val="437802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5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5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8422" cy="34178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31790" y="1"/>
            <a:ext cx="4308422" cy="34178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5D0809-82FB-47E3-865F-DF1D3BE24735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309938" y="850900"/>
            <a:ext cx="3322637" cy="23002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4252" y="3278257"/>
            <a:ext cx="7954010" cy="26822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70183"/>
            <a:ext cx="4308422" cy="34178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31790" y="6470183"/>
            <a:ext cx="4308422" cy="34178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5632E4-4934-431F-8263-4B8BF32990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103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b="1" dirty="0" smtClean="0"/>
              <a:t>Figure S1.</a:t>
            </a:r>
            <a:endParaRPr lang="en-IE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8513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b="1" dirty="0" smtClean="0"/>
              <a:t>Figure</a:t>
            </a:r>
            <a:r>
              <a:rPr lang="en-IE" b="1" baseline="0" dirty="0" smtClean="0"/>
              <a:t> S2.</a:t>
            </a:r>
            <a:endParaRPr lang="en-IE" b="1" dirty="0" smtClean="0"/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6018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b="1" dirty="0" smtClean="0"/>
              <a:t>Figure S3.</a:t>
            </a:r>
            <a:endParaRPr lang="en-IE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65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200" b="1" kern="1200" dirty="0" smtClean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4. </a:t>
            </a:r>
            <a:endParaRPr lang="en-I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34172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b="1" dirty="0" smtClean="0"/>
              <a:t>Figure</a:t>
            </a:r>
            <a:r>
              <a:rPr lang="en-IE" b="1" baseline="0" dirty="0" smtClean="0"/>
              <a:t> S5.</a:t>
            </a:r>
            <a:endParaRPr lang="en-IE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65230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200" b="1" kern="1200" dirty="0" smtClean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6. </a:t>
            </a:r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9887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200" b="1" kern="1200" dirty="0" smtClean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7. </a:t>
            </a:r>
            <a:endParaRPr lang="en-I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5632E4-4934-431F-8263-4B8BF32990E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31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35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229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962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067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22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141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454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25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599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501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371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F301D-903D-4CDF-ACB3-F7FFE007BF4C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B84DC-D0C6-4A73-9601-70985A268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410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image" Target="../media/image17.emf"/><Relationship Id="rId3" Type="http://schemas.openxmlformats.org/officeDocument/2006/relationships/image" Target="../media/image7.png"/><Relationship Id="rId7" Type="http://schemas.openxmlformats.org/officeDocument/2006/relationships/image" Target="../media/image11.emf"/><Relationship Id="rId12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emf"/><Relationship Id="rId5" Type="http://schemas.openxmlformats.org/officeDocument/2006/relationships/image" Target="../media/image9.png"/><Relationship Id="rId10" Type="http://schemas.openxmlformats.org/officeDocument/2006/relationships/image" Target="../media/image14.emf"/><Relationship Id="rId4" Type="http://schemas.openxmlformats.org/officeDocument/2006/relationships/image" Target="../media/image8.png"/><Relationship Id="rId9" Type="http://schemas.openxmlformats.org/officeDocument/2006/relationships/image" Target="../media/image13.emf"/><Relationship Id="rId14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0.png"/><Relationship Id="rId10" Type="http://schemas.openxmlformats.org/officeDocument/2006/relationships/chart" Target="../charts/chart4.xml"/><Relationship Id="rId4" Type="http://schemas.microsoft.com/office/2007/relationships/hdphoto" Target="../media/hdphoto1.wdp"/><Relationship Id="rId9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image" Target="../media/image32.emf"/><Relationship Id="rId18" Type="http://schemas.openxmlformats.org/officeDocument/2006/relationships/image" Target="../media/image37.png"/><Relationship Id="rId26" Type="http://schemas.openxmlformats.org/officeDocument/2006/relationships/image" Target="../media/image45.png"/><Relationship Id="rId39" Type="http://schemas.openxmlformats.org/officeDocument/2006/relationships/image" Target="../media/image58.png"/><Relationship Id="rId3" Type="http://schemas.openxmlformats.org/officeDocument/2006/relationships/image" Target="../media/image22.png"/><Relationship Id="rId21" Type="http://schemas.openxmlformats.org/officeDocument/2006/relationships/image" Target="../media/image40.emf"/><Relationship Id="rId34" Type="http://schemas.openxmlformats.org/officeDocument/2006/relationships/image" Target="../media/image53.png"/><Relationship Id="rId7" Type="http://schemas.openxmlformats.org/officeDocument/2006/relationships/image" Target="../media/image26.png"/><Relationship Id="rId12" Type="http://schemas.openxmlformats.org/officeDocument/2006/relationships/image" Target="../media/image31.emf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33" Type="http://schemas.openxmlformats.org/officeDocument/2006/relationships/image" Target="../media/image52.png"/><Relationship Id="rId38" Type="http://schemas.openxmlformats.org/officeDocument/2006/relationships/image" Target="../media/image57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35.png"/><Relationship Id="rId20" Type="http://schemas.openxmlformats.org/officeDocument/2006/relationships/image" Target="../media/image39.emf"/><Relationship Id="rId29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24" Type="http://schemas.openxmlformats.org/officeDocument/2006/relationships/image" Target="../media/image43.png"/><Relationship Id="rId32" Type="http://schemas.openxmlformats.org/officeDocument/2006/relationships/image" Target="../media/image51.png"/><Relationship Id="rId37" Type="http://schemas.openxmlformats.org/officeDocument/2006/relationships/image" Target="../media/image56.png"/><Relationship Id="rId40" Type="http://schemas.openxmlformats.org/officeDocument/2006/relationships/image" Target="../media/image59.png"/><Relationship Id="rId5" Type="http://schemas.openxmlformats.org/officeDocument/2006/relationships/image" Target="../media/image24.png"/><Relationship Id="rId15" Type="http://schemas.openxmlformats.org/officeDocument/2006/relationships/image" Target="../media/image34.emf"/><Relationship Id="rId23" Type="http://schemas.openxmlformats.org/officeDocument/2006/relationships/image" Target="../media/image42.png"/><Relationship Id="rId28" Type="http://schemas.openxmlformats.org/officeDocument/2006/relationships/image" Target="../media/image47.png"/><Relationship Id="rId36" Type="http://schemas.openxmlformats.org/officeDocument/2006/relationships/image" Target="../media/image55.png"/><Relationship Id="rId10" Type="http://schemas.openxmlformats.org/officeDocument/2006/relationships/image" Target="../media/image29.png"/><Relationship Id="rId19" Type="http://schemas.openxmlformats.org/officeDocument/2006/relationships/image" Target="../media/image38.emf"/><Relationship Id="rId31" Type="http://schemas.openxmlformats.org/officeDocument/2006/relationships/image" Target="../media/image50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emf"/><Relationship Id="rId22" Type="http://schemas.openxmlformats.org/officeDocument/2006/relationships/image" Target="../media/image41.png"/><Relationship Id="rId27" Type="http://schemas.openxmlformats.org/officeDocument/2006/relationships/image" Target="../media/image46.png"/><Relationship Id="rId30" Type="http://schemas.openxmlformats.org/officeDocument/2006/relationships/image" Target="../media/image49.png"/><Relationship Id="rId35" Type="http://schemas.openxmlformats.org/officeDocument/2006/relationships/image" Target="../media/image5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BC0AF79D-734D-480F-B1FB-BDD07A1DF0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5847779"/>
              </p:ext>
            </p:extLst>
          </p:nvPr>
        </p:nvGraphicFramePr>
        <p:xfrm>
          <a:off x="1419291" y="1344535"/>
          <a:ext cx="6410916" cy="36899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ight Brace 2"/>
          <p:cNvSpPr/>
          <p:nvPr/>
        </p:nvSpPr>
        <p:spPr>
          <a:xfrm rot="16200000">
            <a:off x="4587551" y="718743"/>
            <a:ext cx="45719" cy="2900955"/>
          </a:xfrm>
          <a:prstGeom prst="rightBrac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3"/>
          <p:cNvSpPr txBox="1"/>
          <p:nvPr/>
        </p:nvSpPr>
        <p:spPr>
          <a:xfrm>
            <a:off x="4480435" y="188014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ight Brace 4"/>
          <p:cNvSpPr/>
          <p:nvPr/>
        </p:nvSpPr>
        <p:spPr>
          <a:xfrm rot="16200000">
            <a:off x="5323141" y="614507"/>
            <a:ext cx="154281" cy="2673698"/>
          </a:xfrm>
          <a:prstGeom prst="rightBrac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33"/>
          <p:cNvSpPr txBox="1"/>
          <p:nvPr/>
        </p:nvSpPr>
        <p:spPr>
          <a:xfrm>
            <a:off x="5213912" y="161372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03622" y="48081"/>
            <a:ext cx="1423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714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-2" r="-285"/>
          <a:stretch/>
        </p:blipFill>
        <p:spPr>
          <a:xfrm>
            <a:off x="760727" y="4300453"/>
            <a:ext cx="7704000" cy="4137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25135" y="4099203"/>
            <a:ext cx="1170203" cy="8485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93776" y="4231203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4417830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  <a:endParaRPr lang="en-US" sz="12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1164" y="4032544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00068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85002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02249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311496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483686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694691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94647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105601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97012" y="40329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62785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657114" y="4032978"/>
            <a:ext cx="346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864647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073063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282619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469310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650216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861239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043302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238173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33196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649644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45865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036465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256750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440075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627542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823763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015473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208108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396611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581878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785941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921328" y="3812976"/>
            <a:ext cx="20693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 from untreate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077019" y="5859958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ranchin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436875" y="5839358"/>
            <a:ext cx="12330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lactosylatio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065754" y="5839358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alylatio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01088" y="606751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312" y="6254144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  <a:endParaRPr lang="en-US" sz="12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Freeform 24"/>
          <p:cNvSpPr>
            <a:spLocks/>
          </p:cNvSpPr>
          <p:nvPr/>
        </p:nvSpPr>
        <p:spPr bwMode="auto">
          <a:xfrm>
            <a:off x="674769" y="85458"/>
            <a:ext cx="8124825" cy="1187450"/>
          </a:xfrm>
          <a:custGeom>
            <a:avLst/>
            <a:gdLst>
              <a:gd name="T0" fmla="*/ 79 w 5118"/>
              <a:gd name="T1" fmla="*/ 397 h 748"/>
              <a:gd name="T2" fmla="*/ 160 w 5118"/>
              <a:gd name="T3" fmla="*/ 496 h 748"/>
              <a:gd name="T4" fmla="*/ 241 w 5118"/>
              <a:gd name="T5" fmla="*/ 625 h 748"/>
              <a:gd name="T6" fmla="*/ 324 w 5118"/>
              <a:gd name="T7" fmla="*/ 650 h 748"/>
              <a:gd name="T8" fmla="*/ 405 w 5118"/>
              <a:gd name="T9" fmla="*/ 627 h 748"/>
              <a:gd name="T10" fmla="*/ 486 w 5118"/>
              <a:gd name="T11" fmla="*/ 677 h 748"/>
              <a:gd name="T12" fmla="*/ 567 w 5118"/>
              <a:gd name="T13" fmla="*/ 682 h 748"/>
              <a:gd name="T14" fmla="*/ 648 w 5118"/>
              <a:gd name="T15" fmla="*/ 702 h 748"/>
              <a:gd name="T16" fmla="*/ 729 w 5118"/>
              <a:gd name="T17" fmla="*/ 713 h 748"/>
              <a:gd name="T18" fmla="*/ 810 w 5118"/>
              <a:gd name="T19" fmla="*/ 706 h 748"/>
              <a:gd name="T20" fmla="*/ 891 w 5118"/>
              <a:gd name="T21" fmla="*/ 702 h 748"/>
              <a:gd name="T22" fmla="*/ 973 w 5118"/>
              <a:gd name="T23" fmla="*/ 711 h 748"/>
              <a:gd name="T24" fmla="*/ 1053 w 5118"/>
              <a:gd name="T25" fmla="*/ 721 h 748"/>
              <a:gd name="T26" fmla="*/ 1134 w 5118"/>
              <a:gd name="T27" fmla="*/ 699 h 748"/>
              <a:gd name="T28" fmla="*/ 1217 w 5118"/>
              <a:gd name="T29" fmla="*/ 726 h 748"/>
              <a:gd name="T30" fmla="*/ 1301 w 5118"/>
              <a:gd name="T31" fmla="*/ 700 h 748"/>
              <a:gd name="T32" fmla="*/ 1382 w 5118"/>
              <a:gd name="T33" fmla="*/ 418 h 748"/>
              <a:gd name="T34" fmla="*/ 1463 w 5118"/>
              <a:gd name="T35" fmla="*/ 721 h 748"/>
              <a:gd name="T36" fmla="*/ 1546 w 5118"/>
              <a:gd name="T37" fmla="*/ 724 h 748"/>
              <a:gd name="T38" fmla="*/ 1627 w 5118"/>
              <a:gd name="T39" fmla="*/ 704 h 748"/>
              <a:gd name="T40" fmla="*/ 1708 w 5118"/>
              <a:gd name="T41" fmla="*/ 707 h 748"/>
              <a:gd name="T42" fmla="*/ 1791 w 5118"/>
              <a:gd name="T43" fmla="*/ 722 h 748"/>
              <a:gd name="T44" fmla="*/ 1872 w 5118"/>
              <a:gd name="T45" fmla="*/ 523 h 748"/>
              <a:gd name="T46" fmla="*/ 1953 w 5118"/>
              <a:gd name="T47" fmla="*/ 710 h 748"/>
              <a:gd name="T48" fmla="*/ 2035 w 5118"/>
              <a:gd name="T49" fmla="*/ 734 h 748"/>
              <a:gd name="T50" fmla="*/ 2118 w 5118"/>
              <a:gd name="T51" fmla="*/ 697 h 748"/>
              <a:gd name="T52" fmla="*/ 2198 w 5118"/>
              <a:gd name="T53" fmla="*/ 725 h 748"/>
              <a:gd name="T54" fmla="*/ 2281 w 5118"/>
              <a:gd name="T55" fmla="*/ 719 h 748"/>
              <a:gd name="T56" fmla="*/ 2363 w 5118"/>
              <a:gd name="T57" fmla="*/ 584 h 748"/>
              <a:gd name="T58" fmla="*/ 2444 w 5118"/>
              <a:gd name="T59" fmla="*/ 704 h 748"/>
              <a:gd name="T60" fmla="*/ 2525 w 5118"/>
              <a:gd name="T61" fmla="*/ 703 h 748"/>
              <a:gd name="T62" fmla="*/ 2606 w 5118"/>
              <a:gd name="T63" fmla="*/ 727 h 748"/>
              <a:gd name="T64" fmla="*/ 2689 w 5118"/>
              <a:gd name="T65" fmla="*/ 538 h 748"/>
              <a:gd name="T66" fmla="*/ 2770 w 5118"/>
              <a:gd name="T67" fmla="*/ 659 h 748"/>
              <a:gd name="T68" fmla="*/ 2851 w 5118"/>
              <a:gd name="T69" fmla="*/ 727 h 748"/>
              <a:gd name="T70" fmla="*/ 2932 w 5118"/>
              <a:gd name="T71" fmla="*/ 731 h 748"/>
              <a:gd name="T72" fmla="*/ 3013 w 5118"/>
              <a:gd name="T73" fmla="*/ 708 h 748"/>
              <a:gd name="T74" fmla="*/ 3094 w 5118"/>
              <a:gd name="T75" fmla="*/ 674 h 748"/>
              <a:gd name="T76" fmla="*/ 3177 w 5118"/>
              <a:gd name="T77" fmla="*/ 733 h 748"/>
              <a:gd name="T78" fmla="*/ 3258 w 5118"/>
              <a:gd name="T79" fmla="*/ 727 h 748"/>
              <a:gd name="T80" fmla="*/ 3340 w 5118"/>
              <a:gd name="T81" fmla="*/ 721 h 748"/>
              <a:gd name="T82" fmla="*/ 3423 w 5118"/>
              <a:gd name="T83" fmla="*/ 733 h 748"/>
              <a:gd name="T84" fmla="*/ 3504 w 5118"/>
              <a:gd name="T85" fmla="*/ 732 h 748"/>
              <a:gd name="T86" fmla="*/ 3585 w 5118"/>
              <a:gd name="T87" fmla="*/ 740 h 748"/>
              <a:gd name="T88" fmla="*/ 3665 w 5118"/>
              <a:gd name="T89" fmla="*/ 719 h 748"/>
              <a:gd name="T90" fmla="*/ 3747 w 5118"/>
              <a:gd name="T91" fmla="*/ 730 h 748"/>
              <a:gd name="T92" fmla="*/ 3830 w 5118"/>
              <a:gd name="T93" fmla="*/ 734 h 748"/>
              <a:gd name="T94" fmla="*/ 3911 w 5118"/>
              <a:gd name="T95" fmla="*/ 739 h 748"/>
              <a:gd name="T96" fmla="*/ 3994 w 5118"/>
              <a:gd name="T97" fmla="*/ 724 h 748"/>
              <a:gd name="T98" fmla="*/ 4077 w 5118"/>
              <a:gd name="T99" fmla="*/ 739 h 748"/>
              <a:gd name="T100" fmla="*/ 4161 w 5118"/>
              <a:gd name="T101" fmla="*/ 726 h 748"/>
              <a:gd name="T102" fmla="*/ 4242 w 5118"/>
              <a:gd name="T103" fmla="*/ 743 h 748"/>
              <a:gd name="T104" fmla="*/ 4322 w 5118"/>
              <a:gd name="T105" fmla="*/ 736 h 748"/>
              <a:gd name="T106" fmla="*/ 4410 w 5118"/>
              <a:gd name="T107" fmla="*/ 741 h 748"/>
              <a:gd name="T108" fmla="*/ 4491 w 5118"/>
              <a:gd name="T109" fmla="*/ 735 h 748"/>
              <a:gd name="T110" fmla="*/ 4575 w 5118"/>
              <a:gd name="T111" fmla="*/ 742 h 748"/>
              <a:gd name="T112" fmla="*/ 4655 w 5118"/>
              <a:gd name="T113" fmla="*/ 745 h 748"/>
              <a:gd name="T114" fmla="*/ 4741 w 5118"/>
              <a:gd name="T115" fmla="*/ 744 h 748"/>
              <a:gd name="T116" fmla="*/ 4828 w 5118"/>
              <a:gd name="T117" fmla="*/ 744 h 748"/>
              <a:gd name="T118" fmla="*/ 4913 w 5118"/>
              <a:gd name="T119" fmla="*/ 744 h 748"/>
              <a:gd name="T120" fmla="*/ 5001 w 5118"/>
              <a:gd name="T121" fmla="*/ 743 h 748"/>
              <a:gd name="T122" fmla="*/ 5084 w 5118"/>
              <a:gd name="T123" fmla="*/ 744 h 7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5118" h="748">
                <a:moveTo>
                  <a:pt x="0" y="139"/>
                </a:moveTo>
                <a:lnTo>
                  <a:pt x="2" y="201"/>
                </a:lnTo>
                <a:lnTo>
                  <a:pt x="4" y="246"/>
                </a:lnTo>
                <a:lnTo>
                  <a:pt x="6" y="281"/>
                </a:lnTo>
                <a:lnTo>
                  <a:pt x="8" y="311"/>
                </a:lnTo>
                <a:lnTo>
                  <a:pt x="11" y="336"/>
                </a:lnTo>
                <a:lnTo>
                  <a:pt x="13" y="360"/>
                </a:lnTo>
                <a:lnTo>
                  <a:pt x="15" y="384"/>
                </a:lnTo>
                <a:lnTo>
                  <a:pt x="17" y="407"/>
                </a:lnTo>
                <a:lnTo>
                  <a:pt x="19" y="429"/>
                </a:lnTo>
                <a:lnTo>
                  <a:pt x="22" y="448"/>
                </a:lnTo>
                <a:lnTo>
                  <a:pt x="23" y="463"/>
                </a:lnTo>
                <a:lnTo>
                  <a:pt x="25" y="474"/>
                </a:lnTo>
                <a:lnTo>
                  <a:pt x="27" y="482"/>
                </a:lnTo>
                <a:lnTo>
                  <a:pt x="30" y="487"/>
                </a:lnTo>
                <a:lnTo>
                  <a:pt x="32" y="489"/>
                </a:lnTo>
                <a:lnTo>
                  <a:pt x="34" y="491"/>
                </a:lnTo>
                <a:lnTo>
                  <a:pt x="36" y="493"/>
                </a:lnTo>
                <a:lnTo>
                  <a:pt x="38" y="494"/>
                </a:lnTo>
                <a:lnTo>
                  <a:pt x="41" y="496"/>
                </a:lnTo>
                <a:lnTo>
                  <a:pt x="43" y="496"/>
                </a:lnTo>
                <a:lnTo>
                  <a:pt x="44" y="495"/>
                </a:lnTo>
                <a:lnTo>
                  <a:pt x="47" y="494"/>
                </a:lnTo>
                <a:lnTo>
                  <a:pt x="49" y="492"/>
                </a:lnTo>
                <a:lnTo>
                  <a:pt x="51" y="490"/>
                </a:lnTo>
                <a:lnTo>
                  <a:pt x="53" y="489"/>
                </a:lnTo>
                <a:lnTo>
                  <a:pt x="55" y="488"/>
                </a:lnTo>
                <a:lnTo>
                  <a:pt x="58" y="488"/>
                </a:lnTo>
                <a:lnTo>
                  <a:pt x="60" y="486"/>
                </a:lnTo>
                <a:lnTo>
                  <a:pt x="62" y="483"/>
                </a:lnTo>
                <a:lnTo>
                  <a:pt x="64" y="478"/>
                </a:lnTo>
                <a:lnTo>
                  <a:pt x="66" y="469"/>
                </a:lnTo>
                <a:lnTo>
                  <a:pt x="68" y="458"/>
                </a:lnTo>
                <a:lnTo>
                  <a:pt x="70" y="445"/>
                </a:lnTo>
                <a:lnTo>
                  <a:pt x="72" y="431"/>
                </a:lnTo>
                <a:lnTo>
                  <a:pt x="74" y="418"/>
                </a:lnTo>
                <a:lnTo>
                  <a:pt x="77" y="406"/>
                </a:lnTo>
                <a:lnTo>
                  <a:pt x="79" y="397"/>
                </a:lnTo>
                <a:lnTo>
                  <a:pt x="81" y="391"/>
                </a:lnTo>
                <a:lnTo>
                  <a:pt x="83" y="388"/>
                </a:lnTo>
                <a:lnTo>
                  <a:pt x="85" y="388"/>
                </a:lnTo>
                <a:lnTo>
                  <a:pt x="87" y="391"/>
                </a:lnTo>
                <a:lnTo>
                  <a:pt x="89" y="397"/>
                </a:lnTo>
                <a:lnTo>
                  <a:pt x="91" y="406"/>
                </a:lnTo>
                <a:lnTo>
                  <a:pt x="94" y="416"/>
                </a:lnTo>
                <a:lnTo>
                  <a:pt x="96" y="428"/>
                </a:lnTo>
                <a:lnTo>
                  <a:pt x="98" y="440"/>
                </a:lnTo>
                <a:lnTo>
                  <a:pt x="100" y="453"/>
                </a:lnTo>
                <a:lnTo>
                  <a:pt x="102" y="466"/>
                </a:lnTo>
                <a:lnTo>
                  <a:pt x="105" y="478"/>
                </a:lnTo>
                <a:lnTo>
                  <a:pt x="107" y="489"/>
                </a:lnTo>
                <a:lnTo>
                  <a:pt x="108" y="500"/>
                </a:lnTo>
                <a:lnTo>
                  <a:pt x="110" y="509"/>
                </a:lnTo>
                <a:lnTo>
                  <a:pt x="113" y="518"/>
                </a:lnTo>
                <a:lnTo>
                  <a:pt x="115" y="526"/>
                </a:lnTo>
                <a:lnTo>
                  <a:pt x="117" y="533"/>
                </a:lnTo>
                <a:lnTo>
                  <a:pt x="119" y="539"/>
                </a:lnTo>
                <a:lnTo>
                  <a:pt x="121" y="544"/>
                </a:lnTo>
                <a:lnTo>
                  <a:pt x="124" y="549"/>
                </a:lnTo>
                <a:lnTo>
                  <a:pt x="126" y="553"/>
                </a:lnTo>
                <a:lnTo>
                  <a:pt x="128" y="557"/>
                </a:lnTo>
                <a:lnTo>
                  <a:pt x="130" y="560"/>
                </a:lnTo>
                <a:lnTo>
                  <a:pt x="132" y="562"/>
                </a:lnTo>
                <a:lnTo>
                  <a:pt x="134" y="562"/>
                </a:lnTo>
                <a:lnTo>
                  <a:pt x="136" y="561"/>
                </a:lnTo>
                <a:lnTo>
                  <a:pt x="138" y="557"/>
                </a:lnTo>
                <a:lnTo>
                  <a:pt x="141" y="551"/>
                </a:lnTo>
                <a:lnTo>
                  <a:pt x="143" y="542"/>
                </a:lnTo>
                <a:lnTo>
                  <a:pt x="145" y="533"/>
                </a:lnTo>
                <a:lnTo>
                  <a:pt x="147" y="523"/>
                </a:lnTo>
                <a:lnTo>
                  <a:pt x="149" y="514"/>
                </a:lnTo>
                <a:lnTo>
                  <a:pt x="152" y="507"/>
                </a:lnTo>
                <a:lnTo>
                  <a:pt x="153" y="502"/>
                </a:lnTo>
                <a:lnTo>
                  <a:pt x="155" y="498"/>
                </a:lnTo>
                <a:lnTo>
                  <a:pt x="157" y="496"/>
                </a:lnTo>
                <a:lnTo>
                  <a:pt x="160" y="496"/>
                </a:lnTo>
                <a:lnTo>
                  <a:pt x="162" y="496"/>
                </a:lnTo>
                <a:lnTo>
                  <a:pt x="164" y="496"/>
                </a:lnTo>
                <a:lnTo>
                  <a:pt x="166" y="498"/>
                </a:lnTo>
                <a:lnTo>
                  <a:pt x="169" y="500"/>
                </a:lnTo>
                <a:lnTo>
                  <a:pt x="171" y="504"/>
                </a:lnTo>
                <a:lnTo>
                  <a:pt x="173" y="510"/>
                </a:lnTo>
                <a:lnTo>
                  <a:pt x="174" y="517"/>
                </a:lnTo>
                <a:lnTo>
                  <a:pt x="177" y="526"/>
                </a:lnTo>
                <a:lnTo>
                  <a:pt x="179" y="534"/>
                </a:lnTo>
                <a:lnTo>
                  <a:pt x="181" y="543"/>
                </a:lnTo>
                <a:lnTo>
                  <a:pt x="183" y="552"/>
                </a:lnTo>
                <a:lnTo>
                  <a:pt x="185" y="559"/>
                </a:lnTo>
                <a:lnTo>
                  <a:pt x="188" y="566"/>
                </a:lnTo>
                <a:lnTo>
                  <a:pt x="190" y="571"/>
                </a:lnTo>
                <a:lnTo>
                  <a:pt x="192" y="575"/>
                </a:lnTo>
                <a:lnTo>
                  <a:pt x="194" y="579"/>
                </a:lnTo>
                <a:lnTo>
                  <a:pt x="196" y="582"/>
                </a:lnTo>
                <a:lnTo>
                  <a:pt x="198" y="584"/>
                </a:lnTo>
                <a:lnTo>
                  <a:pt x="200" y="586"/>
                </a:lnTo>
                <a:lnTo>
                  <a:pt x="202" y="588"/>
                </a:lnTo>
                <a:lnTo>
                  <a:pt x="205" y="590"/>
                </a:lnTo>
                <a:lnTo>
                  <a:pt x="207" y="592"/>
                </a:lnTo>
                <a:lnTo>
                  <a:pt x="209" y="594"/>
                </a:lnTo>
                <a:lnTo>
                  <a:pt x="211" y="595"/>
                </a:lnTo>
                <a:lnTo>
                  <a:pt x="213" y="597"/>
                </a:lnTo>
                <a:lnTo>
                  <a:pt x="216" y="598"/>
                </a:lnTo>
                <a:lnTo>
                  <a:pt x="217" y="600"/>
                </a:lnTo>
                <a:lnTo>
                  <a:pt x="219" y="603"/>
                </a:lnTo>
                <a:lnTo>
                  <a:pt x="221" y="605"/>
                </a:lnTo>
                <a:lnTo>
                  <a:pt x="224" y="608"/>
                </a:lnTo>
                <a:lnTo>
                  <a:pt x="226" y="611"/>
                </a:lnTo>
                <a:lnTo>
                  <a:pt x="228" y="613"/>
                </a:lnTo>
                <a:lnTo>
                  <a:pt x="230" y="616"/>
                </a:lnTo>
                <a:lnTo>
                  <a:pt x="232" y="618"/>
                </a:lnTo>
                <a:lnTo>
                  <a:pt x="235" y="620"/>
                </a:lnTo>
                <a:lnTo>
                  <a:pt x="237" y="622"/>
                </a:lnTo>
                <a:lnTo>
                  <a:pt x="238" y="623"/>
                </a:lnTo>
                <a:lnTo>
                  <a:pt x="241" y="625"/>
                </a:lnTo>
                <a:lnTo>
                  <a:pt x="243" y="626"/>
                </a:lnTo>
                <a:lnTo>
                  <a:pt x="245" y="627"/>
                </a:lnTo>
                <a:lnTo>
                  <a:pt x="247" y="628"/>
                </a:lnTo>
                <a:lnTo>
                  <a:pt x="249" y="629"/>
                </a:lnTo>
                <a:lnTo>
                  <a:pt x="252" y="630"/>
                </a:lnTo>
                <a:lnTo>
                  <a:pt x="254" y="632"/>
                </a:lnTo>
                <a:lnTo>
                  <a:pt x="256" y="633"/>
                </a:lnTo>
                <a:lnTo>
                  <a:pt x="258" y="635"/>
                </a:lnTo>
                <a:lnTo>
                  <a:pt x="260" y="637"/>
                </a:lnTo>
                <a:lnTo>
                  <a:pt x="262" y="638"/>
                </a:lnTo>
                <a:lnTo>
                  <a:pt x="264" y="640"/>
                </a:lnTo>
                <a:lnTo>
                  <a:pt x="266" y="642"/>
                </a:lnTo>
                <a:lnTo>
                  <a:pt x="268" y="643"/>
                </a:lnTo>
                <a:lnTo>
                  <a:pt x="271" y="645"/>
                </a:lnTo>
                <a:lnTo>
                  <a:pt x="273" y="646"/>
                </a:lnTo>
                <a:lnTo>
                  <a:pt x="275" y="647"/>
                </a:lnTo>
                <a:lnTo>
                  <a:pt x="277" y="648"/>
                </a:lnTo>
                <a:lnTo>
                  <a:pt x="279" y="649"/>
                </a:lnTo>
                <a:lnTo>
                  <a:pt x="282" y="650"/>
                </a:lnTo>
                <a:lnTo>
                  <a:pt x="283" y="651"/>
                </a:lnTo>
                <a:lnTo>
                  <a:pt x="285" y="652"/>
                </a:lnTo>
                <a:lnTo>
                  <a:pt x="288" y="652"/>
                </a:lnTo>
                <a:lnTo>
                  <a:pt x="290" y="653"/>
                </a:lnTo>
                <a:lnTo>
                  <a:pt x="292" y="654"/>
                </a:lnTo>
                <a:lnTo>
                  <a:pt x="294" y="654"/>
                </a:lnTo>
                <a:lnTo>
                  <a:pt x="296" y="655"/>
                </a:lnTo>
                <a:lnTo>
                  <a:pt x="299" y="655"/>
                </a:lnTo>
                <a:lnTo>
                  <a:pt x="301" y="655"/>
                </a:lnTo>
                <a:lnTo>
                  <a:pt x="303" y="656"/>
                </a:lnTo>
                <a:lnTo>
                  <a:pt x="304" y="656"/>
                </a:lnTo>
                <a:lnTo>
                  <a:pt x="307" y="656"/>
                </a:lnTo>
                <a:lnTo>
                  <a:pt x="309" y="656"/>
                </a:lnTo>
                <a:lnTo>
                  <a:pt x="311" y="655"/>
                </a:lnTo>
                <a:lnTo>
                  <a:pt x="316" y="655"/>
                </a:lnTo>
                <a:lnTo>
                  <a:pt x="318" y="655"/>
                </a:lnTo>
                <a:lnTo>
                  <a:pt x="320" y="654"/>
                </a:lnTo>
                <a:lnTo>
                  <a:pt x="322" y="653"/>
                </a:lnTo>
                <a:lnTo>
                  <a:pt x="324" y="650"/>
                </a:lnTo>
                <a:lnTo>
                  <a:pt x="326" y="645"/>
                </a:lnTo>
                <a:lnTo>
                  <a:pt x="328" y="638"/>
                </a:lnTo>
                <a:lnTo>
                  <a:pt x="330" y="627"/>
                </a:lnTo>
                <a:lnTo>
                  <a:pt x="332" y="613"/>
                </a:lnTo>
                <a:lnTo>
                  <a:pt x="335" y="597"/>
                </a:lnTo>
                <a:lnTo>
                  <a:pt x="337" y="579"/>
                </a:lnTo>
                <a:lnTo>
                  <a:pt x="339" y="561"/>
                </a:lnTo>
                <a:lnTo>
                  <a:pt x="341" y="545"/>
                </a:lnTo>
                <a:lnTo>
                  <a:pt x="343" y="532"/>
                </a:lnTo>
                <a:lnTo>
                  <a:pt x="346" y="521"/>
                </a:lnTo>
                <a:lnTo>
                  <a:pt x="347" y="513"/>
                </a:lnTo>
                <a:lnTo>
                  <a:pt x="349" y="507"/>
                </a:lnTo>
                <a:lnTo>
                  <a:pt x="352" y="503"/>
                </a:lnTo>
                <a:lnTo>
                  <a:pt x="354" y="500"/>
                </a:lnTo>
                <a:lnTo>
                  <a:pt x="356" y="498"/>
                </a:lnTo>
                <a:lnTo>
                  <a:pt x="358" y="497"/>
                </a:lnTo>
                <a:lnTo>
                  <a:pt x="360" y="497"/>
                </a:lnTo>
                <a:lnTo>
                  <a:pt x="363" y="498"/>
                </a:lnTo>
                <a:lnTo>
                  <a:pt x="365" y="501"/>
                </a:lnTo>
                <a:lnTo>
                  <a:pt x="367" y="506"/>
                </a:lnTo>
                <a:lnTo>
                  <a:pt x="368" y="513"/>
                </a:lnTo>
                <a:lnTo>
                  <a:pt x="371" y="522"/>
                </a:lnTo>
                <a:lnTo>
                  <a:pt x="373" y="532"/>
                </a:lnTo>
                <a:lnTo>
                  <a:pt x="375" y="544"/>
                </a:lnTo>
                <a:lnTo>
                  <a:pt x="377" y="555"/>
                </a:lnTo>
                <a:lnTo>
                  <a:pt x="379" y="566"/>
                </a:lnTo>
                <a:lnTo>
                  <a:pt x="382" y="577"/>
                </a:lnTo>
                <a:lnTo>
                  <a:pt x="384" y="586"/>
                </a:lnTo>
                <a:lnTo>
                  <a:pt x="386" y="594"/>
                </a:lnTo>
                <a:lnTo>
                  <a:pt x="388" y="600"/>
                </a:lnTo>
                <a:lnTo>
                  <a:pt x="390" y="606"/>
                </a:lnTo>
                <a:lnTo>
                  <a:pt x="392" y="610"/>
                </a:lnTo>
                <a:lnTo>
                  <a:pt x="394" y="614"/>
                </a:lnTo>
                <a:lnTo>
                  <a:pt x="396" y="617"/>
                </a:lnTo>
                <a:lnTo>
                  <a:pt x="399" y="619"/>
                </a:lnTo>
                <a:lnTo>
                  <a:pt x="401" y="621"/>
                </a:lnTo>
                <a:lnTo>
                  <a:pt x="403" y="624"/>
                </a:lnTo>
                <a:lnTo>
                  <a:pt x="405" y="627"/>
                </a:lnTo>
                <a:lnTo>
                  <a:pt x="407" y="630"/>
                </a:lnTo>
                <a:lnTo>
                  <a:pt x="410" y="633"/>
                </a:lnTo>
                <a:lnTo>
                  <a:pt x="412" y="637"/>
                </a:lnTo>
                <a:lnTo>
                  <a:pt x="413" y="641"/>
                </a:lnTo>
                <a:lnTo>
                  <a:pt x="415" y="645"/>
                </a:lnTo>
                <a:lnTo>
                  <a:pt x="418" y="650"/>
                </a:lnTo>
                <a:lnTo>
                  <a:pt x="420" y="654"/>
                </a:lnTo>
                <a:lnTo>
                  <a:pt x="422" y="658"/>
                </a:lnTo>
                <a:lnTo>
                  <a:pt x="424" y="662"/>
                </a:lnTo>
                <a:lnTo>
                  <a:pt x="426" y="665"/>
                </a:lnTo>
                <a:lnTo>
                  <a:pt x="429" y="667"/>
                </a:lnTo>
                <a:lnTo>
                  <a:pt x="431" y="667"/>
                </a:lnTo>
                <a:lnTo>
                  <a:pt x="433" y="667"/>
                </a:lnTo>
                <a:lnTo>
                  <a:pt x="435" y="667"/>
                </a:lnTo>
                <a:lnTo>
                  <a:pt x="437" y="665"/>
                </a:lnTo>
                <a:lnTo>
                  <a:pt x="439" y="663"/>
                </a:lnTo>
                <a:lnTo>
                  <a:pt x="441" y="662"/>
                </a:lnTo>
                <a:lnTo>
                  <a:pt x="443" y="661"/>
                </a:lnTo>
                <a:lnTo>
                  <a:pt x="446" y="660"/>
                </a:lnTo>
                <a:lnTo>
                  <a:pt x="448" y="660"/>
                </a:lnTo>
                <a:lnTo>
                  <a:pt x="450" y="661"/>
                </a:lnTo>
                <a:lnTo>
                  <a:pt x="452" y="662"/>
                </a:lnTo>
                <a:lnTo>
                  <a:pt x="454" y="663"/>
                </a:lnTo>
                <a:lnTo>
                  <a:pt x="456" y="665"/>
                </a:lnTo>
                <a:lnTo>
                  <a:pt x="458" y="666"/>
                </a:lnTo>
                <a:lnTo>
                  <a:pt x="460" y="668"/>
                </a:lnTo>
                <a:lnTo>
                  <a:pt x="462" y="669"/>
                </a:lnTo>
                <a:lnTo>
                  <a:pt x="465" y="671"/>
                </a:lnTo>
                <a:lnTo>
                  <a:pt x="467" y="672"/>
                </a:lnTo>
                <a:lnTo>
                  <a:pt x="469" y="673"/>
                </a:lnTo>
                <a:lnTo>
                  <a:pt x="471" y="674"/>
                </a:lnTo>
                <a:lnTo>
                  <a:pt x="474" y="676"/>
                </a:lnTo>
                <a:lnTo>
                  <a:pt x="476" y="677"/>
                </a:lnTo>
                <a:lnTo>
                  <a:pt x="477" y="677"/>
                </a:lnTo>
                <a:lnTo>
                  <a:pt x="479" y="678"/>
                </a:lnTo>
                <a:lnTo>
                  <a:pt x="482" y="678"/>
                </a:lnTo>
                <a:lnTo>
                  <a:pt x="484" y="678"/>
                </a:lnTo>
                <a:lnTo>
                  <a:pt x="486" y="677"/>
                </a:lnTo>
                <a:lnTo>
                  <a:pt x="488" y="676"/>
                </a:lnTo>
                <a:lnTo>
                  <a:pt x="490" y="673"/>
                </a:lnTo>
                <a:lnTo>
                  <a:pt x="493" y="669"/>
                </a:lnTo>
                <a:lnTo>
                  <a:pt x="495" y="662"/>
                </a:lnTo>
                <a:lnTo>
                  <a:pt x="497" y="655"/>
                </a:lnTo>
                <a:lnTo>
                  <a:pt x="499" y="647"/>
                </a:lnTo>
                <a:lnTo>
                  <a:pt x="501" y="642"/>
                </a:lnTo>
                <a:lnTo>
                  <a:pt x="503" y="641"/>
                </a:lnTo>
                <a:lnTo>
                  <a:pt x="505" y="643"/>
                </a:lnTo>
                <a:lnTo>
                  <a:pt x="507" y="647"/>
                </a:lnTo>
                <a:lnTo>
                  <a:pt x="510" y="653"/>
                </a:lnTo>
                <a:lnTo>
                  <a:pt x="512" y="659"/>
                </a:lnTo>
                <a:lnTo>
                  <a:pt x="514" y="664"/>
                </a:lnTo>
                <a:lnTo>
                  <a:pt x="516" y="669"/>
                </a:lnTo>
                <a:lnTo>
                  <a:pt x="518" y="673"/>
                </a:lnTo>
                <a:lnTo>
                  <a:pt x="521" y="676"/>
                </a:lnTo>
                <a:lnTo>
                  <a:pt x="522" y="679"/>
                </a:lnTo>
                <a:lnTo>
                  <a:pt x="524" y="682"/>
                </a:lnTo>
                <a:lnTo>
                  <a:pt x="526" y="684"/>
                </a:lnTo>
                <a:lnTo>
                  <a:pt x="529" y="685"/>
                </a:lnTo>
                <a:lnTo>
                  <a:pt x="531" y="686"/>
                </a:lnTo>
                <a:lnTo>
                  <a:pt x="533" y="687"/>
                </a:lnTo>
                <a:lnTo>
                  <a:pt x="535" y="687"/>
                </a:lnTo>
                <a:lnTo>
                  <a:pt x="537" y="687"/>
                </a:lnTo>
                <a:lnTo>
                  <a:pt x="540" y="687"/>
                </a:lnTo>
                <a:lnTo>
                  <a:pt x="542" y="687"/>
                </a:lnTo>
                <a:lnTo>
                  <a:pt x="543" y="686"/>
                </a:lnTo>
                <a:lnTo>
                  <a:pt x="546" y="686"/>
                </a:lnTo>
                <a:lnTo>
                  <a:pt x="548" y="685"/>
                </a:lnTo>
                <a:lnTo>
                  <a:pt x="550" y="685"/>
                </a:lnTo>
                <a:lnTo>
                  <a:pt x="552" y="684"/>
                </a:lnTo>
                <a:lnTo>
                  <a:pt x="554" y="684"/>
                </a:lnTo>
                <a:lnTo>
                  <a:pt x="557" y="684"/>
                </a:lnTo>
                <a:lnTo>
                  <a:pt x="559" y="683"/>
                </a:lnTo>
                <a:lnTo>
                  <a:pt x="561" y="683"/>
                </a:lnTo>
                <a:lnTo>
                  <a:pt x="563" y="682"/>
                </a:lnTo>
                <a:lnTo>
                  <a:pt x="565" y="682"/>
                </a:lnTo>
                <a:lnTo>
                  <a:pt x="567" y="682"/>
                </a:lnTo>
                <a:lnTo>
                  <a:pt x="569" y="682"/>
                </a:lnTo>
                <a:lnTo>
                  <a:pt x="571" y="682"/>
                </a:lnTo>
                <a:lnTo>
                  <a:pt x="573" y="683"/>
                </a:lnTo>
                <a:lnTo>
                  <a:pt x="576" y="684"/>
                </a:lnTo>
                <a:lnTo>
                  <a:pt x="578" y="684"/>
                </a:lnTo>
                <a:lnTo>
                  <a:pt x="580" y="685"/>
                </a:lnTo>
                <a:lnTo>
                  <a:pt x="582" y="686"/>
                </a:lnTo>
                <a:lnTo>
                  <a:pt x="584" y="687"/>
                </a:lnTo>
                <a:lnTo>
                  <a:pt x="586" y="689"/>
                </a:lnTo>
                <a:lnTo>
                  <a:pt x="588" y="690"/>
                </a:lnTo>
                <a:lnTo>
                  <a:pt x="590" y="691"/>
                </a:lnTo>
                <a:lnTo>
                  <a:pt x="593" y="692"/>
                </a:lnTo>
                <a:lnTo>
                  <a:pt x="595" y="693"/>
                </a:lnTo>
                <a:lnTo>
                  <a:pt x="597" y="694"/>
                </a:lnTo>
                <a:lnTo>
                  <a:pt x="599" y="695"/>
                </a:lnTo>
                <a:lnTo>
                  <a:pt x="601" y="695"/>
                </a:lnTo>
                <a:lnTo>
                  <a:pt x="604" y="696"/>
                </a:lnTo>
                <a:lnTo>
                  <a:pt x="606" y="696"/>
                </a:lnTo>
                <a:lnTo>
                  <a:pt x="607" y="696"/>
                </a:lnTo>
                <a:lnTo>
                  <a:pt x="609" y="696"/>
                </a:lnTo>
                <a:lnTo>
                  <a:pt x="612" y="696"/>
                </a:lnTo>
                <a:lnTo>
                  <a:pt x="614" y="697"/>
                </a:lnTo>
                <a:lnTo>
                  <a:pt x="616" y="697"/>
                </a:lnTo>
                <a:lnTo>
                  <a:pt x="618" y="698"/>
                </a:lnTo>
                <a:lnTo>
                  <a:pt x="621" y="699"/>
                </a:lnTo>
                <a:lnTo>
                  <a:pt x="623" y="699"/>
                </a:lnTo>
                <a:lnTo>
                  <a:pt x="625" y="700"/>
                </a:lnTo>
                <a:lnTo>
                  <a:pt x="627" y="700"/>
                </a:lnTo>
                <a:lnTo>
                  <a:pt x="629" y="701"/>
                </a:lnTo>
                <a:lnTo>
                  <a:pt x="631" y="701"/>
                </a:lnTo>
                <a:lnTo>
                  <a:pt x="633" y="702"/>
                </a:lnTo>
                <a:lnTo>
                  <a:pt x="635" y="702"/>
                </a:lnTo>
                <a:lnTo>
                  <a:pt x="637" y="702"/>
                </a:lnTo>
                <a:lnTo>
                  <a:pt x="640" y="703"/>
                </a:lnTo>
                <a:lnTo>
                  <a:pt x="642" y="703"/>
                </a:lnTo>
                <a:lnTo>
                  <a:pt x="644" y="703"/>
                </a:lnTo>
                <a:lnTo>
                  <a:pt x="646" y="703"/>
                </a:lnTo>
                <a:lnTo>
                  <a:pt x="648" y="702"/>
                </a:lnTo>
                <a:lnTo>
                  <a:pt x="651" y="702"/>
                </a:lnTo>
                <a:lnTo>
                  <a:pt x="652" y="700"/>
                </a:lnTo>
                <a:lnTo>
                  <a:pt x="654" y="699"/>
                </a:lnTo>
                <a:lnTo>
                  <a:pt x="657" y="696"/>
                </a:lnTo>
                <a:lnTo>
                  <a:pt x="659" y="693"/>
                </a:lnTo>
                <a:lnTo>
                  <a:pt x="661" y="690"/>
                </a:lnTo>
                <a:lnTo>
                  <a:pt x="663" y="686"/>
                </a:lnTo>
                <a:lnTo>
                  <a:pt x="665" y="682"/>
                </a:lnTo>
                <a:lnTo>
                  <a:pt x="668" y="677"/>
                </a:lnTo>
                <a:lnTo>
                  <a:pt x="670" y="673"/>
                </a:lnTo>
                <a:lnTo>
                  <a:pt x="672" y="669"/>
                </a:lnTo>
                <a:lnTo>
                  <a:pt x="673" y="666"/>
                </a:lnTo>
                <a:lnTo>
                  <a:pt x="676" y="663"/>
                </a:lnTo>
                <a:lnTo>
                  <a:pt x="678" y="661"/>
                </a:lnTo>
                <a:lnTo>
                  <a:pt x="680" y="660"/>
                </a:lnTo>
                <a:lnTo>
                  <a:pt x="682" y="658"/>
                </a:lnTo>
                <a:lnTo>
                  <a:pt x="684" y="658"/>
                </a:lnTo>
                <a:lnTo>
                  <a:pt x="687" y="658"/>
                </a:lnTo>
                <a:lnTo>
                  <a:pt x="689" y="658"/>
                </a:lnTo>
                <a:lnTo>
                  <a:pt x="691" y="660"/>
                </a:lnTo>
                <a:lnTo>
                  <a:pt x="693" y="662"/>
                </a:lnTo>
                <a:lnTo>
                  <a:pt x="695" y="665"/>
                </a:lnTo>
                <a:lnTo>
                  <a:pt x="697" y="669"/>
                </a:lnTo>
                <a:lnTo>
                  <a:pt x="699" y="673"/>
                </a:lnTo>
                <a:lnTo>
                  <a:pt x="701" y="678"/>
                </a:lnTo>
                <a:lnTo>
                  <a:pt x="704" y="682"/>
                </a:lnTo>
                <a:lnTo>
                  <a:pt x="706" y="687"/>
                </a:lnTo>
                <a:lnTo>
                  <a:pt x="708" y="691"/>
                </a:lnTo>
                <a:lnTo>
                  <a:pt x="710" y="695"/>
                </a:lnTo>
                <a:lnTo>
                  <a:pt x="712" y="699"/>
                </a:lnTo>
                <a:lnTo>
                  <a:pt x="715" y="702"/>
                </a:lnTo>
                <a:lnTo>
                  <a:pt x="716" y="705"/>
                </a:lnTo>
                <a:lnTo>
                  <a:pt x="718" y="708"/>
                </a:lnTo>
                <a:lnTo>
                  <a:pt x="720" y="710"/>
                </a:lnTo>
                <a:lnTo>
                  <a:pt x="723" y="711"/>
                </a:lnTo>
                <a:lnTo>
                  <a:pt x="725" y="713"/>
                </a:lnTo>
                <a:lnTo>
                  <a:pt x="727" y="713"/>
                </a:lnTo>
                <a:lnTo>
                  <a:pt x="729" y="713"/>
                </a:lnTo>
                <a:lnTo>
                  <a:pt x="731" y="711"/>
                </a:lnTo>
                <a:lnTo>
                  <a:pt x="734" y="710"/>
                </a:lnTo>
                <a:lnTo>
                  <a:pt x="736" y="708"/>
                </a:lnTo>
                <a:lnTo>
                  <a:pt x="737" y="706"/>
                </a:lnTo>
                <a:lnTo>
                  <a:pt x="740" y="704"/>
                </a:lnTo>
                <a:lnTo>
                  <a:pt x="742" y="702"/>
                </a:lnTo>
                <a:lnTo>
                  <a:pt x="744" y="701"/>
                </a:lnTo>
                <a:lnTo>
                  <a:pt x="746" y="700"/>
                </a:lnTo>
                <a:lnTo>
                  <a:pt x="748" y="699"/>
                </a:lnTo>
                <a:lnTo>
                  <a:pt x="751" y="698"/>
                </a:lnTo>
                <a:lnTo>
                  <a:pt x="753" y="696"/>
                </a:lnTo>
                <a:lnTo>
                  <a:pt x="755" y="695"/>
                </a:lnTo>
                <a:lnTo>
                  <a:pt x="757" y="693"/>
                </a:lnTo>
                <a:lnTo>
                  <a:pt x="759" y="692"/>
                </a:lnTo>
                <a:lnTo>
                  <a:pt x="761" y="690"/>
                </a:lnTo>
                <a:lnTo>
                  <a:pt x="763" y="689"/>
                </a:lnTo>
                <a:lnTo>
                  <a:pt x="765" y="687"/>
                </a:lnTo>
                <a:lnTo>
                  <a:pt x="768" y="686"/>
                </a:lnTo>
                <a:lnTo>
                  <a:pt x="770" y="685"/>
                </a:lnTo>
                <a:lnTo>
                  <a:pt x="772" y="684"/>
                </a:lnTo>
                <a:lnTo>
                  <a:pt x="774" y="684"/>
                </a:lnTo>
                <a:lnTo>
                  <a:pt x="776" y="684"/>
                </a:lnTo>
                <a:lnTo>
                  <a:pt x="779" y="685"/>
                </a:lnTo>
                <a:lnTo>
                  <a:pt x="781" y="685"/>
                </a:lnTo>
                <a:lnTo>
                  <a:pt x="782" y="686"/>
                </a:lnTo>
                <a:lnTo>
                  <a:pt x="784" y="687"/>
                </a:lnTo>
                <a:lnTo>
                  <a:pt x="787" y="689"/>
                </a:lnTo>
                <a:lnTo>
                  <a:pt x="789" y="690"/>
                </a:lnTo>
                <a:lnTo>
                  <a:pt x="791" y="691"/>
                </a:lnTo>
                <a:lnTo>
                  <a:pt x="793" y="693"/>
                </a:lnTo>
                <a:lnTo>
                  <a:pt x="795" y="694"/>
                </a:lnTo>
                <a:lnTo>
                  <a:pt x="798" y="696"/>
                </a:lnTo>
                <a:lnTo>
                  <a:pt x="800" y="698"/>
                </a:lnTo>
                <a:lnTo>
                  <a:pt x="802" y="700"/>
                </a:lnTo>
                <a:lnTo>
                  <a:pt x="804" y="702"/>
                </a:lnTo>
                <a:lnTo>
                  <a:pt x="806" y="703"/>
                </a:lnTo>
                <a:lnTo>
                  <a:pt x="808" y="704"/>
                </a:lnTo>
                <a:lnTo>
                  <a:pt x="810" y="706"/>
                </a:lnTo>
                <a:lnTo>
                  <a:pt x="812" y="707"/>
                </a:lnTo>
                <a:lnTo>
                  <a:pt x="815" y="708"/>
                </a:lnTo>
                <a:lnTo>
                  <a:pt x="817" y="709"/>
                </a:lnTo>
                <a:lnTo>
                  <a:pt x="819" y="710"/>
                </a:lnTo>
                <a:lnTo>
                  <a:pt x="821" y="711"/>
                </a:lnTo>
                <a:lnTo>
                  <a:pt x="823" y="711"/>
                </a:lnTo>
                <a:lnTo>
                  <a:pt x="825" y="712"/>
                </a:lnTo>
                <a:lnTo>
                  <a:pt x="827" y="712"/>
                </a:lnTo>
                <a:lnTo>
                  <a:pt x="829" y="712"/>
                </a:lnTo>
                <a:lnTo>
                  <a:pt x="831" y="713"/>
                </a:lnTo>
                <a:lnTo>
                  <a:pt x="834" y="713"/>
                </a:lnTo>
                <a:lnTo>
                  <a:pt x="836" y="713"/>
                </a:lnTo>
                <a:lnTo>
                  <a:pt x="838" y="714"/>
                </a:lnTo>
                <a:lnTo>
                  <a:pt x="840" y="714"/>
                </a:lnTo>
                <a:lnTo>
                  <a:pt x="842" y="715"/>
                </a:lnTo>
                <a:lnTo>
                  <a:pt x="845" y="715"/>
                </a:lnTo>
                <a:lnTo>
                  <a:pt x="846" y="715"/>
                </a:lnTo>
                <a:lnTo>
                  <a:pt x="848" y="715"/>
                </a:lnTo>
                <a:lnTo>
                  <a:pt x="851" y="715"/>
                </a:lnTo>
                <a:lnTo>
                  <a:pt x="853" y="715"/>
                </a:lnTo>
                <a:lnTo>
                  <a:pt x="855" y="715"/>
                </a:lnTo>
                <a:lnTo>
                  <a:pt x="857" y="714"/>
                </a:lnTo>
                <a:lnTo>
                  <a:pt x="859" y="713"/>
                </a:lnTo>
                <a:lnTo>
                  <a:pt x="862" y="713"/>
                </a:lnTo>
                <a:lnTo>
                  <a:pt x="864" y="712"/>
                </a:lnTo>
                <a:lnTo>
                  <a:pt x="866" y="711"/>
                </a:lnTo>
                <a:lnTo>
                  <a:pt x="867" y="711"/>
                </a:lnTo>
                <a:lnTo>
                  <a:pt x="870" y="711"/>
                </a:lnTo>
                <a:lnTo>
                  <a:pt x="872" y="711"/>
                </a:lnTo>
                <a:lnTo>
                  <a:pt x="874" y="710"/>
                </a:lnTo>
                <a:lnTo>
                  <a:pt x="876" y="710"/>
                </a:lnTo>
                <a:lnTo>
                  <a:pt x="878" y="709"/>
                </a:lnTo>
                <a:lnTo>
                  <a:pt x="881" y="709"/>
                </a:lnTo>
                <a:lnTo>
                  <a:pt x="883" y="708"/>
                </a:lnTo>
                <a:lnTo>
                  <a:pt x="885" y="707"/>
                </a:lnTo>
                <a:lnTo>
                  <a:pt x="887" y="706"/>
                </a:lnTo>
                <a:lnTo>
                  <a:pt x="889" y="704"/>
                </a:lnTo>
                <a:lnTo>
                  <a:pt x="891" y="702"/>
                </a:lnTo>
                <a:lnTo>
                  <a:pt x="893" y="698"/>
                </a:lnTo>
                <a:lnTo>
                  <a:pt x="895" y="695"/>
                </a:lnTo>
                <a:lnTo>
                  <a:pt x="898" y="691"/>
                </a:lnTo>
                <a:lnTo>
                  <a:pt x="900" y="686"/>
                </a:lnTo>
                <a:lnTo>
                  <a:pt x="902" y="681"/>
                </a:lnTo>
                <a:lnTo>
                  <a:pt x="904" y="676"/>
                </a:lnTo>
                <a:lnTo>
                  <a:pt x="906" y="671"/>
                </a:lnTo>
                <a:lnTo>
                  <a:pt x="909" y="667"/>
                </a:lnTo>
                <a:lnTo>
                  <a:pt x="911" y="663"/>
                </a:lnTo>
                <a:lnTo>
                  <a:pt x="912" y="660"/>
                </a:lnTo>
                <a:lnTo>
                  <a:pt x="914" y="657"/>
                </a:lnTo>
                <a:lnTo>
                  <a:pt x="917" y="654"/>
                </a:lnTo>
                <a:lnTo>
                  <a:pt x="919" y="653"/>
                </a:lnTo>
                <a:lnTo>
                  <a:pt x="921" y="651"/>
                </a:lnTo>
                <a:lnTo>
                  <a:pt x="923" y="651"/>
                </a:lnTo>
                <a:lnTo>
                  <a:pt x="926" y="651"/>
                </a:lnTo>
                <a:lnTo>
                  <a:pt x="928" y="652"/>
                </a:lnTo>
                <a:lnTo>
                  <a:pt x="930" y="654"/>
                </a:lnTo>
                <a:lnTo>
                  <a:pt x="932" y="656"/>
                </a:lnTo>
                <a:lnTo>
                  <a:pt x="934" y="660"/>
                </a:lnTo>
                <a:lnTo>
                  <a:pt x="936" y="665"/>
                </a:lnTo>
                <a:lnTo>
                  <a:pt x="938" y="670"/>
                </a:lnTo>
                <a:lnTo>
                  <a:pt x="940" y="675"/>
                </a:lnTo>
                <a:lnTo>
                  <a:pt x="942" y="680"/>
                </a:lnTo>
                <a:lnTo>
                  <a:pt x="945" y="685"/>
                </a:lnTo>
                <a:lnTo>
                  <a:pt x="947" y="689"/>
                </a:lnTo>
                <a:lnTo>
                  <a:pt x="949" y="693"/>
                </a:lnTo>
                <a:lnTo>
                  <a:pt x="951" y="696"/>
                </a:lnTo>
                <a:lnTo>
                  <a:pt x="953" y="699"/>
                </a:lnTo>
                <a:lnTo>
                  <a:pt x="955" y="701"/>
                </a:lnTo>
                <a:lnTo>
                  <a:pt x="957" y="703"/>
                </a:lnTo>
                <a:lnTo>
                  <a:pt x="959" y="704"/>
                </a:lnTo>
                <a:lnTo>
                  <a:pt x="962" y="706"/>
                </a:lnTo>
                <a:lnTo>
                  <a:pt x="964" y="707"/>
                </a:lnTo>
                <a:lnTo>
                  <a:pt x="966" y="708"/>
                </a:lnTo>
                <a:lnTo>
                  <a:pt x="968" y="709"/>
                </a:lnTo>
                <a:lnTo>
                  <a:pt x="970" y="710"/>
                </a:lnTo>
                <a:lnTo>
                  <a:pt x="973" y="711"/>
                </a:lnTo>
                <a:lnTo>
                  <a:pt x="975" y="712"/>
                </a:lnTo>
                <a:lnTo>
                  <a:pt x="976" y="713"/>
                </a:lnTo>
                <a:lnTo>
                  <a:pt x="978" y="714"/>
                </a:lnTo>
                <a:lnTo>
                  <a:pt x="981" y="715"/>
                </a:lnTo>
                <a:lnTo>
                  <a:pt x="983" y="715"/>
                </a:lnTo>
                <a:lnTo>
                  <a:pt x="985" y="716"/>
                </a:lnTo>
                <a:lnTo>
                  <a:pt x="987" y="716"/>
                </a:lnTo>
                <a:lnTo>
                  <a:pt x="989" y="717"/>
                </a:lnTo>
                <a:lnTo>
                  <a:pt x="992" y="717"/>
                </a:lnTo>
                <a:lnTo>
                  <a:pt x="994" y="717"/>
                </a:lnTo>
                <a:lnTo>
                  <a:pt x="996" y="716"/>
                </a:lnTo>
                <a:lnTo>
                  <a:pt x="998" y="715"/>
                </a:lnTo>
                <a:lnTo>
                  <a:pt x="1000" y="715"/>
                </a:lnTo>
                <a:lnTo>
                  <a:pt x="1002" y="713"/>
                </a:lnTo>
                <a:lnTo>
                  <a:pt x="1004" y="712"/>
                </a:lnTo>
                <a:lnTo>
                  <a:pt x="1006" y="711"/>
                </a:lnTo>
                <a:lnTo>
                  <a:pt x="1009" y="709"/>
                </a:lnTo>
                <a:lnTo>
                  <a:pt x="1011" y="708"/>
                </a:lnTo>
                <a:lnTo>
                  <a:pt x="1013" y="706"/>
                </a:lnTo>
                <a:lnTo>
                  <a:pt x="1015" y="705"/>
                </a:lnTo>
                <a:lnTo>
                  <a:pt x="1017" y="704"/>
                </a:lnTo>
                <a:lnTo>
                  <a:pt x="1019" y="704"/>
                </a:lnTo>
                <a:lnTo>
                  <a:pt x="1021" y="703"/>
                </a:lnTo>
                <a:lnTo>
                  <a:pt x="1023" y="703"/>
                </a:lnTo>
                <a:lnTo>
                  <a:pt x="1025" y="703"/>
                </a:lnTo>
                <a:lnTo>
                  <a:pt x="1028" y="703"/>
                </a:lnTo>
                <a:lnTo>
                  <a:pt x="1030" y="704"/>
                </a:lnTo>
                <a:lnTo>
                  <a:pt x="1032" y="705"/>
                </a:lnTo>
                <a:lnTo>
                  <a:pt x="1034" y="706"/>
                </a:lnTo>
                <a:lnTo>
                  <a:pt x="1036" y="708"/>
                </a:lnTo>
                <a:lnTo>
                  <a:pt x="1039" y="709"/>
                </a:lnTo>
                <a:lnTo>
                  <a:pt x="1041" y="711"/>
                </a:lnTo>
                <a:lnTo>
                  <a:pt x="1042" y="713"/>
                </a:lnTo>
                <a:lnTo>
                  <a:pt x="1045" y="715"/>
                </a:lnTo>
                <a:lnTo>
                  <a:pt x="1047" y="717"/>
                </a:lnTo>
                <a:lnTo>
                  <a:pt x="1049" y="719"/>
                </a:lnTo>
                <a:lnTo>
                  <a:pt x="1051" y="720"/>
                </a:lnTo>
                <a:lnTo>
                  <a:pt x="1053" y="721"/>
                </a:lnTo>
                <a:lnTo>
                  <a:pt x="1056" y="722"/>
                </a:lnTo>
                <a:lnTo>
                  <a:pt x="1058" y="723"/>
                </a:lnTo>
                <a:lnTo>
                  <a:pt x="1060" y="724"/>
                </a:lnTo>
                <a:lnTo>
                  <a:pt x="1062" y="724"/>
                </a:lnTo>
                <a:lnTo>
                  <a:pt x="1064" y="724"/>
                </a:lnTo>
                <a:lnTo>
                  <a:pt x="1066" y="724"/>
                </a:lnTo>
                <a:lnTo>
                  <a:pt x="1068" y="724"/>
                </a:lnTo>
                <a:lnTo>
                  <a:pt x="1070" y="723"/>
                </a:lnTo>
                <a:lnTo>
                  <a:pt x="1073" y="722"/>
                </a:lnTo>
                <a:lnTo>
                  <a:pt x="1075" y="722"/>
                </a:lnTo>
                <a:lnTo>
                  <a:pt x="1077" y="721"/>
                </a:lnTo>
                <a:lnTo>
                  <a:pt x="1079" y="720"/>
                </a:lnTo>
                <a:lnTo>
                  <a:pt x="1081" y="719"/>
                </a:lnTo>
                <a:lnTo>
                  <a:pt x="1084" y="718"/>
                </a:lnTo>
                <a:lnTo>
                  <a:pt x="1085" y="717"/>
                </a:lnTo>
                <a:lnTo>
                  <a:pt x="1087" y="715"/>
                </a:lnTo>
                <a:lnTo>
                  <a:pt x="1089" y="714"/>
                </a:lnTo>
                <a:lnTo>
                  <a:pt x="1092" y="712"/>
                </a:lnTo>
                <a:lnTo>
                  <a:pt x="1094" y="711"/>
                </a:lnTo>
                <a:lnTo>
                  <a:pt x="1096" y="709"/>
                </a:lnTo>
                <a:lnTo>
                  <a:pt x="1098" y="708"/>
                </a:lnTo>
                <a:lnTo>
                  <a:pt x="1100" y="707"/>
                </a:lnTo>
                <a:lnTo>
                  <a:pt x="1103" y="706"/>
                </a:lnTo>
                <a:lnTo>
                  <a:pt x="1105" y="704"/>
                </a:lnTo>
                <a:lnTo>
                  <a:pt x="1106" y="704"/>
                </a:lnTo>
                <a:lnTo>
                  <a:pt x="1109" y="702"/>
                </a:lnTo>
                <a:lnTo>
                  <a:pt x="1111" y="702"/>
                </a:lnTo>
                <a:lnTo>
                  <a:pt x="1113" y="701"/>
                </a:lnTo>
                <a:lnTo>
                  <a:pt x="1115" y="700"/>
                </a:lnTo>
                <a:lnTo>
                  <a:pt x="1117" y="699"/>
                </a:lnTo>
                <a:lnTo>
                  <a:pt x="1120" y="698"/>
                </a:lnTo>
                <a:lnTo>
                  <a:pt x="1122" y="698"/>
                </a:lnTo>
                <a:lnTo>
                  <a:pt x="1124" y="698"/>
                </a:lnTo>
                <a:lnTo>
                  <a:pt x="1126" y="698"/>
                </a:lnTo>
                <a:lnTo>
                  <a:pt x="1128" y="698"/>
                </a:lnTo>
                <a:lnTo>
                  <a:pt x="1130" y="698"/>
                </a:lnTo>
                <a:lnTo>
                  <a:pt x="1132" y="698"/>
                </a:lnTo>
                <a:lnTo>
                  <a:pt x="1134" y="699"/>
                </a:lnTo>
                <a:lnTo>
                  <a:pt x="1136" y="699"/>
                </a:lnTo>
                <a:lnTo>
                  <a:pt x="1139" y="700"/>
                </a:lnTo>
                <a:lnTo>
                  <a:pt x="1141" y="700"/>
                </a:lnTo>
                <a:lnTo>
                  <a:pt x="1143" y="701"/>
                </a:lnTo>
                <a:lnTo>
                  <a:pt x="1145" y="702"/>
                </a:lnTo>
                <a:lnTo>
                  <a:pt x="1147" y="704"/>
                </a:lnTo>
                <a:lnTo>
                  <a:pt x="1149" y="705"/>
                </a:lnTo>
                <a:lnTo>
                  <a:pt x="1151" y="706"/>
                </a:lnTo>
                <a:lnTo>
                  <a:pt x="1153" y="707"/>
                </a:lnTo>
                <a:lnTo>
                  <a:pt x="1156" y="708"/>
                </a:lnTo>
                <a:lnTo>
                  <a:pt x="1158" y="710"/>
                </a:lnTo>
                <a:lnTo>
                  <a:pt x="1160" y="711"/>
                </a:lnTo>
                <a:lnTo>
                  <a:pt x="1162" y="713"/>
                </a:lnTo>
                <a:lnTo>
                  <a:pt x="1164" y="714"/>
                </a:lnTo>
                <a:lnTo>
                  <a:pt x="1167" y="716"/>
                </a:lnTo>
                <a:lnTo>
                  <a:pt x="1169" y="717"/>
                </a:lnTo>
                <a:lnTo>
                  <a:pt x="1171" y="718"/>
                </a:lnTo>
                <a:lnTo>
                  <a:pt x="1172" y="719"/>
                </a:lnTo>
                <a:lnTo>
                  <a:pt x="1175" y="720"/>
                </a:lnTo>
                <a:lnTo>
                  <a:pt x="1177" y="721"/>
                </a:lnTo>
                <a:lnTo>
                  <a:pt x="1179" y="721"/>
                </a:lnTo>
                <a:lnTo>
                  <a:pt x="1181" y="722"/>
                </a:lnTo>
                <a:lnTo>
                  <a:pt x="1183" y="722"/>
                </a:lnTo>
                <a:lnTo>
                  <a:pt x="1186" y="723"/>
                </a:lnTo>
                <a:lnTo>
                  <a:pt x="1188" y="723"/>
                </a:lnTo>
                <a:lnTo>
                  <a:pt x="1190" y="724"/>
                </a:lnTo>
                <a:lnTo>
                  <a:pt x="1192" y="724"/>
                </a:lnTo>
                <a:lnTo>
                  <a:pt x="1194" y="724"/>
                </a:lnTo>
                <a:lnTo>
                  <a:pt x="1196" y="724"/>
                </a:lnTo>
                <a:lnTo>
                  <a:pt x="1198" y="724"/>
                </a:lnTo>
                <a:lnTo>
                  <a:pt x="1200" y="725"/>
                </a:lnTo>
                <a:lnTo>
                  <a:pt x="1203" y="725"/>
                </a:lnTo>
                <a:lnTo>
                  <a:pt x="1205" y="725"/>
                </a:lnTo>
                <a:lnTo>
                  <a:pt x="1209" y="725"/>
                </a:lnTo>
                <a:lnTo>
                  <a:pt x="1211" y="725"/>
                </a:lnTo>
                <a:lnTo>
                  <a:pt x="1214" y="726"/>
                </a:lnTo>
                <a:lnTo>
                  <a:pt x="1215" y="726"/>
                </a:lnTo>
                <a:lnTo>
                  <a:pt x="1217" y="726"/>
                </a:lnTo>
                <a:lnTo>
                  <a:pt x="1222" y="726"/>
                </a:lnTo>
                <a:lnTo>
                  <a:pt x="1224" y="726"/>
                </a:lnTo>
                <a:lnTo>
                  <a:pt x="1226" y="726"/>
                </a:lnTo>
                <a:lnTo>
                  <a:pt x="1228" y="726"/>
                </a:lnTo>
                <a:lnTo>
                  <a:pt x="1231" y="726"/>
                </a:lnTo>
                <a:lnTo>
                  <a:pt x="1233" y="727"/>
                </a:lnTo>
                <a:lnTo>
                  <a:pt x="1235" y="727"/>
                </a:lnTo>
                <a:lnTo>
                  <a:pt x="1236" y="727"/>
                </a:lnTo>
                <a:lnTo>
                  <a:pt x="1239" y="727"/>
                </a:lnTo>
                <a:lnTo>
                  <a:pt x="1241" y="727"/>
                </a:lnTo>
                <a:lnTo>
                  <a:pt x="1243" y="727"/>
                </a:lnTo>
                <a:lnTo>
                  <a:pt x="1245" y="728"/>
                </a:lnTo>
                <a:lnTo>
                  <a:pt x="1247" y="728"/>
                </a:lnTo>
                <a:lnTo>
                  <a:pt x="1250" y="728"/>
                </a:lnTo>
                <a:lnTo>
                  <a:pt x="1252" y="728"/>
                </a:lnTo>
                <a:lnTo>
                  <a:pt x="1254" y="728"/>
                </a:lnTo>
                <a:lnTo>
                  <a:pt x="1256" y="728"/>
                </a:lnTo>
                <a:lnTo>
                  <a:pt x="1258" y="728"/>
                </a:lnTo>
                <a:lnTo>
                  <a:pt x="1260" y="728"/>
                </a:lnTo>
                <a:lnTo>
                  <a:pt x="1262" y="728"/>
                </a:lnTo>
                <a:lnTo>
                  <a:pt x="1264" y="727"/>
                </a:lnTo>
                <a:lnTo>
                  <a:pt x="1267" y="726"/>
                </a:lnTo>
                <a:lnTo>
                  <a:pt x="1269" y="726"/>
                </a:lnTo>
                <a:lnTo>
                  <a:pt x="1271" y="724"/>
                </a:lnTo>
                <a:lnTo>
                  <a:pt x="1273" y="723"/>
                </a:lnTo>
                <a:lnTo>
                  <a:pt x="1275" y="721"/>
                </a:lnTo>
                <a:lnTo>
                  <a:pt x="1278" y="719"/>
                </a:lnTo>
                <a:lnTo>
                  <a:pt x="1280" y="717"/>
                </a:lnTo>
                <a:lnTo>
                  <a:pt x="1281" y="715"/>
                </a:lnTo>
                <a:lnTo>
                  <a:pt x="1283" y="713"/>
                </a:lnTo>
                <a:lnTo>
                  <a:pt x="1286" y="711"/>
                </a:lnTo>
                <a:lnTo>
                  <a:pt x="1288" y="709"/>
                </a:lnTo>
                <a:lnTo>
                  <a:pt x="1290" y="707"/>
                </a:lnTo>
                <a:lnTo>
                  <a:pt x="1292" y="705"/>
                </a:lnTo>
                <a:lnTo>
                  <a:pt x="1294" y="704"/>
                </a:lnTo>
                <a:lnTo>
                  <a:pt x="1297" y="702"/>
                </a:lnTo>
                <a:lnTo>
                  <a:pt x="1299" y="701"/>
                </a:lnTo>
                <a:lnTo>
                  <a:pt x="1301" y="700"/>
                </a:lnTo>
                <a:lnTo>
                  <a:pt x="1303" y="700"/>
                </a:lnTo>
                <a:lnTo>
                  <a:pt x="1305" y="700"/>
                </a:lnTo>
                <a:lnTo>
                  <a:pt x="1307" y="700"/>
                </a:lnTo>
                <a:lnTo>
                  <a:pt x="1309" y="701"/>
                </a:lnTo>
                <a:lnTo>
                  <a:pt x="1311" y="702"/>
                </a:lnTo>
                <a:lnTo>
                  <a:pt x="1314" y="704"/>
                </a:lnTo>
                <a:lnTo>
                  <a:pt x="1316" y="705"/>
                </a:lnTo>
                <a:lnTo>
                  <a:pt x="1318" y="707"/>
                </a:lnTo>
                <a:lnTo>
                  <a:pt x="1320" y="709"/>
                </a:lnTo>
                <a:lnTo>
                  <a:pt x="1322" y="711"/>
                </a:lnTo>
                <a:lnTo>
                  <a:pt x="1324" y="712"/>
                </a:lnTo>
                <a:lnTo>
                  <a:pt x="1326" y="712"/>
                </a:lnTo>
                <a:lnTo>
                  <a:pt x="1328" y="711"/>
                </a:lnTo>
                <a:lnTo>
                  <a:pt x="1330" y="708"/>
                </a:lnTo>
                <a:lnTo>
                  <a:pt x="1333" y="703"/>
                </a:lnTo>
                <a:lnTo>
                  <a:pt x="1335" y="695"/>
                </a:lnTo>
                <a:lnTo>
                  <a:pt x="1337" y="684"/>
                </a:lnTo>
                <a:lnTo>
                  <a:pt x="1339" y="669"/>
                </a:lnTo>
                <a:lnTo>
                  <a:pt x="1341" y="651"/>
                </a:lnTo>
                <a:lnTo>
                  <a:pt x="1344" y="628"/>
                </a:lnTo>
                <a:lnTo>
                  <a:pt x="1345" y="602"/>
                </a:lnTo>
                <a:lnTo>
                  <a:pt x="1347" y="573"/>
                </a:lnTo>
                <a:lnTo>
                  <a:pt x="1350" y="541"/>
                </a:lnTo>
                <a:lnTo>
                  <a:pt x="1352" y="509"/>
                </a:lnTo>
                <a:lnTo>
                  <a:pt x="1354" y="477"/>
                </a:lnTo>
                <a:lnTo>
                  <a:pt x="1356" y="446"/>
                </a:lnTo>
                <a:lnTo>
                  <a:pt x="1358" y="417"/>
                </a:lnTo>
                <a:lnTo>
                  <a:pt x="1361" y="392"/>
                </a:lnTo>
                <a:lnTo>
                  <a:pt x="1363" y="370"/>
                </a:lnTo>
                <a:lnTo>
                  <a:pt x="1365" y="352"/>
                </a:lnTo>
                <a:lnTo>
                  <a:pt x="1366" y="340"/>
                </a:lnTo>
                <a:lnTo>
                  <a:pt x="1369" y="333"/>
                </a:lnTo>
                <a:lnTo>
                  <a:pt x="1371" y="332"/>
                </a:lnTo>
                <a:lnTo>
                  <a:pt x="1373" y="337"/>
                </a:lnTo>
                <a:lnTo>
                  <a:pt x="1375" y="349"/>
                </a:lnTo>
                <a:lnTo>
                  <a:pt x="1378" y="367"/>
                </a:lnTo>
                <a:lnTo>
                  <a:pt x="1380" y="390"/>
                </a:lnTo>
                <a:lnTo>
                  <a:pt x="1382" y="418"/>
                </a:lnTo>
                <a:lnTo>
                  <a:pt x="1384" y="448"/>
                </a:lnTo>
                <a:lnTo>
                  <a:pt x="1386" y="480"/>
                </a:lnTo>
                <a:lnTo>
                  <a:pt x="1388" y="511"/>
                </a:lnTo>
                <a:lnTo>
                  <a:pt x="1390" y="542"/>
                </a:lnTo>
                <a:lnTo>
                  <a:pt x="1392" y="569"/>
                </a:lnTo>
                <a:lnTo>
                  <a:pt x="1394" y="593"/>
                </a:lnTo>
                <a:lnTo>
                  <a:pt x="1397" y="614"/>
                </a:lnTo>
                <a:lnTo>
                  <a:pt x="1399" y="632"/>
                </a:lnTo>
                <a:lnTo>
                  <a:pt x="1401" y="646"/>
                </a:lnTo>
                <a:lnTo>
                  <a:pt x="1403" y="658"/>
                </a:lnTo>
                <a:lnTo>
                  <a:pt x="1405" y="667"/>
                </a:lnTo>
                <a:lnTo>
                  <a:pt x="1408" y="674"/>
                </a:lnTo>
                <a:lnTo>
                  <a:pt x="1410" y="680"/>
                </a:lnTo>
                <a:lnTo>
                  <a:pt x="1411" y="684"/>
                </a:lnTo>
                <a:lnTo>
                  <a:pt x="1414" y="687"/>
                </a:lnTo>
                <a:lnTo>
                  <a:pt x="1416" y="691"/>
                </a:lnTo>
                <a:lnTo>
                  <a:pt x="1418" y="693"/>
                </a:lnTo>
                <a:lnTo>
                  <a:pt x="1420" y="694"/>
                </a:lnTo>
                <a:lnTo>
                  <a:pt x="1422" y="695"/>
                </a:lnTo>
                <a:lnTo>
                  <a:pt x="1425" y="696"/>
                </a:lnTo>
                <a:lnTo>
                  <a:pt x="1427" y="697"/>
                </a:lnTo>
                <a:lnTo>
                  <a:pt x="1429" y="698"/>
                </a:lnTo>
                <a:lnTo>
                  <a:pt x="1431" y="699"/>
                </a:lnTo>
                <a:lnTo>
                  <a:pt x="1433" y="700"/>
                </a:lnTo>
                <a:lnTo>
                  <a:pt x="1435" y="702"/>
                </a:lnTo>
                <a:lnTo>
                  <a:pt x="1437" y="703"/>
                </a:lnTo>
                <a:lnTo>
                  <a:pt x="1439" y="704"/>
                </a:lnTo>
                <a:lnTo>
                  <a:pt x="1441" y="706"/>
                </a:lnTo>
                <a:lnTo>
                  <a:pt x="1444" y="707"/>
                </a:lnTo>
                <a:lnTo>
                  <a:pt x="1446" y="709"/>
                </a:lnTo>
                <a:lnTo>
                  <a:pt x="1448" y="710"/>
                </a:lnTo>
                <a:lnTo>
                  <a:pt x="1450" y="711"/>
                </a:lnTo>
                <a:lnTo>
                  <a:pt x="1452" y="713"/>
                </a:lnTo>
                <a:lnTo>
                  <a:pt x="1454" y="715"/>
                </a:lnTo>
                <a:lnTo>
                  <a:pt x="1456" y="716"/>
                </a:lnTo>
                <a:lnTo>
                  <a:pt x="1458" y="718"/>
                </a:lnTo>
                <a:lnTo>
                  <a:pt x="1461" y="719"/>
                </a:lnTo>
                <a:lnTo>
                  <a:pt x="1463" y="721"/>
                </a:lnTo>
                <a:lnTo>
                  <a:pt x="1465" y="722"/>
                </a:lnTo>
                <a:lnTo>
                  <a:pt x="1467" y="724"/>
                </a:lnTo>
                <a:lnTo>
                  <a:pt x="1469" y="725"/>
                </a:lnTo>
                <a:lnTo>
                  <a:pt x="1472" y="726"/>
                </a:lnTo>
                <a:lnTo>
                  <a:pt x="1474" y="728"/>
                </a:lnTo>
                <a:lnTo>
                  <a:pt x="1475" y="728"/>
                </a:lnTo>
                <a:lnTo>
                  <a:pt x="1477" y="729"/>
                </a:lnTo>
                <a:lnTo>
                  <a:pt x="1480" y="730"/>
                </a:lnTo>
                <a:lnTo>
                  <a:pt x="1482" y="730"/>
                </a:lnTo>
                <a:lnTo>
                  <a:pt x="1484" y="731"/>
                </a:lnTo>
                <a:lnTo>
                  <a:pt x="1486" y="731"/>
                </a:lnTo>
                <a:lnTo>
                  <a:pt x="1491" y="731"/>
                </a:lnTo>
                <a:lnTo>
                  <a:pt x="1493" y="730"/>
                </a:lnTo>
                <a:lnTo>
                  <a:pt x="1495" y="730"/>
                </a:lnTo>
                <a:lnTo>
                  <a:pt x="1497" y="730"/>
                </a:lnTo>
                <a:lnTo>
                  <a:pt x="1499" y="729"/>
                </a:lnTo>
                <a:lnTo>
                  <a:pt x="1501" y="728"/>
                </a:lnTo>
                <a:lnTo>
                  <a:pt x="1503" y="728"/>
                </a:lnTo>
                <a:lnTo>
                  <a:pt x="1505" y="727"/>
                </a:lnTo>
                <a:lnTo>
                  <a:pt x="1508" y="726"/>
                </a:lnTo>
                <a:lnTo>
                  <a:pt x="1510" y="724"/>
                </a:lnTo>
                <a:lnTo>
                  <a:pt x="1512" y="724"/>
                </a:lnTo>
                <a:lnTo>
                  <a:pt x="1514" y="722"/>
                </a:lnTo>
                <a:lnTo>
                  <a:pt x="1516" y="722"/>
                </a:lnTo>
                <a:lnTo>
                  <a:pt x="1518" y="721"/>
                </a:lnTo>
                <a:lnTo>
                  <a:pt x="1520" y="720"/>
                </a:lnTo>
                <a:lnTo>
                  <a:pt x="1522" y="719"/>
                </a:lnTo>
                <a:lnTo>
                  <a:pt x="1524" y="719"/>
                </a:lnTo>
                <a:lnTo>
                  <a:pt x="1527" y="719"/>
                </a:lnTo>
                <a:lnTo>
                  <a:pt x="1529" y="719"/>
                </a:lnTo>
                <a:lnTo>
                  <a:pt x="1531" y="719"/>
                </a:lnTo>
                <a:lnTo>
                  <a:pt x="1533" y="719"/>
                </a:lnTo>
                <a:lnTo>
                  <a:pt x="1536" y="719"/>
                </a:lnTo>
                <a:lnTo>
                  <a:pt x="1538" y="720"/>
                </a:lnTo>
                <a:lnTo>
                  <a:pt x="1540" y="720"/>
                </a:lnTo>
                <a:lnTo>
                  <a:pt x="1541" y="722"/>
                </a:lnTo>
                <a:lnTo>
                  <a:pt x="1544" y="722"/>
                </a:lnTo>
                <a:lnTo>
                  <a:pt x="1546" y="724"/>
                </a:lnTo>
                <a:lnTo>
                  <a:pt x="1548" y="724"/>
                </a:lnTo>
                <a:lnTo>
                  <a:pt x="1550" y="726"/>
                </a:lnTo>
                <a:lnTo>
                  <a:pt x="1552" y="726"/>
                </a:lnTo>
                <a:lnTo>
                  <a:pt x="1555" y="727"/>
                </a:lnTo>
                <a:lnTo>
                  <a:pt x="1557" y="728"/>
                </a:lnTo>
                <a:lnTo>
                  <a:pt x="1559" y="729"/>
                </a:lnTo>
                <a:lnTo>
                  <a:pt x="1561" y="729"/>
                </a:lnTo>
                <a:lnTo>
                  <a:pt x="1563" y="730"/>
                </a:lnTo>
                <a:lnTo>
                  <a:pt x="1565" y="730"/>
                </a:lnTo>
                <a:lnTo>
                  <a:pt x="1567" y="731"/>
                </a:lnTo>
                <a:lnTo>
                  <a:pt x="1569" y="731"/>
                </a:lnTo>
                <a:lnTo>
                  <a:pt x="1572" y="731"/>
                </a:lnTo>
                <a:lnTo>
                  <a:pt x="1574" y="731"/>
                </a:lnTo>
                <a:lnTo>
                  <a:pt x="1576" y="731"/>
                </a:lnTo>
                <a:lnTo>
                  <a:pt x="1578" y="731"/>
                </a:lnTo>
                <a:lnTo>
                  <a:pt x="1580" y="731"/>
                </a:lnTo>
                <a:lnTo>
                  <a:pt x="1583" y="731"/>
                </a:lnTo>
                <a:lnTo>
                  <a:pt x="1584" y="731"/>
                </a:lnTo>
                <a:lnTo>
                  <a:pt x="1586" y="730"/>
                </a:lnTo>
                <a:lnTo>
                  <a:pt x="1588" y="730"/>
                </a:lnTo>
                <a:lnTo>
                  <a:pt x="1591" y="729"/>
                </a:lnTo>
                <a:lnTo>
                  <a:pt x="1593" y="729"/>
                </a:lnTo>
                <a:lnTo>
                  <a:pt x="1595" y="728"/>
                </a:lnTo>
                <a:lnTo>
                  <a:pt x="1597" y="727"/>
                </a:lnTo>
                <a:lnTo>
                  <a:pt x="1599" y="726"/>
                </a:lnTo>
                <a:lnTo>
                  <a:pt x="1602" y="725"/>
                </a:lnTo>
                <a:lnTo>
                  <a:pt x="1604" y="723"/>
                </a:lnTo>
                <a:lnTo>
                  <a:pt x="1605" y="722"/>
                </a:lnTo>
                <a:lnTo>
                  <a:pt x="1608" y="720"/>
                </a:lnTo>
                <a:lnTo>
                  <a:pt x="1610" y="719"/>
                </a:lnTo>
                <a:lnTo>
                  <a:pt x="1612" y="717"/>
                </a:lnTo>
                <a:lnTo>
                  <a:pt x="1614" y="715"/>
                </a:lnTo>
                <a:lnTo>
                  <a:pt x="1616" y="713"/>
                </a:lnTo>
                <a:lnTo>
                  <a:pt x="1619" y="711"/>
                </a:lnTo>
                <a:lnTo>
                  <a:pt x="1621" y="709"/>
                </a:lnTo>
                <a:lnTo>
                  <a:pt x="1623" y="708"/>
                </a:lnTo>
                <a:lnTo>
                  <a:pt x="1625" y="706"/>
                </a:lnTo>
                <a:lnTo>
                  <a:pt x="1627" y="704"/>
                </a:lnTo>
                <a:lnTo>
                  <a:pt x="1629" y="702"/>
                </a:lnTo>
                <a:lnTo>
                  <a:pt x="1631" y="700"/>
                </a:lnTo>
                <a:lnTo>
                  <a:pt x="1633" y="699"/>
                </a:lnTo>
                <a:lnTo>
                  <a:pt x="1635" y="698"/>
                </a:lnTo>
                <a:lnTo>
                  <a:pt x="1638" y="698"/>
                </a:lnTo>
                <a:lnTo>
                  <a:pt x="1640" y="697"/>
                </a:lnTo>
                <a:lnTo>
                  <a:pt x="1642" y="697"/>
                </a:lnTo>
                <a:lnTo>
                  <a:pt x="1644" y="697"/>
                </a:lnTo>
                <a:lnTo>
                  <a:pt x="1646" y="697"/>
                </a:lnTo>
                <a:lnTo>
                  <a:pt x="1648" y="698"/>
                </a:lnTo>
                <a:lnTo>
                  <a:pt x="1650" y="698"/>
                </a:lnTo>
                <a:lnTo>
                  <a:pt x="1652" y="699"/>
                </a:lnTo>
                <a:lnTo>
                  <a:pt x="1655" y="699"/>
                </a:lnTo>
                <a:lnTo>
                  <a:pt x="1657" y="700"/>
                </a:lnTo>
                <a:lnTo>
                  <a:pt x="1659" y="700"/>
                </a:lnTo>
                <a:lnTo>
                  <a:pt x="1661" y="700"/>
                </a:lnTo>
                <a:lnTo>
                  <a:pt x="1663" y="700"/>
                </a:lnTo>
                <a:lnTo>
                  <a:pt x="1666" y="700"/>
                </a:lnTo>
                <a:lnTo>
                  <a:pt x="1668" y="699"/>
                </a:lnTo>
                <a:lnTo>
                  <a:pt x="1670" y="699"/>
                </a:lnTo>
                <a:lnTo>
                  <a:pt x="1671" y="699"/>
                </a:lnTo>
                <a:lnTo>
                  <a:pt x="1674" y="698"/>
                </a:lnTo>
                <a:lnTo>
                  <a:pt x="1676" y="698"/>
                </a:lnTo>
                <a:lnTo>
                  <a:pt x="1678" y="698"/>
                </a:lnTo>
                <a:lnTo>
                  <a:pt x="1680" y="698"/>
                </a:lnTo>
                <a:lnTo>
                  <a:pt x="1683" y="698"/>
                </a:lnTo>
                <a:lnTo>
                  <a:pt x="1685" y="699"/>
                </a:lnTo>
                <a:lnTo>
                  <a:pt x="1687" y="700"/>
                </a:lnTo>
                <a:lnTo>
                  <a:pt x="1689" y="702"/>
                </a:lnTo>
                <a:lnTo>
                  <a:pt x="1691" y="704"/>
                </a:lnTo>
                <a:lnTo>
                  <a:pt x="1693" y="706"/>
                </a:lnTo>
                <a:lnTo>
                  <a:pt x="1695" y="708"/>
                </a:lnTo>
                <a:lnTo>
                  <a:pt x="1697" y="709"/>
                </a:lnTo>
                <a:lnTo>
                  <a:pt x="1699" y="710"/>
                </a:lnTo>
                <a:lnTo>
                  <a:pt x="1702" y="711"/>
                </a:lnTo>
                <a:lnTo>
                  <a:pt x="1704" y="711"/>
                </a:lnTo>
                <a:lnTo>
                  <a:pt x="1706" y="709"/>
                </a:lnTo>
                <a:lnTo>
                  <a:pt x="1708" y="707"/>
                </a:lnTo>
                <a:lnTo>
                  <a:pt x="1710" y="703"/>
                </a:lnTo>
                <a:lnTo>
                  <a:pt x="1713" y="699"/>
                </a:lnTo>
                <a:lnTo>
                  <a:pt x="1714" y="693"/>
                </a:lnTo>
                <a:lnTo>
                  <a:pt x="1716" y="687"/>
                </a:lnTo>
                <a:lnTo>
                  <a:pt x="1719" y="681"/>
                </a:lnTo>
                <a:lnTo>
                  <a:pt x="1721" y="674"/>
                </a:lnTo>
                <a:lnTo>
                  <a:pt x="1723" y="667"/>
                </a:lnTo>
                <a:lnTo>
                  <a:pt x="1725" y="661"/>
                </a:lnTo>
                <a:lnTo>
                  <a:pt x="1727" y="655"/>
                </a:lnTo>
                <a:lnTo>
                  <a:pt x="1730" y="650"/>
                </a:lnTo>
                <a:lnTo>
                  <a:pt x="1732" y="646"/>
                </a:lnTo>
                <a:lnTo>
                  <a:pt x="1734" y="643"/>
                </a:lnTo>
                <a:lnTo>
                  <a:pt x="1735" y="642"/>
                </a:lnTo>
                <a:lnTo>
                  <a:pt x="1738" y="642"/>
                </a:lnTo>
                <a:lnTo>
                  <a:pt x="1740" y="643"/>
                </a:lnTo>
                <a:lnTo>
                  <a:pt x="1742" y="646"/>
                </a:lnTo>
                <a:lnTo>
                  <a:pt x="1744" y="651"/>
                </a:lnTo>
                <a:lnTo>
                  <a:pt x="1746" y="656"/>
                </a:lnTo>
                <a:lnTo>
                  <a:pt x="1749" y="663"/>
                </a:lnTo>
                <a:lnTo>
                  <a:pt x="1751" y="671"/>
                </a:lnTo>
                <a:lnTo>
                  <a:pt x="1753" y="678"/>
                </a:lnTo>
                <a:lnTo>
                  <a:pt x="1755" y="686"/>
                </a:lnTo>
                <a:lnTo>
                  <a:pt x="1757" y="693"/>
                </a:lnTo>
                <a:lnTo>
                  <a:pt x="1759" y="700"/>
                </a:lnTo>
                <a:lnTo>
                  <a:pt x="1761" y="706"/>
                </a:lnTo>
                <a:lnTo>
                  <a:pt x="1763" y="711"/>
                </a:lnTo>
                <a:lnTo>
                  <a:pt x="1766" y="715"/>
                </a:lnTo>
                <a:lnTo>
                  <a:pt x="1768" y="718"/>
                </a:lnTo>
                <a:lnTo>
                  <a:pt x="1770" y="720"/>
                </a:lnTo>
                <a:lnTo>
                  <a:pt x="1772" y="722"/>
                </a:lnTo>
                <a:lnTo>
                  <a:pt x="1774" y="724"/>
                </a:lnTo>
                <a:lnTo>
                  <a:pt x="1777" y="724"/>
                </a:lnTo>
                <a:lnTo>
                  <a:pt x="1778" y="724"/>
                </a:lnTo>
                <a:lnTo>
                  <a:pt x="1782" y="724"/>
                </a:lnTo>
                <a:lnTo>
                  <a:pt x="1785" y="724"/>
                </a:lnTo>
                <a:lnTo>
                  <a:pt x="1787" y="723"/>
                </a:lnTo>
                <a:lnTo>
                  <a:pt x="1789" y="722"/>
                </a:lnTo>
                <a:lnTo>
                  <a:pt x="1791" y="722"/>
                </a:lnTo>
                <a:lnTo>
                  <a:pt x="1793" y="721"/>
                </a:lnTo>
                <a:lnTo>
                  <a:pt x="1796" y="721"/>
                </a:lnTo>
                <a:lnTo>
                  <a:pt x="1798" y="720"/>
                </a:lnTo>
                <a:lnTo>
                  <a:pt x="1800" y="720"/>
                </a:lnTo>
                <a:lnTo>
                  <a:pt x="1802" y="719"/>
                </a:lnTo>
                <a:lnTo>
                  <a:pt x="1804" y="717"/>
                </a:lnTo>
                <a:lnTo>
                  <a:pt x="1806" y="715"/>
                </a:lnTo>
                <a:lnTo>
                  <a:pt x="1808" y="711"/>
                </a:lnTo>
                <a:lnTo>
                  <a:pt x="1810" y="707"/>
                </a:lnTo>
                <a:lnTo>
                  <a:pt x="1813" y="701"/>
                </a:lnTo>
                <a:lnTo>
                  <a:pt x="1815" y="693"/>
                </a:lnTo>
                <a:lnTo>
                  <a:pt x="1817" y="684"/>
                </a:lnTo>
                <a:lnTo>
                  <a:pt x="1819" y="674"/>
                </a:lnTo>
                <a:lnTo>
                  <a:pt x="1821" y="662"/>
                </a:lnTo>
                <a:lnTo>
                  <a:pt x="1823" y="649"/>
                </a:lnTo>
                <a:lnTo>
                  <a:pt x="1825" y="635"/>
                </a:lnTo>
                <a:lnTo>
                  <a:pt x="1827" y="620"/>
                </a:lnTo>
                <a:lnTo>
                  <a:pt x="1829" y="605"/>
                </a:lnTo>
                <a:lnTo>
                  <a:pt x="1832" y="590"/>
                </a:lnTo>
                <a:lnTo>
                  <a:pt x="1834" y="575"/>
                </a:lnTo>
                <a:lnTo>
                  <a:pt x="1836" y="560"/>
                </a:lnTo>
                <a:lnTo>
                  <a:pt x="1838" y="545"/>
                </a:lnTo>
                <a:lnTo>
                  <a:pt x="1841" y="531"/>
                </a:lnTo>
                <a:lnTo>
                  <a:pt x="1843" y="518"/>
                </a:lnTo>
                <a:lnTo>
                  <a:pt x="1844" y="505"/>
                </a:lnTo>
                <a:lnTo>
                  <a:pt x="1846" y="494"/>
                </a:lnTo>
                <a:lnTo>
                  <a:pt x="1849" y="485"/>
                </a:lnTo>
                <a:lnTo>
                  <a:pt x="1851" y="477"/>
                </a:lnTo>
                <a:lnTo>
                  <a:pt x="1853" y="471"/>
                </a:lnTo>
                <a:lnTo>
                  <a:pt x="1855" y="466"/>
                </a:lnTo>
                <a:lnTo>
                  <a:pt x="1857" y="464"/>
                </a:lnTo>
                <a:lnTo>
                  <a:pt x="1860" y="464"/>
                </a:lnTo>
                <a:lnTo>
                  <a:pt x="1862" y="467"/>
                </a:lnTo>
                <a:lnTo>
                  <a:pt x="1864" y="472"/>
                </a:lnTo>
                <a:lnTo>
                  <a:pt x="1866" y="481"/>
                </a:lnTo>
                <a:lnTo>
                  <a:pt x="1868" y="492"/>
                </a:lnTo>
                <a:lnTo>
                  <a:pt x="1870" y="506"/>
                </a:lnTo>
                <a:lnTo>
                  <a:pt x="1872" y="523"/>
                </a:lnTo>
                <a:lnTo>
                  <a:pt x="1874" y="541"/>
                </a:lnTo>
                <a:lnTo>
                  <a:pt x="1877" y="561"/>
                </a:lnTo>
                <a:lnTo>
                  <a:pt x="1879" y="581"/>
                </a:lnTo>
                <a:lnTo>
                  <a:pt x="1881" y="601"/>
                </a:lnTo>
                <a:lnTo>
                  <a:pt x="1883" y="620"/>
                </a:lnTo>
                <a:lnTo>
                  <a:pt x="1885" y="637"/>
                </a:lnTo>
                <a:lnTo>
                  <a:pt x="1887" y="653"/>
                </a:lnTo>
                <a:lnTo>
                  <a:pt x="1889" y="667"/>
                </a:lnTo>
                <a:lnTo>
                  <a:pt x="1891" y="678"/>
                </a:lnTo>
                <a:lnTo>
                  <a:pt x="1893" y="687"/>
                </a:lnTo>
                <a:lnTo>
                  <a:pt x="1896" y="694"/>
                </a:lnTo>
                <a:lnTo>
                  <a:pt x="1898" y="699"/>
                </a:lnTo>
                <a:lnTo>
                  <a:pt x="1900" y="703"/>
                </a:lnTo>
                <a:lnTo>
                  <a:pt x="1902" y="706"/>
                </a:lnTo>
                <a:lnTo>
                  <a:pt x="1904" y="707"/>
                </a:lnTo>
                <a:lnTo>
                  <a:pt x="1907" y="708"/>
                </a:lnTo>
                <a:lnTo>
                  <a:pt x="1908" y="709"/>
                </a:lnTo>
                <a:lnTo>
                  <a:pt x="1910" y="709"/>
                </a:lnTo>
                <a:lnTo>
                  <a:pt x="1913" y="708"/>
                </a:lnTo>
                <a:lnTo>
                  <a:pt x="1915" y="708"/>
                </a:lnTo>
                <a:lnTo>
                  <a:pt x="1917" y="707"/>
                </a:lnTo>
                <a:lnTo>
                  <a:pt x="1919" y="706"/>
                </a:lnTo>
                <a:lnTo>
                  <a:pt x="1921" y="705"/>
                </a:lnTo>
                <a:lnTo>
                  <a:pt x="1924" y="704"/>
                </a:lnTo>
                <a:lnTo>
                  <a:pt x="1926" y="704"/>
                </a:lnTo>
                <a:lnTo>
                  <a:pt x="1928" y="704"/>
                </a:lnTo>
                <a:lnTo>
                  <a:pt x="1930" y="703"/>
                </a:lnTo>
                <a:lnTo>
                  <a:pt x="1932" y="703"/>
                </a:lnTo>
                <a:lnTo>
                  <a:pt x="1934" y="704"/>
                </a:lnTo>
                <a:lnTo>
                  <a:pt x="1936" y="704"/>
                </a:lnTo>
                <a:lnTo>
                  <a:pt x="1938" y="704"/>
                </a:lnTo>
                <a:lnTo>
                  <a:pt x="1940" y="705"/>
                </a:lnTo>
                <a:lnTo>
                  <a:pt x="1943" y="706"/>
                </a:lnTo>
                <a:lnTo>
                  <a:pt x="1945" y="706"/>
                </a:lnTo>
                <a:lnTo>
                  <a:pt x="1947" y="708"/>
                </a:lnTo>
                <a:lnTo>
                  <a:pt x="1949" y="708"/>
                </a:lnTo>
                <a:lnTo>
                  <a:pt x="1951" y="709"/>
                </a:lnTo>
                <a:lnTo>
                  <a:pt x="1953" y="710"/>
                </a:lnTo>
                <a:lnTo>
                  <a:pt x="1955" y="710"/>
                </a:lnTo>
                <a:lnTo>
                  <a:pt x="1957" y="711"/>
                </a:lnTo>
                <a:lnTo>
                  <a:pt x="1960" y="711"/>
                </a:lnTo>
                <a:lnTo>
                  <a:pt x="1962" y="712"/>
                </a:lnTo>
                <a:lnTo>
                  <a:pt x="1964" y="712"/>
                </a:lnTo>
                <a:lnTo>
                  <a:pt x="1966" y="713"/>
                </a:lnTo>
                <a:lnTo>
                  <a:pt x="1968" y="714"/>
                </a:lnTo>
                <a:lnTo>
                  <a:pt x="1971" y="715"/>
                </a:lnTo>
                <a:lnTo>
                  <a:pt x="1973" y="716"/>
                </a:lnTo>
                <a:lnTo>
                  <a:pt x="1974" y="717"/>
                </a:lnTo>
                <a:lnTo>
                  <a:pt x="1976" y="719"/>
                </a:lnTo>
                <a:lnTo>
                  <a:pt x="1979" y="720"/>
                </a:lnTo>
                <a:lnTo>
                  <a:pt x="1981" y="722"/>
                </a:lnTo>
                <a:lnTo>
                  <a:pt x="1983" y="724"/>
                </a:lnTo>
                <a:lnTo>
                  <a:pt x="1985" y="726"/>
                </a:lnTo>
                <a:lnTo>
                  <a:pt x="1988" y="727"/>
                </a:lnTo>
                <a:lnTo>
                  <a:pt x="1990" y="728"/>
                </a:lnTo>
                <a:lnTo>
                  <a:pt x="1992" y="729"/>
                </a:lnTo>
                <a:lnTo>
                  <a:pt x="1994" y="730"/>
                </a:lnTo>
                <a:lnTo>
                  <a:pt x="1996" y="731"/>
                </a:lnTo>
                <a:lnTo>
                  <a:pt x="1998" y="731"/>
                </a:lnTo>
                <a:lnTo>
                  <a:pt x="2000" y="732"/>
                </a:lnTo>
                <a:lnTo>
                  <a:pt x="2002" y="732"/>
                </a:lnTo>
                <a:lnTo>
                  <a:pt x="2004" y="733"/>
                </a:lnTo>
                <a:lnTo>
                  <a:pt x="2007" y="733"/>
                </a:lnTo>
                <a:lnTo>
                  <a:pt x="2009" y="732"/>
                </a:lnTo>
                <a:lnTo>
                  <a:pt x="2011" y="732"/>
                </a:lnTo>
                <a:lnTo>
                  <a:pt x="2013" y="732"/>
                </a:lnTo>
                <a:lnTo>
                  <a:pt x="2015" y="732"/>
                </a:lnTo>
                <a:lnTo>
                  <a:pt x="2017" y="731"/>
                </a:lnTo>
                <a:lnTo>
                  <a:pt x="2019" y="732"/>
                </a:lnTo>
                <a:lnTo>
                  <a:pt x="2021" y="732"/>
                </a:lnTo>
                <a:lnTo>
                  <a:pt x="2024" y="732"/>
                </a:lnTo>
                <a:lnTo>
                  <a:pt x="2026" y="733"/>
                </a:lnTo>
                <a:lnTo>
                  <a:pt x="2028" y="733"/>
                </a:lnTo>
                <a:lnTo>
                  <a:pt x="2030" y="733"/>
                </a:lnTo>
                <a:lnTo>
                  <a:pt x="2032" y="733"/>
                </a:lnTo>
                <a:lnTo>
                  <a:pt x="2035" y="734"/>
                </a:lnTo>
                <a:lnTo>
                  <a:pt x="2038" y="734"/>
                </a:lnTo>
                <a:lnTo>
                  <a:pt x="2040" y="734"/>
                </a:lnTo>
                <a:lnTo>
                  <a:pt x="2043" y="733"/>
                </a:lnTo>
                <a:lnTo>
                  <a:pt x="2045" y="733"/>
                </a:lnTo>
                <a:lnTo>
                  <a:pt x="2047" y="732"/>
                </a:lnTo>
                <a:lnTo>
                  <a:pt x="2049" y="731"/>
                </a:lnTo>
                <a:lnTo>
                  <a:pt x="2051" y="730"/>
                </a:lnTo>
                <a:lnTo>
                  <a:pt x="2054" y="728"/>
                </a:lnTo>
                <a:lnTo>
                  <a:pt x="2056" y="726"/>
                </a:lnTo>
                <a:lnTo>
                  <a:pt x="2058" y="724"/>
                </a:lnTo>
                <a:lnTo>
                  <a:pt x="2060" y="721"/>
                </a:lnTo>
                <a:lnTo>
                  <a:pt x="2062" y="719"/>
                </a:lnTo>
                <a:lnTo>
                  <a:pt x="2064" y="715"/>
                </a:lnTo>
                <a:lnTo>
                  <a:pt x="2066" y="712"/>
                </a:lnTo>
                <a:lnTo>
                  <a:pt x="2068" y="709"/>
                </a:lnTo>
                <a:lnTo>
                  <a:pt x="2071" y="705"/>
                </a:lnTo>
                <a:lnTo>
                  <a:pt x="2073" y="701"/>
                </a:lnTo>
                <a:lnTo>
                  <a:pt x="2075" y="697"/>
                </a:lnTo>
                <a:lnTo>
                  <a:pt x="2077" y="693"/>
                </a:lnTo>
                <a:lnTo>
                  <a:pt x="2079" y="689"/>
                </a:lnTo>
                <a:lnTo>
                  <a:pt x="2082" y="685"/>
                </a:lnTo>
                <a:lnTo>
                  <a:pt x="2083" y="682"/>
                </a:lnTo>
                <a:lnTo>
                  <a:pt x="2085" y="679"/>
                </a:lnTo>
                <a:lnTo>
                  <a:pt x="2087" y="676"/>
                </a:lnTo>
                <a:lnTo>
                  <a:pt x="2090" y="674"/>
                </a:lnTo>
                <a:lnTo>
                  <a:pt x="2092" y="673"/>
                </a:lnTo>
                <a:lnTo>
                  <a:pt x="2094" y="671"/>
                </a:lnTo>
                <a:lnTo>
                  <a:pt x="2096" y="671"/>
                </a:lnTo>
                <a:lnTo>
                  <a:pt x="2098" y="671"/>
                </a:lnTo>
                <a:lnTo>
                  <a:pt x="2101" y="673"/>
                </a:lnTo>
                <a:lnTo>
                  <a:pt x="2103" y="674"/>
                </a:lnTo>
                <a:lnTo>
                  <a:pt x="2104" y="676"/>
                </a:lnTo>
                <a:lnTo>
                  <a:pt x="2107" y="679"/>
                </a:lnTo>
                <a:lnTo>
                  <a:pt x="2109" y="682"/>
                </a:lnTo>
                <a:lnTo>
                  <a:pt x="2111" y="685"/>
                </a:lnTo>
                <a:lnTo>
                  <a:pt x="2113" y="689"/>
                </a:lnTo>
                <a:lnTo>
                  <a:pt x="2115" y="693"/>
                </a:lnTo>
                <a:lnTo>
                  <a:pt x="2118" y="697"/>
                </a:lnTo>
                <a:lnTo>
                  <a:pt x="2120" y="702"/>
                </a:lnTo>
                <a:lnTo>
                  <a:pt x="2122" y="706"/>
                </a:lnTo>
                <a:lnTo>
                  <a:pt x="2124" y="709"/>
                </a:lnTo>
                <a:lnTo>
                  <a:pt x="2126" y="713"/>
                </a:lnTo>
                <a:lnTo>
                  <a:pt x="2128" y="716"/>
                </a:lnTo>
                <a:lnTo>
                  <a:pt x="2130" y="719"/>
                </a:lnTo>
                <a:lnTo>
                  <a:pt x="2132" y="721"/>
                </a:lnTo>
                <a:lnTo>
                  <a:pt x="2134" y="723"/>
                </a:lnTo>
                <a:lnTo>
                  <a:pt x="2137" y="725"/>
                </a:lnTo>
                <a:lnTo>
                  <a:pt x="2139" y="726"/>
                </a:lnTo>
                <a:lnTo>
                  <a:pt x="2141" y="728"/>
                </a:lnTo>
                <a:lnTo>
                  <a:pt x="2143" y="729"/>
                </a:lnTo>
                <a:lnTo>
                  <a:pt x="2146" y="729"/>
                </a:lnTo>
                <a:lnTo>
                  <a:pt x="2147" y="729"/>
                </a:lnTo>
                <a:lnTo>
                  <a:pt x="2149" y="729"/>
                </a:lnTo>
                <a:lnTo>
                  <a:pt x="2151" y="729"/>
                </a:lnTo>
                <a:lnTo>
                  <a:pt x="2154" y="729"/>
                </a:lnTo>
                <a:lnTo>
                  <a:pt x="2156" y="728"/>
                </a:lnTo>
                <a:lnTo>
                  <a:pt x="2158" y="728"/>
                </a:lnTo>
                <a:lnTo>
                  <a:pt x="2160" y="727"/>
                </a:lnTo>
                <a:lnTo>
                  <a:pt x="2162" y="726"/>
                </a:lnTo>
                <a:lnTo>
                  <a:pt x="2165" y="726"/>
                </a:lnTo>
                <a:lnTo>
                  <a:pt x="2167" y="725"/>
                </a:lnTo>
                <a:lnTo>
                  <a:pt x="2168" y="725"/>
                </a:lnTo>
                <a:lnTo>
                  <a:pt x="2171" y="724"/>
                </a:lnTo>
                <a:lnTo>
                  <a:pt x="2173" y="724"/>
                </a:lnTo>
                <a:lnTo>
                  <a:pt x="2175" y="724"/>
                </a:lnTo>
                <a:lnTo>
                  <a:pt x="2177" y="724"/>
                </a:lnTo>
                <a:lnTo>
                  <a:pt x="2179" y="724"/>
                </a:lnTo>
                <a:lnTo>
                  <a:pt x="2182" y="724"/>
                </a:lnTo>
                <a:lnTo>
                  <a:pt x="2184" y="724"/>
                </a:lnTo>
                <a:lnTo>
                  <a:pt x="2186" y="724"/>
                </a:lnTo>
                <a:lnTo>
                  <a:pt x="2188" y="724"/>
                </a:lnTo>
                <a:lnTo>
                  <a:pt x="2190" y="724"/>
                </a:lnTo>
                <a:lnTo>
                  <a:pt x="2192" y="724"/>
                </a:lnTo>
                <a:lnTo>
                  <a:pt x="2194" y="725"/>
                </a:lnTo>
                <a:lnTo>
                  <a:pt x="2196" y="725"/>
                </a:lnTo>
                <a:lnTo>
                  <a:pt x="2198" y="725"/>
                </a:lnTo>
                <a:lnTo>
                  <a:pt x="2201" y="726"/>
                </a:lnTo>
                <a:lnTo>
                  <a:pt x="2203" y="726"/>
                </a:lnTo>
                <a:lnTo>
                  <a:pt x="2205" y="726"/>
                </a:lnTo>
                <a:lnTo>
                  <a:pt x="2207" y="726"/>
                </a:lnTo>
                <a:lnTo>
                  <a:pt x="2209" y="726"/>
                </a:lnTo>
                <a:lnTo>
                  <a:pt x="2212" y="726"/>
                </a:lnTo>
                <a:lnTo>
                  <a:pt x="2213" y="725"/>
                </a:lnTo>
                <a:lnTo>
                  <a:pt x="2215" y="725"/>
                </a:lnTo>
                <a:lnTo>
                  <a:pt x="2218" y="725"/>
                </a:lnTo>
                <a:lnTo>
                  <a:pt x="2220" y="725"/>
                </a:lnTo>
                <a:lnTo>
                  <a:pt x="2222" y="724"/>
                </a:lnTo>
                <a:lnTo>
                  <a:pt x="2224" y="724"/>
                </a:lnTo>
                <a:lnTo>
                  <a:pt x="2226" y="724"/>
                </a:lnTo>
                <a:lnTo>
                  <a:pt x="2229" y="724"/>
                </a:lnTo>
                <a:lnTo>
                  <a:pt x="2231" y="724"/>
                </a:lnTo>
                <a:lnTo>
                  <a:pt x="2233" y="723"/>
                </a:lnTo>
                <a:lnTo>
                  <a:pt x="2234" y="723"/>
                </a:lnTo>
                <a:lnTo>
                  <a:pt x="2237" y="722"/>
                </a:lnTo>
                <a:lnTo>
                  <a:pt x="2239" y="722"/>
                </a:lnTo>
                <a:lnTo>
                  <a:pt x="2241" y="722"/>
                </a:lnTo>
                <a:lnTo>
                  <a:pt x="2243" y="721"/>
                </a:lnTo>
                <a:lnTo>
                  <a:pt x="2245" y="720"/>
                </a:lnTo>
                <a:lnTo>
                  <a:pt x="2248" y="720"/>
                </a:lnTo>
                <a:lnTo>
                  <a:pt x="2250" y="719"/>
                </a:lnTo>
                <a:lnTo>
                  <a:pt x="2252" y="719"/>
                </a:lnTo>
                <a:lnTo>
                  <a:pt x="2254" y="718"/>
                </a:lnTo>
                <a:lnTo>
                  <a:pt x="2256" y="718"/>
                </a:lnTo>
                <a:lnTo>
                  <a:pt x="2258" y="718"/>
                </a:lnTo>
                <a:lnTo>
                  <a:pt x="2260" y="717"/>
                </a:lnTo>
                <a:lnTo>
                  <a:pt x="2262" y="717"/>
                </a:lnTo>
                <a:lnTo>
                  <a:pt x="2265" y="717"/>
                </a:lnTo>
                <a:lnTo>
                  <a:pt x="2269" y="717"/>
                </a:lnTo>
                <a:lnTo>
                  <a:pt x="2271" y="717"/>
                </a:lnTo>
                <a:lnTo>
                  <a:pt x="2273" y="717"/>
                </a:lnTo>
                <a:lnTo>
                  <a:pt x="2276" y="718"/>
                </a:lnTo>
                <a:lnTo>
                  <a:pt x="2277" y="718"/>
                </a:lnTo>
                <a:lnTo>
                  <a:pt x="2279" y="719"/>
                </a:lnTo>
                <a:lnTo>
                  <a:pt x="2281" y="719"/>
                </a:lnTo>
                <a:lnTo>
                  <a:pt x="2284" y="719"/>
                </a:lnTo>
                <a:lnTo>
                  <a:pt x="2286" y="719"/>
                </a:lnTo>
                <a:lnTo>
                  <a:pt x="2288" y="717"/>
                </a:lnTo>
                <a:lnTo>
                  <a:pt x="2290" y="716"/>
                </a:lnTo>
                <a:lnTo>
                  <a:pt x="2293" y="713"/>
                </a:lnTo>
                <a:lnTo>
                  <a:pt x="2295" y="709"/>
                </a:lnTo>
                <a:lnTo>
                  <a:pt x="2297" y="703"/>
                </a:lnTo>
                <a:lnTo>
                  <a:pt x="2298" y="694"/>
                </a:lnTo>
                <a:lnTo>
                  <a:pt x="2301" y="682"/>
                </a:lnTo>
                <a:lnTo>
                  <a:pt x="2303" y="665"/>
                </a:lnTo>
                <a:lnTo>
                  <a:pt x="2305" y="643"/>
                </a:lnTo>
                <a:lnTo>
                  <a:pt x="2307" y="615"/>
                </a:lnTo>
                <a:lnTo>
                  <a:pt x="2309" y="580"/>
                </a:lnTo>
                <a:lnTo>
                  <a:pt x="2312" y="538"/>
                </a:lnTo>
                <a:lnTo>
                  <a:pt x="2314" y="489"/>
                </a:lnTo>
                <a:lnTo>
                  <a:pt x="2316" y="434"/>
                </a:lnTo>
                <a:lnTo>
                  <a:pt x="2318" y="373"/>
                </a:lnTo>
                <a:lnTo>
                  <a:pt x="2320" y="310"/>
                </a:lnTo>
                <a:lnTo>
                  <a:pt x="2322" y="245"/>
                </a:lnTo>
                <a:lnTo>
                  <a:pt x="2324" y="183"/>
                </a:lnTo>
                <a:lnTo>
                  <a:pt x="2326" y="125"/>
                </a:lnTo>
                <a:lnTo>
                  <a:pt x="2329" y="76"/>
                </a:lnTo>
                <a:lnTo>
                  <a:pt x="2331" y="37"/>
                </a:lnTo>
                <a:lnTo>
                  <a:pt x="2333" y="11"/>
                </a:lnTo>
                <a:lnTo>
                  <a:pt x="2335" y="0"/>
                </a:lnTo>
                <a:lnTo>
                  <a:pt x="2337" y="4"/>
                </a:lnTo>
                <a:lnTo>
                  <a:pt x="2340" y="23"/>
                </a:lnTo>
                <a:lnTo>
                  <a:pt x="2342" y="56"/>
                </a:lnTo>
                <a:lnTo>
                  <a:pt x="2343" y="101"/>
                </a:lnTo>
                <a:lnTo>
                  <a:pt x="2345" y="155"/>
                </a:lnTo>
                <a:lnTo>
                  <a:pt x="2348" y="215"/>
                </a:lnTo>
                <a:lnTo>
                  <a:pt x="2350" y="278"/>
                </a:lnTo>
                <a:lnTo>
                  <a:pt x="2352" y="341"/>
                </a:lnTo>
                <a:lnTo>
                  <a:pt x="2354" y="401"/>
                </a:lnTo>
                <a:lnTo>
                  <a:pt x="2356" y="456"/>
                </a:lnTo>
                <a:lnTo>
                  <a:pt x="2359" y="505"/>
                </a:lnTo>
                <a:lnTo>
                  <a:pt x="2361" y="548"/>
                </a:lnTo>
                <a:lnTo>
                  <a:pt x="2363" y="584"/>
                </a:lnTo>
                <a:lnTo>
                  <a:pt x="2365" y="614"/>
                </a:lnTo>
                <a:lnTo>
                  <a:pt x="2367" y="638"/>
                </a:lnTo>
                <a:lnTo>
                  <a:pt x="2369" y="657"/>
                </a:lnTo>
                <a:lnTo>
                  <a:pt x="2371" y="671"/>
                </a:lnTo>
                <a:lnTo>
                  <a:pt x="2373" y="682"/>
                </a:lnTo>
                <a:lnTo>
                  <a:pt x="2376" y="690"/>
                </a:lnTo>
                <a:lnTo>
                  <a:pt x="2378" y="695"/>
                </a:lnTo>
                <a:lnTo>
                  <a:pt x="2380" y="698"/>
                </a:lnTo>
                <a:lnTo>
                  <a:pt x="2382" y="700"/>
                </a:lnTo>
                <a:lnTo>
                  <a:pt x="2384" y="701"/>
                </a:lnTo>
                <a:lnTo>
                  <a:pt x="2386" y="701"/>
                </a:lnTo>
                <a:lnTo>
                  <a:pt x="2388" y="701"/>
                </a:lnTo>
                <a:lnTo>
                  <a:pt x="2390" y="701"/>
                </a:lnTo>
                <a:lnTo>
                  <a:pt x="2392" y="701"/>
                </a:lnTo>
                <a:lnTo>
                  <a:pt x="2395" y="701"/>
                </a:lnTo>
                <a:lnTo>
                  <a:pt x="2397" y="701"/>
                </a:lnTo>
                <a:lnTo>
                  <a:pt x="2399" y="702"/>
                </a:lnTo>
                <a:lnTo>
                  <a:pt x="2401" y="702"/>
                </a:lnTo>
                <a:lnTo>
                  <a:pt x="2403" y="704"/>
                </a:lnTo>
                <a:lnTo>
                  <a:pt x="2406" y="705"/>
                </a:lnTo>
                <a:lnTo>
                  <a:pt x="2407" y="707"/>
                </a:lnTo>
                <a:lnTo>
                  <a:pt x="2409" y="708"/>
                </a:lnTo>
                <a:lnTo>
                  <a:pt x="2412" y="710"/>
                </a:lnTo>
                <a:lnTo>
                  <a:pt x="2414" y="712"/>
                </a:lnTo>
                <a:lnTo>
                  <a:pt x="2416" y="714"/>
                </a:lnTo>
                <a:lnTo>
                  <a:pt x="2418" y="716"/>
                </a:lnTo>
                <a:lnTo>
                  <a:pt x="2420" y="718"/>
                </a:lnTo>
                <a:lnTo>
                  <a:pt x="2423" y="719"/>
                </a:lnTo>
                <a:lnTo>
                  <a:pt x="2425" y="720"/>
                </a:lnTo>
                <a:lnTo>
                  <a:pt x="2427" y="721"/>
                </a:lnTo>
                <a:lnTo>
                  <a:pt x="2428" y="722"/>
                </a:lnTo>
                <a:lnTo>
                  <a:pt x="2431" y="721"/>
                </a:lnTo>
                <a:lnTo>
                  <a:pt x="2433" y="720"/>
                </a:lnTo>
                <a:lnTo>
                  <a:pt x="2435" y="718"/>
                </a:lnTo>
                <a:lnTo>
                  <a:pt x="2437" y="716"/>
                </a:lnTo>
                <a:lnTo>
                  <a:pt x="2439" y="712"/>
                </a:lnTo>
                <a:lnTo>
                  <a:pt x="2442" y="708"/>
                </a:lnTo>
                <a:lnTo>
                  <a:pt x="2444" y="704"/>
                </a:lnTo>
                <a:lnTo>
                  <a:pt x="2446" y="699"/>
                </a:lnTo>
                <a:lnTo>
                  <a:pt x="2448" y="694"/>
                </a:lnTo>
                <a:lnTo>
                  <a:pt x="2451" y="689"/>
                </a:lnTo>
                <a:lnTo>
                  <a:pt x="2452" y="685"/>
                </a:lnTo>
                <a:lnTo>
                  <a:pt x="2454" y="682"/>
                </a:lnTo>
                <a:lnTo>
                  <a:pt x="2456" y="679"/>
                </a:lnTo>
                <a:lnTo>
                  <a:pt x="2459" y="677"/>
                </a:lnTo>
                <a:lnTo>
                  <a:pt x="2461" y="676"/>
                </a:lnTo>
                <a:lnTo>
                  <a:pt x="2463" y="676"/>
                </a:lnTo>
                <a:lnTo>
                  <a:pt x="2465" y="677"/>
                </a:lnTo>
                <a:lnTo>
                  <a:pt x="2467" y="679"/>
                </a:lnTo>
                <a:lnTo>
                  <a:pt x="2470" y="682"/>
                </a:lnTo>
                <a:lnTo>
                  <a:pt x="2472" y="686"/>
                </a:lnTo>
                <a:lnTo>
                  <a:pt x="2473" y="690"/>
                </a:lnTo>
                <a:lnTo>
                  <a:pt x="2476" y="695"/>
                </a:lnTo>
                <a:lnTo>
                  <a:pt x="2478" y="699"/>
                </a:lnTo>
                <a:lnTo>
                  <a:pt x="2480" y="703"/>
                </a:lnTo>
                <a:lnTo>
                  <a:pt x="2482" y="708"/>
                </a:lnTo>
                <a:lnTo>
                  <a:pt x="2484" y="711"/>
                </a:lnTo>
                <a:lnTo>
                  <a:pt x="2487" y="715"/>
                </a:lnTo>
                <a:lnTo>
                  <a:pt x="2489" y="717"/>
                </a:lnTo>
                <a:lnTo>
                  <a:pt x="2491" y="720"/>
                </a:lnTo>
                <a:lnTo>
                  <a:pt x="2493" y="722"/>
                </a:lnTo>
                <a:lnTo>
                  <a:pt x="2495" y="724"/>
                </a:lnTo>
                <a:lnTo>
                  <a:pt x="2497" y="725"/>
                </a:lnTo>
                <a:lnTo>
                  <a:pt x="2499" y="726"/>
                </a:lnTo>
                <a:lnTo>
                  <a:pt x="2501" y="726"/>
                </a:lnTo>
                <a:lnTo>
                  <a:pt x="2503" y="726"/>
                </a:lnTo>
                <a:lnTo>
                  <a:pt x="2506" y="726"/>
                </a:lnTo>
                <a:lnTo>
                  <a:pt x="2508" y="725"/>
                </a:lnTo>
                <a:lnTo>
                  <a:pt x="2510" y="724"/>
                </a:lnTo>
                <a:lnTo>
                  <a:pt x="2512" y="722"/>
                </a:lnTo>
                <a:lnTo>
                  <a:pt x="2514" y="720"/>
                </a:lnTo>
                <a:lnTo>
                  <a:pt x="2516" y="717"/>
                </a:lnTo>
                <a:lnTo>
                  <a:pt x="2518" y="714"/>
                </a:lnTo>
                <a:lnTo>
                  <a:pt x="2520" y="710"/>
                </a:lnTo>
                <a:lnTo>
                  <a:pt x="2523" y="707"/>
                </a:lnTo>
                <a:lnTo>
                  <a:pt x="2525" y="703"/>
                </a:lnTo>
                <a:lnTo>
                  <a:pt x="2527" y="700"/>
                </a:lnTo>
                <a:lnTo>
                  <a:pt x="2529" y="696"/>
                </a:lnTo>
                <a:lnTo>
                  <a:pt x="2531" y="694"/>
                </a:lnTo>
                <a:lnTo>
                  <a:pt x="2534" y="691"/>
                </a:lnTo>
                <a:lnTo>
                  <a:pt x="2536" y="690"/>
                </a:lnTo>
                <a:lnTo>
                  <a:pt x="2537" y="689"/>
                </a:lnTo>
                <a:lnTo>
                  <a:pt x="2539" y="689"/>
                </a:lnTo>
                <a:lnTo>
                  <a:pt x="2542" y="689"/>
                </a:lnTo>
                <a:lnTo>
                  <a:pt x="2544" y="689"/>
                </a:lnTo>
                <a:lnTo>
                  <a:pt x="2546" y="691"/>
                </a:lnTo>
                <a:lnTo>
                  <a:pt x="2548" y="692"/>
                </a:lnTo>
                <a:lnTo>
                  <a:pt x="2550" y="694"/>
                </a:lnTo>
                <a:lnTo>
                  <a:pt x="2553" y="696"/>
                </a:lnTo>
                <a:lnTo>
                  <a:pt x="2555" y="698"/>
                </a:lnTo>
                <a:lnTo>
                  <a:pt x="2557" y="699"/>
                </a:lnTo>
                <a:lnTo>
                  <a:pt x="2559" y="701"/>
                </a:lnTo>
                <a:lnTo>
                  <a:pt x="2561" y="703"/>
                </a:lnTo>
                <a:lnTo>
                  <a:pt x="2563" y="704"/>
                </a:lnTo>
                <a:lnTo>
                  <a:pt x="2565" y="706"/>
                </a:lnTo>
                <a:lnTo>
                  <a:pt x="2567" y="707"/>
                </a:lnTo>
                <a:lnTo>
                  <a:pt x="2570" y="708"/>
                </a:lnTo>
                <a:lnTo>
                  <a:pt x="2572" y="709"/>
                </a:lnTo>
                <a:lnTo>
                  <a:pt x="2574" y="711"/>
                </a:lnTo>
                <a:lnTo>
                  <a:pt x="2576" y="711"/>
                </a:lnTo>
                <a:lnTo>
                  <a:pt x="2578" y="712"/>
                </a:lnTo>
                <a:lnTo>
                  <a:pt x="2581" y="713"/>
                </a:lnTo>
                <a:lnTo>
                  <a:pt x="2582" y="714"/>
                </a:lnTo>
                <a:lnTo>
                  <a:pt x="2584" y="715"/>
                </a:lnTo>
                <a:lnTo>
                  <a:pt x="2586" y="716"/>
                </a:lnTo>
                <a:lnTo>
                  <a:pt x="2589" y="717"/>
                </a:lnTo>
                <a:lnTo>
                  <a:pt x="2591" y="718"/>
                </a:lnTo>
                <a:lnTo>
                  <a:pt x="2593" y="719"/>
                </a:lnTo>
                <a:lnTo>
                  <a:pt x="2595" y="720"/>
                </a:lnTo>
                <a:lnTo>
                  <a:pt x="2598" y="722"/>
                </a:lnTo>
                <a:lnTo>
                  <a:pt x="2600" y="723"/>
                </a:lnTo>
                <a:lnTo>
                  <a:pt x="2602" y="725"/>
                </a:lnTo>
                <a:lnTo>
                  <a:pt x="2603" y="726"/>
                </a:lnTo>
                <a:lnTo>
                  <a:pt x="2606" y="727"/>
                </a:lnTo>
                <a:lnTo>
                  <a:pt x="2608" y="728"/>
                </a:lnTo>
                <a:lnTo>
                  <a:pt x="2610" y="729"/>
                </a:lnTo>
                <a:lnTo>
                  <a:pt x="2612" y="730"/>
                </a:lnTo>
                <a:lnTo>
                  <a:pt x="2614" y="731"/>
                </a:lnTo>
                <a:lnTo>
                  <a:pt x="2617" y="731"/>
                </a:lnTo>
                <a:lnTo>
                  <a:pt x="2619" y="731"/>
                </a:lnTo>
                <a:lnTo>
                  <a:pt x="2621" y="732"/>
                </a:lnTo>
                <a:lnTo>
                  <a:pt x="2625" y="732"/>
                </a:lnTo>
                <a:lnTo>
                  <a:pt x="2627" y="732"/>
                </a:lnTo>
                <a:lnTo>
                  <a:pt x="2629" y="732"/>
                </a:lnTo>
                <a:lnTo>
                  <a:pt x="2631" y="732"/>
                </a:lnTo>
                <a:lnTo>
                  <a:pt x="2634" y="733"/>
                </a:lnTo>
                <a:lnTo>
                  <a:pt x="2636" y="733"/>
                </a:lnTo>
                <a:lnTo>
                  <a:pt x="2638" y="733"/>
                </a:lnTo>
                <a:lnTo>
                  <a:pt x="2640" y="733"/>
                </a:lnTo>
                <a:lnTo>
                  <a:pt x="2642" y="733"/>
                </a:lnTo>
                <a:lnTo>
                  <a:pt x="2645" y="734"/>
                </a:lnTo>
                <a:lnTo>
                  <a:pt x="2646" y="735"/>
                </a:lnTo>
                <a:lnTo>
                  <a:pt x="2648" y="735"/>
                </a:lnTo>
                <a:lnTo>
                  <a:pt x="2650" y="735"/>
                </a:lnTo>
                <a:lnTo>
                  <a:pt x="2653" y="736"/>
                </a:lnTo>
                <a:lnTo>
                  <a:pt x="2655" y="736"/>
                </a:lnTo>
                <a:lnTo>
                  <a:pt x="2657" y="735"/>
                </a:lnTo>
                <a:lnTo>
                  <a:pt x="2659" y="735"/>
                </a:lnTo>
                <a:lnTo>
                  <a:pt x="2661" y="734"/>
                </a:lnTo>
                <a:lnTo>
                  <a:pt x="2664" y="733"/>
                </a:lnTo>
                <a:lnTo>
                  <a:pt x="2666" y="731"/>
                </a:lnTo>
                <a:lnTo>
                  <a:pt x="2667" y="729"/>
                </a:lnTo>
                <a:lnTo>
                  <a:pt x="2670" y="726"/>
                </a:lnTo>
                <a:lnTo>
                  <a:pt x="2672" y="720"/>
                </a:lnTo>
                <a:lnTo>
                  <a:pt x="2674" y="713"/>
                </a:lnTo>
                <a:lnTo>
                  <a:pt x="2676" y="704"/>
                </a:lnTo>
                <a:lnTo>
                  <a:pt x="2678" y="690"/>
                </a:lnTo>
                <a:lnTo>
                  <a:pt x="2681" y="672"/>
                </a:lnTo>
                <a:lnTo>
                  <a:pt x="2683" y="648"/>
                </a:lnTo>
                <a:lnTo>
                  <a:pt x="2685" y="618"/>
                </a:lnTo>
                <a:lnTo>
                  <a:pt x="2687" y="582"/>
                </a:lnTo>
                <a:lnTo>
                  <a:pt x="2689" y="538"/>
                </a:lnTo>
                <a:lnTo>
                  <a:pt x="2691" y="487"/>
                </a:lnTo>
                <a:lnTo>
                  <a:pt x="2693" y="431"/>
                </a:lnTo>
                <a:lnTo>
                  <a:pt x="2695" y="370"/>
                </a:lnTo>
                <a:lnTo>
                  <a:pt x="2697" y="306"/>
                </a:lnTo>
                <a:lnTo>
                  <a:pt x="2700" y="244"/>
                </a:lnTo>
                <a:lnTo>
                  <a:pt x="2702" y="186"/>
                </a:lnTo>
                <a:lnTo>
                  <a:pt x="2704" y="134"/>
                </a:lnTo>
                <a:lnTo>
                  <a:pt x="2706" y="94"/>
                </a:lnTo>
                <a:lnTo>
                  <a:pt x="2708" y="66"/>
                </a:lnTo>
                <a:lnTo>
                  <a:pt x="2711" y="52"/>
                </a:lnTo>
                <a:lnTo>
                  <a:pt x="2712" y="54"/>
                </a:lnTo>
                <a:lnTo>
                  <a:pt x="2714" y="71"/>
                </a:lnTo>
                <a:lnTo>
                  <a:pt x="2717" y="101"/>
                </a:lnTo>
                <a:lnTo>
                  <a:pt x="2719" y="142"/>
                </a:lnTo>
                <a:lnTo>
                  <a:pt x="2721" y="192"/>
                </a:lnTo>
                <a:lnTo>
                  <a:pt x="2723" y="247"/>
                </a:lnTo>
                <a:lnTo>
                  <a:pt x="2725" y="305"/>
                </a:lnTo>
                <a:lnTo>
                  <a:pt x="2728" y="362"/>
                </a:lnTo>
                <a:lnTo>
                  <a:pt x="2730" y="417"/>
                </a:lnTo>
                <a:lnTo>
                  <a:pt x="2732" y="467"/>
                </a:lnTo>
                <a:lnTo>
                  <a:pt x="2733" y="511"/>
                </a:lnTo>
                <a:lnTo>
                  <a:pt x="2736" y="549"/>
                </a:lnTo>
                <a:lnTo>
                  <a:pt x="2738" y="581"/>
                </a:lnTo>
                <a:lnTo>
                  <a:pt x="2740" y="606"/>
                </a:lnTo>
                <a:lnTo>
                  <a:pt x="2742" y="627"/>
                </a:lnTo>
                <a:lnTo>
                  <a:pt x="2744" y="642"/>
                </a:lnTo>
                <a:lnTo>
                  <a:pt x="2747" y="653"/>
                </a:lnTo>
                <a:lnTo>
                  <a:pt x="2749" y="660"/>
                </a:lnTo>
                <a:lnTo>
                  <a:pt x="2751" y="665"/>
                </a:lnTo>
                <a:lnTo>
                  <a:pt x="2753" y="667"/>
                </a:lnTo>
                <a:lnTo>
                  <a:pt x="2755" y="668"/>
                </a:lnTo>
                <a:lnTo>
                  <a:pt x="2757" y="667"/>
                </a:lnTo>
                <a:lnTo>
                  <a:pt x="2759" y="665"/>
                </a:lnTo>
                <a:lnTo>
                  <a:pt x="2761" y="664"/>
                </a:lnTo>
                <a:lnTo>
                  <a:pt x="2764" y="662"/>
                </a:lnTo>
                <a:lnTo>
                  <a:pt x="2766" y="660"/>
                </a:lnTo>
                <a:lnTo>
                  <a:pt x="2768" y="659"/>
                </a:lnTo>
                <a:lnTo>
                  <a:pt x="2770" y="659"/>
                </a:lnTo>
                <a:lnTo>
                  <a:pt x="2772" y="659"/>
                </a:lnTo>
                <a:lnTo>
                  <a:pt x="2775" y="661"/>
                </a:lnTo>
                <a:lnTo>
                  <a:pt x="2776" y="663"/>
                </a:lnTo>
                <a:lnTo>
                  <a:pt x="2778" y="667"/>
                </a:lnTo>
                <a:lnTo>
                  <a:pt x="2781" y="671"/>
                </a:lnTo>
                <a:lnTo>
                  <a:pt x="2783" y="676"/>
                </a:lnTo>
                <a:lnTo>
                  <a:pt x="2785" y="681"/>
                </a:lnTo>
                <a:lnTo>
                  <a:pt x="2787" y="686"/>
                </a:lnTo>
                <a:lnTo>
                  <a:pt x="2789" y="691"/>
                </a:lnTo>
                <a:lnTo>
                  <a:pt x="2792" y="696"/>
                </a:lnTo>
                <a:lnTo>
                  <a:pt x="2794" y="701"/>
                </a:lnTo>
                <a:lnTo>
                  <a:pt x="2796" y="705"/>
                </a:lnTo>
                <a:lnTo>
                  <a:pt x="2797" y="709"/>
                </a:lnTo>
                <a:lnTo>
                  <a:pt x="2800" y="712"/>
                </a:lnTo>
                <a:lnTo>
                  <a:pt x="2802" y="715"/>
                </a:lnTo>
                <a:lnTo>
                  <a:pt x="2804" y="717"/>
                </a:lnTo>
                <a:lnTo>
                  <a:pt x="2806" y="719"/>
                </a:lnTo>
                <a:lnTo>
                  <a:pt x="2808" y="720"/>
                </a:lnTo>
                <a:lnTo>
                  <a:pt x="2811" y="721"/>
                </a:lnTo>
                <a:lnTo>
                  <a:pt x="2813" y="722"/>
                </a:lnTo>
                <a:lnTo>
                  <a:pt x="2815" y="722"/>
                </a:lnTo>
                <a:lnTo>
                  <a:pt x="2817" y="722"/>
                </a:lnTo>
                <a:lnTo>
                  <a:pt x="2819" y="722"/>
                </a:lnTo>
                <a:lnTo>
                  <a:pt x="2821" y="722"/>
                </a:lnTo>
                <a:lnTo>
                  <a:pt x="2823" y="721"/>
                </a:lnTo>
                <a:lnTo>
                  <a:pt x="2825" y="721"/>
                </a:lnTo>
                <a:lnTo>
                  <a:pt x="2828" y="720"/>
                </a:lnTo>
                <a:lnTo>
                  <a:pt x="2830" y="720"/>
                </a:lnTo>
                <a:lnTo>
                  <a:pt x="2832" y="720"/>
                </a:lnTo>
                <a:lnTo>
                  <a:pt x="2834" y="720"/>
                </a:lnTo>
                <a:lnTo>
                  <a:pt x="2836" y="720"/>
                </a:lnTo>
                <a:lnTo>
                  <a:pt x="2839" y="720"/>
                </a:lnTo>
                <a:lnTo>
                  <a:pt x="2841" y="721"/>
                </a:lnTo>
                <a:lnTo>
                  <a:pt x="2842" y="722"/>
                </a:lnTo>
                <a:lnTo>
                  <a:pt x="2844" y="723"/>
                </a:lnTo>
                <a:lnTo>
                  <a:pt x="2847" y="724"/>
                </a:lnTo>
                <a:lnTo>
                  <a:pt x="2849" y="725"/>
                </a:lnTo>
                <a:lnTo>
                  <a:pt x="2851" y="727"/>
                </a:lnTo>
                <a:lnTo>
                  <a:pt x="2853" y="728"/>
                </a:lnTo>
                <a:lnTo>
                  <a:pt x="2855" y="730"/>
                </a:lnTo>
                <a:lnTo>
                  <a:pt x="2858" y="731"/>
                </a:lnTo>
                <a:lnTo>
                  <a:pt x="2860" y="733"/>
                </a:lnTo>
                <a:lnTo>
                  <a:pt x="2862" y="734"/>
                </a:lnTo>
                <a:lnTo>
                  <a:pt x="2864" y="735"/>
                </a:lnTo>
                <a:lnTo>
                  <a:pt x="2866" y="736"/>
                </a:lnTo>
                <a:lnTo>
                  <a:pt x="2868" y="736"/>
                </a:lnTo>
                <a:lnTo>
                  <a:pt x="2870" y="737"/>
                </a:lnTo>
                <a:lnTo>
                  <a:pt x="2872" y="737"/>
                </a:lnTo>
                <a:lnTo>
                  <a:pt x="2875" y="737"/>
                </a:lnTo>
                <a:lnTo>
                  <a:pt x="2877" y="737"/>
                </a:lnTo>
                <a:lnTo>
                  <a:pt x="2879" y="737"/>
                </a:lnTo>
                <a:lnTo>
                  <a:pt x="2881" y="736"/>
                </a:lnTo>
                <a:lnTo>
                  <a:pt x="2883" y="735"/>
                </a:lnTo>
                <a:lnTo>
                  <a:pt x="2885" y="733"/>
                </a:lnTo>
                <a:lnTo>
                  <a:pt x="2887" y="731"/>
                </a:lnTo>
                <a:lnTo>
                  <a:pt x="2889" y="730"/>
                </a:lnTo>
                <a:lnTo>
                  <a:pt x="2891" y="727"/>
                </a:lnTo>
                <a:lnTo>
                  <a:pt x="2894" y="724"/>
                </a:lnTo>
                <a:lnTo>
                  <a:pt x="2896" y="722"/>
                </a:lnTo>
                <a:lnTo>
                  <a:pt x="2898" y="719"/>
                </a:lnTo>
                <a:lnTo>
                  <a:pt x="2900" y="717"/>
                </a:lnTo>
                <a:lnTo>
                  <a:pt x="2903" y="715"/>
                </a:lnTo>
                <a:lnTo>
                  <a:pt x="2905" y="713"/>
                </a:lnTo>
                <a:lnTo>
                  <a:pt x="2906" y="711"/>
                </a:lnTo>
                <a:lnTo>
                  <a:pt x="2908" y="711"/>
                </a:lnTo>
                <a:lnTo>
                  <a:pt x="2911" y="711"/>
                </a:lnTo>
                <a:lnTo>
                  <a:pt x="2913" y="711"/>
                </a:lnTo>
                <a:lnTo>
                  <a:pt x="2915" y="712"/>
                </a:lnTo>
                <a:lnTo>
                  <a:pt x="2917" y="714"/>
                </a:lnTo>
                <a:lnTo>
                  <a:pt x="2919" y="717"/>
                </a:lnTo>
                <a:lnTo>
                  <a:pt x="2922" y="719"/>
                </a:lnTo>
                <a:lnTo>
                  <a:pt x="2924" y="722"/>
                </a:lnTo>
                <a:lnTo>
                  <a:pt x="2926" y="724"/>
                </a:lnTo>
                <a:lnTo>
                  <a:pt x="2927" y="727"/>
                </a:lnTo>
                <a:lnTo>
                  <a:pt x="2930" y="729"/>
                </a:lnTo>
                <a:lnTo>
                  <a:pt x="2932" y="731"/>
                </a:lnTo>
                <a:lnTo>
                  <a:pt x="2934" y="733"/>
                </a:lnTo>
                <a:lnTo>
                  <a:pt x="2936" y="734"/>
                </a:lnTo>
                <a:lnTo>
                  <a:pt x="2939" y="735"/>
                </a:lnTo>
                <a:lnTo>
                  <a:pt x="2941" y="736"/>
                </a:lnTo>
                <a:lnTo>
                  <a:pt x="2943" y="737"/>
                </a:lnTo>
                <a:lnTo>
                  <a:pt x="2945" y="737"/>
                </a:lnTo>
                <a:lnTo>
                  <a:pt x="2947" y="737"/>
                </a:lnTo>
                <a:lnTo>
                  <a:pt x="2950" y="737"/>
                </a:lnTo>
                <a:lnTo>
                  <a:pt x="2951" y="736"/>
                </a:lnTo>
                <a:lnTo>
                  <a:pt x="2953" y="736"/>
                </a:lnTo>
                <a:lnTo>
                  <a:pt x="2955" y="735"/>
                </a:lnTo>
                <a:lnTo>
                  <a:pt x="2958" y="735"/>
                </a:lnTo>
                <a:lnTo>
                  <a:pt x="2960" y="734"/>
                </a:lnTo>
                <a:lnTo>
                  <a:pt x="2962" y="733"/>
                </a:lnTo>
                <a:lnTo>
                  <a:pt x="2964" y="733"/>
                </a:lnTo>
                <a:lnTo>
                  <a:pt x="2966" y="732"/>
                </a:lnTo>
                <a:lnTo>
                  <a:pt x="2969" y="731"/>
                </a:lnTo>
                <a:lnTo>
                  <a:pt x="2971" y="731"/>
                </a:lnTo>
                <a:lnTo>
                  <a:pt x="2972" y="730"/>
                </a:lnTo>
                <a:lnTo>
                  <a:pt x="2975" y="730"/>
                </a:lnTo>
                <a:lnTo>
                  <a:pt x="2977" y="729"/>
                </a:lnTo>
                <a:lnTo>
                  <a:pt x="2979" y="728"/>
                </a:lnTo>
                <a:lnTo>
                  <a:pt x="2981" y="727"/>
                </a:lnTo>
                <a:lnTo>
                  <a:pt x="2983" y="726"/>
                </a:lnTo>
                <a:lnTo>
                  <a:pt x="2986" y="724"/>
                </a:lnTo>
                <a:lnTo>
                  <a:pt x="2988" y="723"/>
                </a:lnTo>
                <a:lnTo>
                  <a:pt x="2990" y="721"/>
                </a:lnTo>
                <a:lnTo>
                  <a:pt x="2992" y="720"/>
                </a:lnTo>
                <a:lnTo>
                  <a:pt x="2994" y="718"/>
                </a:lnTo>
                <a:lnTo>
                  <a:pt x="2996" y="717"/>
                </a:lnTo>
                <a:lnTo>
                  <a:pt x="2998" y="715"/>
                </a:lnTo>
                <a:lnTo>
                  <a:pt x="3000" y="713"/>
                </a:lnTo>
                <a:lnTo>
                  <a:pt x="3002" y="712"/>
                </a:lnTo>
                <a:lnTo>
                  <a:pt x="3005" y="711"/>
                </a:lnTo>
                <a:lnTo>
                  <a:pt x="3007" y="710"/>
                </a:lnTo>
                <a:lnTo>
                  <a:pt x="3009" y="709"/>
                </a:lnTo>
                <a:lnTo>
                  <a:pt x="3011" y="709"/>
                </a:lnTo>
                <a:lnTo>
                  <a:pt x="3013" y="708"/>
                </a:lnTo>
                <a:lnTo>
                  <a:pt x="3015" y="707"/>
                </a:lnTo>
                <a:lnTo>
                  <a:pt x="3017" y="706"/>
                </a:lnTo>
                <a:lnTo>
                  <a:pt x="3019" y="706"/>
                </a:lnTo>
                <a:lnTo>
                  <a:pt x="3022" y="705"/>
                </a:lnTo>
                <a:lnTo>
                  <a:pt x="3024" y="705"/>
                </a:lnTo>
                <a:lnTo>
                  <a:pt x="3026" y="705"/>
                </a:lnTo>
                <a:lnTo>
                  <a:pt x="3028" y="706"/>
                </a:lnTo>
                <a:lnTo>
                  <a:pt x="3030" y="706"/>
                </a:lnTo>
                <a:lnTo>
                  <a:pt x="3033" y="707"/>
                </a:lnTo>
                <a:lnTo>
                  <a:pt x="3035" y="708"/>
                </a:lnTo>
                <a:lnTo>
                  <a:pt x="3036" y="709"/>
                </a:lnTo>
                <a:lnTo>
                  <a:pt x="3038" y="709"/>
                </a:lnTo>
                <a:lnTo>
                  <a:pt x="3041" y="709"/>
                </a:lnTo>
                <a:lnTo>
                  <a:pt x="3043" y="709"/>
                </a:lnTo>
                <a:lnTo>
                  <a:pt x="3045" y="708"/>
                </a:lnTo>
                <a:lnTo>
                  <a:pt x="3047" y="705"/>
                </a:lnTo>
                <a:lnTo>
                  <a:pt x="3050" y="700"/>
                </a:lnTo>
                <a:lnTo>
                  <a:pt x="3052" y="695"/>
                </a:lnTo>
                <a:lnTo>
                  <a:pt x="3054" y="687"/>
                </a:lnTo>
                <a:lnTo>
                  <a:pt x="3056" y="677"/>
                </a:lnTo>
                <a:lnTo>
                  <a:pt x="3058" y="667"/>
                </a:lnTo>
                <a:lnTo>
                  <a:pt x="3060" y="655"/>
                </a:lnTo>
                <a:lnTo>
                  <a:pt x="3062" y="642"/>
                </a:lnTo>
                <a:lnTo>
                  <a:pt x="3064" y="630"/>
                </a:lnTo>
                <a:lnTo>
                  <a:pt x="3066" y="619"/>
                </a:lnTo>
                <a:lnTo>
                  <a:pt x="3069" y="609"/>
                </a:lnTo>
                <a:lnTo>
                  <a:pt x="3071" y="601"/>
                </a:lnTo>
                <a:lnTo>
                  <a:pt x="3073" y="597"/>
                </a:lnTo>
                <a:lnTo>
                  <a:pt x="3075" y="595"/>
                </a:lnTo>
                <a:lnTo>
                  <a:pt x="3077" y="597"/>
                </a:lnTo>
                <a:lnTo>
                  <a:pt x="3080" y="601"/>
                </a:lnTo>
                <a:lnTo>
                  <a:pt x="3081" y="608"/>
                </a:lnTo>
                <a:lnTo>
                  <a:pt x="3083" y="618"/>
                </a:lnTo>
                <a:lnTo>
                  <a:pt x="3086" y="629"/>
                </a:lnTo>
                <a:lnTo>
                  <a:pt x="3088" y="640"/>
                </a:lnTo>
                <a:lnTo>
                  <a:pt x="3090" y="652"/>
                </a:lnTo>
                <a:lnTo>
                  <a:pt x="3092" y="663"/>
                </a:lnTo>
                <a:lnTo>
                  <a:pt x="3094" y="674"/>
                </a:lnTo>
                <a:lnTo>
                  <a:pt x="3097" y="684"/>
                </a:lnTo>
                <a:lnTo>
                  <a:pt x="3099" y="692"/>
                </a:lnTo>
                <a:lnTo>
                  <a:pt x="3101" y="700"/>
                </a:lnTo>
                <a:lnTo>
                  <a:pt x="3102" y="706"/>
                </a:lnTo>
                <a:lnTo>
                  <a:pt x="3105" y="711"/>
                </a:lnTo>
                <a:lnTo>
                  <a:pt x="3107" y="715"/>
                </a:lnTo>
                <a:lnTo>
                  <a:pt x="3109" y="718"/>
                </a:lnTo>
                <a:lnTo>
                  <a:pt x="3111" y="720"/>
                </a:lnTo>
                <a:lnTo>
                  <a:pt x="3113" y="722"/>
                </a:lnTo>
                <a:lnTo>
                  <a:pt x="3116" y="723"/>
                </a:lnTo>
                <a:lnTo>
                  <a:pt x="3118" y="724"/>
                </a:lnTo>
                <a:lnTo>
                  <a:pt x="3120" y="724"/>
                </a:lnTo>
                <a:lnTo>
                  <a:pt x="3122" y="725"/>
                </a:lnTo>
                <a:lnTo>
                  <a:pt x="3124" y="726"/>
                </a:lnTo>
                <a:lnTo>
                  <a:pt x="3126" y="726"/>
                </a:lnTo>
                <a:lnTo>
                  <a:pt x="3128" y="727"/>
                </a:lnTo>
                <a:lnTo>
                  <a:pt x="3130" y="728"/>
                </a:lnTo>
                <a:lnTo>
                  <a:pt x="3133" y="728"/>
                </a:lnTo>
                <a:lnTo>
                  <a:pt x="3135" y="729"/>
                </a:lnTo>
                <a:lnTo>
                  <a:pt x="3137" y="730"/>
                </a:lnTo>
                <a:lnTo>
                  <a:pt x="3139" y="731"/>
                </a:lnTo>
                <a:lnTo>
                  <a:pt x="3141" y="732"/>
                </a:lnTo>
                <a:lnTo>
                  <a:pt x="3144" y="733"/>
                </a:lnTo>
                <a:lnTo>
                  <a:pt x="3145" y="734"/>
                </a:lnTo>
                <a:lnTo>
                  <a:pt x="3147" y="735"/>
                </a:lnTo>
                <a:lnTo>
                  <a:pt x="3149" y="736"/>
                </a:lnTo>
                <a:lnTo>
                  <a:pt x="3152" y="737"/>
                </a:lnTo>
                <a:lnTo>
                  <a:pt x="3154" y="737"/>
                </a:lnTo>
                <a:lnTo>
                  <a:pt x="3156" y="737"/>
                </a:lnTo>
                <a:lnTo>
                  <a:pt x="3158" y="737"/>
                </a:lnTo>
                <a:lnTo>
                  <a:pt x="3163" y="737"/>
                </a:lnTo>
                <a:lnTo>
                  <a:pt x="3165" y="737"/>
                </a:lnTo>
                <a:lnTo>
                  <a:pt x="3166" y="737"/>
                </a:lnTo>
                <a:lnTo>
                  <a:pt x="3169" y="736"/>
                </a:lnTo>
                <a:lnTo>
                  <a:pt x="3171" y="736"/>
                </a:lnTo>
                <a:lnTo>
                  <a:pt x="3173" y="735"/>
                </a:lnTo>
                <a:lnTo>
                  <a:pt x="3175" y="734"/>
                </a:lnTo>
                <a:lnTo>
                  <a:pt x="3177" y="733"/>
                </a:lnTo>
                <a:lnTo>
                  <a:pt x="3180" y="733"/>
                </a:lnTo>
                <a:lnTo>
                  <a:pt x="3182" y="732"/>
                </a:lnTo>
                <a:lnTo>
                  <a:pt x="3184" y="731"/>
                </a:lnTo>
                <a:lnTo>
                  <a:pt x="3186" y="730"/>
                </a:lnTo>
                <a:lnTo>
                  <a:pt x="3188" y="729"/>
                </a:lnTo>
                <a:lnTo>
                  <a:pt x="3190" y="728"/>
                </a:lnTo>
                <a:lnTo>
                  <a:pt x="3192" y="728"/>
                </a:lnTo>
                <a:lnTo>
                  <a:pt x="3194" y="727"/>
                </a:lnTo>
                <a:lnTo>
                  <a:pt x="3196" y="727"/>
                </a:lnTo>
                <a:lnTo>
                  <a:pt x="3199" y="727"/>
                </a:lnTo>
                <a:lnTo>
                  <a:pt x="3201" y="727"/>
                </a:lnTo>
                <a:lnTo>
                  <a:pt x="3203" y="727"/>
                </a:lnTo>
                <a:lnTo>
                  <a:pt x="3205" y="728"/>
                </a:lnTo>
                <a:lnTo>
                  <a:pt x="3208" y="728"/>
                </a:lnTo>
                <a:lnTo>
                  <a:pt x="3210" y="729"/>
                </a:lnTo>
                <a:lnTo>
                  <a:pt x="3211" y="730"/>
                </a:lnTo>
                <a:lnTo>
                  <a:pt x="3213" y="731"/>
                </a:lnTo>
                <a:lnTo>
                  <a:pt x="3216" y="732"/>
                </a:lnTo>
                <a:lnTo>
                  <a:pt x="3218" y="733"/>
                </a:lnTo>
                <a:lnTo>
                  <a:pt x="3220" y="733"/>
                </a:lnTo>
                <a:lnTo>
                  <a:pt x="3222" y="733"/>
                </a:lnTo>
                <a:lnTo>
                  <a:pt x="3224" y="733"/>
                </a:lnTo>
                <a:lnTo>
                  <a:pt x="3227" y="733"/>
                </a:lnTo>
                <a:lnTo>
                  <a:pt x="3229" y="733"/>
                </a:lnTo>
                <a:lnTo>
                  <a:pt x="3231" y="733"/>
                </a:lnTo>
                <a:lnTo>
                  <a:pt x="3233" y="733"/>
                </a:lnTo>
                <a:lnTo>
                  <a:pt x="3235" y="733"/>
                </a:lnTo>
                <a:lnTo>
                  <a:pt x="3237" y="732"/>
                </a:lnTo>
                <a:lnTo>
                  <a:pt x="3239" y="731"/>
                </a:lnTo>
                <a:lnTo>
                  <a:pt x="3241" y="731"/>
                </a:lnTo>
                <a:lnTo>
                  <a:pt x="3244" y="730"/>
                </a:lnTo>
                <a:lnTo>
                  <a:pt x="3246" y="730"/>
                </a:lnTo>
                <a:lnTo>
                  <a:pt x="3248" y="729"/>
                </a:lnTo>
                <a:lnTo>
                  <a:pt x="3250" y="728"/>
                </a:lnTo>
                <a:lnTo>
                  <a:pt x="3252" y="728"/>
                </a:lnTo>
                <a:lnTo>
                  <a:pt x="3254" y="727"/>
                </a:lnTo>
                <a:lnTo>
                  <a:pt x="3256" y="727"/>
                </a:lnTo>
                <a:lnTo>
                  <a:pt x="3258" y="727"/>
                </a:lnTo>
                <a:lnTo>
                  <a:pt x="3260" y="727"/>
                </a:lnTo>
                <a:lnTo>
                  <a:pt x="3263" y="728"/>
                </a:lnTo>
                <a:lnTo>
                  <a:pt x="3265" y="728"/>
                </a:lnTo>
                <a:lnTo>
                  <a:pt x="3267" y="729"/>
                </a:lnTo>
                <a:lnTo>
                  <a:pt x="3269" y="730"/>
                </a:lnTo>
                <a:lnTo>
                  <a:pt x="3271" y="731"/>
                </a:lnTo>
                <a:lnTo>
                  <a:pt x="3274" y="731"/>
                </a:lnTo>
                <a:lnTo>
                  <a:pt x="3275" y="732"/>
                </a:lnTo>
                <a:lnTo>
                  <a:pt x="3277" y="732"/>
                </a:lnTo>
                <a:lnTo>
                  <a:pt x="3280" y="732"/>
                </a:lnTo>
                <a:lnTo>
                  <a:pt x="3282" y="731"/>
                </a:lnTo>
                <a:lnTo>
                  <a:pt x="3284" y="731"/>
                </a:lnTo>
                <a:lnTo>
                  <a:pt x="3286" y="730"/>
                </a:lnTo>
                <a:lnTo>
                  <a:pt x="3288" y="728"/>
                </a:lnTo>
                <a:lnTo>
                  <a:pt x="3291" y="726"/>
                </a:lnTo>
                <a:lnTo>
                  <a:pt x="3293" y="724"/>
                </a:lnTo>
                <a:lnTo>
                  <a:pt x="3295" y="722"/>
                </a:lnTo>
                <a:lnTo>
                  <a:pt x="3296" y="720"/>
                </a:lnTo>
                <a:lnTo>
                  <a:pt x="3299" y="718"/>
                </a:lnTo>
                <a:lnTo>
                  <a:pt x="3301" y="717"/>
                </a:lnTo>
                <a:lnTo>
                  <a:pt x="3303" y="715"/>
                </a:lnTo>
                <a:lnTo>
                  <a:pt x="3305" y="713"/>
                </a:lnTo>
                <a:lnTo>
                  <a:pt x="3307" y="713"/>
                </a:lnTo>
                <a:lnTo>
                  <a:pt x="3310" y="712"/>
                </a:lnTo>
                <a:lnTo>
                  <a:pt x="3312" y="712"/>
                </a:lnTo>
                <a:lnTo>
                  <a:pt x="3314" y="713"/>
                </a:lnTo>
                <a:lnTo>
                  <a:pt x="3316" y="713"/>
                </a:lnTo>
                <a:lnTo>
                  <a:pt x="3318" y="714"/>
                </a:lnTo>
                <a:lnTo>
                  <a:pt x="3320" y="715"/>
                </a:lnTo>
                <a:lnTo>
                  <a:pt x="3322" y="717"/>
                </a:lnTo>
                <a:lnTo>
                  <a:pt x="3324" y="717"/>
                </a:lnTo>
                <a:lnTo>
                  <a:pt x="3327" y="719"/>
                </a:lnTo>
                <a:lnTo>
                  <a:pt x="3329" y="719"/>
                </a:lnTo>
                <a:lnTo>
                  <a:pt x="3331" y="720"/>
                </a:lnTo>
                <a:lnTo>
                  <a:pt x="3333" y="720"/>
                </a:lnTo>
                <a:lnTo>
                  <a:pt x="3335" y="721"/>
                </a:lnTo>
                <a:lnTo>
                  <a:pt x="3338" y="721"/>
                </a:lnTo>
                <a:lnTo>
                  <a:pt x="3340" y="721"/>
                </a:lnTo>
                <a:lnTo>
                  <a:pt x="3341" y="722"/>
                </a:lnTo>
                <a:lnTo>
                  <a:pt x="3343" y="722"/>
                </a:lnTo>
                <a:lnTo>
                  <a:pt x="3346" y="722"/>
                </a:lnTo>
                <a:lnTo>
                  <a:pt x="3348" y="722"/>
                </a:lnTo>
                <a:lnTo>
                  <a:pt x="3350" y="723"/>
                </a:lnTo>
                <a:lnTo>
                  <a:pt x="3352" y="723"/>
                </a:lnTo>
                <a:lnTo>
                  <a:pt x="3355" y="723"/>
                </a:lnTo>
                <a:lnTo>
                  <a:pt x="3357" y="724"/>
                </a:lnTo>
                <a:lnTo>
                  <a:pt x="3359" y="724"/>
                </a:lnTo>
                <a:lnTo>
                  <a:pt x="3361" y="724"/>
                </a:lnTo>
                <a:lnTo>
                  <a:pt x="3363" y="724"/>
                </a:lnTo>
                <a:lnTo>
                  <a:pt x="3367" y="724"/>
                </a:lnTo>
                <a:lnTo>
                  <a:pt x="3369" y="724"/>
                </a:lnTo>
                <a:lnTo>
                  <a:pt x="3371" y="723"/>
                </a:lnTo>
                <a:lnTo>
                  <a:pt x="3374" y="722"/>
                </a:lnTo>
                <a:lnTo>
                  <a:pt x="3376" y="722"/>
                </a:lnTo>
                <a:lnTo>
                  <a:pt x="3378" y="722"/>
                </a:lnTo>
                <a:lnTo>
                  <a:pt x="3380" y="722"/>
                </a:lnTo>
                <a:lnTo>
                  <a:pt x="3382" y="721"/>
                </a:lnTo>
                <a:lnTo>
                  <a:pt x="3384" y="722"/>
                </a:lnTo>
                <a:lnTo>
                  <a:pt x="3386" y="722"/>
                </a:lnTo>
                <a:lnTo>
                  <a:pt x="3388" y="723"/>
                </a:lnTo>
                <a:lnTo>
                  <a:pt x="3391" y="724"/>
                </a:lnTo>
                <a:lnTo>
                  <a:pt x="3393" y="724"/>
                </a:lnTo>
                <a:lnTo>
                  <a:pt x="3395" y="726"/>
                </a:lnTo>
                <a:lnTo>
                  <a:pt x="3397" y="727"/>
                </a:lnTo>
                <a:lnTo>
                  <a:pt x="3399" y="728"/>
                </a:lnTo>
                <a:lnTo>
                  <a:pt x="3402" y="729"/>
                </a:lnTo>
                <a:lnTo>
                  <a:pt x="3404" y="730"/>
                </a:lnTo>
                <a:lnTo>
                  <a:pt x="3405" y="730"/>
                </a:lnTo>
                <a:lnTo>
                  <a:pt x="3407" y="731"/>
                </a:lnTo>
                <a:lnTo>
                  <a:pt x="3410" y="731"/>
                </a:lnTo>
                <a:lnTo>
                  <a:pt x="3412" y="731"/>
                </a:lnTo>
                <a:lnTo>
                  <a:pt x="3414" y="731"/>
                </a:lnTo>
                <a:lnTo>
                  <a:pt x="3416" y="732"/>
                </a:lnTo>
                <a:lnTo>
                  <a:pt x="3418" y="732"/>
                </a:lnTo>
                <a:lnTo>
                  <a:pt x="3421" y="733"/>
                </a:lnTo>
                <a:lnTo>
                  <a:pt x="3423" y="733"/>
                </a:lnTo>
                <a:lnTo>
                  <a:pt x="3425" y="733"/>
                </a:lnTo>
                <a:lnTo>
                  <a:pt x="3427" y="734"/>
                </a:lnTo>
                <a:lnTo>
                  <a:pt x="3429" y="735"/>
                </a:lnTo>
                <a:lnTo>
                  <a:pt x="3431" y="735"/>
                </a:lnTo>
                <a:lnTo>
                  <a:pt x="3433" y="736"/>
                </a:lnTo>
                <a:lnTo>
                  <a:pt x="3435" y="737"/>
                </a:lnTo>
                <a:lnTo>
                  <a:pt x="3438" y="737"/>
                </a:lnTo>
                <a:lnTo>
                  <a:pt x="3440" y="738"/>
                </a:lnTo>
                <a:lnTo>
                  <a:pt x="3442" y="739"/>
                </a:lnTo>
                <a:lnTo>
                  <a:pt x="3444" y="739"/>
                </a:lnTo>
                <a:lnTo>
                  <a:pt x="3446" y="740"/>
                </a:lnTo>
                <a:lnTo>
                  <a:pt x="3448" y="740"/>
                </a:lnTo>
                <a:lnTo>
                  <a:pt x="3450" y="741"/>
                </a:lnTo>
                <a:lnTo>
                  <a:pt x="3452" y="741"/>
                </a:lnTo>
                <a:lnTo>
                  <a:pt x="3454" y="741"/>
                </a:lnTo>
                <a:lnTo>
                  <a:pt x="3457" y="740"/>
                </a:lnTo>
                <a:lnTo>
                  <a:pt x="3459" y="740"/>
                </a:lnTo>
                <a:lnTo>
                  <a:pt x="3461" y="740"/>
                </a:lnTo>
                <a:lnTo>
                  <a:pt x="3463" y="740"/>
                </a:lnTo>
                <a:lnTo>
                  <a:pt x="3465" y="740"/>
                </a:lnTo>
                <a:lnTo>
                  <a:pt x="3468" y="739"/>
                </a:lnTo>
                <a:lnTo>
                  <a:pt x="3470" y="739"/>
                </a:lnTo>
                <a:lnTo>
                  <a:pt x="3471" y="738"/>
                </a:lnTo>
                <a:lnTo>
                  <a:pt x="3474" y="737"/>
                </a:lnTo>
                <a:lnTo>
                  <a:pt x="3476" y="736"/>
                </a:lnTo>
                <a:lnTo>
                  <a:pt x="3478" y="735"/>
                </a:lnTo>
                <a:lnTo>
                  <a:pt x="3480" y="735"/>
                </a:lnTo>
                <a:lnTo>
                  <a:pt x="3482" y="734"/>
                </a:lnTo>
                <a:lnTo>
                  <a:pt x="3485" y="733"/>
                </a:lnTo>
                <a:lnTo>
                  <a:pt x="3487" y="733"/>
                </a:lnTo>
                <a:lnTo>
                  <a:pt x="3489" y="732"/>
                </a:lnTo>
                <a:lnTo>
                  <a:pt x="3491" y="731"/>
                </a:lnTo>
                <a:lnTo>
                  <a:pt x="3493" y="731"/>
                </a:lnTo>
                <a:lnTo>
                  <a:pt x="3495" y="731"/>
                </a:lnTo>
                <a:lnTo>
                  <a:pt x="3497" y="732"/>
                </a:lnTo>
                <a:lnTo>
                  <a:pt x="3499" y="732"/>
                </a:lnTo>
                <a:lnTo>
                  <a:pt x="3501" y="732"/>
                </a:lnTo>
                <a:lnTo>
                  <a:pt x="3504" y="732"/>
                </a:lnTo>
                <a:lnTo>
                  <a:pt x="3506" y="732"/>
                </a:lnTo>
                <a:lnTo>
                  <a:pt x="3508" y="732"/>
                </a:lnTo>
                <a:lnTo>
                  <a:pt x="3510" y="731"/>
                </a:lnTo>
                <a:lnTo>
                  <a:pt x="3513" y="731"/>
                </a:lnTo>
                <a:lnTo>
                  <a:pt x="3514" y="730"/>
                </a:lnTo>
                <a:lnTo>
                  <a:pt x="3516" y="729"/>
                </a:lnTo>
                <a:lnTo>
                  <a:pt x="3518" y="727"/>
                </a:lnTo>
                <a:lnTo>
                  <a:pt x="3521" y="726"/>
                </a:lnTo>
                <a:lnTo>
                  <a:pt x="3523" y="724"/>
                </a:lnTo>
                <a:lnTo>
                  <a:pt x="3525" y="722"/>
                </a:lnTo>
                <a:lnTo>
                  <a:pt x="3527" y="720"/>
                </a:lnTo>
                <a:lnTo>
                  <a:pt x="3529" y="719"/>
                </a:lnTo>
                <a:lnTo>
                  <a:pt x="3532" y="717"/>
                </a:lnTo>
                <a:lnTo>
                  <a:pt x="3534" y="716"/>
                </a:lnTo>
                <a:lnTo>
                  <a:pt x="3535" y="716"/>
                </a:lnTo>
                <a:lnTo>
                  <a:pt x="3538" y="715"/>
                </a:lnTo>
                <a:lnTo>
                  <a:pt x="3540" y="716"/>
                </a:lnTo>
                <a:lnTo>
                  <a:pt x="3542" y="717"/>
                </a:lnTo>
                <a:lnTo>
                  <a:pt x="3544" y="718"/>
                </a:lnTo>
                <a:lnTo>
                  <a:pt x="3546" y="720"/>
                </a:lnTo>
                <a:lnTo>
                  <a:pt x="3549" y="721"/>
                </a:lnTo>
                <a:lnTo>
                  <a:pt x="3551" y="724"/>
                </a:lnTo>
                <a:lnTo>
                  <a:pt x="3553" y="726"/>
                </a:lnTo>
                <a:lnTo>
                  <a:pt x="3555" y="728"/>
                </a:lnTo>
                <a:lnTo>
                  <a:pt x="3557" y="730"/>
                </a:lnTo>
                <a:lnTo>
                  <a:pt x="3559" y="732"/>
                </a:lnTo>
                <a:lnTo>
                  <a:pt x="3561" y="733"/>
                </a:lnTo>
                <a:lnTo>
                  <a:pt x="3563" y="735"/>
                </a:lnTo>
                <a:lnTo>
                  <a:pt x="3565" y="736"/>
                </a:lnTo>
                <a:lnTo>
                  <a:pt x="3568" y="737"/>
                </a:lnTo>
                <a:lnTo>
                  <a:pt x="3570" y="738"/>
                </a:lnTo>
                <a:lnTo>
                  <a:pt x="3572" y="738"/>
                </a:lnTo>
                <a:lnTo>
                  <a:pt x="3574" y="739"/>
                </a:lnTo>
                <a:lnTo>
                  <a:pt x="3576" y="739"/>
                </a:lnTo>
                <a:lnTo>
                  <a:pt x="3578" y="740"/>
                </a:lnTo>
                <a:lnTo>
                  <a:pt x="3580" y="740"/>
                </a:lnTo>
                <a:lnTo>
                  <a:pt x="3582" y="740"/>
                </a:lnTo>
                <a:lnTo>
                  <a:pt x="3585" y="740"/>
                </a:lnTo>
                <a:lnTo>
                  <a:pt x="3587" y="740"/>
                </a:lnTo>
                <a:lnTo>
                  <a:pt x="3589" y="740"/>
                </a:lnTo>
                <a:lnTo>
                  <a:pt x="3591" y="740"/>
                </a:lnTo>
                <a:lnTo>
                  <a:pt x="3593" y="740"/>
                </a:lnTo>
                <a:lnTo>
                  <a:pt x="3596" y="739"/>
                </a:lnTo>
                <a:lnTo>
                  <a:pt x="3598" y="739"/>
                </a:lnTo>
                <a:lnTo>
                  <a:pt x="3600" y="739"/>
                </a:lnTo>
                <a:lnTo>
                  <a:pt x="3601" y="739"/>
                </a:lnTo>
                <a:lnTo>
                  <a:pt x="3604" y="739"/>
                </a:lnTo>
                <a:lnTo>
                  <a:pt x="3606" y="738"/>
                </a:lnTo>
                <a:lnTo>
                  <a:pt x="3608" y="738"/>
                </a:lnTo>
                <a:lnTo>
                  <a:pt x="3610" y="737"/>
                </a:lnTo>
                <a:lnTo>
                  <a:pt x="3612" y="737"/>
                </a:lnTo>
                <a:lnTo>
                  <a:pt x="3615" y="736"/>
                </a:lnTo>
                <a:lnTo>
                  <a:pt x="3617" y="735"/>
                </a:lnTo>
                <a:lnTo>
                  <a:pt x="3619" y="733"/>
                </a:lnTo>
                <a:lnTo>
                  <a:pt x="3621" y="732"/>
                </a:lnTo>
                <a:lnTo>
                  <a:pt x="3623" y="731"/>
                </a:lnTo>
                <a:lnTo>
                  <a:pt x="3625" y="729"/>
                </a:lnTo>
                <a:lnTo>
                  <a:pt x="3627" y="727"/>
                </a:lnTo>
                <a:lnTo>
                  <a:pt x="3629" y="725"/>
                </a:lnTo>
                <a:lnTo>
                  <a:pt x="3632" y="723"/>
                </a:lnTo>
                <a:lnTo>
                  <a:pt x="3634" y="720"/>
                </a:lnTo>
                <a:lnTo>
                  <a:pt x="3636" y="717"/>
                </a:lnTo>
                <a:lnTo>
                  <a:pt x="3638" y="715"/>
                </a:lnTo>
                <a:lnTo>
                  <a:pt x="3640" y="713"/>
                </a:lnTo>
                <a:lnTo>
                  <a:pt x="3643" y="711"/>
                </a:lnTo>
                <a:lnTo>
                  <a:pt x="3644" y="710"/>
                </a:lnTo>
                <a:lnTo>
                  <a:pt x="3646" y="709"/>
                </a:lnTo>
                <a:lnTo>
                  <a:pt x="3648" y="709"/>
                </a:lnTo>
                <a:lnTo>
                  <a:pt x="3651" y="709"/>
                </a:lnTo>
                <a:lnTo>
                  <a:pt x="3653" y="709"/>
                </a:lnTo>
                <a:lnTo>
                  <a:pt x="3655" y="710"/>
                </a:lnTo>
                <a:lnTo>
                  <a:pt x="3657" y="711"/>
                </a:lnTo>
                <a:lnTo>
                  <a:pt x="3660" y="713"/>
                </a:lnTo>
                <a:lnTo>
                  <a:pt x="3662" y="715"/>
                </a:lnTo>
                <a:lnTo>
                  <a:pt x="3664" y="717"/>
                </a:lnTo>
                <a:lnTo>
                  <a:pt x="3665" y="719"/>
                </a:lnTo>
                <a:lnTo>
                  <a:pt x="3668" y="720"/>
                </a:lnTo>
                <a:lnTo>
                  <a:pt x="3670" y="721"/>
                </a:lnTo>
                <a:lnTo>
                  <a:pt x="3672" y="722"/>
                </a:lnTo>
                <a:lnTo>
                  <a:pt x="3674" y="722"/>
                </a:lnTo>
                <a:lnTo>
                  <a:pt x="3676" y="723"/>
                </a:lnTo>
                <a:lnTo>
                  <a:pt x="3679" y="723"/>
                </a:lnTo>
                <a:lnTo>
                  <a:pt x="3681" y="724"/>
                </a:lnTo>
                <a:lnTo>
                  <a:pt x="3683" y="724"/>
                </a:lnTo>
                <a:lnTo>
                  <a:pt x="3685" y="724"/>
                </a:lnTo>
                <a:lnTo>
                  <a:pt x="3687" y="724"/>
                </a:lnTo>
                <a:lnTo>
                  <a:pt x="3689" y="725"/>
                </a:lnTo>
                <a:lnTo>
                  <a:pt x="3691" y="725"/>
                </a:lnTo>
                <a:lnTo>
                  <a:pt x="3693" y="726"/>
                </a:lnTo>
                <a:lnTo>
                  <a:pt x="3696" y="726"/>
                </a:lnTo>
                <a:lnTo>
                  <a:pt x="3698" y="727"/>
                </a:lnTo>
                <a:lnTo>
                  <a:pt x="3700" y="728"/>
                </a:lnTo>
                <a:lnTo>
                  <a:pt x="3702" y="729"/>
                </a:lnTo>
                <a:lnTo>
                  <a:pt x="3704" y="730"/>
                </a:lnTo>
                <a:lnTo>
                  <a:pt x="3707" y="730"/>
                </a:lnTo>
                <a:lnTo>
                  <a:pt x="3708" y="730"/>
                </a:lnTo>
                <a:lnTo>
                  <a:pt x="3710" y="731"/>
                </a:lnTo>
                <a:lnTo>
                  <a:pt x="3712" y="731"/>
                </a:lnTo>
                <a:lnTo>
                  <a:pt x="3715" y="731"/>
                </a:lnTo>
                <a:lnTo>
                  <a:pt x="3717" y="731"/>
                </a:lnTo>
                <a:lnTo>
                  <a:pt x="3719" y="730"/>
                </a:lnTo>
                <a:lnTo>
                  <a:pt x="3721" y="730"/>
                </a:lnTo>
                <a:lnTo>
                  <a:pt x="3723" y="729"/>
                </a:lnTo>
                <a:lnTo>
                  <a:pt x="3726" y="728"/>
                </a:lnTo>
                <a:lnTo>
                  <a:pt x="3728" y="728"/>
                </a:lnTo>
                <a:lnTo>
                  <a:pt x="3730" y="727"/>
                </a:lnTo>
                <a:lnTo>
                  <a:pt x="3732" y="727"/>
                </a:lnTo>
                <a:lnTo>
                  <a:pt x="3734" y="726"/>
                </a:lnTo>
                <a:lnTo>
                  <a:pt x="3736" y="726"/>
                </a:lnTo>
                <a:lnTo>
                  <a:pt x="3738" y="727"/>
                </a:lnTo>
                <a:lnTo>
                  <a:pt x="3740" y="727"/>
                </a:lnTo>
                <a:lnTo>
                  <a:pt x="3743" y="728"/>
                </a:lnTo>
                <a:lnTo>
                  <a:pt x="3745" y="728"/>
                </a:lnTo>
                <a:lnTo>
                  <a:pt x="3747" y="730"/>
                </a:lnTo>
                <a:lnTo>
                  <a:pt x="3749" y="731"/>
                </a:lnTo>
                <a:lnTo>
                  <a:pt x="3751" y="732"/>
                </a:lnTo>
                <a:lnTo>
                  <a:pt x="3753" y="734"/>
                </a:lnTo>
                <a:lnTo>
                  <a:pt x="3755" y="735"/>
                </a:lnTo>
                <a:lnTo>
                  <a:pt x="3757" y="736"/>
                </a:lnTo>
                <a:lnTo>
                  <a:pt x="3759" y="737"/>
                </a:lnTo>
                <a:lnTo>
                  <a:pt x="3762" y="739"/>
                </a:lnTo>
                <a:lnTo>
                  <a:pt x="3764" y="739"/>
                </a:lnTo>
                <a:lnTo>
                  <a:pt x="3766" y="740"/>
                </a:lnTo>
                <a:lnTo>
                  <a:pt x="3768" y="741"/>
                </a:lnTo>
                <a:lnTo>
                  <a:pt x="3770" y="741"/>
                </a:lnTo>
                <a:lnTo>
                  <a:pt x="3773" y="742"/>
                </a:lnTo>
                <a:lnTo>
                  <a:pt x="3774" y="742"/>
                </a:lnTo>
                <a:lnTo>
                  <a:pt x="3776" y="743"/>
                </a:lnTo>
                <a:lnTo>
                  <a:pt x="3779" y="743"/>
                </a:lnTo>
                <a:lnTo>
                  <a:pt x="3781" y="743"/>
                </a:lnTo>
                <a:lnTo>
                  <a:pt x="3783" y="744"/>
                </a:lnTo>
                <a:lnTo>
                  <a:pt x="3787" y="744"/>
                </a:lnTo>
                <a:lnTo>
                  <a:pt x="3790" y="744"/>
                </a:lnTo>
                <a:lnTo>
                  <a:pt x="3792" y="744"/>
                </a:lnTo>
                <a:lnTo>
                  <a:pt x="3794" y="744"/>
                </a:lnTo>
                <a:lnTo>
                  <a:pt x="3795" y="743"/>
                </a:lnTo>
                <a:lnTo>
                  <a:pt x="3798" y="743"/>
                </a:lnTo>
                <a:lnTo>
                  <a:pt x="3800" y="742"/>
                </a:lnTo>
                <a:lnTo>
                  <a:pt x="3802" y="742"/>
                </a:lnTo>
                <a:lnTo>
                  <a:pt x="3804" y="742"/>
                </a:lnTo>
                <a:lnTo>
                  <a:pt x="3806" y="741"/>
                </a:lnTo>
                <a:lnTo>
                  <a:pt x="3809" y="740"/>
                </a:lnTo>
                <a:lnTo>
                  <a:pt x="3811" y="739"/>
                </a:lnTo>
                <a:lnTo>
                  <a:pt x="3813" y="739"/>
                </a:lnTo>
                <a:lnTo>
                  <a:pt x="3815" y="738"/>
                </a:lnTo>
                <a:lnTo>
                  <a:pt x="3817" y="737"/>
                </a:lnTo>
                <a:lnTo>
                  <a:pt x="3819" y="736"/>
                </a:lnTo>
                <a:lnTo>
                  <a:pt x="3821" y="736"/>
                </a:lnTo>
                <a:lnTo>
                  <a:pt x="3823" y="735"/>
                </a:lnTo>
                <a:lnTo>
                  <a:pt x="3826" y="735"/>
                </a:lnTo>
                <a:lnTo>
                  <a:pt x="3828" y="734"/>
                </a:lnTo>
                <a:lnTo>
                  <a:pt x="3830" y="734"/>
                </a:lnTo>
                <a:lnTo>
                  <a:pt x="3832" y="733"/>
                </a:lnTo>
                <a:lnTo>
                  <a:pt x="3834" y="733"/>
                </a:lnTo>
                <a:lnTo>
                  <a:pt x="3837" y="733"/>
                </a:lnTo>
                <a:lnTo>
                  <a:pt x="3839" y="732"/>
                </a:lnTo>
                <a:lnTo>
                  <a:pt x="3840" y="731"/>
                </a:lnTo>
                <a:lnTo>
                  <a:pt x="3843" y="730"/>
                </a:lnTo>
                <a:lnTo>
                  <a:pt x="3845" y="729"/>
                </a:lnTo>
                <a:lnTo>
                  <a:pt x="3847" y="728"/>
                </a:lnTo>
                <a:lnTo>
                  <a:pt x="3849" y="726"/>
                </a:lnTo>
                <a:lnTo>
                  <a:pt x="3851" y="724"/>
                </a:lnTo>
                <a:lnTo>
                  <a:pt x="3854" y="722"/>
                </a:lnTo>
                <a:lnTo>
                  <a:pt x="3856" y="720"/>
                </a:lnTo>
                <a:lnTo>
                  <a:pt x="3858" y="719"/>
                </a:lnTo>
                <a:lnTo>
                  <a:pt x="3860" y="719"/>
                </a:lnTo>
                <a:lnTo>
                  <a:pt x="3862" y="718"/>
                </a:lnTo>
                <a:lnTo>
                  <a:pt x="3864" y="718"/>
                </a:lnTo>
                <a:lnTo>
                  <a:pt x="3866" y="718"/>
                </a:lnTo>
                <a:lnTo>
                  <a:pt x="3868" y="718"/>
                </a:lnTo>
                <a:lnTo>
                  <a:pt x="3870" y="719"/>
                </a:lnTo>
                <a:lnTo>
                  <a:pt x="3873" y="720"/>
                </a:lnTo>
                <a:lnTo>
                  <a:pt x="3875" y="722"/>
                </a:lnTo>
                <a:lnTo>
                  <a:pt x="3877" y="724"/>
                </a:lnTo>
                <a:lnTo>
                  <a:pt x="3879" y="726"/>
                </a:lnTo>
                <a:lnTo>
                  <a:pt x="3881" y="727"/>
                </a:lnTo>
                <a:lnTo>
                  <a:pt x="3883" y="729"/>
                </a:lnTo>
                <a:lnTo>
                  <a:pt x="3885" y="730"/>
                </a:lnTo>
                <a:lnTo>
                  <a:pt x="3887" y="731"/>
                </a:lnTo>
                <a:lnTo>
                  <a:pt x="3890" y="733"/>
                </a:lnTo>
                <a:lnTo>
                  <a:pt x="3892" y="734"/>
                </a:lnTo>
                <a:lnTo>
                  <a:pt x="3894" y="735"/>
                </a:lnTo>
                <a:lnTo>
                  <a:pt x="3896" y="736"/>
                </a:lnTo>
                <a:lnTo>
                  <a:pt x="3898" y="737"/>
                </a:lnTo>
                <a:lnTo>
                  <a:pt x="3901" y="737"/>
                </a:lnTo>
                <a:lnTo>
                  <a:pt x="3903" y="738"/>
                </a:lnTo>
                <a:lnTo>
                  <a:pt x="3904" y="738"/>
                </a:lnTo>
                <a:lnTo>
                  <a:pt x="3906" y="739"/>
                </a:lnTo>
                <a:lnTo>
                  <a:pt x="3909" y="739"/>
                </a:lnTo>
                <a:lnTo>
                  <a:pt x="3911" y="739"/>
                </a:lnTo>
                <a:lnTo>
                  <a:pt x="3915" y="739"/>
                </a:lnTo>
                <a:lnTo>
                  <a:pt x="3917" y="739"/>
                </a:lnTo>
                <a:lnTo>
                  <a:pt x="3920" y="739"/>
                </a:lnTo>
                <a:lnTo>
                  <a:pt x="3922" y="738"/>
                </a:lnTo>
                <a:lnTo>
                  <a:pt x="3924" y="738"/>
                </a:lnTo>
                <a:lnTo>
                  <a:pt x="3926" y="738"/>
                </a:lnTo>
                <a:lnTo>
                  <a:pt x="3928" y="737"/>
                </a:lnTo>
                <a:lnTo>
                  <a:pt x="3930" y="737"/>
                </a:lnTo>
                <a:lnTo>
                  <a:pt x="3932" y="737"/>
                </a:lnTo>
                <a:lnTo>
                  <a:pt x="3934" y="737"/>
                </a:lnTo>
                <a:lnTo>
                  <a:pt x="3937" y="736"/>
                </a:lnTo>
                <a:lnTo>
                  <a:pt x="3939" y="736"/>
                </a:lnTo>
                <a:lnTo>
                  <a:pt x="3941" y="736"/>
                </a:lnTo>
                <a:lnTo>
                  <a:pt x="3943" y="735"/>
                </a:lnTo>
                <a:lnTo>
                  <a:pt x="3945" y="735"/>
                </a:lnTo>
                <a:lnTo>
                  <a:pt x="3947" y="735"/>
                </a:lnTo>
                <a:lnTo>
                  <a:pt x="3949" y="734"/>
                </a:lnTo>
                <a:lnTo>
                  <a:pt x="3951" y="733"/>
                </a:lnTo>
                <a:lnTo>
                  <a:pt x="3953" y="733"/>
                </a:lnTo>
                <a:lnTo>
                  <a:pt x="3956" y="731"/>
                </a:lnTo>
                <a:lnTo>
                  <a:pt x="3958" y="730"/>
                </a:lnTo>
                <a:lnTo>
                  <a:pt x="3960" y="729"/>
                </a:lnTo>
                <a:lnTo>
                  <a:pt x="3962" y="728"/>
                </a:lnTo>
                <a:lnTo>
                  <a:pt x="3965" y="726"/>
                </a:lnTo>
                <a:lnTo>
                  <a:pt x="3967" y="724"/>
                </a:lnTo>
                <a:lnTo>
                  <a:pt x="3969" y="723"/>
                </a:lnTo>
                <a:lnTo>
                  <a:pt x="3970" y="721"/>
                </a:lnTo>
                <a:lnTo>
                  <a:pt x="3973" y="720"/>
                </a:lnTo>
                <a:lnTo>
                  <a:pt x="3975" y="719"/>
                </a:lnTo>
                <a:lnTo>
                  <a:pt x="3977" y="717"/>
                </a:lnTo>
                <a:lnTo>
                  <a:pt x="3979" y="717"/>
                </a:lnTo>
                <a:lnTo>
                  <a:pt x="3981" y="717"/>
                </a:lnTo>
                <a:lnTo>
                  <a:pt x="3984" y="717"/>
                </a:lnTo>
                <a:lnTo>
                  <a:pt x="3986" y="717"/>
                </a:lnTo>
                <a:lnTo>
                  <a:pt x="3988" y="719"/>
                </a:lnTo>
                <a:lnTo>
                  <a:pt x="3990" y="720"/>
                </a:lnTo>
                <a:lnTo>
                  <a:pt x="3992" y="722"/>
                </a:lnTo>
                <a:lnTo>
                  <a:pt x="3994" y="724"/>
                </a:lnTo>
                <a:lnTo>
                  <a:pt x="3996" y="726"/>
                </a:lnTo>
                <a:lnTo>
                  <a:pt x="3998" y="728"/>
                </a:lnTo>
                <a:lnTo>
                  <a:pt x="4001" y="731"/>
                </a:lnTo>
                <a:lnTo>
                  <a:pt x="4003" y="733"/>
                </a:lnTo>
                <a:lnTo>
                  <a:pt x="4005" y="735"/>
                </a:lnTo>
                <a:lnTo>
                  <a:pt x="4007" y="736"/>
                </a:lnTo>
                <a:lnTo>
                  <a:pt x="4009" y="738"/>
                </a:lnTo>
                <a:lnTo>
                  <a:pt x="4012" y="739"/>
                </a:lnTo>
                <a:lnTo>
                  <a:pt x="4013" y="740"/>
                </a:lnTo>
                <a:lnTo>
                  <a:pt x="4015" y="740"/>
                </a:lnTo>
                <a:lnTo>
                  <a:pt x="4017" y="741"/>
                </a:lnTo>
                <a:lnTo>
                  <a:pt x="4020" y="741"/>
                </a:lnTo>
                <a:lnTo>
                  <a:pt x="4022" y="741"/>
                </a:lnTo>
                <a:lnTo>
                  <a:pt x="4024" y="741"/>
                </a:lnTo>
                <a:lnTo>
                  <a:pt x="4026" y="741"/>
                </a:lnTo>
                <a:lnTo>
                  <a:pt x="4028" y="741"/>
                </a:lnTo>
                <a:lnTo>
                  <a:pt x="4031" y="740"/>
                </a:lnTo>
                <a:lnTo>
                  <a:pt x="4033" y="740"/>
                </a:lnTo>
                <a:lnTo>
                  <a:pt x="4034" y="740"/>
                </a:lnTo>
                <a:lnTo>
                  <a:pt x="4037" y="740"/>
                </a:lnTo>
                <a:lnTo>
                  <a:pt x="4039" y="740"/>
                </a:lnTo>
                <a:lnTo>
                  <a:pt x="4043" y="740"/>
                </a:lnTo>
                <a:lnTo>
                  <a:pt x="4045" y="740"/>
                </a:lnTo>
                <a:lnTo>
                  <a:pt x="4048" y="740"/>
                </a:lnTo>
                <a:lnTo>
                  <a:pt x="4050" y="740"/>
                </a:lnTo>
                <a:lnTo>
                  <a:pt x="4052" y="740"/>
                </a:lnTo>
                <a:lnTo>
                  <a:pt x="4054" y="740"/>
                </a:lnTo>
                <a:lnTo>
                  <a:pt x="4056" y="740"/>
                </a:lnTo>
                <a:lnTo>
                  <a:pt x="4058" y="740"/>
                </a:lnTo>
                <a:lnTo>
                  <a:pt x="4060" y="740"/>
                </a:lnTo>
                <a:lnTo>
                  <a:pt x="4062" y="740"/>
                </a:lnTo>
                <a:lnTo>
                  <a:pt x="4064" y="740"/>
                </a:lnTo>
                <a:lnTo>
                  <a:pt x="4067" y="739"/>
                </a:lnTo>
                <a:lnTo>
                  <a:pt x="4069" y="739"/>
                </a:lnTo>
                <a:lnTo>
                  <a:pt x="4071" y="739"/>
                </a:lnTo>
                <a:lnTo>
                  <a:pt x="4073" y="739"/>
                </a:lnTo>
                <a:lnTo>
                  <a:pt x="4075" y="739"/>
                </a:lnTo>
                <a:lnTo>
                  <a:pt x="4077" y="739"/>
                </a:lnTo>
                <a:lnTo>
                  <a:pt x="4079" y="739"/>
                </a:lnTo>
                <a:lnTo>
                  <a:pt x="4081" y="739"/>
                </a:lnTo>
                <a:lnTo>
                  <a:pt x="4084" y="739"/>
                </a:lnTo>
                <a:lnTo>
                  <a:pt x="4086" y="739"/>
                </a:lnTo>
                <a:lnTo>
                  <a:pt x="4088" y="739"/>
                </a:lnTo>
                <a:lnTo>
                  <a:pt x="4090" y="739"/>
                </a:lnTo>
                <a:lnTo>
                  <a:pt x="4095" y="739"/>
                </a:lnTo>
                <a:lnTo>
                  <a:pt x="4097" y="739"/>
                </a:lnTo>
                <a:lnTo>
                  <a:pt x="4099" y="739"/>
                </a:lnTo>
                <a:lnTo>
                  <a:pt x="4100" y="740"/>
                </a:lnTo>
                <a:lnTo>
                  <a:pt x="4103" y="740"/>
                </a:lnTo>
                <a:lnTo>
                  <a:pt x="4105" y="740"/>
                </a:lnTo>
                <a:lnTo>
                  <a:pt x="4107" y="740"/>
                </a:lnTo>
                <a:lnTo>
                  <a:pt x="4109" y="740"/>
                </a:lnTo>
                <a:lnTo>
                  <a:pt x="4111" y="741"/>
                </a:lnTo>
                <a:lnTo>
                  <a:pt x="4114" y="741"/>
                </a:lnTo>
                <a:lnTo>
                  <a:pt x="4116" y="741"/>
                </a:lnTo>
                <a:lnTo>
                  <a:pt x="4118" y="741"/>
                </a:lnTo>
                <a:lnTo>
                  <a:pt x="4120" y="740"/>
                </a:lnTo>
                <a:lnTo>
                  <a:pt x="4122" y="740"/>
                </a:lnTo>
                <a:lnTo>
                  <a:pt x="4124" y="740"/>
                </a:lnTo>
                <a:lnTo>
                  <a:pt x="4126" y="739"/>
                </a:lnTo>
                <a:lnTo>
                  <a:pt x="4128" y="739"/>
                </a:lnTo>
                <a:lnTo>
                  <a:pt x="4131" y="739"/>
                </a:lnTo>
                <a:lnTo>
                  <a:pt x="4133" y="738"/>
                </a:lnTo>
                <a:lnTo>
                  <a:pt x="4135" y="738"/>
                </a:lnTo>
                <a:lnTo>
                  <a:pt x="4137" y="737"/>
                </a:lnTo>
                <a:lnTo>
                  <a:pt x="4139" y="736"/>
                </a:lnTo>
                <a:lnTo>
                  <a:pt x="4142" y="735"/>
                </a:lnTo>
                <a:lnTo>
                  <a:pt x="4143" y="734"/>
                </a:lnTo>
                <a:lnTo>
                  <a:pt x="4145" y="733"/>
                </a:lnTo>
                <a:lnTo>
                  <a:pt x="4148" y="732"/>
                </a:lnTo>
                <a:lnTo>
                  <a:pt x="4150" y="731"/>
                </a:lnTo>
                <a:lnTo>
                  <a:pt x="4152" y="730"/>
                </a:lnTo>
                <a:lnTo>
                  <a:pt x="4154" y="729"/>
                </a:lnTo>
                <a:lnTo>
                  <a:pt x="4156" y="728"/>
                </a:lnTo>
                <a:lnTo>
                  <a:pt x="4159" y="727"/>
                </a:lnTo>
                <a:lnTo>
                  <a:pt x="4161" y="726"/>
                </a:lnTo>
                <a:lnTo>
                  <a:pt x="4163" y="726"/>
                </a:lnTo>
                <a:lnTo>
                  <a:pt x="4164" y="726"/>
                </a:lnTo>
                <a:lnTo>
                  <a:pt x="4167" y="725"/>
                </a:lnTo>
                <a:lnTo>
                  <a:pt x="4169" y="726"/>
                </a:lnTo>
                <a:lnTo>
                  <a:pt x="4171" y="726"/>
                </a:lnTo>
                <a:lnTo>
                  <a:pt x="4173" y="726"/>
                </a:lnTo>
                <a:lnTo>
                  <a:pt x="4175" y="726"/>
                </a:lnTo>
                <a:lnTo>
                  <a:pt x="4178" y="727"/>
                </a:lnTo>
                <a:lnTo>
                  <a:pt x="4180" y="727"/>
                </a:lnTo>
                <a:lnTo>
                  <a:pt x="4182" y="728"/>
                </a:lnTo>
                <a:lnTo>
                  <a:pt x="4184" y="728"/>
                </a:lnTo>
                <a:lnTo>
                  <a:pt x="4186" y="728"/>
                </a:lnTo>
                <a:lnTo>
                  <a:pt x="4188" y="729"/>
                </a:lnTo>
                <a:lnTo>
                  <a:pt x="4190" y="730"/>
                </a:lnTo>
                <a:lnTo>
                  <a:pt x="4192" y="730"/>
                </a:lnTo>
                <a:lnTo>
                  <a:pt x="4195" y="731"/>
                </a:lnTo>
                <a:lnTo>
                  <a:pt x="4197" y="732"/>
                </a:lnTo>
                <a:lnTo>
                  <a:pt x="4199" y="733"/>
                </a:lnTo>
                <a:lnTo>
                  <a:pt x="4201" y="734"/>
                </a:lnTo>
                <a:lnTo>
                  <a:pt x="4203" y="735"/>
                </a:lnTo>
                <a:lnTo>
                  <a:pt x="4206" y="736"/>
                </a:lnTo>
                <a:lnTo>
                  <a:pt x="4207" y="737"/>
                </a:lnTo>
                <a:lnTo>
                  <a:pt x="4209" y="738"/>
                </a:lnTo>
                <a:lnTo>
                  <a:pt x="4211" y="739"/>
                </a:lnTo>
                <a:lnTo>
                  <a:pt x="4214" y="740"/>
                </a:lnTo>
                <a:lnTo>
                  <a:pt x="4216" y="740"/>
                </a:lnTo>
                <a:lnTo>
                  <a:pt x="4218" y="741"/>
                </a:lnTo>
                <a:lnTo>
                  <a:pt x="4220" y="741"/>
                </a:lnTo>
                <a:lnTo>
                  <a:pt x="4222" y="742"/>
                </a:lnTo>
                <a:lnTo>
                  <a:pt x="4225" y="742"/>
                </a:lnTo>
                <a:lnTo>
                  <a:pt x="4227" y="743"/>
                </a:lnTo>
                <a:lnTo>
                  <a:pt x="4229" y="743"/>
                </a:lnTo>
                <a:lnTo>
                  <a:pt x="4231" y="743"/>
                </a:lnTo>
                <a:lnTo>
                  <a:pt x="4233" y="743"/>
                </a:lnTo>
                <a:lnTo>
                  <a:pt x="4235" y="743"/>
                </a:lnTo>
                <a:lnTo>
                  <a:pt x="4237" y="743"/>
                </a:lnTo>
                <a:lnTo>
                  <a:pt x="4239" y="743"/>
                </a:lnTo>
                <a:lnTo>
                  <a:pt x="4242" y="743"/>
                </a:lnTo>
                <a:lnTo>
                  <a:pt x="4244" y="743"/>
                </a:lnTo>
                <a:lnTo>
                  <a:pt x="4246" y="743"/>
                </a:lnTo>
                <a:lnTo>
                  <a:pt x="4248" y="743"/>
                </a:lnTo>
                <a:lnTo>
                  <a:pt x="4250" y="743"/>
                </a:lnTo>
                <a:lnTo>
                  <a:pt x="4252" y="743"/>
                </a:lnTo>
                <a:lnTo>
                  <a:pt x="4254" y="743"/>
                </a:lnTo>
                <a:lnTo>
                  <a:pt x="4256" y="743"/>
                </a:lnTo>
                <a:lnTo>
                  <a:pt x="4258" y="743"/>
                </a:lnTo>
                <a:lnTo>
                  <a:pt x="4261" y="742"/>
                </a:lnTo>
                <a:lnTo>
                  <a:pt x="4263" y="742"/>
                </a:lnTo>
                <a:lnTo>
                  <a:pt x="4265" y="742"/>
                </a:lnTo>
                <a:lnTo>
                  <a:pt x="4267" y="741"/>
                </a:lnTo>
                <a:lnTo>
                  <a:pt x="4270" y="740"/>
                </a:lnTo>
                <a:lnTo>
                  <a:pt x="4272" y="739"/>
                </a:lnTo>
                <a:lnTo>
                  <a:pt x="4273" y="737"/>
                </a:lnTo>
                <a:lnTo>
                  <a:pt x="4275" y="736"/>
                </a:lnTo>
                <a:lnTo>
                  <a:pt x="4278" y="734"/>
                </a:lnTo>
                <a:lnTo>
                  <a:pt x="4280" y="732"/>
                </a:lnTo>
                <a:lnTo>
                  <a:pt x="4282" y="730"/>
                </a:lnTo>
                <a:lnTo>
                  <a:pt x="4284" y="728"/>
                </a:lnTo>
                <a:lnTo>
                  <a:pt x="4286" y="726"/>
                </a:lnTo>
                <a:lnTo>
                  <a:pt x="4289" y="724"/>
                </a:lnTo>
                <a:lnTo>
                  <a:pt x="4291" y="722"/>
                </a:lnTo>
                <a:lnTo>
                  <a:pt x="4293" y="721"/>
                </a:lnTo>
                <a:lnTo>
                  <a:pt x="4294" y="720"/>
                </a:lnTo>
                <a:lnTo>
                  <a:pt x="4297" y="720"/>
                </a:lnTo>
                <a:lnTo>
                  <a:pt x="4299" y="720"/>
                </a:lnTo>
                <a:lnTo>
                  <a:pt x="4301" y="721"/>
                </a:lnTo>
                <a:lnTo>
                  <a:pt x="4303" y="722"/>
                </a:lnTo>
                <a:lnTo>
                  <a:pt x="4306" y="723"/>
                </a:lnTo>
                <a:lnTo>
                  <a:pt x="4308" y="725"/>
                </a:lnTo>
                <a:lnTo>
                  <a:pt x="4310" y="727"/>
                </a:lnTo>
                <a:lnTo>
                  <a:pt x="4312" y="728"/>
                </a:lnTo>
                <a:lnTo>
                  <a:pt x="4314" y="730"/>
                </a:lnTo>
                <a:lnTo>
                  <a:pt x="4316" y="732"/>
                </a:lnTo>
                <a:lnTo>
                  <a:pt x="4318" y="733"/>
                </a:lnTo>
                <a:lnTo>
                  <a:pt x="4320" y="735"/>
                </a:lnTo>
                <a:lnTo>
                  <a:pt x="4322" y="736"/>
                </a:lnTo>
                <a:lnTo>
                  <a:pt x="4325" y="737"/>
                </a:lnTo>
                <a:lnTo>
                  <a:pt x="4327" y="738"/>
                </a:lnTo>
                <a:lnTo>
                  <a:pt x="4329" y="739"/>
                </a:lnTo>
                <a:lnTo>
                  <a:pt x="4331" y="739"/>
                </a:lnTo>
                <a:lnTo>
                  <a:pt x="4333" y="740"/>
                </a:lnTo>
                <a:lnTo>
                  <a:pt x="4336" y="740"/>
                </a:lnTo>
                <a:lnTo>
                  <a:pt x="4337" y="740"/>
                </a:lnTo>
                <a:lnTo>
                  <a:pt x="4339" y="740"/>
                </a:lnTo>
                <a:lnTo>
                  <a:pt x="4342" y="740"/>
                </a:lnTo>
                <a:lnTo>
                  <a:pt x="4344" y="740"/>
                </a:lnTo>
                <a:lnTo>
                  <a:pt x="4348" y="740"/>
                </a:lnTo>
                <a:lnTo>
                  <a:pt x="4350" y="741"/>
                </a:lnTo>
                <a:lnTo>
                  <a:pt x="4353" y="741"/>
                </a:lnTo>
                <a:lnTo>
                  <a:pt x="4355" y="741"/>
                </a:lnTo>
                <a:lnTo>
                  <a:pt x="4357" y="741"/>
                </a:lnTo>
                <a:lnTo>
                  <a:pt x="4361" y="741"/>
                </a:lnTo>
                <a:lnTo>
                  <a:pt x="4363" y="741"/>
                </a:lnTo>
                <a:lnTo>
                  <a:pt x="4365" y="741"/>
                </a:lnTo>
                <a:lnTo>
                  <a:pt x="4367" y="741"/>
                </a:lnTo>
                <a:lnTo>
                  <a:pt x="4369" y="741"/>
                </a:lnTo>
                <a:lnTo>
                  <a:pt x="4374" y="741"/>
                </a:lnTo>
                <a:lnTo>
                  <a:pt x="4376" y="741"/>
                </a:lnTo>
                <a:lnTo>
                  <a:pt x="4378" y="741"/>
                </a:lnTo>
                <a:lnTo>
                  <a:pt x="4380" y="741"/>
                </a:lnTo>
                <a:lnTo>
                  <a:pt x="4382" y="741"/>
                </a:lnTo>
                <a:lnTo>
                  <a:pt x="4384" y="741"/>
                </a:lnTo>
                <a:lnTo>
                  <a:pt x="4386" y="742"/>
                </a:lnTo>
                <a:lnTo>
                  <a:pt x="4389" y="742"/>
                </a:lnTo>
                <a:lnTo>
                  <a:pt x="4391" y="742"/>
                </a:lnTo>
                <a:lnTo>
                  <a:pt x="4393" y="742"/>
                </a:lnTo>
                <a:lnTo>
                  <a:pt x="4395" y="742"/>
                </a:lnTo>
                <a:lnTo>
                  <a:pt x="4397" y="742"/>
                </a:lnTo>
                <a:lnTo>
                  <a:pt x="4400" y="742"/>
                </a:lnTo>
                <a:lnTo>
                  <a:pt x="4402" y="742"/>
                </a:lnTo>
                <a:lnTo>
                  <a:pt x="4403" y="742"/>
                </a:lnTo>
                <a:lnTo>
                  <a:pt x="4405" y="742"/>
                </a:lnTo>
                <a:lnTo>
                  <a:pt x="4408" y="742"/>
                </a:lnTo>
                <a:lnTo>
                  <a:pt x="4410" y="741"/>
                </a:lnTo>
                <a:lnTo>
                  <a:pt x="4412" y="741"/>
                </a:lnTo>
                <a:lnTo>
                  <a:pt x="4414" y="741"/>
                </a:lnTo>
                <a:lnTo>
                  <a:pt x="4416" y="741"/>
                </a:lnTo>
                <a:lnTo>
                  <a:pt x="4419" y="741"/>
                </a:lnTo>
                <a:lnTo>
                  <a:pt x="4421" y="741"/>
                </a:lnTo>
                <a:lnTo>
                  <a:pt x="4423" y="741"/>
                </a:lnTo>
                <a:lnTo>
                  <a:pt x="4425" y="741"/>
                </a:lnTo>
                <a:lnTo>
                  <a:pt x="4427" y="741"/>
                </a:lnTo>
                <a:lnTo>
                  <a:pt x="4429" y="741"/>
                </a:lnTo>
                <a:lnTo>
                  <a:pt x="4431" y="742"/>
                </a:lnTo>
                <a:lnTo>
                  <a:pt x="4433" y="742"/>
                </a:lnTo>
                <a:lnTo>
                  <a:pt x="4436" y="742"/>
                </a:lnTo>
                <a:lnTo>
                  <a:pt x="4438" y="743"/>
                </a:lnTo>
                <a:lnTo>
                  <a:pt x="4440" y="743"/>
                </a:lnTo>
                <a:lnTo>
                  <a:pt x="4442" y="742"/>
                </a:lnTo>
                <a:lnTo>
                  <a:pt x="4444" y="742"/>
                </a:lnTo>
                <a:lnTo>
                  <a:pt x="4446" y="742"/>
                </a:lnTo>
                <a:lnTo>
                  <a:pt x="4448" y="741"/>
                </a:lnTo>
                <a:lnTo>
                  <a:pt x="4450" y="740"/>
                </a:lnTo>
                <a:lnTo>
                  <a:pt x="4453" y="739"/>
                </a:lnTo>
                <a:lnTo>
                  <a:pt x="4455" y="738"/>
                </a:lnTo>
                <a:lnTo>
                  <a:pt x="4457" y="737"/>
                </a:lnTo>
                <a:lnTo>
                  <a:pt x="4459" y="735"/>
                </a:lnTo>
                <a:lnTo>
                  <a:pt x="4461" y="733"/>
                </a:lnTo>
                <a:lnTo>
                  <a:pt x="4464" y="731"/>
                </a:lnTo>
                <a:lnTo>
                  <a:pt x="4466" y="730"/>
                </a:lnTo>
                <a:lnTo>
                  <a:pt x="4467" y="728"/>
                </a:lnTo>
                <a:lnTo>
                  <a:pt x="4469" y="728"/>
                </a:lnTo>
                <a:lnTo>
                  <a:pt x="4472" y="727"/>
                </a:lnTo>
                <a:lnTo>
                  <a:pt x="4474" y="727"/>
                </a:lnTo>
                <a:lnTo>
                  <a:pt x="4476" y="727"/>
                </a:lnTo>
                <a:lnTo>
                  <a:pt x="4478" y="728"/>
                </a:lnTo>
                <a:lnTo>
                  <a:pt x="4480" y="729"/>
                </a:lnTo>
                <a:lnTo>
                  <a:pt x="4483" y="730"/>
                </a:lnTo>
                <a:lnTo>
                  <a:pt x="4485" y="731"/>
                </a:lnTo>
                <a:lnTo>
                  <a:pt x="4487" y="733"/>
                </a:lnTo>
                <a:lnTo>
                  <a:pt x="4489" y="734"/>
                </a:lnTo>
                <a:lnTo>
                  <a:pt x="4491" y="735"/>
                </a:lnTo>
                <a:lnTo>
                  <a:pt x="4493" y="737"/>
                </a:lnTo>
                <a:lnTo>
                  <a:pt x="4495" y="738"/>
                </a:lnTo>
                <a:lnTo>
                  <a:pt x="4497" y="739"/>
                </a:lnTo>
                <a:lnTo>
                  <a:pt x="4500" y="739"/>
                </a:lnTo>
                <a:lnTo>
                  <a:pt x="4502" y="740"/>
                </a:lnTo>
                <a:lnTo>
                  <a:pt x="4504" y="740"/>
                </a:lnTo>
                <a:lnTo>
                  <a:pt x="4506" y="741"/>
                </a:lnTo>
                <a:lnTo>
                  <a:pt x="4508" y="741"/>
                </a:lnTo>
                <a:lnTo>
                  <a:pt x="4511" y="741"/>
                </a:lnTo>
                <a:lnTo>
                  <a:pt x="4512" y="741"/>
                </a:lnTo>
                <a:lnTo>
                  <a:pt x="4514" y="742"/>
                </a:lnTo>
                <a:lnTo>
                  <a:pt x="4516" y="742"/>
                </a:lnTo>
                <a:lnTo>
                  <a:pt x="4519" y="742"/>
                </a:lnTo>
                <a:lnTo>
                  <a:pt x="4521" y="742"/>
                </a:lnTo>
                <a:lnTo>
                  <a:pt x="4523" y="742"/>
                </a:lnTo>
                <a:lnTo>
                  <a:pt x="4527" y="742"/>
                </a:lnTo>
                <a:lnTo>
                  <a:pt x="4530" y="742"/>
                </a:lnTo>
                <a:lnTo>
                  <a:pt x="4532" y="742"/>
                </a:lnTo>
                <a:lnTo>
                  <a:pt x="4533" y="743"/>
                </a:lnTo>
                <a:lnTo>
                  <a:pt x="4536" y="743"/>
                </a:lnTo>
                <a:lnTo>
                  <a:pt x="4538" y="743"/>
                </a:lnTo>
                <a:lnTo>
                  <a:pt x="4540" y="744"/>
                </a:lnTo>
                <a:lnTo>
                  <a:pt x="4542" y="744"/>
                </a:lnTo>
                <a:lnTo>
                  <a:pt x="4544" y="744"/>
                </a:lnTo>
                <a:lnTo>
                  <a:pt x="4547" y="744"/>
                </a:lnTo>
                <a:lnTo>
                  <a:pt x="4549" y="744"/>
                </a:lnTo>
                <a:lnTo>
                  <a:pt x="4551" y="744"/>
                </a:lnTo>
                <a:lnTo>
                  <a:pt x="4553" y="744"/>
                </a:lnTo>
                <a:lnTo>
                  <a:pt x="4555" y="744"/>
                </a:lnTo>
                <a:lnTo>
                  <a:pt x="4557" y="744"/>
                </a:lnTo>
                <a:lnTo>
                  <a:pt x="4559" y="744"/>
                </a:lnTo>
                <a:lnTo>
                  <a:pt x="4561" y="744"/>
                </a:lnTo>
                <a:lnTo>
                  <a:pt x="4563" y="744"/>
                </a:lnTo>
                <a:lnTo>
                  <a:pt x="4566" y="744"/>
                </a:lnTo>
                <a:lnTo>
                  <a:pt x="4568" y="743"/>
                </a:lnTo>
                <a:lnTo>
                  <a:pt x="4570" y="743"/>
                </a:lnTo>
                <a:lnTo>
                  <a:pt x="4572" y="743"/>
                </a:lnTo>
                <a:lnTo>
                  <a:pt x="4575" y="742"/>
                </a:lnTo>
                <a:lnTo>
                  <a:pt x="4576" y="742"/>
                </a:lnTo>
                <a:lnTo>
                  <a:pt x="4578" y="742"/>
                </a:lnTo>
                <a:lnTo>
                  <a:pt x="4580" y="742"/>
                </a:lnTo>
                <a:lnTo>
                  <a:pt x="4583" y="741"/>
                </a:lnTo>
                <a:lnTo>
                  <a:pt x="4585" y="741"/>
                </a:lnTo>
                <a:lnTo>
                  <a:pt x="4587" y="740"/>
                </a:lnTo>
                <a:lnTo>
                  <a:pt x="4589" y="739"/>
                </a:lnTo>
                <a:lnTo>
                  <a:pt x="4591" y="739"/>
                </a:lnTo>
                <a:lnTo>
                  <a:pt x="4594" y="738"/>
                </a:lnTo>
                <a:lnTo>
                  <a:pt x="4596" y="738"/>
                </a:lnTo>
                <a:lnTo>
                  <a:pt x="4597" y="738"/>
                </a:lnTo>
                <a:lnTo>
                  <a:pt x="4599" y="737"/>
                </a:lnTo>
                <a:lnTo>
                  <a:pt x="4602" y="737"/>
                </a:lnTo>
                <a:lnTo>
                  <a:pt x="4604" y="737"/>
                </a:lnTo>
                <a:lnTo>
                  <a:pt x="4606" y="737"/>
                </a:lnTo>
                <a:lnTo>
                  <a:pt x="4608" y="738"/>
                </a:lnTo>
                <a:lnTo>
                  <a:pt x="4611" y="738"/>
                </a:lnTo>
                <a:lnTo>
                  <a:pt x="4613" y="739"/>
                </a:lnTo>
                <a:lnTo>
                  <a:pt x="4615" y="739"/>
                </a:lnTo>
                <a:lnTo>
                  <a:pt x="4617" y="740"/>
                </a:lnTo>
                <a:lnTo>
                  <a:pt x="4619" y="740"/>
                </a:lnTo>
                <a:lnTo>
                  <a:pt x="4621" y="741"/>
                </a:lnTo>
                <a:lnTo>
                  <a:pt x="4623" y="741"/>
                </a:lnTo>
                <a:lnTo>
                  <a:pt x="4625" y="741"/>
                </a:lnTo>
                <a:lnTo>
                  <a:pt x="4627" y="742"/>
                </a:lnTo>
                <a:lnTo>
                  <a:pt x="4630" y="742"/>
                </a:lnTo>
                <a:lnTo>
                  <a:pt x="4632" y="742"/>
                </a:lnTo>
                <a:lnTo>
                  <a:pt x="4634" y="743"/>
                </a:lnTo>
                <a:lnTo>
                  <a:pt x="4636" y="743"/>
                </a:lnTo>
                <a:lnTo>
                  <a:pt x="4638" y="743"/>
                </a:lnTo>
                <a:lnTo>
                  <a:pt x="4641" y="744"/>
                </a:lnTo>
                <a:lnTo>
                  <a:pt x="4642" y="744"/>
                </a:lnTo>
                <a:lnTo>
                  <a:pt x="4644" y="744"/>
                </a:lnTo>
                <a:lnTo>
                  <a:pt x="4647" y="744"/>
                </a:lnTo>
                <a:lnTo>
                  <a:pt x="4649" y="744"/>
                </a:lnTo>
                <a:lnTo>
                  <a:pt x="4651" y="744"/>
                </a:lnTo>
                <a:lnTo>
                  <a:pt x="4653" y="745"/>
                </a:lnTo>
                <a:lnTo>
                  <a:pt x="4655" y="745"/>
                </a:lnTo>
                <a:lnTo>
                  <a:pt x="4658" y="745"/>
                </a:lnTo>
                <a:lnTo>
                  <a:pt x="4660" y="745"/>
                </a:lnTo>
                <a:lnTo>
                  <a:pt x="4662" y="745"/>
                </a:lnTo>
                <a:lnTo>
                  <a:pt x="4663" y="745"/>
                </a:lnTo>
                <a:lnTo>
                  <a:pt x="4666" y="745"/>
                </a:lnTo>
                <a:lnTo>
                  <a:pt x="4668" y="745"/>
                </a:lnTo>
                <a:lnTo>
                  <a:pt x="4670" y="745"/>
                </a:lnTo>
                <a:lnTo>
                  <a:pt x="4672" y="745"/>
                </a:lnTo>
                <a:lnTo>
                  <a:pt x="4674" y="744"/>
                </a:lnTo>
                <a:lnTo>
                  <a:pt x="4677" y="744"/>
                </a:lnTo>
                <a:lnTo>
                  <a:pt x="4679" y="744"/>
                </a:lnTo>
                <a:lnTo>
                  <a:pt x="4681" y="744"/>
                </a:lnTo>
                <a:lnTo>
                  <a:pt x="4683" y="744"/>
                </a:lnTo>
                <a:lnTo>
                  <a:pt x="4685" y="744"/>
                </a:lnTo>
                <a:lnTo>
                  <a:pt x="4687" y="744"/>
                </a:lnTo>
                <a:lnTo>
                  <a:pt x="4689" y="744"/>
                </a:lnTo>
                <a:lnTo>
                  <a:pt x="4694" y="744"/>
                </a:lnTo>
                <a:lnTo>
                  <a:pt x="4696" y="744"/>
                </a:lnTo>
                <a:lnTo>
                  <a:pt x="4698" y="743"/>
                </a:lnTo>
                <a:lnTo>
                  <a:pt x="4700" y="743"/>
                </a:lnTo>
                <a:lnTo>
                  <a:pt x="4702" y="742"/>
                </a:lnTo>
                <a:lnTo>
                  <a:pt x="4705" y="742"/>
                </a:lnTo>
                <a:lnTo>
                  <a:pt x="4706" y="742"/>
                </a:lnTo>
                <a:lnTo>
                  <a:pt x="4708" y="742"/>
                </a:lnTo>
                <a:lnTo>
                  <a:pt x="4710" y="742"/>
                </a:lnTo>
                <a:lnTo>
                  <a:pt x="4713" y="742"/>
                </a:lnTo>
                <a:lnTo>
                  <a:pt x="4715" y="742"/>
                </a:lnTo>
                <a:lnTo>
                  <a:pt x="4719" y="742"/>
                </a:lnTo>
                <a:lnTo>
                  <a:pt x="4721" y="742"/>
                </a:lnTo>
                <a:lnTo>
                  <a:pt x="4724" y="742"/>
                </a:lnTo>
                <a:lnTo>
                  <a:pt x="4726" y="742"/>
                </a:lnTo>
                <a:lnTo>
                  <a:pt x="4727" y="742"/>
                </a:lnTo>
                <a:lnTo>
                  <a:pt x="4730" y="743"/>
                </a:lnTo>
                <a:lnTo>
                  <a:pt x="4732" y="743"/>
                </a:lnTo>
                <a:lnTo>
                  <a:pt x="4734" y="744"/>
                </a:lnTo>
                <a:lnTo>
                  <a:pt x="4736" y="744"/>
                </a:lnTo>
                <a:lnTo>
                  <a:pt x="4738" y="744"/>
                </a:lnTo>
                <a:lnTo>
                  <a:pt x="4741" y="744"/>
                </a:lnTo>
                <a:lnTo>
                  <a:pt x="4743" y="743"/>
                </a:lnTo>
                <a:lnTo>
                  <a:pt x="4745" y="743"/>
                </a:lnTo>
                <a:lnTo>
                  <a:pt x="4747" y="743"/>
                </a:lnTo>
                <a:lnTo>
                  <a:pt x="4749" y="743"/>
                </a:lnTo>
                <a:lnTo>
                  <a:pt x="4751" y="742"/>
                </a:lnTo>
                <a:lnTo>
                  <a:pt x="4753" y="742"/>
                </a:lnTo>
                <a:lnTo>
                  <a:pt x="4758" y="742"/>
                </a:lnTo>
                <a:lnTo>
                  <a:pt x="4760" y="742"/>
                </a:lnTo>
                <a:lnTo>
                  <a:pt x="4762" y="743"/>
                </a:lnTo>
                <a:lnTo>
                  <a:pt x="4764" y="743"/>
                </a:lnTo>
                <a:lnTo>
                  <a:pt x="4766" y="743"/>
                </a:lnTo>
                <a:lnTo>
                  <a:pt x="4769" y="743"/>
                </a:lnTo>
                <a:lnTo>
                  <a:pt x="4771" y="744"/>
                </a:lnTo>
                <a:lnTo>
                  <a:pt x="4772" y="744"/>
                </a:lnTo>
                <a:lnTo>
                  <a:pt x="4774" y="744"/>
                </a:lnTo>
                <a:lnTo>
                  <a:pt x="4777" y="744"/>
                </a:lnTo>
                <a:lnTo>
                  <a:pt x="4779" y="744"/>
                </a:lnTo>
                <a:lnTo>
                  <a:pt x="4783" y="744"/>
                </a:lnTo>
                <a:lnTo>
                  <a:pt x="4785" y="744"/>
                </a:lnTo>
                <a:lnTo>
                  <a:pt x="4788" y="744"/>
                </a:lnTo>
                <a:lnTo>
                  <a:pt x="4790" y="744"/>
                </a:lnTo>
                <a:lnTo>
                  <a:pt x="4792" y="744"/>
                </a:lnTo>
                <a:lnTo>
                  <a:pt x="4794" y="744"/>
                </a:lnTo>
                <a:lnTo>
                  <a:pt x="4796" y="744"/>
                </a:lnTo>
                <a:lnTo>
                  <a:pt x="4798" y="744"/>
                </a:lnTo>
                <a:lnTo>
                  <a:pt x="4800" y="744"/>
                </a:lnTo>
                <a:lnTo>
                  <a:pt x="4802" y="744"/>
                </a:lnTo>
                <a:lnTo>
                  <a:pt x="4805" y="744"/>
                </a:lnTo>
                <a:lnTo>
                  <a:pt x="4809" y="744"/>
                </a:lnTo>
                <a:lnTo>
                  <a:pt x="4811" y="744"/>
                </a:lnTo>
                <a:lnTo>
                  <a:pt x="4813" y="744"/>
                </a:lnTo>
                <a:lnTo>
                  <a:pt x="4815" y="744"/>
                </a:lnTo>
                <a:lnTo>
                  <a:pt x="4817" y="744"/>
                </a:lnTo>
                <a:lnTo>
                  <a:pt x="4819" y="744"/>
                </a:lnTo>
                <a:lnTo>
                  <a:pt x="4821" y="744"/>
                </a:lnTo>
                <a:lnTo>
                  <a:pt x="4824" y="744"/>
                </a:lnTo>
                <a:lnTo>
                  <a:pt x="4826" y="744"/>
                </a:lnTo>
                <a:lnTo>
                  <a:pt x="4828" y="744"/>
                </a:lnTo>
                <a:lnTo>
                  <a:pt x="4830" y="744"/>
                </a:lnTo>
                <a:lnTo>
                  <a:pt x="4832" y="744"/>
                </a:lnTo>
                <a:lnTo>
                  <a:pt x="4835" y="745"/>
                </a:lnTo>
                <a:lnTo>
                  <a:pt x="4836" y="745"/>
                </a:lnTo>
                <a:lnTo>
                  <a:pt x="4838" y="745"/>
                </a:lnTo>
                <a:lnTo>
                  <a:pt x="4841" y="745"/>
                </a:lnTo>
                <a:lnTo>
                  <a:pt x="4843" y="745"/>
                </a:lnTo>
                <a:lnTo>
                  <a:pt x="4847" y="745"/>
                </a:lnTo>
                <a:lnTo>
                  <a:pt x="4849" y="745"/>
                </a:lnTo>
                <a:lnTo>
                  <a:pt x="4852" y="745"/>
                </a:lnTo>
                <a:lnTo>
                  <a:pt x="4854" y="745"/>
                </a:lnTo>
                <a:lnTo>
                  <a:pt x="4856" y="745"/>
                </a:lnTo>
                <a:lnTo>
                  <a:pt x="4857" y="745"/>
                </a:lnTo>
                <a:lnTo>
                  <a:pt x="4860" y="745"/>
                </a:lnTo>
                <a:lnTo>
                  <a:pt x="4862" y="745"/>
                </a:lnTo>
                <a:lnTo>
                  <a:pt x="4864" y="745"/>
                </a:lnTo>
                <a:lnTo>
                  <a:pt x="4866" y="745"/>
                </a:lnTo>
                <a:lnTo>
                  <a:pt x="4868" y="745"/>
                </a:lnTo>
                <a:lnTo>
                  <a:pt x="4871" y="745"/>
                </a:lnTo>
                <a:lnTo>
                  <a:pt x="4873" y="746"/>
                </a:lnTo>
                <a:lnTo>
                  <a:pt x="4875" y="746"/>
                </a:lnTo>
                <a:lnTo>
                  <a:pt x="4877" y="746"/>
                </a:lnTo>
                <a:lnTo>
                  <a:pt x="4880" y="746"/>
                </a:lnTo>
                <a:lnTo>
                  <a:pt x="4881" y="746"/>
                </a:lnTo>
                <a:lnTo>
                  <a:pt x="4883" y="746"/>
                </a:lnTo>
                <a:lnTo>
                  <a:pt x="4885" y="746"/>
                </a:lnTo>
                <a:lnTo>
                  <a:pt x="4888" y="746"/>
                </a:lnTo>
                <a:lnTo>
                  <a:pt x="4890" y="746"/>
                </a:lnTo>
                <a:lnTo>
                  <a:pt x="4892" y="746"/>
                </a:lnTo>
                <a:lnTo>
                  <a:pt x="4894" y="746"/>
                </a:lnTo>
                <a:lnTo>
                  <a:pt x="4899" y="746"/>
                </a:lnTo>
                <a:lnTo>
                  <a:pt x="4901" y="746"/>
                </a:lnTo>
                <a:lnTo>
                  <a:pt x="4902" y="746"/>
                </a:lnTo>
                <a:lnTo>
                  <a:pt x="4904" y="745"/>
                </a:lnTo>
                <a:lnTo>
                  <a:pt x="4907" y="745"/>
                </a:lnTo>
                <a:lnTo>
                  <a:pt x="4909" y="745"/>
                </a:lnTo>
                <a:lnTo>
                  <a:pt x="4911" y="744"/>
                </a:lnTo>
                <a:lnTo>
                  <a:pt x="4913" y="744"/>
                </a:lnTo>
                <a:lnTo>
                  <a:pt x="4916" y="744"/>
                </a:lnTo>
                <a:lnTo>
                  <a:pt x="4918" y="743"/>
                </a:lnTo>
                <a:lnTo>
                  <a:pt x="4920" y="743"/>
                </a:lnTo>
                <a:lnTo>
                  <a:pt x="4922" y="743"/>
                </a:lnTo>
                <a:lnTo>
                  <a:pt x="4924" y="743"/>
                </a:lnTo>
                <a:lnTo>
                  <a:pt x="4926" y="743"/>
                </a:lnTo>
                <a:lnTo>
                  <a:pt x="4928" y="743"/>
                </a:lnTo>
                <a:lnTo>
                  <a:pt x="4930" y="743"/>
                </a:lnTo>
                <a:lnTo>
                  <a:pt x="4932" y="743"/>
                </a:lnTo>
                <a:lnTo>
                  <a:pt x="4935" y="743"/>
                </a:lnTo>
                <a:lnTo>
                  <a:pt x="4937" y="743"/>
                </a:lnTo>
                <a:lnTo>
                  <a:pt x="4939" y="743"/>
                </a:lnTo>
                <a:lnTo>
                  <a:pt x="4941" y="743"/>
                </a:lnTo>
                <a:lnTo>
                  <a:pt x="4943" y="743"/>
                </a:lnTo>
                <a:lnTo>
                  <a:pt x="4945" y="743"/>
                </a:lnTo>
                <a:lnTo>
                  <a:pt x="4947" y="743"/>
                </a:lnTo>
                <a:lnTo>
                  <a:pt x="4949" y="743"/>
                </a:lnTo>
                <a:lnTo>
                  <a:pt x="4952" y="743"/>
                </a:lnTo>
                <a:lnTo>
                  <a:pt x="4954" y="743"/>
                </a:lnTo>
                <a:lnTo>
                  <a:pt x="4956" y="743"/>
                </a:lnTo>
                <a:lnTo>
                  <a:pt x="4958" y="743"/>
                </a:lnTo>
                <a:lnTo>
                  <a:pt x="4963" y="743"/>
                </a:lnTo>
                <a:lnTo>
                  <a:pt x="4965" y="743"/>
                </a:lnTo>
                <a:lnTo>
                  <a:pt x="4966" y="743"/>
                </a:lnTo>
                <a:lnTo>
                  <a:pt x="4968" y="743"/>
                </a:lnTo>
                <a:lnTo>
                  <a:pt x="4971" y="743"/>
                </a:lnTo>
                <a:lnTo>
                  <a:pt x="4975" y="742"/>
                </a:lnTo>
                <a:lnTo>
                  <a:pt x="4977" y="742"/>
                </a:lnTo>
                <a:lnTo>
                  <a:pt x="4979" y="742"/>
                </a:lnTo>
                <a:lnTo>
                  <a:pt x="4982" y="742"/>
                </a:lnTo>
                <a:lnTo>
                  <a:pt x="4984" y="742"/>
                </a:lnTo>
                <a:lnTo>
                  <a:pt x="4988" y="743"/>
                </a:lnTo>
                <a:lnTo>
                  <a:pt x="4990" y="743"/>
                </a:lnTo>
                <a:lnTo>
                  <a:pt x="4992" y="743"/>
                </a:lnTo>
                <a:lnTo>
                  <a:pt x="4994" y="743"/>
                </a:lnTo>
                <a:lnTo>
                  <a:pt x="4996" y="743"/>
                </a:lnTo>
                <a:lnTo>
                  <a:pt x="4999" y="743"/>
                </a:lnTo>
                <a:lnTo>
                  <a:pt x="5001" y="743"/>
                </a:lnTo>
                <a:lnTo>
                  <a:pt x="5003" y="743"/>
                </a:lnTo>
                <a:lnTo>
                  <a:pt x="5005" y="744"/>
                </a:lnTo>
                <a:lnTo>
                  <a:pt x="5007" y="744"/>
                </a:lnTo>
                <a:lnTo>
                  <a:pt x="5010" y="744"/>
                </a:lnTo>
                <a:lnTo>
                  <a:pt x="5011" y="744"/>
                </a:lnTo>
                <a:lnTo>
                  <a:pt x="5013" y="744"/>
                </a:lnTo>
                <a:lnTo>
                  <a:pt x="5015" y="744"/>
                </a:lnTo>
                <a:lnTo>
                  <a:pt x="5018" y="744"/>
                </a:lnTo>
                <a:lnTo>
                  <a:pt x="5020" y="745"/>
                </a:lnTo>
                <a:lnTo>
                  <a:pt x="5022" y="745"/>
                </a:lnTo>
                <a:lnTo>
                  <a:pt x="5024" y="745"/>
                </a:lnTo>
                <a:lnTo>
                  <a:pt x="5026" y="745"/>
                </a:lnTo>
                <a:lnTo>
                  <a:pt x="5029" y="745"/>
                </a:lnTo>
                <a:lnTo>
                  <a:pt x="5031" y="745"/>
                </a:lnTo>
                <a:lnTo>
                  <a:pt x="5032" y="745"/>
                </a:lnTo>
                <a:lnTo>
                  <a:pt x="5035" y="745"/>
                </a:lnTo>
                <a:lnTo>
                  <a:pt x="5037" y="746"/>
                </a:lnTo>
                <a:lnTo>
                  <a:pt x="5039" y="746"/>
                </a:lnTo>
                <a:lnTo>
                  <a:pt x="5041" y="746"/>
                </a:lnTo>
                <a:lnTo>
                  <a:pt x="5043" y="746"/>
                </a:lnTo>
                <a:lnTo>
                  <a:pt x="5046" y="747"/>
                </a:lnTo>
                <a:lnTo>
                  <a:pt x="5048" y="747"/>
                </a:lnTo>
                <a:lnTo>
                  <a:pt x="5050" y="747"/>
                </a:lnTo>
                <a:lnTo>
                  <a:pt x="5052" y="747"/>
                </a:lnTo>
                <a:lnTo>
                  <a:pt x="5054" y="747"/>
                </a:lnTo>
                <a:lnTo>
                  <a:pt x="5056" y="748"/>
                </a:lnTo>
                <a:lnTo>
                  <a:pt x="5058" y="748"/>
                </a:lnTo>
                <a:lnTo>
                  <a:pt x="5060" y="748"/>
                </a:lnTo>
                <a:lnTo>
                  <a:pt x="5065" y="748"/>
                </a:lnTo>
                <a:lnTo>
                  <a:pt x="5067" y="747"/>
                </a:lnTo>
                <a:lnTo>
                  <a:pt x="5069" y="747"/>
                </a:lnTo>
                <a:lnTo>
                  <a:pt x="5071" y="747"/>
                </a:lnTo>
                <a:lnTo>
                  <a:pt x="5074" y="747"/>
                </a:lnTo>
                <a:lnTo>
                  <a:pt x="5075" y="746"/>
                </a:lnTo>
                <a:lnTo>
                  <a:pt x="5077" y="746"/>
                </a:lnTo>
                <a:lnTo>
                  <a:pt x="5079" y="746"/>
                </a:lnTo>
                <a:lnTo>
                  <a:pt x="5082" y="745"/>
                </a:lnTo>
                <a:lnTo>
                  <a:pt x="5084" y="744"/>
                </a:lnTo>
                <a:lnTo>
                  <a:pt x="5086" y="744"/>
                </a:lnTo>
                <a:lnTo>
                  <a:pt x="5088" y="743"/>
                </a:lnTo>
                <a:lnTo>
                  <a:pt x="5090" y="743"/>
                </a:lnTo>
                <a:lnTo>
                  <a:pt x="5093" y="742"/>
                </a:lnTo>
                <a:lnTo>
                  <a:pt x="5095" y="742"/>
                </a:lnTo>
                <a:lnTo>
                  <a:pt x="5096" y="742"/>
                </a:lnTo>
                <a:lnTo>
                  <a:pt x="5099" y="742"/>
                </a:lnTo>
                <a:lnTo>
                  <a:pt x="5101" y="742"/>
                </a:lnTo>
                <a:lnTo>
                  <a:pt x="5103" y="742"/>
                </a:lnTo>
                <a:lnTo>
                  <a:pt x="5105" y="742"/>
                </a:lnTo>
                <a:lnTo>
                  <a:pt x="5107" y="742"/>
                </a:lnTo>
                <a:lnTo>
                  <a:pt x="5110" y="742"/>
                </a:lnTo>
                <a:lnTo>
                  <a:pt x="5112" y="742"/>
                </a:lnTo>
                <a:lnTo>
                  <a:pt x="5116" y="742"/>
                </a:lnTo>
                <a:lnTo>
                  <a:pt x="5118" y="743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/>
          </a:p>
        </p:txBody>
      </p:sp>
      <p:sp>
        <p:nvSpPr>
          <p:cNvPr id="65" name="Freeform 324"/>
          <p:cNvSpPr>
            <a:spLocks/>
          </p:cNvSpPr>
          <p:nvPr/>
        </p:nvSpPr>
        <p:spPr bwMode="auto">
          <a:xfrm>
            <a:off x="674769" y="1018591"/>
            <a:ext cx="8124825" cy="1187450"/>
          </a:xfrm>
          <a:custGeom>
            <a:avLst/>
            <a:gdLst>
              <a:gd name="T0" fmla="*/ 77 w 5118"/>
              <a:gd name="T1" fmla="*/ 440 h 748"/>
              <a:gd name="T2" fmla="*/ 155 w 5118"/>
              <a:gd name="T3" fmla="*/ 415 h 748"/>
              <a:gd name="T4" fmla="*/ 235 w 5118"/>
              <a:gd name="T5" fmla="*/ 599 h 748"/>
              <a:gd name="T6" fmla="*/ 313 w 5118"/>
              <a:gd name="T7" fmla="*/ 624 h 748"/>
              <a:gd name="T8" fmla="*/ 392 w 5118"/>
              <a:gd name="T9" fmla="*/ 589 h 748"/>
              <a:gd name="T10" fmla="*/ 471 w 5118"/>
              <a:gd name="T11" fmla="*/ 671 h 748"/>
              <a:gd name="T12" fmla="*/ 552 w 5118"/>
              <a:gd name="T13" fmla="*/ 673 h 748"/>
              <a:gd name="T14" fmla="*/ 633 w 5118"/>
              <a:gd name="T15" fmla="*/ 687 h 748"/>
              <a:gd name="T16" fmla="*/ 712 w 5118"/>
              <a:gd name="T17" fmla="*/ 668 h 748"/>
              <a:gd name="T18" fmla="*/ 791 w 5118"/>
              <a:gd name="T19" fmla="*/ 685 h 748"/>
              <a:gd name="T20" fmla="*/ 870 w 5118"/>
              <a:gd name="T21" fmla="*/ 698 h 748"/>
              <a:gd name="T22" fmla="*/ 949 w 5118"/>
              <a:gd name="T23" fmla="*/ 702 h 748"/>
              <a:gd name="T24" fmla="*/ 1028 w 5118"/>
              <a:gd name="T25" fmla="*/ 661 h 748"/>
              <a:gd name="T26" fmla="*/ 1109 w 5118"/>
              <a:gd name="T27" fmla="*/ 706 h 748"/>
              <a:gd name="T28" fmla="*/ 1190 w 5118"/>
              <a:gd name="T29" fmla="*/ 718 h 748"/>
              <a:gd name="T30" fmla="*/ 1275 w 5118"/>
              <a:gd name="T31" fmla="*/ 720 h 748"/>
              <a:gd name="T32" fmla="*/ 1354 w 5118"/>
              <a:gd name="T33" fmla="*/ 436 h 748"/>
              <a:gd name="T34" fmla="*/ 1433 w 5118"/>
              <a:gd name="T35" fmla="*/ 709 h 748"/>
              <a:gd name="T36" fmla="*/ 1514 w 5118"/>
              <a:gd name="T37" fmla="*/ 716 h 748"/>
              <a:gd name="T38" fmla="*/ 1597 w 5118"/>
              <a:gd name="T39" fmla="*/ 723 h 748"/>
              <a:gd name="T40" fmla="*/ 1676 w 5118"/>
              <a:gd name="T41" fmla="*/ 724 h 748"/>
              <a:gd name="T42" fmla="*/ 1757 w 5118"/>
              <a:gd name="T43" fmla="*/ 726 h 748"/>
              <a:gd name="T44" fmla="*/ 1836 w 5118"/>
              <a:gd name="T45" fmla="*/ 584 h 748"/>
              <a:gd name="T46" fmla="*/ 1915 w 5118"/>
              <a:gd name="T47" fmla="*/ 720 h 748"/>
              <a:gd name="T48" fmla="*/ 1994 w 5118"/>
              <a:gd name="T49" fmla="*/ 731 h 748"/>
              <a:gd name="T50" fmla="*/ 2073 w 5118"/>
              <a:gd name="T51" fmla="*/ 686 h 748"/>
              <a:gd name="T52" fmla="*/ 2154 w 5118"/>
              <a:gd name="T53" fmla="*/ 730 h 748"/>
              <a:gd name="T54" fmla="*/ 2234 w 5118"/>
              <a:gd name="T55" fmla="*/ 720 h 748"/>
              <a:gd name="T56" fmla="*/ 2314 w 5118"/>
              <a:gd name="T57" fmla="*/ 331 h 748"/>
              <a:gd name="T58" fmla="*/ 2392 w 5118"/>
              <a:gd name="T59" fmla="*/ 719 h 748"/>
              <a:gd name="T60" fmla="*/ 2472 w 5118"/>
              <a:gd name="T61" fmla="*/ 723 h 748"/>
              <a:gd name="T62" fmla="*/ 2550 w 5118"/>
              <a:gd name="T63" fmla="*/ 713 h 748"/>
              <a:gd name="T64" fmla="*/ 2629 w 5118"/>
              <a:gd name="T65" fmla="*/ 711 h 748"/>
              <a:gd name="T66" fmla="*/ 2708 w 5118"/>
              <a:gd name="T67" fmla="*/ 295 h 748"/>
              <a:gd name="T68" fmla="*/ 2787 w 5118"/>
              <a:gd name="T69" fmla="*/ 717 h 748"/>
              <a:gd name="T70" fmla="*/ 2866 w 5118"/>
              <a:gd name="T71" fmla="*/ 734 h 748"/>
              <a:gd name="T72" fmla="*/ 2945 w 5118"/>
              <a:gd name="T73" fmla="*/ 736 h 748"/>
              <a:gd name="T74" fmla="*/ 3024 w 5118"/>
              <a:gd name="T75" fmla="*/ 727 h 748"/>
              <a:gd name="T76" fmla="*/ 3102 w 5118"/>
              <a:gd name="T77" fmla="*/ 728 h 748"/>
              <a:gd name="T78" fmla="*/ 3184 w 5118"/>
              <a:gd name="T79" fmla="*/ 734 h 748"/>
              <a:gd name="T80" fmla="*/ 3267 w 5118"/>
              <a:gd name="T81" fmla="*/ 736 h 748"/>
              <a:gd name="T82" fmla="*/ 3350 w 5118"/>
              <a:gd name="T83" fmla="*/ 734 h 748"/>
              <a:gd name="T84" fmla="*/ 3431 w 5118"/>
              <a:gd name="T85" fmla="*/ 738 h 748"/>
              <a:gd name="T86" fmla="*/ 3514 w 5118"/>
              <a:gd name="T87" fmla="*/ 727 h 748"/>
              <a:gd name="T88" fmla="*/ 3596 w 5118"/>
              <a:gd name="T89" fmla="*/ 737 h 748"/>
              <a:gd name="T90" fmla="*/ 3674 w 5118"/>
              <a:gd name="T91" fmla="*/ 734 h 748"/>
              <a:gd name="T92" fmla="*/ 3753 w 5118"/>
              <a:gd name="T93" fmla="*/ 738 h 748"/>
              <a:gd name="T94" fmla="*/ 3837 w 5118"/>
              <a:gd name="T95" fmla="*/ 738 h 748"/>
              <a:gd name="T96" fmla="*/ 3920 w 5118"/>
              <a:gd name="T97" fmla="*/ 737 h 748"/>
              <a:gd name="T98" fmla="*/ 4001 w 5118"/>
              <a:gd name="T99" fmla="*/ 741 h 748"/>
              <a:gd name="T100" fmla="*/ 4081 w 5118"/>
              <a:gd name="T101" fmla="*/ 742 h 748"/>
              <a:gd name="T102" fmla="*/ 4164 w 5118"/>
              <a:gd name="T103" fmla="*/ 738 h 748"/>
              <a:gd name="T104" fmla="*/ 4248 w 5118"/>
              <a:gd name="T105" fmla="*/ 743 h 748"/>
              <a:gd name="T106" fmla="*/ 4327 w 5118"/>
              <a:gd name="T107" fmla="*/ 743 h 748"/>
              <a:gd name="T108" fmla="*/ 4405 w 5118"/>
              <a:gd name="T109" fmla="*/ 740 h 748"/>
              <a:gd name="T110" fmla="*/ 4487 w 5118"/>
              <a:gd name="T111" fmla="*/ 738 h 748"/>
              <a:gd name="T112" fmla="*/ 4568 w 5118"/>
              <a:gd name="T113" fmla="*/ 745 h 748"/>
              <a:gd name="T114" fmla="*/ 4651 w 5118"/>
              <a:gd name="T115" fmla="*/ 745 h 748"/>
              <a:gd name="T116" fmla="*/ 4734 w 5118"/>
              <a:gd name="T117" fmla="*/ 746 h 748"/>
              <a:gd name="T118" fmla="*/ 4821 w 5118"/>
              <a:gd name="T119" fmla="*/ 745 h 748"/>
              <a:gd name="T120" fmla="*/ 4907 w 5118"/>
              <a:gd name="T121" fmla="*/ 746 h 748"/>
              <a:gd name="T122" fmla="*/ 5001 w 5118"/>
              <a:gd name="T123" fmla="*/ 746 h 748"/>
              <a:gd name="T124" fmla="*/ 5086 w 5118"/>
              <a:gd name="T125" fmla="*/ 747 h 7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5118" h="748">
                <a:moveTo>
                  <a:pt x="0" y="0"/>
                </a:moveTo>
                <a:lnTo>
                  <a:pt x="2" y="40"/>
                </a:lnTo>
                <a:lnTo>
                  <a:pt x="4" y="68"/>
                </a:lnTo>
                <a:lnTo>
                  <a:pt x="6" y="93"/>
                </a:lnTo>
                <a:lnTo>
                  <a:pt x="8" y="120"/>
                </a:lnTo>
                <a:lnTo>
                  <a:pt x="11" y="151"/>
                </a:lnTo>
                <a:lnTo>
                  <a:pt x="13" y="186"/>
                </a:lnTo>
                <a:lnTo>
                  <a:pt x="15" y="224"/>
                </a:lnTo>
                <a:lnTo>
                  <a:pt x="17" y="262"/>
                </a:lnTo>
                <a:lnTo>
                  <a:pt x="19" y="298"/>
                </a:lnTo>
                <a:lnTo>
                  <a:pt x="22" y="329"/>
                </a:lnTo>
                <a:lnTo>
                  <a:pt x="23" y="354"/>
                </a:lnTo>
                <a:lnTo>
                  <a:pt x="25" y="372"/>
                </a:lnTo>
                <a:lnTo>
                  <a:pt x="27" y="384"/>
                </a:lnTo>
                <a:lnTo>
                  <a:pt x="30" y="392"/>
                </a:lnTo>
                <a:lnTo>
                  <a:pt x="32" y="397"/>
                </a:lnTo>
                <a:lnTo>
                  <a:pt x="34" y="400"/>
                </a:lnTo>
                <a:lnTo>
                  <a:pt x="36" y="403"/>
                </a:lnTo>
                <a:lnTo>
                  <a:pt x="38" y="405"/>
                </a:lnTo>
                <a:lnTo>
                  <a:pt x="41" y="407"/>
                </a:lnTo>
                <a:lnTo>
                  <a:pt x="43" y="409"/>
                </a:lnTo>
                <a:lnTo>
                  <a:pt x="44" y="413"/>
                </a:lnTo>
                <a:lnTo>
                  <a:pt x="47" y="415"/>
                </a:lnTo>
                <a:lnTo>
                  <a:pt x="49" y="418"/>
                </a:lnTo>
                <a:lnTo>
                  <a:pt x="51" y="422"/>
                </a:lnTo>
                <a:lnTo>
                  <a:pt x="53" y="426"/>
                </a:lnTo>
                <a:lnTo>
                  <a:pt x="55" y="431"/>
                </a:lnTo>
                <a:lnTo>
                  <a:pt x="58" y="435"/>
                </a:lnTo>
                <a:lnTo>
                  <a:pt x="60" y="440"/>
                </a:lnTo>
                <a:lnTo>
                  <a:pt x="62" y="444"/>
                </a:lnTo>
                <a:lnTo>
                  <a:pt x="64" y="446"/>
                </a:lnTo>
                <a:lnTo>
                  <a:pt x="66" y="448"/>
                </a:lnTo>
                <a:lnTo>
                  <a:pt x="68" y="448"/>
                </a:lnTo>
                <a:lnTo>
                  <a:pt x="70" y="447"/>
                </a:lnTo>
                <a:lnTo>
                  <a:pt x="72" y="445"/>
                </a:lnTo>
                <a:lnTo>
                  <a:pt x="74" y="443"/>
                </a:lnTo>
                <a:lnTo>
                  <a:pt x="77" y="440"/>
                </a:lnTo>
                <a:lnTo>
                  <a:pt x="79" y="435"/>
                </a:lnTo>
                <a:lnTo>
                  <a:pt x="81" y="430"/>
                </a:lnTo>
                <a:lnTo>
                  <a:pt x="83" y="423"/>
                </a:lnTo>
                <a:lnTo>
                  <a:pt x="85" y="416"/>
                </a:lnTo>
                <a:lnTo>
                  <a:pt x="87" y="409"/>
                </a:lnTo>
                <a:lnTo>
                  <a:pt x="89" y="405"/>
                </a:lnTo>
                <a:lnTo>
                  <a:pt x="91" y="403"/>
                </a:lnTo>
                <a:lnTo>
                  <a:pt x="94" y="404"/>
                </a:lnTo>
                <a:lnTo>
                  <a:pt x="96" y="408"/>
                </a:lnTo>
                <a:lnTo>
                  <a:pt x="98" y="415"/>
                </a:lnTo>
                <a:lnTo>
                  <a:pt x="100" y="423"/>
                </a:lnTo>
                <a:lnTo>
                  <a:pt x="102" y="434"/>
                </a:lnTo>
                <a:lnTo>
                  <a:pt x="105" y="445"/>
                </a:lnTo>
                <a:lnTo>
                  <a:pt x="107" y="458"/>
                </a:lnTo>
                <a:lnTo>
                  <a:pt x="108" y="470"/>
                </a:lnTo>
                <a:lnTo>
                  <a:pt x="110" y="482"/>
                </a:lnTo>
                <a:lnTo>
                  <a:pt x="113" y="493"/>
                </a:lnTo>
                <a:lnTo>
                  <a:pt x="115" y="503"/>
                </a:lnTo>
                <a:lnTo>
                  <a:pt x="117" y="511"/>
                </a:lnTo>
                <a:lnTo>
                  <a:pt x="119" y="518"/>
                </a:lnTo>
                <a:lnTo>
                  <a:pt x="121" y="524"/>
                </a:lnTo>
                <a:lnTo>
                  <a:pt x="124" y="528"/>
                </a:lnTo>
                <a:lnTo>
                  <a:pt x="126" y="532"/>
                </a:lnTo>
                <a:lnTo>
                  <a:pt x="128" y="534"/>
                </a:lnTo>
                <a:lnTo>
                  <a:pt x="130" y="535"/>
                </a:lnTo>
                <a:lnTo>
                  <a:pt x="132" y="534"/>
                </a:lnTo>
                <a:lnTo>
                  <a:pt x="134" y="529"/>
                </a:lnTo>
                <a:lnTo>
                  <a:pt x="136" y="521"/>
                </a:lnTo>
                <a:lnTo>
                  <a:pt x="138" y="509"/>
                </a:lnTo>
                <a:lnTo>
                  <a:pt x="141" y="494"/>
                </a:lnTo>
                <a:lnTo>
                  <a:pt x="143" y="478"/>
                </a:lnTo>
                <a:lnTo>
                  <a:pt x="145" y="461"/>
                </a:lnTo>
                <a:lnTo>
                  <a:pt x="147" y="446"/>
                </a:lnTo>
                <a:lnTo>
                  <a:pt x="149" y="434"/>
                </a:lnTo>
                <a:lnTo>
                  <a:pt x="152" y="425"/>
                </a:lnTo>
                <a:lnTo>
                  <a:pt x="153" y="419"/>
                </a:lnTo>
                <a:lnTo>
                  <a:pt x="155" y="415"/>
                </a:lnTo>
                <a:lnTo>
                  <a:pt x="157" y="412"/>
                </a:lnTo>
                <a:lnTo>
                  <a:pt x="160" y="411"/>
                </a:lnTo>
                <a:lnTo>
                  <a:pt x="162" y="411"/>
                </a:lnTo>
                <a:lnTo>
                  <a:pt x="164" y="412"/>
                </a:lnTo>
                <a:lnTo>
                  <a:pt x="166" y="415"/>
                </a:lnTo>
                <a:lnTo>
                  <a:pt x="169" y="422"/>
                </a:lnTo>
                <a:lnTo>
                  <a:pt x="171" y="431"/>
                </a:lnTo>
                <a:lnTo>
                  <a:pt x="173" y="443"/>
                </a:lnTo>
                <a:lnTo>
                  <a:pt x="174" y="458"/>
                </a:lnTo>
                <a:lnTo>
                  <a:pt x="177" y="474"/>
                </a:lnTo>
                <a:lnTo>
                  <a:pt x="179" y="491"/>
                </a:lnTo>
                <a:lnTo>
                  <a:pt x="181" y="506"/>
                </a:lnTo>
                <a:lnTo>
                  <a:pt x="183" y="519"/>
                </a:lnTo>
                <a:lnTo>
                  <a:pt x="185" y="531"/>
                </a:lnTo>
                <a:lnTo>
                  <a:pt x="188" y="541"/>
                </a:lnTo>
                <a:lnTo>
                  <a:pt x="190" y="548"/>
                </a:lnTo>
                <a:lnTo>
                  <a:pt x="192" y="554"/>
                </a:lnTo>
                <a:lnTo>
                  <a:pt x="194" y="558"/>
                </a:lnTo>
                <a:lnTo>
                  <a:pt x="196" y="562"/>
                </a:lnTo>
                <a:lnTo>
                  <a:pt x="198" y="565"/>
                </a:lnTo>
                <a:lnTo>
                  <a:pt x="200" y="567"/>
                </a:lnTo>
                <a:lnTo>
                  <a:pt x="202" y="569"/>
                </a:lnTo>
                <a:lnTo>
                  <a:pt x="205" y="570"/>
                </a:lnTo>
                <a:lnTo>
                  <a:pt x="207" y="571"/>
                </a:lnTo>
                <a:lnTo>
                  <a:pt x="209" y="573"/>
                </a:lnTo>
                <a:lnTo>
                  <a:pt x="211" y="574"/>
                </a:lnTo>
                <a:lnTo>
                  <a:pt x="213" y="575"/>
                </a:lnTo>
                <a:lnTo>
                  <a:pt x="216" y="577"/>
                </a:lnTo>
                <a:lnTo>
                  <a:pt x="217" y="579"/>
                </a:lnTo>
                <a:lnTo>
                  <a:pt x="219" y="582"/>
                </a:lnTo>
                <a:lnTo>
                  <a:pt x="221" y="584"/>
                </a:lnTo>
                <a:lnTo>
                  <a:pt x="224" y="587"/>
                </a:lnTo>
                <a:lnTo>
                  <a:pt x="226" y="590"/>
                </a:lnTo>
                <a:lnTo>
                  <a:pt x="228" y="592"/>
                </a:lnTo>
                <a:lnTo>
                  <a:pt x="230" y="595"/>
                </a:lnTo>
                <a:lnTo>
                  <a:pt x="232" y="597"/>
                </a:lnTo>
                <a:lnTo>
                  <a:pt x="235" y="599"/>
                </a:lnTo>
                <a:lnTo>
                  <a:pt x="237" y="601"/>
                </a:lnTo>
                <a:lnTo>
                  <a:pt x="238" y="603"/>
                </a:lnTo>
                <a:lnTo>
                  <a:pt x="241" y="604"/>
                </a:lnTo>
                <a:lnTo>
                  <a:pt x="243" y="605"/>
                </a:lnTo>
                <a:lnTo>
                  <a:pt x="245" y="606"/>
                </a:lnTo>
                <a:lnTo>
                  <a:pt x="247" y="606"/>
                </a:lnTo>
                <a:lnTo>
                  <a:pt x="249" y="607"/>
                </a:lnTo>
                <a:lnTo>
                  <a:pt x="252" y="608"/>
                </a:lnTo>
                <a:lnTo>
                  <a:pt x="254" y="608"/>
                </a:lnTo>
                <a:lnTo>
                  <a:pt x="256" y="609"/>
                </a:lnTo>
                <a:lnTo>
                  <a:pt x="258" y="610"/>
                </a:lnTo>
                <a:lnTo>
                  <a:pt x="260" y="611"/>
                </a:lnTo>
                <a:lnTo>
                  <a:pt x="262" y="611"/>
                </a:lnTo>
                <a:lnTo>
                  <a:pt x="264" y="612"/>
                </a:lnTo>
                <a:lnTo>
                  <a:pt x="266" y="612"/>
                </a:lnTo>
                <a:lnTo>
                  <a:pt x="268" y="613"/>
                </a:lnTo>
                <a:lnTo>
                  <a:pt x="271" y="613"/>
                </a:lnTo>
                <a:lnTo>
                  <a:pt x="273" y="613"/>
                </a:lnTo>
                <a:lnTo>
                  <a:pt x="275" y="614"/>
                </a:lnTo>
                <a:lnTo>
                  <a:pt x="277" y="614"/>
                </a:lnTo>
                <a:lnTo>
                  <a:pt x="279" y="615"/>
                </a:lnTo>
                <a:lnTo>
                  <a:pt x="282" y="615"/>
                </a:lnTo>
                <a:lnTo>
                  <a:pt x="283" y="616"/>
                </a:lnTo>
                <a:lnTo>
                  <a:pt x="285" y="617"/>
                </a:lnTo>
                <a:lnTo>
                  <a:pt x="288" y="618"/>
                </a:lnTo>
                <a:lnTo>
                  <a:pt x="290" y="619"/>
                </a:lnTo>
                <a:lnTo>
                  <a:pt x="292" y="619"/>
                </a:lnTo>
                <a:lnTo>
                  <a:pt x="294" y="619"/>
                </a:lnTo>
                <a:lnTo>
                  <a:pt x="296" y="619"/>
                </a:lnTo>
                <a:lnTo>
                  <a:pt x="299" y="619"/>
                </a:lnTo>
                <a:lnTo>
                  <a:pt x="301" y="620"/>
                </a:lnTo>
                <a:lnTo>
                  <a:pt x="303" y="621"/>
                </a:lnTo>
                <a:lnTo>
                  <a:pt x="304" y="621"/>
                </a:lnTo>
                <a:lnTo>
                  <a:pt x="307" y="622"/>
                </a:lnTo>
                <a:lnTo>
                  <a:pt x="309" y="623"/>
                </a:lnTo>
                <a:lnTo>
                  <a:pt x="311" y="624"/>
                </a:lnTo>
                <a:lnTo>
                  <a:pt x="313" y="624"/>
                </a:lnTo>
                <a:lnTo>
                  <a:pt x="316" y="625"/>
                </a:lnTo>
                <a:lnTo>
                  <a:pt x="318" y="625"/>
                </a:lnTo>
                <a:lnTo>
                  <a:pt x="320" y="626"/>
                </a:lnTo>
                <a:lnTo>
                  <a:pt x="322" y="625"/>
                </a:lnTo>
                <a:lnTo>
                  <a:pt x="324" y="624"/>
                </a:lnTo>
                <a:lnTo>
                  <a:pt x="326" y="621"/>
                </a:lnTo>
                <a:lnTo>
                  <a:pt x="328" y="617"/>
                </a:lnTo>
                <a:lnTo>
                  <a:pt x="330" y="611"/>
                </a:lnTo>
                <a:lnTo>
                  <a:pt x="332" y="606"/>
                </a:lnTo>
                <a:lnTo>
                  <a:pt x="335" y="600"/>
                </a:lnTo>
                <a:lnTo>
                  <a:pt x="337" y="594"/>
                </a:lnTo>
                <a:lnTo>
                  <a:pt x="339" y="588"/>
                </a:lnTo>
                <a:lnTo>
                  <a:pt x="341" y="584"/>
                </a:lnTo>
                <a:lnTo>
                  <a:pt x="343" y="580"/>
                </a:lnTo>
                <a:lnTo>
                  <a:pt x="346" y="578"/>
                </a:lnTo>
                <a:lnTo>
                  <a:pt x="347" y="576"/>
                </a:lnTo>
                <a:lnTo>
                  <a:pt x="349" y="575"/>
                </a:lnTo>
                <a:lnTo>
                  <a:pt x="352" y="575"/>
                </a:lnTo>
                <a:lnTo>
                  <a:pt x="354" y="574"/>
                </a:lnTo>
                <a:lnTo>
                  <a:pt x="356" y="574"/>
                </a:lnTo>
                <a:lnTo>
                  <a:pt x="358" y="575"/>
                </a:lnTo>
                <a:lnTo>
                  <a:pt x="360" y="576"/>
                </a:lnTo>
                <a:lnTo>
                  <a:pt x="363" y="577"/>
                </a:lnTo>
                <a:lnTo>
                  <a:pt x="365" y="579"/>
                </a:lnTo>
                <a:lnTo>
                  <a:pt x="367" y="582"/>
                </a:lnTo>
                <a:lnTo>
                  <a:pt x="368" y="584"/>
                </a:lnTo>
                <a:lnTo>
                  <a:pt x="371" y="587"/>
                </a:lnTo>
                <a:lnTo>
                  <a:pt x="373" y="589"/>
                </a:lnTo>
                <a:lnTo>
                  <a:pt x="375" y="591"/>
                </a:lnTo>
                <a:lnTo>
                  <a:pt x="377" y="592"/>
                </a:lnTo>
                <a:lnTo>
                  <a:pt x="379" y="593"/>
                </a:lnTo>
                <a:lnTo>
                  <a:pt x="382" y="593"/>
                </a:lnTo>
                <a:lnTo>
                  <a:pt x="384" y="593"/>
                </a:lnTo>
                <a:lnTo>
                  <a:pt x="386" y="593"/>
                </a:lnTo>
                <a:lnTo>
                  <a:pt x="388" y="592"/>
                </a:lnTo>
                <a:lnTo>
                  <a:pt x="390" y="591"/>
                </a:lnTo>
                <a:lnTo>
                  <a:pt x="392" y="589"/>
                </a:lnTo>
                <a:lnTo>
                  <a:pt x="394" y="586"/>
                </a:lnTo>
                <a:lnTo>
                  <a:pt x="396" y="582"/>
                </a:lnTo>
                <a:lnTo>
                  <a:pt x="399" y="577"/>
                </a:lnTo>
                <a:lnTo>
                  <a:pt x="401" y="573"/>
                </a:lnTo>
                <a:lnTo>
                  <a:pt x="403" y="568"/>
                </a:lnTo>
                <a:lnTo>
                  <a:pt x="405" y="565"/>
                </a:lnTo>
                <a:lnTo>
                  <a:pt x="407" y="564"/>
                </a:lnTo>
                <a:lnTo>
                  <a:pt x="410" y="565"/>
                </a:lnTo>
                <a:lnTo>
                  <a:pt x="412" y="567"/>
                </a:lnTo>
                <a:lnTo>
                  <a:pt x="413" y="570"/>
                </a:lnTo>
                <a:lnTo>
                  <a:pt x="415" y="573"/>
                </a:lnTo>
                <a:lnTo>
                  <a:pt x="418" y="577"/>
                </a:lnTo>
                <a:lnTo>
                  <a:pt x="420" y="581"/>
                </a:lnTo>
                <a:lnTo>
                  <a:pt x="422" y="587"/>
                </a:lnTo>
                <a:lnTo>
                  <a:pt x="424" y="592"/>
                </a:lnTo>
                <a:lnTo>
                  <a:pt x="426" y="598"/>
                </a:lnTo>
                <a:lnTo>
                  <a:pt x="429" y="604"/>
                </a:lnTo>
                <a:lnTo>
                  <a:pt x="431" y="611"/>
                </a:lnTo>
                <a:lnTo>
                  <a:pt x="433" y="618"/>
                </a:lnTo>
                <a:lnTo>
                  <a:pt x="435" y="625"/>
                </a:lnTo>
                <a:lnTo>
                  <a:pt x="437" y="631"/>
                </a:lnTo>
                <a:lnTo>
                  <a:pt x="439" y="637"/>
                </a:lnTo>
                <a:lnTo>
                  <a:pt x="441" y="643"/>
                </a:lnTo>
                <a:lnTo>
                  <a:pt x="443" y="647"/>
                </a:lnTo>
                <a:lnTo>
                  <a:pt x="446" y="650"/>
                </a:lnTo>
                <a:lnTo>
                  <a:pt x="448" y="653"/>
                </a:lnTo>
                <a:lnTo>
                  <a:pt x="450" y="655"/>
                </a:lnTo>
                <a:lnTo>
                  <a:pt x="452" y="657"/>
                </a:lnTo>
                <a:lnTo>
                  <a:pt x="454" y="659"/>
                </a:lnTo>
                <a:lnTo>
                  <a:pt x="456" y="661"/>
                </a:lnTo>
                <a:lnTo>
                  <a:pt x="458" y="663"/>
                </a:lnTo>
                <a:lnTo>
                  <a:pt x="460" y="664"/>
                </a:lnTo>
                <a:lnTo>
                  <a:pt x="462" y="665"/>
                </a:lnTo>
                <a:lnTo>
                  <a:pt x="465" y="667"/>
                </a:lnTo>
                <a:lnTo>
                  <a:pt x="467" y="668"/>
                </a:lnTo>
                <a:lnTo>
                  <a:pt x="469" y="670"/>
                </a:lnTo>
                <a:lnTo>
                  <a:pt x="471" y="671"/>
                </a:lnTo>
                <a:lnTo>
                  <a:pt x="474" y="672"/>
                </a:lnTo>
                <a:lnTo>
                  <a:pt x="476" y="673"/>
                </a:lnTo>
                <a:lnTo>
                  <a:pt x="477" y="674"/>
                </a:lnTo>
                <a:lnTo>
                  <a:pt x="479" y="675"/>
                </a:lnTo>
                <a:lnTo>
                  <a:pt x="482" y="676"/>
                </a:lnTo>
                <a:lnTo>
                  <a:pt x="484" y="676"/>
                </a:lnTo>
                <a:lnTo>
                  <a:pt x="486" y="677"/>
                </a:lnTo>
                <a:lnTo>
                  <a:pt x="488" y="677"/>
                </a:lnTo>
                <a:lnTo>
                  <a:pt x="490" y="678"/>
                </a:lnTo>
                <a:lnTo>
                  <a:pt x="493" y="678"/>
                </a:lnTo>
                <a:lnTo>
                  <a:pt x="495" y="679"/>
                </a:lnTo>
                <a:lnTo>
                  <a:pt x="497" y="679"/>
                </a:lnTo>
                <a:lnTo>
                  <a:pt x="499" y="679"/>
                </a:lnTo>
                <a:lnTo>
                  <a:pt x="501" y="679"/>
                </a:lnTo>
                <a:lnTo>
                  <a:pt x="503" y="677"/>
                </a:lnTo>
                <a:lnTo>
                  <a:pt x="505" y="673"/>
                </a:lnTo>
                <a:lnTo>
                  <a:pt x="507" y="668"/>
                </a:lnTo>
                <a:lnTo>
                  <a:pt x="510" y="665"/>
                </a:lnTo>
                <a:lnTo>
                  <a:pt x="512" y="662"/>
                </a:lnTo>
                <a:lnTo>
                  <a:pt x="514" y="661"/>
                </a:lnTo>
                <a:lnTo>
                  <a:pt x="516" y="663"/>
                </a:lnTo>
                <a:lnTo>
                  <a:pt x="518" y="664"/>
                </a:lnTo>
                <a:lnTo>
                  <a:pt x="521" y="666"/>
                </a:lnTo>
                <a:lnTo>
                  <a:pt x="522" y="667"/>
                </a:lnTo>
                <a:lnTo>
                  <a:pt x="524" y="669"/>
                </a:lnTo>
                <a:lnTo>
                  <a:pt x="526" y="670"/>
                </a:lnTo>
                <a:lnTo>
                  <a:pt x="529" y="671"/>
                </a:lnTo>
                <a:lnTo>
                  <a:pt x="531" y="672"/>
                </a:lnTo>
                <a:lnTo>
                  <a:pt x="533" y="672"/>
                </a:lnTo>
                <a:lnTo>
                  <a:pt x="535" y="673"/>
                </a:lnTo>
                <a:lnTo>
                  <a:pt x="537" y="673"/>
                </a:lnTo>
                <a:lnTo>
                  <a:pt x="540" y="672"/>
                </a:lnTo>
                <a:lnTo>
                  <a:pt x="542" y="672"/>
                </a:lnTo>
                <a:lnTo>
                  <a:pt x="546" y="673"/>
                </a:lnTo>
                <a:lnTo>
                  <a:pt x="548" y="673"/>
                </a:lnTo>
                <a:lnTo>
                  <a:pt x="550" y="673"/>
                </a:lnTo>
                <a:lnTo>
                  <a:pt x="552" y="673"/>
                </a:lnTo>
                <a:lnTo>
                  <a:pt x="554" y="673"/>
                </a:lnTo>
                <a:lnTo>
                  <a:pt x="559" y="673"/>
                </a:lnTo>
                <a:lnTo>
                  <a:pt x="561" y="672"/>
                </a:lnTo>
                <a:lnTo>
                  <a:pt x="563" y="672"/>
                </a:lnTo>
                <a:lnTo>
                  <a:pt x="565" y="672"/>
                </a:lnTo>
                <a:lnTo>
                  <a:pt x="567" y="673"/>
                </a:lnTo>
                <a:lnTo>
                  <a:pt x="569" y="674"/>
                </a:lnTo>
                <a:lnTo>
                  <a:pt x="571" y="674"/>
                </a:lnTo>
                <a:lnTo>
                  <a:pt x="573" y="675"/>
                </a:lnTo>
                <a:lnTo>
                  <a:pt x="576" y="676"/>
                </a:lnTo>
                <a:lnTo>
                  <a:pt x="578" y="676"/>
                </a:lnTo>
                <a:lnTo>
                  <a:pt x="580" y="677"/>
                </a:lnTo>
                <a:lnTo>
                  <a:pt x="582" y="677"/>
                </a:lnTo>
                <a:lnTo>
                  <a:pt x="584" y="677"/>
                </a:lnTo>
                <a:lnTo>
                  <a:pt x="586" y="678"/>
                </a:lnTo>
                <a:lnTo>
                  <a:pt x="588" y="677"/>
                </a:lnTo>
                <a:lnTo>
                  <a:pt x="590" y="677"/>
                </a:lnTo>
                <a:lnTo>
                  <a:pt x="593" y="677"/>
                </a:lnTo>
                <a:lnTo>
                  <a:pt x="595" y="676"/>
                </a:lnTo>
                <a:lnTo>
                  <a:pt x="597" y="675"/>
                </a:lnTo>
                <a:lnTo>
                  <a:pt x="599" y="674"/>
                </a:lnTo>
                <a:lnTo>
                  <a:pt x="601" y="674"/>
                </a:lnTo>
                <a:lnTo>
                  <a:pt x="604" y="674"/>
                </a:lnTo>
                <a:lnTo>
                  <a:pt x="606" y="675"/>
                </a:lnTo>
                <a:lnTo>
                  <a:pt x="607" y="676"/>
                </a:lnTo>
                <a:lnTo>
                  <a:pt x="609" y="677"/>
                </a:lnTo>
                <a:lnTo>
                  <a:pt x="612" y="678"/>
                </a:lnTo>
                <a:lnTo>
                  <a:pt x="614" y="679"/>
                </a:lnTo>
                <a:lnTo>
                  <a:pt x="616" y="681"/>
                </a:lnTo>
                <a:lnTo>
                  <a:pt x="618" y="682"/>
                </a:lnTo>
                <a:lnTo>
                  <a:pt x="621" y="683"/>
                </a:lnTo>
                <a:lnTo>
                  <a:pt x="623" y="684"/>
                </a:lnTo>
                <a:lnTo>
                  <a:pt x="625" y="684"/>
                </a:lnTo>
                <a:lnTo>
                  <a:pt x="627" y="685"/>
                </a:lnTo>
                <a:lnTo>
                  <a:pt x="629" y="685"/>
                </a:lnTo>
                <a:lnTo>
                  <a:pt x="631" y="686"/>
                </a:lnTo>
                <a:lnTo>
                  <a:pt x="633" y="687"/>
                </a:lnTo>
                <a:lnTo>
                  <a:pt x="635" y="687"/>
                </a:lnTo>
                <a:lnTo>
                  <a:pt x="637" y="687"/>
                </a:lnTo>
                <a:lnTo>
                  <a:pt x="640" y="687"/>
                </a:lnTo>
                <a:lnTo>
                  <a:pt x="642" y="687"/>
                </a:lnTo>
                <a:lnTo>
                  <a:pt x="644" y="686"/>
                </a:lnTo>
                <a:lnTo>
                  <a:pt x="646" y="686"/>
                </a:lnTo>
                <a:lnTo>
                  <a:pt x="648" y="685"/>
                </a:lnTo>
                <a:lnTo>
                  <a:pt x="651" y="683"/>
                </a:lnTo>
                <a:lnTo>
                  <a:pt x="652" y="681"/>
                </a:lnTo>
                <a:lnTo>
                  <a:pt x="654" y="678"/>
                </a:lnTo>
                <a:lnTo>
                  <a:pt x="657" y="674"/>
                </a:lnTo>
                <a:lnTo>
                  <a:pt x="659" y="669"/>
                </a:lnTo>
                <a:lnTo>
                  <a:pt x="661" y="663"/>
                </a:lnTo>
                <a:lnTo>
                  <a:pt x="663" y="656"/>
                </a:lnTo>
                <a:lnTo>
                  <a:pt x="665" y="649"/>
                </a:lnTo>
                <a:lnTo>
                  <a:pt x="668" y="641"/>
                </a:lnTo>
                <a:lnTo>
                  <a:pt x="670" y="632"/>
                </a:lnTo>
                <a:lnTo>
                  <a:pt x="672" y="623"/>
                </a:lnTo>
                <a:lnTo>
                  <a:pt x="673" y="615"/>
                </a:lnTo>
                <a:lnTo>
                  <a:pt x="676" y="607"/>
                </a:lnTo>
                <a:lnTo>
                  <a:pt x="678" y="600"/>
                </a:lnTo>
                <a:lnTo>
                  <a:pt x="680" y="594"/>
                </a:lnTo>
                <a:lnTo>
                  <a:pt x="682" y="589"/>
                </a:lnTo>
                <a:lnTo>
                  <a:pt x="684" y="586"/>
                </a:lnTo>
                <a:lnTo>
                  <a:pt x="687" y="585"/>
                </a:lnTo>
                <a:lnTo>
                  <a:pt x="689" y="585"/>
                </a:lnTo>
                <a:lnTo>
                  <a:pt x="691" y="587"/>
                </a:lnTo>
                <a:lnTo>
                  <a:pt x="693" y="589"/>
                </a:lnTo>
                <a:lnTo>
                  <a:pt x="695" y="594"/>
                </a:lnTo>
                <a:lnTo>
                  <a:pt x="697" y="600"/>
                </a:lnTo>
                <a:lnTo>
                  <a:pt x="699" y="607"/>
                </a:lnTo>
                <a:lnTo>
                  <a:pt x="701" y="616"/>
                </a:lnTo>
                <a:lnTo>
                  <a:pt x="704" y="625"/>
                </a:lnTo>
                <a:lnTo>
                  <a:pt x="706" y="635"/>
                </a:lnTo>
                <a:lnTo>
                  <a:pt x="708" y="646"/>
                </a:lnTo>
                <a:lnTo>
                  <a:pt x="710" y="657"/>
                </a:lnTo>
                <a:lnTo>
                  <a:pt x="712" y="668"/>
                </a:lnTo>
                <a:lnTo>
                  <a:pt x="715" y="678"/>
                </a:lnTo>
                <a:lnTo>
                  <a:pt x="716" y="687"/>
                </a:lnTo>
                <a:lnTo>
                  <a:pt x="718" y="694"/>
                </a:lnTo>
                <a:lnTo>
                  <a:pt x="720" y="699"/>
                </a:lnTo>
                <a:lnTo>
                  <a:pt x="723" y="703"/>
                </a:lnTo>
                <a:lnTo>
                  <a:pt x="725" y="706"/>
                </a:lnTo>
                <a:lnTo>
                  <a:pt x="727" y="709"/>
                </a:lnTo>
                <a:lnTo>
                  <a:pt x="729" y="710"/>
                </a:lnTo>
                <a:lnTo>
                  <a:pt x="731" y="710"/>
                </a:lnTo>
                <a:lnTo>
                  <a:pt x="734" y="711"/>
                </a:lnTo>
                <a:lnTo>
                  <a:pt x="736" y="710"/>
                </a:lnTo>
                <a:lnTo>
                  <a:pt x="737" y="709"/>
                </a:lnTo>
                <a:lnTo>
                  <a:pt x="740" y="708"/>
                </a:lnTo>
                <a:lnTo>
                  <a:pt x="742" y="705"/>
                </a:lnTo>
                <a:lnTo>
                  <a:pt x="744" y="700"/>
                </a:lnTo>
                <a:lnTo>
                  <a:pt x="746" y="694"/>
                </a:lnTo>
                <a:lnTo>
                  <a:pt x="748" y="687"/>
                </a:lnTo>
                <a:lnTo>
                  <a:pt x="751" y="680"/>
                </a:lnTo>
                <a:lnTo>
                  <a:pt x="753" y="674"/>
                </a:lnTo>
                <a:lnTo>
                  <a:pt x="755" y="670"/>
                </a:lnTo>
                <a:lnTo>
                  <a:pt x="757" y="668"/>
                </a:lnTo>
                <a:lnTo>
                  <a:pt x="759" y="668"/>
                </a:lnTo>
                <a:lnTo>
                  <a:pt x="761" y="669"/>
                </a:lnTo>
                <a:lnTo>
                  <a:pt x="763" y="670"/>
                </a:lnTo>
                <a:lnTo>
                  <a:pt x="765" y="671"/>
                </a:lnTo>
                <a:lnTo>
                  <a:pt x="768" y="672"/>
                </a:lnTo>
                <a:lnTo>
                  <a:pt x="770" y="673"/>
                </a:lnTo>
                <a:lnTo>
                  <a:pt x="772" y="674"/>
                </a:lnTo>
                <a:lnTo>
                  <a:pt x="774" y="676"/>
                </a:lnTo>
                <a:lnTo>
                  <a:pt x="776" y="677"/>
                </a:lnTo>
                <a:lnTo>
                  <a:pt x="779" y="679"/>
                </a:lnTo>
                <a:lnTo>
                  <a:pt x="781" y="680"/>
                </a:lnTo>
                <a:lnTo>
                  <a:pt x="782" y="681"/>
                </a:lnTo>
                <a:lnTo>
                  <a:pt x="784" y="682"/>
                </a:lnTo>
                <a:lnTo>
                  <a:pt x="787" y="683"/>
                </a:lnTo>
                <a:lnTo>
                  <a:pt x="789" y="684"/>
                </a:lnTo>
                <a:lnTo>
                  <a:pt x="791" y="685"/>
                </a:lnTo>
                <a:lnTo>
                  <a:pt x="793" y="685"/>
                </a:lnTo>
                <a:lnTo>
                  <a:pt x="795" y="686"/>
                </a:lnTo>
                <a:lnTo>
                  <a:pt x="798" y="686"/>
                </a:lnTo>
                <a:lnTo>
                  <a:pt x="800" y="686"/>
                </a:lnTo>
                <a:lnTo>
                  <a:pt x="802" y="687"/>
                </a:lnTo>
                <a:lnTo>
                  <a:pt x="804" y="687"/>
                </a:lnTo>
                <a:lnTo>
                  <a:pt x="806" y="687"/>
                </a:lnTo>
                <a:lnTo>
                  <a:pt x="808" y="687"/>
                </a:lnTo>
                <a:lnTo>
                  <a:pt x="810" y="687"/>
                </a:lnTo>
                <a:lnTo>
                  <a:pt x="812" y="688"/>
                </a:lnTo>
                <a:lnTo>
                  <a:pt x="815" y="688"/>
                </a:lnTo>
                <a:lnTo>
                  <a:pt x="817" y="689"/>
                </a:lnTo>
                <a:lnTo>
                  <a:pt x="819" y="690"/>
                </a:lnTo>
                <a:lnTo>
                  <a:pt x="821" y="690"/>
                </a:lnTo>
                <a:lnTo>
                  <a:pt x="823" y="691"/>
                </a:lnTo>
                <a:lnTo>
                  <a:pt x="825" y="691"/>
                </a:lnTo>
                <a:lnTo>
                  <a:pt x="827" y="692"/>
                </a:lnTo>
                <a:lnTo>
                  <a:pt x="829" y="692"/>
                </a:lnTo>
                <a:lnTo>
                  <a:pt x="831" y="693"/>
                </a:lnTo>
                <a:lnTo>
                  <a:pt x="834" y="693"/>
                </a:lnTo>
                <a:lnTo>
                  <a:pt x="836" y="694"/>
                </a:lnTo>
                <a:lnTo>
                  <a:pt x="838" y="694"/>
                </a:lnTo>
                <a:lnTo>
                  <a:pt x="840" y="695"/>
                </a:lnTo>
                <a:lnTo>
                  <a:pt x="842" y="695"/>
                </a:lnTo>
                <a:lnTo>
                  <a:pt x="845" y="696"/>
                </a:lnTo>
                <a:lnTo>
                  <a:pt x="846" y="696"/>
                </a:lnTo>
                <a:lnTo>
                  <a:pt x="848" y="697"/>
                </a:lnTo>
                <a:lnTo>
                  <a:pt x="851" y="697"/>
                </a:lnTo>
                <a:lnTo>
                  <a:pt x="853" y="698"/>
                </a:lnTo>
                <a:lnTo>
                  <a:pt x="855" y="698"/>
                </a:lnTo>
                <a:lnTo>
                  <a:pt x="857" y="698"/>
                </a:lnTo>
                <a:lnTo>
                  <a:pt x="859" y="698"/>
                </a:lnTo>
                <a:lnTo>
                  <a:pt x="862" y="699"/>
                </a:lnTo>
                <a:lnTo>
                  <a:pt x="864" y="699"/>
                </a:lnTo>
                <a:lnTo>
                  <a:pt x="866" y="698"/>
                </a:lnTo>
                <a:lnTo>
                  <a:pt x="867" y="698"/>
                </a:lnTo>
                <a:lnTo>
                  <a:pt x="870" y="698"/>
                </a:lnTo>
                <a:lnTo>
                  <a:pt x="872" y="698"/>
                </a:lnTo>
                <a:lnTo>
                  <a:pt x="874" y="698"/>
                </a:lnTo>
                <a:lnTo>
                  <a:pt x="876" y="698"/>
                </a:lnTo>
                <a:lnTo>
                  <a:pt x="878" y="697"/>
                </a:lnTo>
                <a:lnTo>
                  <a:pt x="881" y="697"/>
                </a:lnTo>
                <a:lnTo>
                  <a:pt x="883" y="696"/>
                </a:lnTo>
                <a:lnTo>
                  <a:pt x="885" y="696"/>
                </a:lnTo>
                <a:lnTo>
                  <a:pt x="887" y="695"/>
                </a:lnTo>
                <a:lnTo>
                  <a:pt x="889" y="694"/>
                </a:lnTo>
                <a:lnTo>
                  <a:pt x="891" y="692"/>
                </a:lnTo>
                <a:lnTo>
                  <a:pt x="893" y="690"/>
                </a:lnTo>
                <a:lnTo>
                  <a:pt x="895" y="689"/>
                </a:lnTo>
                <a:lnTo>
                  <a:pt x="898" y="687"/>
                </a:lnTo>
                <a:lnTo>
                  <a:pt x="900" y="685"/>
                </a:lnTo>
                <a:lnTo>
                  <a:pt x="902" y="683"/>
                </a:lnTo>
                <a:lnTo>
                  <a:pt x="904" y="682"/>
                </a:lnTo>
                <a:lnTo>
                  <a:pt x="906" y="680"/>
                </a:lnTo>
                <a:lnTo>
                  <a:pt x="909" y="679"/>
                </a:lnTo>
                <a:lnTo>
                  <a:pt x="911" y="678"/>
                </a:lnTo>
                <a:lnTo>
                  <a:pt x="912" y="677"/>
                </a:lnTo>
                <a:lnTo>
                  <a:pt x="914" y="677"/>
                </a:lnTo>
                <a:lnTo>
                  <a:pt x="917" y="677"/>
                </a:lnTo>
                <a:lnTo>
                  <a:pt x="919" y="677"/>
                </a:lnTo>
                <a:lnTo>
                  <a:pt x="921" y="678"/>
                </a:lnTo>
                <a:lnTo>
                  <a:pt x="923" y="679"/>
                </a:lnTo>
                <a:lnTo>
                  <a:pt x="926" y="680"/>
                </a:lnTo>
                <a:lnTo>
                  <a:pt x="928" y="682"/>
                </a:lnTo>
                <a:lnTo>
                  <a:pt x="930" y="685"/>
                </a:lnTo>
                <a:lnTo>
                  <a:pt x="932" y="687"/>
                </a:lnTo>
                <a:lnTo>
                  <a:pt x="934" y="690"/>
                </a:lnTo>
                <a:lnTo>
                  <a:pt x="936" y="693"/>
                </a:lnTo>
                <a:lnTo>
                  <a:pt x="938" y="695"/>
                </a:lnTo>
                <a:lnTo>
                  <a:pt x="940" y="697"/>
                </a:lnTo>
                <a:lnTo>
                  <a:pt x="942" y="699"/>
                </a:lnTo>
                <a:lnTo>
                  <a:pt x="945" y="700"/>
                </a:lnTo>
                <a:lnTo>
                  <a:pt x="947" y="701"/>
                </a:lnTo>
                <a:lnTo>
                  <a:pt x="949" y="702"/>
                </a:lnTo>
                <a:lnTo>
                  <a:pt x="951" y="703"/>
                </a:lnTo>
                <a:lnTo>
                  <a:pt x="953" y="703"/>
                </a:lnTo>
                <a:lnTo>
                  <a:pt x="955" y="703"/>
                </a:lnTo>
                <a:lnTo>
                  <a:pt x="957" y="703"/>
                </a:lnTo>
                <a:lnTo>
                  <a:pt x="959" y="704"/>
                </a:lnTo>
                <a:lnTo>
                  <a:pt x="962" y="704"/>
                </a:lnTo>
                <a:lnTo>
                  <a:pt x="964" y="705"/>
                </a:lnTo>
                <a:lnTo>
                  <a:pt x="966" y="705"/>
                </a:lnTo>
                <a:lnTo>
                  <a:pt x="968" y="705"/>
                </a:lnTo>
                <a:lnTo>
                  <a:pt x="970" y="706"/>
                </a:lnTo>
                <a:lnTo>
                  <a:pt x="973" y="707"/>
                </a:lnTo>
                <a:lnTo>
                  <a:pt x="975" y="707"/>
                </a:lnTo>
                <a:lnTo>
                  <a:pt x="976" y="707"/>
                </a:lnTo>
                <a:lnTo>
                  <a:pt x="978" y="707"/>
                </a:lnTo>
                <a:lnTo>
                  <a:pt x="981" y="707"/>
                </a:lnTo>
                <a:lnTo>
                  <a:pt x="983" y="707"/>
                </a:lnTo>
                <a:lnTo>
                  <a:pt x="985" y="705"/>
                </a:lnTo>
                <a:lnTo>
                  <a:pt x="987" y="704"/>
                </a:lnTo>
                <a:lnTo>
                  <a:pt x="989" y="702"/>
                </a:lnTo>
                <a:lnTo>
                  <a:pt x="992" y="700"/>
                </a:lnTo>
                <a:lnTo>
                  <a:pt x="994" y="698"/>
                </a:lnTo>
                <a:lnTo>
                  <a:pt x="996" y="694"/>
                </a:lnTo>
                <a:lnTo>
                  <a:pt x="998" y="691"/>
                </a:lnTo>
                <a:lnTo>
                  <a:pt x="1000" y="687"/>
                </a:lnTo>
                <a:lnTo>
                  <a:pt x="1002" y="682"/>
                </a:lnTo>
                <a:lnTo>
                  <a:pt x="1004" y="677"/>
                </a:lnTo>
                <a:lnTo>
                  <a:pt x="1006" y="672"/>
                </a:lnTo>
                <a:lnTo>
                  <a:pt x="1009" y="668"/>
                </a:lnTo>
                <a:lnTo>
                  <a:pt x="1011" y="665"/>
                </a:lnTo>
                <a:lnTo>
                  <a:pt x="1013" y="661"/>
                </a:lnTo>
                <a:lnTo>
                  <a:pt x="1015" y="659"/>
                </a:lnTo>
                <a:lnTo>
                  <a:pt x="1017" y="657"/>
                </a:lnTo>
                <a:lnTo>
                  <a:pt x="1019" y="656"/>
                </a:lnTo>
                <a:lnTo>
                  <a:pt x="1021" y="656"/>
                </a:lnTo>
                <a:lnTo>
                  <a:pt x="1023" y="657"/>
                </a:lnTo>
                <a:lnTo>
                  <a:pt x="1025" y="658"/>
                </a:lnTo>
                <a:lnTo>
                  <a:pt x="1028" y="661"/>
                </a:lnTo>
                <a:lnTo>
                  <a:pt x="1030" y="664"/>
                </a:lnTo>
                <a:lnTo>
                  <a:pt x="1032" y="668"/>
                </a:lnTo>
                <a:lnTo>
                  <a:pt x="1034" y="672"/>
                </a:lnTo>
                <a:lnTo>
                  <a:pt x="1036" y="677"/>
                </a:lnTo>
                <a:lnTo>
                  <a:pt x="1039" y="682"/>
                </a:lnTo>
                <a:lnTo>
                  <a:pt x="1041" y="687"/>
                </a:lnTo>
                <a:lnTo>
                  <a:pt x="1042" y="692"/>
                </a:lnTo>
                <a:lnTo>
                  <a:pt x="1045" y="696"/>
                </a:lnTo>
                <a:lnTo>
                  <a:pt x="1047" y="699"/>
                </a:lnTo>
                <a:lnTo>
                  <a:pt x="1049" y="702"/>
                </a:lnTo>
                <a:lnTo>
                  <a:pt x="1051" y="705"/>
                </a:lnTo>
                <a:lnTo>
                  <a:pt x="1053" y="706"/>
                </a:lnTo>
                <a:lnTo>
                  <a:pt x="1056" y="708"/>
                </a:lnTo>
                <a:lnTo>
                  <a:pt x="1058" y="709"/>
                </a:lnTo>
                <a:lnTo>
                  <a:pt x="1060" y="709"/>
                </a:lnTo>
                <a:lnTo>
                  <a:pt x="1062" y="709"/>
                </a:lnTo>
                <a:lnTo>
                  <a:pt x="1064" y="709"/>
                </a:lnTo>
                <a:lnTo>
                  <a:pt x="1066" y="709"/>
                </a:lnTo>
                <a:lnTo>
                  <a:pt x="1068" y="709"/>
                </a:lnTo>
                <a:lnTo>
                  <a:pt x="1070" y="709"/>
                </a:lnTo>
                <a:lnTo>
                  <a:pt x="1073" y="708"/>
                </a:lnTo>
                <a:lnTo>
                  <a:pt x="1075" y="707"/>
                </a:lnTo>
                <a:lnTo>
                  <a:pt x="1077" y="707"/>
                </a:lnTo>
                <a:lnTo>
                  <a:pt x="1079" y="707"/>
                </a:lnTo>
                <a:lnTo>
                  <a:pt x="1081" y="706"/>
                </a:lnTo>
                <a:lnTo>
                  <a:pt x="1084" y="706"/>
                </a:lnTo>
                <a:lnTo>
                  <a:pt x="1085" y="706"/>
                </a:lnTo>
                <a:lnTo>
                  <a:pt x="1087" y="705"/>
                </a:lnTo>
                <a:lnTo>
                  <a:pt x="1089" y="705"/>
                </a:lnTo>
                <a:lnTo>
                  <a:pt x="1094" y="705"/>
                </a:lnTo>
                <a:lnTo>
                  <a:pt x="1096" y="706"/>
                </a:lnTo>
                <a:lnTo>
                  <a:pt x="1098" y="707"/>
                </a:lnTo>
                <a:lnTo>
                  <a:pt x="1100" y="707"/>
                </a:lnTo>
                <a:lnTo>
                  <a:pt x="1103" y="707"/>
                </a:lnTo>
                <a:lnTo>
                  <a:pt x="1105" y="707"/>
                </a:lnTo>
                <a:lnTo>
                  <a:pt x="1106" y="707"/>
                </a:lnTo>
                <a:lnTo>
                  <a:pt x="1109" y="706"/>
                </a:lnTo>
                <a:lnTo>
                  <a:pt x="1111" y="706"/>
                </a:lnTo>
                <a:lnTo>
                  <a:pt x="1113" y="706"/>
                </a:lnTo>
                <a:lnTo>
                  <a:pt x="1115" y="706"/>
                </a:lnTo>
                <a:lnTo>
                  <a:pt x="1120" y="706"/>
                </a:lnTo>
                <a:lnTo>
                  <a:pt x="1122" y="706"/>
                </a:lnTo>
                <a:lnTo>
                  <a:pt x="1124" y="705"/>
                </a:lnTo>
                <a:lnTo>
                  <a:pt x="1126" y="705"/>
                </a:lnTo>
                <a:lnTo>
                  <a:pt x="1128" y="705"/>
                </a:lnTo>
                <a:lnTo>
                  <a:pt x="1130" y="705"/>
                </a:lnTo>
                <a:lnTo>
                  <a:pt x="1132" y="705"/>
                </a:lnTo>
                <a:lnTo>
                  <a:pt x="1134" y="705"/>
                </a:lnTo>
                <a:lnTo>
                  <a:pt x="1136" y="705"/>
                </a:lnTo>
                <a:lnTo>
                  <a:pt x="1139" y="705"/>
                </a:lnTo>
                <a:lnTo>
                  <a:pt x="1141" y="705"/>
                </a:lnTo>
                <a:lnTo>
                  <a:pt x="1143" y="706"/>
                </a:lnTo>
                <a:lnTo>
                  <a:pt x="1145" y="707"/>
                </a:lnTo>
                <a:lnTo>
                  <a:pt x="1147" y="707"/>
                </a:lnTo>
                <a:lnTo>
                  <a:pt x="1149" y="707"/>
                </a:lnTo>
                <a:lnTo>
                  <a:pt x="1151" y="708"/>
                </a:lnTo>
                <a:lnTo>
                  <a:pt x="1153" y="708"/>
                </a:lnTo>
                <a:lnTo>
                  <a:pt x="1156" y="709"/>
                </a:lnTo>
                <a:lnTo>
                  <a:pt x="1158" y="710"/>
                </a:lnTo>
                <a:lnTo>
                  <a:pt x="1160" y="711"/>
                </a:lnTo>
                <a:lnTo>
                  <a:pt x="1162" y="711"/>
                </a:lnTo>
                <a:lnTo>
                  <a:pt x="1164" y="712"/>
                </a:lnTo>
                <a:lnTo>
                  <a:pt x="1167" y="712"/>
                </a:lnTo>
                <a:lnTo>
                  <a:pt x="1169" y="713"/>
                </a:lnTo>
                <a:lnTo>
                  <a:pt x="1171" y="713"/>
                </a:lnTo>
                <a:lnTo>
                  <a:pt x="1172" y="714"/>
                </a:lnTo>
                <a:lnTo>
                  <a:pt x="1175" y="714"/>
                </a:lnTo>
                <a:lnTo>
                  <a:pt x="1177" y="715"/>
                </a:lnTo>
                <a:lnTo>
                  <a:pt x="1179" y="716"/>
                </a:lnTo>
                <a:lnTo>
                  <a:pt x="1181" y="717"/>
                </a:lnTo>
                <a:lnTo>
                  <a:pt x="1183" y="717"/>
                </a:lnTo>
                <a:lnTo>
                  <a:pt x="1186" y="717"/>
                </a:lnTo>
                <a:lnTo>
                  <a:pt x="1188" y="718"/>
                </a:lnTo>
                <a:lnTo>
                  <a:pt x="1190" y="718"/>
                </a:lnTo>
                <a:lnTo>
                  <a:pt x="1192" y="718"/>
                </a:lnTo>
                <a:lnTo>
                  <a:pt x="1194" y="718"/>
                </a:lnTo>
                <a:lnTo>
                  <a:pt x="1196" y="718"/>
                </a:lnTo>
                <a:lnTo>
                  <a:pt x="1198" y="719"/>
                </a:lnTo>
                <a:lnTo>
                  <a:pt x="1200" y="719"/>
                </a:lnTo>
                <a:lnTo>
                  <a:pt x="1203" y="719"/>
                </a:lnTo>
                <a:lnTo>
                  <a:pt x="1205" y="718"/>
                </a:lnTo>
                <a:lnTo>
                  <a:pt x="1209" y="718"/>
                </a:lnTo>
                <a:lnTo>
                  <a:pt x="1211" y="718"/>
                </a:lnTo>
                <a:lnTo>
                  <a:pt x="1214" y="718"/>
                </a:lnTo>
                <a:lnTo>
                  <a:pt x="1215" y="718"/>
                </a:lnTo>
                <a:lnTo>
                  <a:pt x="1217" y="718"/>
                </a:lnTo>
                <a:lnTo>
                  <a:pt x="1222" y="718"/>
                </a:lnTo>
                <a:lnTo>
                  <a:pt x="1224" y="718"/>
                </a:lnTo>
                <a:lnTo>
                  <a:pt x="1226" y="718"/>
                </a:lnTo>
                <a:lnTo>
                  <a:pt x="1228" y="718"/>
                </a:lnTo>
                <a:lnTo>
                  <a:pt x="1231" y="718"/>
                </a:lnTo>
                <a:lnTo>
                  <a:pt x="1233" y="718"/>
                </a:lnTo>
                <a:lnTo>
                  <a:pt x="1235" y="718"/>
                </a:lnTo>
                <a:lnTo>
                  <a:pt x="1236" y="718"/>
                </a:lnTo>
                <a:lnTo>
                  <a:pt x="1239" y="718"/>
                </a:lnTo>
                <a:lnTo>
                  <a:pt x="1241" y="718"/>
                </a:lnTo>
                <a:lnTo>
                  <a:pt x="1243" y="718"/>
                </a:lnTo>
                <a:lnTo>
                  <a:pt x="1247" y="718"/>
                </a:lnTo>
                <a:lnTo>
                  <a:pt x="1250" y="719"/>
                </a:lnTo>
                <a:lnTo>
                  <a:pt x="1252" y="719"/>
                </a:lnTo>
                <a:lnTo>
                  <a:pt x="1254" y="719"/>
                </a:lnTo>
                <a:lnTo>
                  <a:pt x="1256" y="719"/>
                </a:lnTo>
                <a:lnTo>
                  <a:pt x="1258" y="719"/>
                </a:lnTo>
                <a:lnTo>
                  <a:pt x="1260" y="719"/>
                </a:lnTo>
                <a:lnTo>
                  <a:pt x="1262" y="720"/>
                </a:lnTo>
                <a:lnTo>
                  <a:pt x="1264" y="720"/>
                </a:lnTo>
                <a:lnTo>
                  <a:pt x="1267" y="720"/>
                </a:lnTo>
                <a:lnTo>
                  <a:pt x="1269" y="720"/>
                </a:lnTo>
                <a:lnTo>
                  <a:pt x="1271" y="720"/>
                </a:lnTo>
                <a:lnTo>
                  <a:pt x="1273" y="720"/>
                </a:lnTo>
                <a:lnTo>
                  <a:pt x="1275" y="720"/>
                </a:lnTo>
                <a:lnTo>
                  <a:pt x="1278" y="720"/>
                </a:lnTo>
                <a:lnTo>
                  <a:pt x="1280" y="720"/>
                </a:lnTo>
                <a:lnTo>
                  <a:pt x="1281" y="720"/>
                </a:lnTo>
                <a:lnTo>
                  <a:pt x="1283" y="720"/>
                </a:lnTo>
                <a:lnTo>
                  <a:pt x="1286" y="720"/>
                </a:lnTo>
                <a:lnTo>
                  <a:pt x="1288" y="720"/>
                </a:lnTo>
                <a:lnTo>
                  <a:pt x="1290" y="720"/>
                </a:lnTo>
                <a:lnTo>
                  <a:pt x="1292" y="720"/>
                </a:lnTo>
                <a:lnTo>
                  <a:pt x="1294" y="720"/>
                </a:lnTo>
                <a:lnTo>
                  <a:pt x="1297" y="720"/>
                </a:lnTo>
                <a:lnTo>
                  <a:pt x="1299" y="720"/>
                </a:lnTo>
                <a:lnTo>
                  <a:pt x="1301" y="720"/>
                </a:lnTo>
                <a:lnTo>
                  <a:pt x="1303" y="720"/>
                </a:lnTo>
                <a:lnTo>
                  <a:pt x="1305" y="720"/>
                </a:lnTo>
                <a:lnTo>
                  <a:pt x="1307" y="720"/>
                </a:lnTo>
                <a:lnTo>
                  <a:pt x="1309" y="719"/>
                </a:lnTo>
                <a:lnTo>
                  <a:pt x="1311" y="718"/>
                </a:lnTo>
                <a:lnTo>
                  <a:pt x="1314" y="718"/>
                </a:lnTo>
                <a:lnTo>
                  <a:pt x="1316" y="717"/>
                </a:lnTo>
                <a:lnTo>
                  <a:pt x="1318" y="716"/>
                </a:lnTo>
                <a:lnTo>
                  <a:pt x="1320" y="714"/>
                </a:lnTo>
                <a:lnTo>
                  <a:pt x="1322" y="712"/>
                </a:lnTo>
                <a:lnTo>
                  <a:pt x="1324" y="708"/>
                </a:lnTo>
                <a:lnTo>
                  <a:pt x="1326" y="703"/>
                </a:lnTo>
                <a:lnTo>
                  <a:pt x="1328" y="695"/>
                </a:lnTo>
                <a:lnTo>
                  <a:pt x="1330" y="685"/>
                </a:lnTo>
                <a:lnTo>
                  <a:pt x="1333" y="672"/>
                </a:lnTo>
                <a:lnTo>
                  <a:pt x="1335" y="655"/>
                </a:lnTo>
                <a:lnTo>
                  <a:pt x="1337" y="636"/>
                </a:lnTo>
                <a:lnTo>
                  <a:pt x="1339" y="613"/>
                </a:lnTo>
                <a:lnTo>
                  <a:pt x="1341" y="588"/>
                </a:lnTo>
                <a:lnTo>
                  <a:pt x="1344" y="562"/>
                </a:lnTo>
                <a:lnTo>
                  <a:pt x="1345" y="534"/>
                </a:lnTo>
                <a:lnTo>
                  <a:pt x="1347" y="508"/>
                </a:lnTo>
                <a:lnTo>
                  <a:pt x="1350" y="481"/>
                </a:lnTo>
                <a:lnTo>
                  <a:pt x="1352" y="457"/>
                </a:lnTo>
                <a:lnTo>
                  <a:pt x="1354" y="436"/>
                </a:lnTo>
                <a:lnTo>
                  <a:pt x="1356" y="418"/>
                </a:lnTo>
                <a:lnTo>
                  <a:pt x="1358" y="404"/>
                </a:lnTo>
                <a:lnTo>
                  <a:pt x="1361" y="395"/>
                </a:lnTo>
                <a:lnTo>
                  <a:pt x="1363" y="391"/>
                </a:lnTo>
                <a:lnTo>
                  <a:pt x="1365" y="392"/>
                </a:lnTo>
                <a:lnTo>
                  <a:pt x="1366" y="398"/>
                </a:lnTo>
                <a:lnTo>
                  <a:pt x="1369" y="409"/>
                </a:lnTo>
                <a:lnTo>
                  <a:pt x="1371" y="427"/>
                </a:lnTo>
                <a:lnTo>
                  <a:pt x="1373" y="448"/>
                </a:lnTo>
                <a:lnTo>
                  <a:pt x="1375" y="472"/>
                </a:lnTo>
                <a:lnTo>
                  <a:pt x="1378" y="499"/>
                </a:lnTo>
                <a:lnTo>
                  <a:pt x="1380" y="526"/>
                </a:lnTo>
                <a:lnTo>
                  <a:pt x="1382" y="553"/>
                </a:lnTo>
                <a:lnTo>
                  <a:pt x="1384" y="578"/>
                </a:lnTo>
                <a:lnTo>
                  <a:pt x="1386" y="600"/>
                </a:lnTo>
                <a:lnTo>
                  <a:pt x="1388" y="621"/>
                </a:lnTo>
                <a:lnTo>
                  <a:pt x="1390" y="637"/>
                </a:lnTo>
                <a:lnTo>
                  <a:pt x="1392" y="652"/>
                </a:lnTo>
                <a:lnTo>
                  <a:pt x="1394" y="663"/>
                </a:lnTo>
                <a:lnTo>
                  <a:pt x="1397" y="672"/>
                </a:lnTo>
                <a:lnTo>
                  <a:pt x="1399" y="679"/>
                </a:lnTo>
                <a:lnTo>
                  <a:pt x="1401" y="685"/>
                </a:lnTo>
                <a:lnTo>
                  <a:pt x="1403" y="690"/>
                </a:lnTo>
                <a:lnTo>
                  <a:pt x="1405" y="693"/>
                </a:lnTo>
                <a:lnTo>
                  <a:pt x="1408" y="696"/>
                </a:lnTo>
                <a:lnTo>
                  <a:pt x="1410" y="698"/>
                </a:lnTo>
                <a:lnTo>
                  <a:pt x="1411" y="700"/>
                </a:lnTo>
                <a:lnTo>
                  <a:pt x="1414" y="701"/>
                </a:lnTo>
                <a:lnTo>
                  <a:pt x="1416" y="703"/>
                </a:lnTo>
                <a:lnTo>
                  <a:pt x="1418" y="704"/>
                </a:lnTo>
                <a:lnTo>
                  <a:pt x="1420" y="705"/>
                </a:lnTo>
                <a:lnTo>
                  <a:pt x="1422" y="706"/>
                </a:lnTo>
                <a:lnTo>
                  <a:pt x="1425" y="707"/>
                </a:lnTo>
                <a:lnTo>
                  <a:pt x="1427" y="707"/>
                </a:lnTo>
                <a:lnTo>
                  <a:pt x="1429" y="708"/>
                </a:lnTo>
                <a:lnTo>
                  <a:pt x="1431" y="709"/>
                </a:lnTo>
                <a:lnTo>
                  <a:pt x="1433" y="709"/>
                </a:lnTo>
                <a:lnTo>
                  <a:pt x="1435" y="710"/>
                </a:lnTo>
                <a:lnTo>
                  <a:pt x="1437" y="711"/>
                </a:lnTo>
                <a:lnTo>
                  <a:pt x="1439" y="712"/>
                </a:lnTo>
                <a:lnTo>
                  <a:pt x="1441" y="713"/>
                </a:lnTo>
                <a:lnTo>
                  <a:pt x="1444" y="714"/>
                </a:lnTo>
                <a:lnTo>
                  <a:pt x="1446" y="715"/>
                </a:lnTo>
                <a:lnTo>
                  <a:pt x="1448" y="716"/>
                </a:lnTo>
                <a:lnTo>
                  <a:pt x="1450" y="717"/>
                </a:lnTo>
                <a:lnTo>
                  <a:pt x="1452" y="718"/>
                </a:lnTo>
                <a:lnTo>
                  <a:pt x="1454" y="718"/>
                </a:lnTo>
                <a:lnTo>
                  <a:pt x="1456" y="719"/>
                </a:lnTo>
                <a:lnTo>
                  <a:pt x="1458" y="720"/>
                </a:lnTo>
                <a:lnTo>
                  <a:pt x="1461" y="720"/>
                </a:lnTo>
                <a:lnTo>
                  <a:pt x="1463" y="721"/>
                </a:lnTo>
                <a:lnTo>
                  <a:pt x="1465" y="721"/>
                </a:lnTo>
                <a:lnTo>
                  <a:pt x="1467" y="722"/>
                </a:lnTo>
                <a:lnTo>
                  <a:pt x="1469" y="722"/>
                </a:lnTo>
                <a:lnTo>
                  <a:pt x="1472" y="722"/>
                </a:lnTo>
                <a:lnTo>
                  <a:pt x="1474" y="723"/>
                </a:lnTo>
                <a:lnTo>
                  <a:pt x="1477" y="723"/>
                </a:lnTo>
                <a:lnTo>
                  <a:pt x="1480" y="723"/>
                </a:lnTo>
                <a:lnTo>
                  <a:pt x="1482" y="723"/>
                </a:lnTo>
                <a:lnTo>
                  <a:pt x="1484" y="723"/>
                </a:lnTo>
                <a:lnTo>
                  <a:pt x="1486" y="722"/>
                </a:lnTo>
                <a:lnTo>
                  <a:pt x="1488" y="722"/>
                </a:lnTo>
                <a:lnTo>
                  <a:pt x="1491" y="722"/>
                </a:lnTo>
                <a:lnTo>
                  <a:pt x="1493" y="721"/>
                </a:lnTo>
                <a:lnTo>
                  <a:pt x="1495" y="721"/>
                </a:lnTo>
                <a:lnTo>
                  <a:pt x="1497" y="720"/>
                </a:lnTo>
                <a:lnTo>
                  <a:pt x="1499" y="720"/>
                </a:lnTo>
                <a:lnTo>
                  <a:pt x="1501" y="719"/>
                </a:lnTo>
                <a:lnTo>
                  <a:pt x="1503" y="718"/>
                </a:lnTo>
                <a:lnTo>
                  <a:pt x="1505" y="718"/>
                </a:lnTo>
                <a:lnTo>
                  <a:pt x="1508" y="717"/>
                </a:lnTo>
                <a:lnTo>
                  <a:pt x="1510" y="717"/>
                </a:lnTo>
                <a:lnTo>
                  <a:pt x="1512" y="716"/>
                </a:lnTo>
                <a:lnTo>
                  <a:pt x="1514" y="716"/>
                </a:lnTo>
                <a:lnTo>
                  <a:pt x="1516" y="716"/>
                </a:lnTo>
                <a:lnTo>
                  <a:pt x="1518" y="716"/>
                </a:lnTo>
                <a:lnTo>
                  <a:pt x="1520" y="716"/>
                </a:lnTo>
                <a:lnTo>
                  <a:pt x="1522" y="717"/>
                </a:lnTo>
                <a:lnTo>
                  <a:pt x="1524" y="718"/>
                </a:lnTo>
                <a:lnTo>
                  <a:pt x="1527" y="718"/>
                </a:lnTo>
                <a:lnTo>
                  <a:pt x="1529" y="719"/>
                </a:lnTo>
                <a:lnTo>
                  <a:pt x="1531" y="720"/>
                </a:lnTo>
                <a:lnTo>
                  <a:pt x="1533" y="721"/>
                </a:lnTo>
                <a:lnTo>
                  <a:pt x="1536" y="722"/>
                </a:lnTo>
                <a:lnTo>
                  <a:pt x="1538" y="723"/>
                </a:lnTo>
                <a:lnTo>
                  <a:pt x="1540" y="724"/>
                </a:lnTo>
                <a:lnTo>
                  <a:pt x="1541" y="724"/>
                </a:lnTo>
                <a:lnTo>
                  <a:pt x="1544" y="725"/>
                </a:lnTo>
                <a:lnTo>
                  <a:pt x="1546" y="725"/>
                </a:lnTo>
                <a:lnTo>
                  <a:pt x="1548" y="726"/>
                </a:lnTo>
                <a:lnTo>
                  <a:pt x="1550" y="726"/>
                </a:lnTo>
                <a:lnTo>
                  <a:pt x="1555" y="726"/>
                </a:lnTo>
                <a:lnTo>
                  <a:pt x="1557" y="726"/>
                </a:lnTo>
                <a:lnTo>
                  <a:pt x="1559" y="725"/>
                </a:lnTo>
                <a:lnTo>
                  <a:pt x="1561" y="725"/>
                </a:lnTo>
                <a:lnTo>
                  <a:pt x="1563" y="725"/>
                </a:lnTo>
                <a:lnTo>
                  <a:pt x="1565" y="726"/>
                </a:lnTo>
                <a:lnTo>
                  <a:pt x="1567" y="726"/>
                </a:lnTo>
                <a:lnTo>
                  <a:pt x="1569" y="726"/>
                </a:lnTo>
                <a:lnTo>
                  <a:pt x="1572" y="726"/>
                </a:lnTo>
                <a:lnTo>
                  <a:pt x="1574" y="726"/>
                </a:lnTo>
                <a:lnTo>
                  <a:pt x="1576" y="726"/>
                </a:lnTo>
                <a:lnTo>
                  <a:pt x="1580" y="726"/>
                </a:lnTo>
                <a:lnTo>
                  <a:pt x="1583" y="726"/>
                </a:lnTo>
                <a:lnTo>
                  <a:pt x="1584" y="726"/>
                </a:lnTo>
                <a:lnTo>
                  <a:pt x="1586" y="726"/>
                </a:lnTo>
                <a:lnTo>
                  <a:pt x="1588" y="725"/>
                </a:lnTo>
                <a:lnTo>
                  <a:pt x="1591" y="725"/>
                </a:lnTo>
                <a:lnTo>
                  <a:pt x="1593" y="725"/>
                </a:lnTo>
                <a:lnTo>
                  <a:pt x="1595" y="724"/>
                </a:lnTo>
                <a:lnTo>
                  <a:pt x="1597" y="723"/>
                </a:lnTo>
                <a:lnTo>
                  <a:pt x="1599" y="723"/>
                </a:lnTo>
                <a:lnTo>
                  <a:pt x="1602" y="722"/>
                </a:lnTo>
                <a:lnTo>
                  <a:pt x="1604" y="721"/>
                </a:lnTo>
                <a:lnTo>
                  <a:pt x="1605" y="720"/>
                </a:lnTo>
                <a:lnTo>
                  <a:pt x="1608" y="718"/>
                </a:lnTo>
                <a:lnTo>
                  <a:pt x="1610" y="717"/>
                </a:lnTo>
                <a:lnTo>
                  <a:pt x="1612" y="715"/>
                </a:lnTo>
                <a:lnTo>
                  <a:pt x="1614" y="713"/>
                </a:lnTo>
                <a:lnTo>
                  <a:pt x="1616" y="712"/>
                </a:lnTo>
                <a:lnTo>
                  <a:pt x="1619" y="710"/>
                </a:lnTo>
                <a:lnTo>
                  <a:pt x="1621" y="709"/>
                </a:lnTo>
                <a:lnTo>
                  <a:pt x="1623" y="707"/>
                </a:lnTo>
                <a:lnTo>
                  <a:pt x="1625" y="706"/>
                </a:lnTo>
                <a:lnTo>
                  <a:pt x="1627" y="705"/>
                </a:lnTo>
                <a:lnTo>
                  <a:pt x="1629" y="705"/>
                </a:lnTo>
                <a:lnTo>
                  <a:pt x="1631" y="704"/>
                </a:lnTo>
                <a:lnTo>
                  <a:pt x="1633" y="704"/>
                </a:lnTo>
                <a:lnTo>
                  <a:pt x="1635" y="704"/>
                </a:lnTo>
                <a:lnTo>
                  <a:pt x="1638" y="704"/>
                </a:lnTo>
                <a:lnTo>
                  <a:pt x="1640" y="705"/>
                </a:lnTo>
                <a:lnTo>
                  <a:pt x="1642" y="706"/>
                </a:lnTo>
                <a:lnTo>
                  <a:pt x="1644" y="708"/>
                </a:lnTo>
                <a:lnTo>
                  <a:pt x="1646" y="709"/>
                </a:lnTo>
                <a:lnTo>
                  <a:pt x="1648" y="711"/>
                </a:lnTo>
                <a:lnTo>
                  <a:pt x="1650" y="712"/>
                </a:lnTo>
                <a:lnTo>
                  <a:pt x="1652" y="714"/>
                </a:lnTo>
                <a:lnTo>
                  <a:pt x="1655" y="716"/>
                </a:lnTo>
                <a:lnTo>
                  <a:pt x="1657" y="717"/>
                </a:lnTo>
                <a:lnTo>
                  <a:pt x="1659" y="718"/>
                </a:lnTo>
                <a:lnTo>
                  <a:pt x="1661" y="720"/>
                </a:lnTo>
                <a:lnTo>
                  <a:pt x="1663" y="721"/>
                </a:lnTo>
                <a:lnTo>
                  <a:pt x="1666" y="722"/>
                </a:lnTo>
                <a:lnTo>
                  <a:pt x="1668" y="723"/>
                </a:lnTo>
                <a:lnTo>
                  <a:pt x="1670" y="723"/>
                </a:lnTo>
                <a:lnTo>
                  <a:pt x="1671" y="724"/>
                </a:lnTo>
                <a:lnTo>
                  <a:pt x="1674" y="724"/>
                </a:lnTo>
                <a:lnTo>
                  <a:pt x="1676" y="724"/>
                </a:lnTo>
                <a:lnTo>
                  <a:pt x="1678" y="724"/>
                </a:lnTo>
                <a:lnTo>
                  <a:pt x="1680" y="725"/>
                </a:lnTo>
                <a:lnTo>
                  <a:pt x="1683" y="725"/>
                </a:lnTo>
                <a:lnTo>
                  <a:pt x="1685" y="725"/>
                </a:lnTo>
                <a:lnTo>
                  <a:pt x="1687" y="726"/>
                </a:lnTo>
                <a:lnTo>
                  <a:pt x="1689" y="726"/>
                </a:lnTo>
                <a:lnTo>
                  <a:pt x="1691" y="726"/>
                </a:lnTo>
                <a:lnTo>
                  <a:pt x="1695" y="726"/>
                </a:lnTo>
                <a:lnTo>
                  <a:pt x="1697" y="726"/>
                </a:lnTo>
                <a:lnTo>
                  <a:pt x="1699" y="725"/>
                </a:lnTo>
                <a:lnTo>
                  <a:pt x="1702" y="725"/>
                </a:lnTo>
                <a:lnTo>
                  <a:pt x="1704" y="725"/>
                </a:lnTo>
                <a:lnTo>
                  <a:pt x="1706" y="724"/>
                </a:lnTo>
                <a:lnTo>
                  <a:pt x="1708" y="723"/>
                </a:lnTo>
                <a:lnTo>
                  <a:pt x="1710" y="723"/>
                </a:lnTo>
                <a:lnTo>
                  <a:pt x="1713" y="722"/>
                </a:lnTo>
                <a:lnTo>
                  <a:pt x="1714" y="722"/>
                </a:lnTo>
                <a:lnTo>
                  <a:pt x="1716" y="721"/>
                </a:lnTo>
                <a:lnTo>
                  <a:pt x="1719" y="721"/>
                </a:lnTo>
                <a:lnTo>
                  <a:pt x="1721" y="721"/>
                </a:lnTo>
                <a:lnTo>
                  <a:pt x="1723" y="721"/>
                </a:lnTo>
                <a:lnTo>
                  <a:pt x="1725" y="722"/>
                </a:lnTo>
                <a:lnTo>
                  <a:pt x="1727" y="722"/>
                </a:lnTo>
                <a:lnTo>
                  <a:pt x="1730" y="722"/>
                </a:lnTo>
                <a:lnTo>
                  <a:pt x="1732" y="723"/>
                </a:lnTo>
                <a:lnTo>
                  <a:pt x="1734" y="724"/>
                </a:lnTo>
                <a:lnTo>
                  <a:pt x="1735" y="725"/>
                </a:lnTo>
                <a:lnTo>
                  <a:pt x="1738" y="725"/>
                </a:lnTo>
                <a:lnTo>
                  <a:pt x="1740" y="726"/>
                </a:lnTo>
                <a:lnTo>
                  <a:pt x="1742" y="727"/>
                </a:lnTo>
                <a:lnTo>
                  <a:pt x="1744" y="727"/>
                </a:lnTo>
                <a:lnTo>
                  <a:pt x="1746" y="727"/>
                </a:lnTo>
                <a:lnTo>
                  <a:pt x="1749" y="727"/>
                </a:lnTo>
                <a:lnTo>
                  <a:pt x="1751" y="727"/>
                </a:lnTo>
                <a:lnTo>
                  <a:pt x="1753" y="727"/>
                </a:lnTo>
                <a:lnTo>
                  <a:pt x="1755" y="727"/>
                </a:lnTo>
                <a:lnTo>
                  <a:pt x="1757" y="726"/>
                </a:lnTo>
                <a:lnTo>
                  <a:pt x="1759" y="726"/>
                </a:lnTo>
                <a:lnTo>
                  <a:pt x="1761" y="725"/>
                </a:lnTo>
                <a:lnTo>
                  <a:pt x="1763" y="724"/>
                </a:lnTo>
                <a:lnTo>
                  <a:pt x="1766" y="723"/>
                </a:lnTo>
                <a:lnTo>
                  <a:pt x="1768" y="722"/>
                </a:lnTo>
                <a:lnTo>
                  <a:pt x="1770" y="721"/>
                </a:lnTo>
                <a:lnTo>
                  <a:pt x="1772" y="720"/>
                </a:lnTo>
                <a:lnTo>
                  <a:pt x="1774" y="720"/>
                </a:lnTo>
                <a:lnTo>
                  <a:pt x="1777" y="719"/>
                </a:lnTo>
                <a:lnTo>
                  <a:pt x="1778" y="719"/>
                </a:lnTo>
                <a:lnTo>
                  <a:pt x="1780" y="718"/>
                </a:lnTo>
                <a:lnTo>
                  <a:pt x="1782" y="718"/>
                </a:lnTo>
                <a:lnTo>
                  <a:pt x="1785" y="718"/>
                </a:lnTo>
                <a:lnTo>
                  <a:pt x="1787" y="717"/>
                </a:lnTo>
                <a:lnTo>
                  <a:pt x="1789" y="717"/>
                </a:lnTo>
                <a:lnTo>
                  <a:pt x="1791" y="717"/>
                </a:lnTo>
                <a:lnTo>
                  <a:pt x="1793" y="717"/>
                </a:lnTo>
                <a:lnTo>
                  <a:pt x="1796" y="716"/>
                </a:lnTo>
                <a:lnTo>
                  <a:pt x="1798" y="716"/>
                </a:lnTo>
                <a:lnTo>
                  <a:pt x="1800" y="714"/>
                </a:lnTo>
                <a:lnTo>
                  <a:pt x="1802" y="711"/>
                </a:lnTo>
                <a:lnTo>
                  <a:pt x="1804" y="708"/>
                </a:lnTo>
                <a:lnTo>
                  <a:pt x="1806" y="704"/>
                </a:lnTo>
                <a:lnTo>
                  <a:pt x="1808" y="699"/>
                </a:lnTo>
                <a:lnTo>
                  <a:pt x="1810" y="693"/>
                </a:lnTo>
                <a:lnTo>
                  <a:pt x="1813" y="686"/>
                </a:lnTo>
                <a:lnTo>
                  <a:pt x="1815" y="678"/>
                </a:lnTo>
                <a:lnTo>
                  <a:pt x="1817" y="670"/>
                </a:lnTo>
                <a:lnTo>
                  <a:pt x="1819" y="661"/>
                </a:lnTo>
                <a:lnTo>
                  <a:pt x="1821" y="652"/>
                </a:lnTo>
                <a:lnTo>
                  <a:pt x="1823" y="643"/>
                </a:lnTo>
                <a:lnTo>
                  <a:pt x="1825" y="633"/>
                </a:lnTo>
                <a:lnTo>
                  <a:pt x="1827" y="623"/>
                </a:lnTo>
                <a:lnTo>
                  <a:pt x="1829" y="613"/>
                </a:lnTo>
                <a:lnTo>
                  <a:pt x="1832" y="603"/>
                </a:lnTo>
                <a:lnTo>
                  <a:pt x="1834" y="593"/>
                </a:lnTo>
                <a:lnTo>
                  <a:pt x="1836" y="584"/>
                </a:lnTo>
                <a:lnTo>
                  <a:pt x="1838" y="576"/>
                </a:lnTo>
                <a:lnTo>
                  <a:pt x="1841" y="569"/>
                </a:lnTo>
                <a:lnTo>
                  <a:pt x="1843" y="562"/>
                </a:lnTo>
                <a:lnTo>
                  <a:pt x="1844" y="556"/>
                </a:lnTo>
                <a:lnTo>
                  <a:pt x="1846" y="552"/>
                </a:lnTo>
                <a:lnTo>
                  <a:pt x="1849" y="549"/>
                </a:lnTo>
                <a:lnTo>
                  <a:pt x="1851" y="548"/>
                </a:lnTo>
                <a:lnTo>
                  <a:pt x="1853" y="549"/>
                </a:lnTo>
                <a:lnTo>
                  <a:pt x="1855" y="552"/>
                </a:lnTo>
                <a:lnTo>
                  <a:pt x="1857" y="557"/>
                </a:lnTo>
                <a:lnTo>
                  <a:pt x="1860" y="565"/>
                </a:lnTo>
                <a:lnTo>
                  <a:pt x="1862" y="574"/>
                </a:lnTo>
                <a:lnTo>
                  <a:pt x="1864" y="586"/>
                </a:lnTo>
                <a:lnTo>
                  <a:pt x="1866" y="598"/>
                </a:lnTo>
                <a:lnTo>
                  <a:pt x="1868" y="612"/>
                </a:lnTo>
                <a:lnTo>
                  <a:pt x="1870" y="626"/>
                </a:lnTo>
                <a:lnTo>
                  <a:pt x="1872" y="640"/>
                </a:lnTo>
                <a:lnTo>
                  <a:pt x="1874" y="653"/>
                </a:lnTo>
                <a:lnTo>
                  <a:pt x="1877" y="666"/>
                </a:lnTo>
                <a:lnTo>
                  <a:pt x="1879" y="677"/>
                </a:lnTo>
                <a:lnTo>
                  <a:pt x="1881" y="686"/>
                </a:lnTo>
                <a:lnTo>
                  <a:pt x="1883" y="694"/>
                </a:lnTo>
                <a:lnTo>
                  <a:pt x="1885" y="700"/>
                </a:lnTo>
                <a:lnTo>
                  <a:pt x="1887" y="706"/>
                </a:lnTo>
                <a:lnTo>
                  <a:pt x="1889" y="710"/>
                </a:lnTo>
                <a:lnTo>
                  <a:pt x="1891" y="713"/>
                </a:lnTo>
                <a:lnTo>
                  <a:pt x="1893" y="716"/>
                </a:lnTo>
                <a:lnTo>
                  <a:pt x="1896" y="718"/>
                </a:lnTo>
                <a:lnTo>
                  <a:pt x="1898" y="719"/>
                </a:lnTo>
                <a:lnTo>
                  <a:pt x="1900" y="720"/>
                </a:lnTo>
                <a:lnTo>
                  <a:pt x="1902" y="720"/>
                </a:lnTo>
                <a:lnTo>
                  <a:pt x="1904" y="720"/>
                </a:lnTo>
                <a:lnTo>
                  <a:pt x="1907" y="721"/>
                </a:lnTo>
                <a:lnTo>
                  <a:pt x="1908" y="721"/>
                </a:lnTo>
                <a:lnTo>
                  <a:pt x="1910" y="720"/>
                </a:lnTo>
                <a:lnTo>
                  <a:pt x="1913" y="720"/>
                </a:lnTo>
                <a:lnTo>
                  <a:pt x="1915" y="720"/>
                </a:lnTo>
                <a:lnTo>
                  <a:pt x="1917" y="719"/>
                </a:lnTo>
                <a:lnTo>
                  <a:pt x="1919" y="719"/>
                </a:lnTo>
                <a:lnTo>
                  <a:pt x="1921" y="719"/>
                </a:lnTo>
                <a:lnTo>
                  <a:pt x="1924" y="718"/>
                </a:lnTo>
                <a:lnTo>
                  <a:pt x="1926" y="718"/>
                </a:lnTo>
                <a:lnTo>
                  <a:pt x="1928" y="718"/>
                </a:lnTo>
                <a:lnTo>
                  <a:pt x="1930" y="717"/>
                </a:lnTo>
                <a:lnTo>
                  <a:pt x="1932" y="717"/>
                </a:lnTo>
                <a:lnTo>
                  <a:pt x="1934" y="716"/>
                </a:lnTo>
                <a:lnTo>
                  <a:pt x="1936" y="716"/>
                </a:lnTo>
                <a:lnTo>
                  <a:pt x="1938" y="715"/>
                </a:lnTo>
                <a:lnTo>
                  <a:pt x="1940" y="714"/>
                </a:lnTo>
                <a:lnTo>
                  <a:pt x="1943" y="714"/>
                </a:lnTo>
                <a:lnTo>
                  <a:pt x="1945" y="713"/>
                </a:lnTo>
                <a:lnTo>
                  <a:pt x="1947" y="712"/>
                </a:lnTo>
                <a:lnTo>
                  <a:pt x="1949" y="711"/>
                </a:lnTo>
                <a:lnTo>
                  <a:pt x="1951" y="711"/>
                </a:lnTo>
                <a:lnTo>
                  <a:pt x="1953" y="710"/>
                </a:lnTo>
                <a:lnTo>
                  <a:pt x="1955" y="709"/>
                </a:lnTo>
                <a:lnTo>
                  <a:pt x="1957" y="709"/>
                </a:lnTo>
                <a:lnTo>
                  <a:pt x="1960" y="709"/>
                </a:lnTo>
                <a:lnTo>
                  <a:pt x="1962" y="710"/>
                </a:lnTo>
                <a:lnTo>
                  <a:pt x="1964" y="711"/>
                </a:lnTo>
                <a:lnTo>
                  <a:pt x="1966" y="712"/>
                </a:lnTo>
                <a:lnTo>
                  <a:pt x="1968" y="713"/>
                </a:lnTo>
                <a:lnTo>
                  <a:pt x="1971" y="715"/>
                </a:lnTo>
                <a:lnTo>
                  <a:pt x="1973" y="717"/>
                </a:lnTo>
                <a:lnTo>
                  <a:pt x="1974" y="719"/>
                </a:lnTo>
                <a:lnTo>
                  <a:pt x="1976" y="722"/>
                </a:lnTo>
                <a:lnTo>
                  <a:pt x="1979" y="723"/>
                </a:lnTo>
                <a:lnTo>
                  <a:pt x="1981" y="725"/>
                </a:lnTo>
                <a:lnTo>
                  <a:pt x="1983" y="727"/>
                </a:lnTo>
                <a:lnTo>
                  <a:pt x="1985" y="728"/>
                </a:lnTo>
                <a:lnTo>
                  <a:pt x="1988" y="729"/>
                </a:lnTo>
                <a:lnTo>
                  <a:pt x="1990" y="730"/>
                </a:lnTo>
                <a:lnTo>
                  <a:pt x="1992" y="731"/>
                </a:lnTo>
                <a:lnTo>
                  <a:pt x="1994" y="731"/>
                </a:lnTo>
                <a:lnTo>
                  <a:pt x="1996" y="731"/>
                </a:lnTo>
                <a:lnTo>
                  <a:pt x="1998" y="732"/>
                </a:lnTo>
                <a:lnTo>
                  <a:pt x="2000" y="733"/>
                </a:lnTo>
                <a:lnTo>
                  <a:pt x="2002" y="733"/>
                </a:lnTo>
                <a:lnTo>
                  <a:pt x="2004" y="733"/>
                </a:lnTo>
                <a:lnTo>
                  <a:pt x="2007" y="733"/>
                </a:lnTo>
                <a:lnTo>
                  <a:pt x="2009" y="733"/>
                </a:lnTo>
                <a:lnTo>
                  <a:pt x="2011" y="733"/>
                </a:lnTo>
                <a:lnTo>
                  <a:pt x="2013" y="734"/>
                </a:lnTo>
                <a:lnTo>
                  <a:pt x="2015" y="734"/>
                </a:lnTo>
                <a:lnTo>
                  <a:pt x="2017" y="734"/>
                </a:lnTo>
                <a:lnTo>
                  <a:pt x="2019" y="733"/>
                </a:lnTo>
                <a:lnTo>
                  <a:pt x="2021" y="733"/>
                </a:lnTo>
                <a:lnTo>
                  <a:pt x="2024" y="733"/>
                </a:lnTo>
                <a:lnTo>
                  <a:pt x="2026" y="732"/>
                </a:lnTo>
                <a:lnTo>
                  <a:pt x="2028" y="732"/>
                </a:lnTo>
                <a:lnTo>
                  <a:pt x="2030" y="731"/>
                </a:lnTo>
                <a:lnTo>
                  <a:pt x="2032" y="731"/>
                </a:lnTo>
                <a:lnTo>
                  <a:pt x="2035" y="730"/>
                </a:lnTo>
                <a:lnTo>
                  <a:pt x="2037" y="729"/>
                </a:lnTo>
                <a:lnTo>
                  <a:pt x="2038" y="728"/>
                </a:lnTo>
                <a:lnTo>
                  <a:pt x="2040" y="726"/>
                </a:lnTo>
                <a:lnTo>
                  <a:pt x="2043" y="725"/>
                </a:lnTo>
                <a:lnTo>
                  <a:pt x="2045" y="723"/>
                </a:lnTo>
                <a:lnTo>
                  <a:pt x="2047" y="721"/>
                </a:lnTo>
                <a:lnTo>
                  <a:pt x="2049" y="719"/>
                </a:lnTo>
                <a:lnTo>
                  <a:pt x="2051" y="716"/>
                </a:lnTo>
                <a:lnTo>
                  <a:pt x="2054" y="713"/>
                </a:lnTo>
                <a:lnTo>
                  <a:pt x="2056" y="710"/>
                </a:lnTo>
                <a:lnTo>
                  <a:pt x="2058" y="707"/>
                </a:lnTo>
                <a:lnTo>
                  <a:pt x="2060" y="704"/>
                </a:lnTo>
                <a:lnTo>
                  <a:pt x="2062" y="701"/>
                </a:lnTo>
                <a:lnTo>
                  <a:pt x="2064" y="698"/>
                </a:lnTo>
                <a:lnTo>
                  <a:pt x="2066" y="694"/>
                </a:lnTo>
                <a:lnTo>
                  <a:pt x="2068" y="691"/>
                </a:lnTo>
                <a:lnTo>
                  <a:pt x="2071" y="688"/>
                </a:lnTo>
                <a:lnTo>
                  <a:pt x="2073" y="686"/>
                </a:lnTo>
                <a:lnTo>
                  <a:pt x="2075" y="684"/>
                </a:lnTo>
                <a:lnTo>
                  <a:pt x="2077" y="683"/>
                </a:lnTo>
                <a:lnTo>
                  <a:pt x="2079" y="682"/>
                </a:lnTo>
                <a:lnTo>
                  <a:pt x="2082" y="682"/>
                </a:lnTo>
                <a:lnTo>
                  <a:pt x="2083" y="683"/>
                </a:lnTo>
                <a:lnTo>
                  <a:pt x="2085" y="684"/>
                </a:lnTo>
                <a:lnTo>
                  <a:pt x="2087" y="686"/>
                </a:lnTo>
                <a:lnTo>
                  <a:pt x="2090" y="688"/>
                </a:lnTo>
                <a:lnTo>
                  <a:pt x="2092" y="691"/>
                </a:lnTo>
                <a:lnTo>
                  <a:pt x="2094" y="694"/>
                </a:lnTo>
                <a:lnTo>
                  <a:pt x="2096" y="697"/>
                </a:lnTo>
                <a:lnTo>
                  <a:pt x="2098" y="701"/>
                </a:lnTo>
                <a:lnTo>
                  <a:pt x="2101" y="704"/>
                </a:lnTo>
                <a:lnTo>
                  <a:pt x="2103" y="708"/>
                </a:lnTo>
                <a:lnTo>
                  <a:pt x="2104" y="711"/>
                </a:lnTo>
                <a:lnTo>
                  <a:pt x="2107" y="713"/>
                </a:lnTo>
                <a:lnTo>
                  <a:pt x="2109" y="716"/>
                </a:lnTo>
                <a:lnTo>
                  <a:pt x="2111" y="718"/>
                </a:lnTo>
                <a:lnTo>
                  <a:pt x="2113" y="720"/>
                </a:lnTo>
                <a:lnTo>
                  <a:pt x="2115" y="722"/>
                </a:lnTo>
                <a:lnTo>
                  <a:pt x="2118" y="723"/>
                </a:lnTo>
                <a:lnTo>
                  <a:pt x="2120" y="725"/>
                </a:lnTo>
                <a:lnTo>
                  <a:pt x="2122" y="726"/>
                </a:lnTo>
                <a:lnTo>
                  <a:pt x="2124" y="727"/>
                </a:lnTo>
                <a:lnTo>
                  <a:pt x="2126" y="728"/>
                </a:lnTo>
                <a:lnTo>
                  <a:pt x="2128" y="728"/>
                </a:lnTo>
                <a:lnTo>
                  <a:pt x="2130" y="729"/>
                </a:lnTo>
                <a:lnTo>
                  <a:pt x="2132" y="729"/>
                </a:lnTo>
                <a:lnTo>
                  <a:pt x="2134" y="729"/>
                </a:lnTo>
                <a:lnTo>
                  <a:pt x="2137" y="729"/>
                </a:lnTo>
                <a:lnTo>
                  <a:pt x="2139" y="730"/>
                </a:lnTo>
                <a:lnTo>
                  <a:pt x="2141" y="730"/>
                </a:lnTo>
                <a:lnTo>
                  <a:pt x="2143" y="730"/>
                </a:lnTo>
                <a:lnTo>
                  <a:pt x="2146" y="730"/>
                </a:lnTo>
                <a:lnTo>
                  <a:pt x="2147" y="730"/>
                </a:lnTo>
                <a:lnTo>
                  <a:pt x="2149" y="730"/>
                </a:lnTo>
                <a:lnTo>
                  <a:pt x="2154" y="730"/>
                </a:lnTo>
                <a:lnTo>
                  <a:pt x="2156" y="730"/>
                </a:lnTo>
                <a:lnTo>
                  <a:pt x="2158" y="730"/>
                </a:lnTo>
                <a:lnTo>
                  <a:pt x="2160" y="729"/>
                </a:lnTo>
                <a:lnTo>
                  <a:pt x="2162" y="729"/>
                </a:lnTo>
                <a:lnTo>
                  <a:pt x="2165" y="729"/>
                </a:lnTo>
                <a:lnTo>
                  <a:pt x="2167" y="728"/>
                </a:lnTo>
                <a:lnTo>
                  <a:pt x="2168" y="728"/>
                </a:lnTo>
                <a:lnTo>
                  <a:pt x="2171" y="728"/>
                </a:lnTo>
                <a:lnTo>
                  <a:pt x="2173" y="727"/>
                </a:lnTo>
                <a:lnTo>
                  <a:pt x="2175" y="727"/>
                </a:lnTo>
                <a:lnTo>
                  <a:pt x="2177" y="726"/>
                </a:lnTo>
                <a:lnTo>
                  <a:pt x="2179" y="726"/>
                </a:lnTo>
                <a:lnTo>
                  <a:pt x="2182" y="725"/>
                </a:lnTo>
                <a:lnTo>
                  <a:pt x="2184" y="725"/>
                </a:lnTo>
                <a:lnTo>
                  <a:pt x="2186" y="725"/>
                </a:lnTo>
                <a:lnTo>
                  <a:pt x="2188" y="724"/>
                </a:lnTo>
                <a:lnTo>
                  <a:pt x="2190" y="724"/>
                </a:lnTo>
                <a:lnTo>
                  <a:pt x="2192" y="724"/>
                </a:lnTo>
                <a:lnTo>
                  <a:pt x="2194" y="724"/>
                </a:lnTo>
                <a:lnTo>
                  <a:pt x="2196" y="724"/>
                </a:lnTo>
                <a:lnTo>
                  <a:pt x="2198" y="724"/>
                </a:lnTo>
                <a:lnTo>
                  <a:pt x="2201" y="724"/>
                </a:lnTo>
                <a:lnTo>
                  <a:pt x="2203" y="724"/>
                </a:lnTo>
                <a:lnTo>
                  <a:pt x="2205" y="724"/>
                </a:lnTo>
                <a:lnTo>
                  <a:pt x="2207" y="724"/>
                </a:lnTo>
                <a:lnTo>
                  <a:pt x="2209" y="724"/>
                </a:lnTo>
                <a:lnTo>
                  <a:pt x="2212" y="724"/>
                </a:lnTo>
                <a:lnTo>
                  <a:pt x="2213" y="724"/>
                </a:lnTo>
                <a:lnTo>
                  <a:pt x="2218" y="724"/>
                </a:lnTo>
                <a:lnTo>
                  <a:pt x="2220" y="724"/>
                </a:lnTo>
                <a:lnTo>
                  <a:pt x="2222" y="723"/>
                </a:lnTo>
                <a:lnTo>
                  <a:pt x="2224" y="723"/>
                </a:lnTo>
                <a:lnTo>
                  <a:pt x="2226" y="723"/>
                </a:lnTo>
                <a:lnTo>
                  <a:pt x="2229" y="722"/>
                </a:lnTo>
                <a:lnTo>
                  <a:pt x="2231" y="722"/>
                </a:lnTo>
                <a:lnTo>
                  <a:pt x="2233" y="721"/>
                </a:lnTo>
                <a:lnTo>
                  <a:pt x="2234" y="720"/>
                </a:lnTo>
                <a:lnTo>
                  <a:pt x="2237" y="720"/>
                </a:lnTo>
                <a:lnTo>
                  <a:pt x="2239" y="718"/>
                </a:lnTo>
                <a:lnTo>
                  <a:pt x="2241" y="717"/>
                </a:lnTo>
                <a:lnTo>
                  <a:pt x="2243" y="716"/>
                </a:lnTo>
                <a:lnTo>
                  <a:pt x="2245" y="715"/>
                </a:lnTo>
                <a:lnTo>
                  <a:pt x="2248" y="714"/>
                </a:lnTo>
                <a:lnTo>
                  <a:pt x="2250" y="713"/>
                </a:lnTo>
                <a:lnTo>
                  <a:pt x="2252" y="712"/>
                </a:lnTo>
                <a:lnTo>
                  <a:pt x="2254" y="711"/>
                </a:lnTo>
                <a:lnTo>
                  <a:pt x="2256" y="711"/>
                </a:lnTo>
                <a:lnTo>
                  <a:pt x="2258" y="711"/>
                </a:lnTo>
                <a:lnTo>
                  <a:pt x="2260" y="711"/>
                </a:lnTo>
                <a:lnTo>
                  <a:pt x="2262" y="711"/>
                </a:lnTo>
                <a:lnTo>
                  <a:pt x="2265" y="712"/>
                </a:lnTo>
                <a:lnTo>
                  <a:pt x="2267" y="712"/>
                </a:lnTo>
                <a:lnTo>
                  <a:pt x="2269" y="713"/>
                </a:lnTo>
                <a:lnTo>
                  <a:pt x="2271" y="714"/>
                </a:lnTo>
                <a:lnTo>
                  <a:pt x="2273" y="716"/>
                </a:lnTo>
                <a:lnTo>
                  <a:pt x="2276" y="716"/>
                </a:lnTo>
                <a:lnTo>
                  <a:pt x="2277" y="717"/>
                </a:lnTo>
                <a:lnTo>
                  <a:pt x="2279" y="717"/>
                </a:lnTo>
                <a:lnTo>
                  <a:pt x="2281" y="716"/>
                </a:lnTo>
                <a:lnTo>
                  <a:pt x="2284" y="714"/>
                </a:lnTo>
                <a:lnTo>
                  <a:pt x="2286" y="710"/>
                </a:lnTo>
                <a:lnTo>
                  <a:pt x="2288" y="705"/>
                </a:lnTo>
                <a:lnTo>
                  <a:pt x="2290" y="696"/>
                </a:lnTo>
                <a:lnTo>
                  <a:pt x="2293" y="684"/>
                </a:lnTo>
                <a:lnTo>
                  <a:pt x="2295" y="667"/>
                </a:lnTo>
                <a:lnTo>
                  <a:pt x="2297" y="646"/>
                </a:lnTo>
                <a:lnTo>
                  <a:pt x="2298" y="620"/>
                </a:lnTo>
                <a:lnTo>
                  <a:pt x="2301" y="589"/>
                </a:lnTo>
                <a:lnTo>
                  <a:pt x="2303" y="553"/>
                </a:lnTo>
                <a:lnTo>
                  <a:pt x="2305" y="511"/>
                </a:lnTo>
                <a:lnTo>
                  <a:pt x="2307" y="467"/>
                </a:lnTo>
                <a:lnTo>
                  <a:pt x="2309" y="421"/>
                </a:lnTo>
                <a:lnTo>
                  <a:pt x="2312" y="375"/>
                </a:lnTo>
                <a:lnTo>
                  <a:pt x="2314" y="331"/>
                </a:lnTo>
                <a:lnTo>
                  <a:pt x="2316" y="292"/>
                </a:lnTo>
                <a:lnTo>
                  <a:pt x="2318" y="259"/>
                </a:lnTo>
                <a:lnTo>
                  <a:pt x="2320" y="235"/>
                </a:lnTo>
                <a:lnTo>
                  <a:pt x="2322" y="221"/>
                </a:lnTo>
                <a:lnTo>
                  <a:pt x="2324" y="218"/>
                </a:lnTo>
                <a:lnTo>
                  <a:pt x="2326" y="226"/>
                </a:lnTo>
                <a:lnTo>
                  <a:pt x="2329" y="245"/>
                </a:lnTo>
                <a:lnTo>
                  <a:pt x="2331" y="273"/>
                </a:lnTo>
                <a:lnTo>
                  <a:pt x="2333" y="308"/>
                </a:lnTo>
                <a:lnTo>
                  <a:pt x="2335" y="347"/>
                </a:lnTo>
                <a:lnTo>
                  <a:pt x="2337" y="391"/>
                </a:lnTo>
                <a:lnTo>
                  <a:pt x="2340" y="434"/>
                </a:lnTo>
                <a:lnTo>
                  <a:pt x="2342" y="477"/>
                </a:lnTo>
                <a:lnTo>
                  <a:pt x="2343" y="518"/>
                </a:lnTo>
                <a:lnTo>
                  <a:pt x="2345" y="555"/>
                </a:lnTo>
                <a:lnTo>
                  <a:pt x="2348" y="587"/>
                </a:lnTo>
                <a:lnTo>
                  <a:pt x="2350" y="615"/>
                </a:lnTo>
                <a:lnTo>
                  <a:pt x="2352" y="639"/>
                </a:lnTo>
                <a:lnTo>
                  <a:pt x="2354" y="657"/>
                </a:lnTo>
                <a:lnTo>
                  <a:pt x="2356" y="673"/>
                </a:lnTo>
                <a:lnTo>
                  <a:pt x="2359" y="685"/>
                </a:lnTo>
                <a:lnTo>
                  <a:pt x="2361" y="694"/>
                </a:lnTo>
                <a:lnTo>
                  <a:pt x="2363" y="700"/>
                </a:lnTo>
                <a:lnTo>
                  <a:pt x="2365" y="705"/>
                </a:lnTo>
                <a:lnTo>
                  <a:pt x="2367" y="709"/>
                </a:lnTo>
                <a:lnTo>
                  <a:pt x="2369" y="711"/>
                </a:lnTo>
                <a:lnTo>
                  <a:pt x="2371" y="712"/>
                </a:lnTo>
                <a:lnTo>
                  <a:pt x="2373" y="714"/>
                </a:lnTo>
                <a:lnTo>
                  <a:pt x="2376" y="714"/>
                </a:lnTo>
                <a:lnTo>
                  <a:pt x="2378" y="714"/>
                </a:lnTo>
                <a:lnTo>
                  <a:pt x="2380" y="715"/>
                </a:lnTo>
                <a:lnTo>
                  <a:pt x="2382" y="716"/>
                </a:lnTo>
                <a:lnTo>
                  <a:pt x="2384" y="716"/>
                </a:lnTo>
                <a:lnTo>
                  <a:pt x="2386" y="717"/>
                </a:lnTo>
                <a:lnTo>
                  <a:pt x="2388" y="718"/>
                </a:lnTo>
                <a:lnTo>
                  <a:pt x="2390" y="718"/>
                </a:lnTo>
                <a:lnTo>
                  <a:pt x="2392" y="719"/>
                </a:lnTo>
                <a:lnTo>
                  <a:pt x="2395" y="720"/>
                </a:lnTo>
                <a:lnTo>
                  <a:pt x="2397" y="722"/>
                </a:lnTo>
                <a:lnTo>
                  <a:pt x="2399" y="722"/>
                </a:lnTo>
                <a:lnTo>
                  <a:pt x="2401" y="724"/>
                </a:lnTo>
                <a:lnTo>
                  <a:pt x="2403" y="725"/>
                </a:lnTo>
                <a:lnTo>
                  <a:pt x="2406" y="726"/>
                </a:lnTo>
                <a:lnTo>
                  <a:pt x="2407" y="727"/>
                </a:lnTo>
                <a:lnTo>
                  <a:pt x="2409" y="728"/>
                </a:lnTo>
                <a:lnTo>
                  <a:pt x="2412" y="729"/>
                </a:lnTo>
                <a:lnTo>
                  <a:pt x="2414" y="730"/>
                </a:lnTo>
                <a:lnTo>
                  <a:pt x="2416" y="730"/>
                </a:lnTo>
                <a:lnTo>
                  <a:pt x="2418" y="730"/>
                </a:lnTo>
                <a:lnTo>
                  <a:pt x="2420" y="729"/>
                </a:lnTo>
                <a:lnTo>
                  <a:pt x="2423" y="729"/>
                </a:lnTo>
                <a:lnTo>
                  <a:pt x="2425" y="728"/>
                </a:lnTo>
                <a:lnTo>
                  <a:pt x="2427" y="727"/>
                </a:lnTo>
                <a:lnTo>
                  <a:pt x="2428" y="725"/>
                </a:lnTo>
                <a:lnTo>
                  <a:pt x="2431" y="723"/>
                </a:lnTo>
                <a:lnTo>
                  <a:pt x="2433" y="722"/>
                </a:lnTo>
                <a:lnTo>
                  <a:pt x="2435" y="720"/>
                </a:lnTo>
                <a:lnTo>
                  <a:pt x="2437" y="719"/>
                </a:lnTo>
                <a:lnTo>
                  <a:pt x="2439" y="717"/>
                </a:lnTo>
                <a:lnTo>
                  <a:pt x="2442" y="716"/>
                </a:lnTo>
                <a:lnTo>
                  <a:pt x="2444" y="716"/>
                </a:lnTo>
                <a:lnTo>
                  <a:pt x="2446" y="715"/>
                </a:lnTo>
                <a:lnTo>
                  <a:pt x="2448" y="715"/>
                </a:lnTo>
                <a:lnTo>
                  <a:pt x="2451" y="716"/>
                </a:lnTo>
                <a:lnTo>
                  <a:pt x="2452" y="716"/>
                </a:lnTo>
                <a:lnTo>
                  <a:pt x="2454" y="717"/>
                </a:lnTo>
                <a:lnTo>
                  <a:pt x="2456" y="718"/>
                </a:lnTo>
                <a:lnTo>
                  <a:pt x="2459" y="719"/>
                </a:lnTo>
                <a:lnTo>
                  <a:pt x="2461" y="720"/>
                </a:lnTo>
                <a:lnTo>
                  <a:pt x="2463" y="721"/>
                </a:lnTo>
                <a:lnTo>
                  <a:pt x="2465" y="722"/>
                </a:lnTo>
                <a:lnTo>
                  <a:pt x="2467" y="722"/>
                </a:lnTo>
                <a:lnTo>
                  <a:pt x="2470" y="722"/>
                </a:lnTo>
                <a:lnTo>
                  <a:pt x="2472" y="723"/>
                </a:lnTo>
                <a:lnTo>
                  <a:pt x="2473" y="723"/>
                </a:lnTo>
                <a:lnTo>
                  <a:pt x="2476" y="723"/>
                </a:lnTo>
                <a:lnTo>
                  <a:pt x="2478" y="723"/>
                </a:lnTo>
                <a:lnTo>
                  <a:pt x="2480" y="723"/>
                </a:lnTo>
                <a:lnTo>
                  <a:pt x="2482" y="723"/>
                </a:lnTo>
                <a:lnTo>
                  <a:pt x="2484" y="723"/>
                </a:lnTo>
                <a:lnTo>
                  <a:pt x="2487" y="724"/>
                </a:lnTo>
                <a:lnTo>
                  <a:pt x="2489" y="724"/>
                </a:lnTo>
                <a:lnTo>
                  <a:pt x="2491" y="724"/>
                </a:lnTo>
                <a:lnTo>
                  <a:pt x="2493" y="723"/>
                </a:lnTo>
                <a:lnTo>
                  <a:pt x="2495" y="723"/>
                </a:lnTo>
                <a:lnTo>
                  <a:pt x="2497" y="722"/>
                </a:lnTo>
                <a:lnTo>
                  <a:pt x="2499" y="721"/>
                </a:lnTo>
                <a:lnTo>
                  <a:pt x="2501" y="719"/>
                </a:lnTo>
                <a:lnTo>
                  <a:pt x="2503" y="717"/>
                </a:lnTo>
                <a:lnTo>
                  <a:pt x="2506" y="714"/>
                </a:lnTo>
                <a:lnTo>
                  <a:pt x="2508" y="712"/>
                </a:lnTo>
                <a:lnTo>
                  <a:pt x="2510" y="708"/>
                </a:lnTo>
                <a:lnTo>
                  <a:pt x="2512" y="705"/>
                </a:lnTo>
                <a:lnTo>
                  <a:pt x="2514" y="701"/>
                </a:lnTo>
                <a:lnTo>
                  <a:pt x="2516" y="697"/>
                </a:lnTo>
                <a:lnTo>
                  <a:pt x="2518" y="694"/>
                </a:lnTo>
                <a:lnTo>
                  <a:pt x="2520" y="692"/>
                </a:lnTo>
                <a:lnTo>
                  <a:pt x="2523" y="690"/>
                </a:lnTo>
                <a:lnTo>
                  <a:pt x="2525" y="688"/>
                </a:lnTo>
                <a:lnTo>
                  <a:pt x="2527" y="687"/>
                </a:lnTo>
                <a:lnTo>
                  <a:pt x="2529" y="688"/>
                </a:lnTo>
                <a:lnTo>
                  <a:pt x="2531" y="689"/>
                </a:lnTo>
                <a:lnTo>
                  <a:pt x="2534" y="691"/>
                </a:lnTo>
                <a:lnTo>
                  <a:pt x="2536" y="694"/>
                </a:lnTo>
                <a:lnTo>
                  <a:pt x="2537" y="696"/>
                </a:lnTo>
                <a:lnTo>
                  <a:pt x="2539" y="699"/>
                </a:lnTo>
                <a:lnTo>
                  <a:pt x="2542" y="703"/>
                </a:lnTo>
                <a:lnTo>
                  <a:pt x="2544" y="705"/>
                </a:lnTo>
                <a:lnTo>
                  <a:pt x="2546" y="709"/>
                </a:lnTo>
                <a:lnTo>
                  <a:pt x="2548" y="711"/>
                </a:lnTo>
                <a:lnTo>
                  <a:pt x="2550" y="713"/>
                </a:lnTo>
                <a:lnTo>
                  <a:pt x="2553" y="716"/>
                </a:lnTo>
                <a:lnTo>
                  <a:pt x="2555" y="717"/>
                </a:lnTo>
                <a:lnTo>
                  <a:pt x="2557" y="719"/>
                </a:lnTo>
                <a:lnTo>
                  <a:pt x="2559" y="720"/>
                </a:lnTo>
                <a:lnTo>
                  <a:pt x="2561" y="720"/>
                </a:lnTo>
                <a:lnTo>
                  <a:pt x="2563" y="721"/>
                </a:lnTo>
                <a:lnTo>
                  <a:pt x="2565" y="722"/>
                </a:lnTo>
                <a:lnTo>
                  <a:pt x="2567" y="722"/>
                </a:lnTo>
                <a:lnTo>
                  <a:pt x="2570" y="723"/>
                </a:lnTo>
                <a:lnTo>
                  <a:pt x="2572" y="723"/>
                </a:lnTo>
                <a:lnTo>
                  <a:pt x="2574" y="723"/>
                </a:lnTo>
                <a:lnTo>
                  <a:pt x="2576" y="724"/>
                </a:lnTo>
                <a:lnTo>
                  <a:pt x="2578" y="724"/>
                </a:lnTo>
                <a:lnTo>
                  <a:pt x="2581" y="725"/>
                </a:lnTo>
                <a:lnTo>
                  <a:pt x="2582" y="725"/>
                </a:lnTo>
                <a:lnTo>
                  <a:pt x="2584" y="725"/>
                </a:lnTo>
                <a:lnTo>
                  <a:pt x="2586" y="726"/>
                </a:lnTo>
                <a:lnTo>
                  <a:pt x="2589" y="727"/>
                </a:lnTo>
                <a:lnTo>
                  <a:pt x="2591" y="727"/>
                </a:lnTo>
                <a:lnTo>
                  <a:pt x="2593" y="727"/>
                </a:lnTo>
                <a:lnTo>
                  <a:pt x="2595" y="727"/>
                </a:lnTo>
                <a:lnTo>
                  <a:pt x="2598" y="727"/>
                </a:lnTo>
                <a:lnTo>
                  <a:pt x="2600" y="726"/>
                </a:lnTo>
                <a:lnTo>
                  <a:pt x="2602" y="725"/>
                </a:lnTo>
                <a:lnTo>
                  <a:pt x="2603" y="724"/>
                </a:lnTo>
                <a:lnTo>
                  <a:pt x="2606" y="723"/>
                </a:lnTo>
                <a:lnTo>
                  <a:pt x="2608" y="721"/>
                </a:lnTo>
                <a:lnTo>
                  <a:pt x="2610" y="719"/>
                </a:lnTo>
                <a:lnTo>
                  <a:pt x="2612" y="716"/>
                </a:lnTo>
                <a:lnTo>
                  <a:pt x="2614" y="714"/>
                </a:lnTo>
                <a:lnTo>
                  <a:pt x="2617" y="712"/>
                </a:lnTo>
                <a:lnTo>
                  <a:pt x="2619" y="711"/>
                </a:lnTo>
                <a:lnTo>
                  <a:pt x="2621" y="710"/>
                </a:lnTo>
                <a:lnTo>
                  <a:pt x="2623" y="709"/>
                </a:lnTo>
                <a:lnTo>
                  <a:pt x="2625" y="709"/>
                </a:lnTo>
                <a:lnTo>
                  <a:pt x="2627" y="709"/>
                </a:lnTo>
                <a:lnTo>
                  <a:pt x="2629" y="711"/>
                </a:lnTo>
                <a:lnTo>
                  <a:pt x="2631" y="712"/>
                </a:lnTo>
                <a:lnTo>
                  <a:pt x="2634" y="714"/>
                </a:lnTo>
                <a:lnTo>
                  <a:pt x="2636" y="716"/>
                </a:lnTo>
                <a:lnTo>
                  <a:pt x="2638" y="718"/>
                </a:lnTo>
                <a:lnTo>
                  <a:pt x="2640" y="721"/>
                </a:lnTo>
                <a:lnTo>
                  <a:pt x="2642" y="723"/>
                </a:lnTo>
                <a:lnTo>
                  <a:pt x="2645" y="725"/>
                </a:lnTo>
                <a:lnTo>
                  <a:pt x="2646" y="727"/>
                </a:lnTo>
                <a:lnTo>
                  <a:pt x="2648" y="728"/>
                </a:lnTo>
                <a:lnTo>
                  <a:pt x="2650" y="729"/>
                </a:lnTo>
                <a:lnTo>
                  <a:pt x="2653" y="730"/>
                </a:lnTo>
                <a:lnTo>
                  <a:pt x="2655" y="730"/>
                </a:lnTo>
                <a:lnTo>
                  <a:pt x="2657" y="728"/>
                </a:lnTo>
                <a:lnTo>
                  <a:pt x="2659" y="726"/>
                </a:lnTo>
                <a:lnTo>
                  <a:pt x="2661" y="722"/>
                </a:lnTo>
                <a:lnTo>
                  <a:pt x="2664" y="716"/>
                </a:lnTo>
                <a:lnTo>
                  <a:pt x="2666" y="707"/>
                </a:lnTo>
                <a:lnTo>
                  <a:pt x="2667" y="695"/>
                </a:lnTo>
                <a:lnTo>
                  <a:pt x="2670" y="678"/>
                </a:lnTo>
                <a:lnTo>
                  <a:pt x="2672" y="656"/>
                </a:lnTo>
                <a:lnTo>
                  <a:pt x="2674" y="629"/>
                </a:lnTo>
                <a:lnTo>
                  <a:pt x="2676" y="595"/>
                </a:lnTo>
                <a:lnTo>
                  <a:pt x="2678" y="555"/>
                </a:lnTo>
                <a:lnTo>
                  <a:pt x="2681" y="510"/>
                </a:lnTo>
                <a:lnTo>
                  <a:pt x="2683" y="461"/>
                </a:lnTo>
                <a:lnTo>
                  <a:pt x="2685" y="410"/>
                </a:lnTo>
                <a:lnTo>
                  <a:pt x="2687" y="359"/>
                </a:lnTo>
                <a:lnTo>
                  <a:pt x="2689" y="310"/>
                </a:lnTo>
                <a:lnTo>
                  <a:pt x="2691" y="267"/>
                </a:lnTo>
                <a:lnTo>
                  <a:pt x="2693" y="232"/>
                </a:lnTo>
                <a:lnTo>
                  <a:pt x="2695" y="208"/>
                </a:lnTo>
                <a:lnTo>
                  <a:pt x="2697" y="194"/>
                </a:lnTo>
                <a:lnTo>
                  <a:pt x="2700" y="194"/>
                </a:lnTo>
                <a:lnTo>
                  <a:pt x="2702" y="204"/>
                </a:lnTo>
                <a:lnTo>
                  <a:pt x="2704" y="226"/>
                </a:lnTo>
                <a:lnTo>
                  <a:pt x="2706" y="257"/>
                </a:lnTo>
                <a:lnTo>
                  <a:pt x="2708" y="295"/>
                </a:lnTo>
                <a:lnTo>
                  <a:pt x="2711" y="338"/>
                </a:lnTo>
                <a:lnTo>
                  <a:pt x="2712" y="383"/>
                </a:lnTo>
                <a:lnTo>
                  <a:pt x="2714" y="428"/>
                </a:lnTo>
                <a:lnTo>
                  <a:pt x="2717" y="471"/>
                </a:lnTo>
                <a:lnTo>
                  <a:pt x="2719" y="511"/>
                </a:lnTo>
                <a:lnTo>
                  <a:pt x="2721" y="546"/>
                </a:lnTo>
                <a:lnTo>
                  <a:pt x="2723" y="577"/>
                </a:lnTo>
                <a:lnTo>
                  <a:pt x="2725" y="604"/>
                </a:lnTo>
                <a:lnTo>
                  <a:pt x="2728" y="625"/>
                </a:lnTo>
                <a:lnTo>
                  <a:pt x="2730" y="642"/>
                </a:lnTo>
                <a:lnTo>
                  <a:pt x="2732" y="655"/>
                </a:lnTo>
                <a:lnTo>
                  <a:pt x="2733" y="665"/>
                </a:lnTo>
                <a:lnTo>
                  <a:pt x="2736" y="672"/>
                </a:lnTo>
                <a:lnTo>
                  <a:pt x="2738" y="676"/>
                </a:lnTo>
                <a:lnTo>
                  <a:pt x="2740" y="679"/>
                </a:lnTo>
                <a:lnTo>
                  <a:pt x="2742" y="679"/>
                </a:lnTo>
                <a:lnTo>
                  <a:pt x="2744" y="679"/>
                </a:lnTo>
                <a:lnTo>
                  <a:pt x="2747" y="678"/>
                </a:lnTo>
                <a:lnTo>
                  <a:pt x="2749" y="676"/>
                </a:lnTo>
                <a:lnTo>
                  <a:pt x="2751" y="674"/>
                </a:lnTo>
                <a:lnTo>
                  <a:pt x="2753" y="673"/>
                </a:lnTo>
                <a:lnTo>
                  <a:pt x="2755" y="672"/>
                </a:lnTo>
                <a:lnTo>
                  <a:pt x="2757" y="672"/>
                </a:lnTo>
                <a:lnTo>
                  <a:pt x="2759" y="672"/>
                </a:lnTo>
                <a:lnTo>
                  <a:pt x="2761" y="674"/>
                </a:lnTo>
                <a:lnTo>
                  <a:pt x="2764" y="676"/>
                </a:lnTo>
                <a:lnTo>
                  <a:pt x="2766" y="678"/>
                </a:lnTo>
                <a:lnTo>
                  <a:pt x="2768" y="681"/>
                </a:lnTo>
                <a:lnTo>
                  <a:pt x="2770" y="686"/>
                </a:lnTo>
                <a:lnTo>
                  <a:pt x="2772" y="690"/>
                </a:lnTo>
                <a:lnTo>
                  <a:pt x="2775" y="695"/>
                </a:lnTo>
                <a:lnTo>
                  <a:pt x="2776" y="699"/>
                </a:lnTo>
                <a:lnTo>
                  <a:pt x="2778" y="703"/>
                </a:lnTo>
                <a:lnTo>
                  <a:pt x="2781" y="707"/>
                </a:lnTo>
                <a:lnTo>
                  <a:pt x="2783" y="711"/>
                </a:lnTo>
                <a:lnTo>
                  <a:pt x="2785" y="714"/>
                </a:lnTo>
                <a:lnTo>
                  <a:pt x="2787" y="717"/>
                </a:lnTo>
                <a:lnTo>
                  <a:pt x="2789" y="720"/>
                </a:lnTo>
                <a:lnTo>
                  <a:pt x="2792" y="722"/>
                </a:lnTo>
                <a:lnTo>
                  <a:pt x="2794" y="723"/>
                </a:lnTo>
                <a:lnTo>
                  <a:pt x="2796" y="725"/>
                </a:lnTo>
                <a:lnTo>
                  <a:pt x="2797" y="726"/>
                </a:lnTo>
                <a:lnTo>
                  <a:pt x="2800" y="727"/>
                </a:lnTo>
                <a:lnTo>
                  <a:pt x="2802" y="728"/>
                </a:lnTo>
                <a:lnTo>
                  <a:pt x="2804" y="729"/>
                </a:lnTo>
                <a:lnTo>
                  <a:pt x="2806" y="729"/>
                </a:lnTo>
                <a:lnTo>
                  <a:pt x="2808" y="730"/>
                </a:lnTo>
                <a:lnTo>
                  <a:pt x="2811" y="731"/>
                </a:lnTo>
                <a:lnTo>
                  <a:pt x="2813" y="731"/>
                </a:lnTo>
                <a:lnTo>
                  <a:pt x="2815" y="731"/>
                </a:lnTo>
                <a:lnTo>
                  <a:pt x="2817" y="731"/>
                </a:lnTo>
                <a:lnTo>
                  <a:pt x="2819" y="732"/>
                </a:lnTo>
                <a:lnTo>
                  <a:pt x="2821" y="732"/>
                </a:lnTo>
                <a:lnTo>
                  <a:pt x="2823" y="732"/>
                </a:lnTo>
                <a:lnTo>
                  <a:pt x="2825" y="733"/>
                </a:lnTo>
                <a:lnTo>
                  <a:pt x="2828" y="733"/>
                </a:lnTo>
                <a:lnTo>
                  <a:pt x="2830" y="733"/>
                </a:lnTo>
                <a:lnTo>
                  <a:pt x="2832" y="733"/>
                </a:lnTo>
                <a:lnTo>
                  <a:pt x="2834" y="734"/>
                </a:lnTo>
                <a:lnTo>
                  <a:pt x="2836" y="734"/>
                </a:lnTo>
                <a:lnTo>
                  <a:pt x="2839" y="734"/>
                </a:lnTo>
                <a:lnTo>
                  <a:pt x="2841" y="734"/>
                </a:lnTo>
                <a:lnTo>
                  <a:pt x="2842" y="734"/>
                </a:lnTo>
                <a:lnTo>
                  <a:pt x="2844" y="734"/>
                </a:lnTo>
                <a:lnTo>
                  <a:pt x="2847" y="735"/>
                </a:lnTo>
                <a:lnTo>
                  <a:pt x="2849" y="735"/>
                </a:lnTo>
                <a:lnTo>
                  <a:pt x="2851" y="736"/>
                </a:lnTo>
                <a:lnTo>
                  <a:pt x="2853" y="736"/>
                </a:lnTo>
                <a:lnTo>
                  <a:pt x="2855" y="736"/>
                </a:lnTo>
                <a:lnTo>
                  <a:pt x="2858" y="736"/>
                </a:lnTo>
                <a:lnTo>
                  <a:pt x="2860" y="735"/>
                </a:lnTo>
                <a:lnTo>
                  <a:pt x="2862" y="735"/>
                </a:lnTo>
                <a:lnTo>
                  <a:pt x="2864" y="734"/>
                </a:lnTo>
                <a:lnTo>
                  <a:pt x="2866" y="734"/>
                </a:lnTo>
                <a:lnTo>
                  <a:pt x="2868" y="734"/>
                </a:lnTo>
                <a:lnTo>
                  <a:pt x="2870" y="733"/>
                </a:lnTo>
                <a:lnTo>
                  <a:pt x="2872" y="733"/>
                </a:lnTo>
                <a:lnTo>
                  <a:pt x="2875" y="733"/>
                </a:lnTo>
                <a:lnTo>
                  <a:pt x="2877" y="733"/>
                </a:lnTo>
                <a:lnTo>
                  <a:pt x="2879" y="732"/>
                </a:lnTo>
                <a:lnTo>
                  <a:pt x="2881" y="731"/>
                </a:lnTo>
                <a:lnTo>
                  <a:pt x="2883" y="731"/>
                </a:lnTo>
                <a:lnTo>
                  <a:pt x="2885" y="731"/>
                </a:lnTo>
                <a:lnTo>
                  <a:pt x="2887" y="730"/>
                </a:lnTo>
                <a:lnTo>
                  <a:pt x="2889" y="730"/>
                </a:lnTo>
                <a:lnTo>
                  <a:pt x="2891" y="729"/>
                </a:lnTo>
                <a:lnTo>
                  <a:pt x="2894" y="729"/>
                </a:lnTo>
                <a:lnTo>
                  <a:pt x="2896" y="729"/>
                </a:lnTo>
                <a:lnTo>
                  <a:pt x="2898" y="729"/>
                </a:lnTo>
                <a:lnTo>
                  <a:pt x="2900" y="729"/>
                </a:lnTo>
                <a:lnTo>
                  <a:pt x="2903" y="730"/>
                </a:lnTo>
                <a:lnTo>
                  <a:pt x="2905" y="730"/>
                </a:lnTo>
                <a:lnTo>
                  <a:pt x="2906" y="731"/>
                </a:lnTo>
                <a:lnTo>
                  <a:pt x="2908" y="732"/>
                </a:lnTo>
                <a:lnTo>
                  <a:pt x="2911" y="733"/>
                </a:lnTo>
                <a:lnTo>
                  <a:pt x="2913" y="734"/>
                </a:lnTo>
                <a:lnTo>
                  <a:pt x="2915" y="735"/>
                </a:lnTo>
                <a:lnTo>
                  <a:pt x="2917" y="736"/>
                </a:lnTo>
                <a:lnTo>
                  <a:pt x="2919" y="736"/>
                </a:lnTo>
                <a:lnTo>
                  <a:pt x="2922" y="736"/>
                </a:lnTo>
                <a:lnTo>
                  <a:pt x="2924" y="737"/>
                </a:lnTo>
                <a:lnTo>
                  <a:pt x="2926" y="737"/>
                </a:lnTo>
                <a:lnTo>
                  <a:pt x="2927" y="737"/>
                </a:lnTo>
                <a:lnTo>
                  <a:pt x="2930" y="738"/>
                </a:lnTo>
                <a:lnTo>
                  <a:pt x="2932" y="738"/>
                </a:lnTo>
                <a:lnTo>
                  <a:pt x="2934" y="738"/>
                </a:lnTo>
                <a:lnTo>
                  <a:pt x="2936" y="738"/>
                </a:lnTo>
                <a:lnTo>
                  <a:pt x="2939" y="738"/>
                </a:lnTo>
                <a:lnTo>
                  <a:pt x="2941" y="737"/>
                </a:lnTo>
                <a:lnTo>
                  <a:pt x="2943" y="737"/>
                </a:lnTo>
                <a:lnTo>
                  <a:pt x="2945" y="736"/>
                </a:lnTo>
                <a:lnTo>
                  <a:pt x="2947" y="736"/>
                </a:lnTo>
                <a:lnTo>
                  <a:pt x="2950" y="735"/>
                </a:lnTo>
                <a:lnTo>
                  <a:pt x="2951" y="734"/>
                </a:lnTo>
                <a:lnTo>
                  <a:pt x="2953" y="733"/>
                </a:lnTo>
                <a:lnTo>
                  <a:pt x="2955" y="733"/>
                </a:lnTo>
                <a:lnTo>
                  <a:pt x="2958" y="732"/>
                </a:lnTo>
                <a:lnTo>
                  <a:pt x="2960" y="732"/>
                </a:lnTo>
                <a:lnTo>
                  <a:pt x="2962" y="731"/>
                </a:lnTo>
                <a:lnTo>
                  <a:pt x="2964" y="731"/>
                </a:lnTo>
                <a:lnTo>
                  <a:pt x="2966" y="730"/>
                </a:lnTo>
                <a:lnTo>
                  <a:pt x="2969" y="729"/>
                </a:lnTo>
                <a:lnTo>
                  <a:pt x="2971" y="729"/>
                </a:lnTo>
                <a:lnTo>
                  <a:pt x="2972" y="728"/>
                </a:lnTo>
                <a:lnTo>
                  <a:pt x="2975" y="728"/>
                </a:lnTo>
                <a:lnTo>
                  <a:pt x="2977" y="727"/>
                </a:lnTo>
                <a:lnTo>
                  <a:pt x="2979" y="727"/>
                </a:lnTo>
                <a:lnTo>
                  <a:pt x="2981" y="726"/>
                </a:lnTo>
                <a:lnTo>
                  <a:pt x="2983" y="726"/>
                </a:lnTo>
                <a:lnTo>
                  <a:pt x="2986" y="725"/>
                </a:lnTo>
                <a:lnTo>
                  <a:pt x="2988" y="725"/>
                </a:lnTo>
                <a:lnTo>
                  <a:pt x="2990" y="724"/>
                </a:lnTo>
                <a:lnTo>
                  <a:pt x="2992" y="724"/>
                </a:lnTo>
                <a:lnTo>
                  <a:pt x="2994" y="723"/>
                </a:lnTo>
                <a:lnTo>
                  <a:pt x="2996" y="723"/>
                </a:lnTo>
                <a:lnTo>
                  <a:pt x="2998" y="723"/>
                </a:lnTo>
                <a:lnTo>
                  <a:pt x="3000" y="723"/>
                </a:lnTo>
                <a:lnTo>
                  <a:pt x="3002" y="723"/>
                </a:lnTo>
                <a:lnTo>
                  <a:pt x="3005" y="723"/>
                </a:lnTo>
                <a:lnTo>
                  <a:pt x="3007" y="723"/>
                </a:lnTo>
                <a:lnTo>
                  <a:pt x="3009" y="723"/>
                </a:lnTo>
                <a:lnTo>
                  <a:pt x="3011" y="724"/>
                </a:lnTo>
                <a:lnTo>
                  <a:pt x="3013" y="725"/>
                </a:lnTo>
                <a:lnTo>
                  <a:pt x="3015" y="725"/>
                </a:lnTo>
                <a:lnTo>
                  <a:pt x="3017" y="725"/>
                </a:lnTo>
                <a:lnTo>
                  <a:pt x="3019" y="726"/>
                </a:lnTo>
                <a:lnTo>
                  <a:pt x="3022" y="727"/>
                </a:lnTo>
                <a:lnTo>
                  <a:pt x="3024" y="727"/>
                </a:lnTo>
                <a:lnTo>
                  <a:pt x="3026" y="728"/>
                </a:lnTo>
                <a:lnTo>
                  <a:pt x="3028" y="728"/>
                </a:lnTo>
                <a:lnTo>
                  <a:pt x="3030" y="727"/>
                </a:lnTo>
                <a:lnTo>
                  <a:pt x="3033" y="725"/>
                </a:lnTo>
                <a:lnTo>
                  <a:pt x="3035" y="723"/>
                </a:lnTo>
                <a:lnTo>
                  <a:pt x="3036" y="719"/>
                </a:lnTo>
                <a:lnTo>
                  <a:pt x="3038" y="714"/>
                </a:lnTo>
                <a:lnTo>
                  <a:pt x="3041" y="708"/>
                </a:lnTo>
                <a:lnTo>
                  <a:pt x="3043" y="701"/>
                </a:lnTo>
                <a:lnTo>
                  <a:pt x="3045" y="693"/>
                </a:lnTo>
                <a:lnTo>
                  <a:pt x="3047" y="683"/>
                </a:lnTo>
                <a:lnTo>
                  <a:pt x="3050" y="674"/>
                </a:lnTo>
                <a:lnTo>
                  <a:pt x="3052" y="664"/>
                </a:lnTo>
                <a:lnTo>
                  <a:pt x="3054" y="655"/>
                </a:lnTo>
                <a:lnTo>
                  <a:pt x="3056" y="648"/>
                </a:lnTo>
                <a:lnTo>
                  <a:pt x="3058" y="642"/>
                </a:lnTo>
                <a:lnTo>
                  <a:pt x="3060" y="638"/>
                </a:lnTo>
                <a:lnTo>
                  <a:pt x="3062" y="636"/>
                </a:lnTo>
                <a:lnTo>
                  <a:pt x="3064" y="637"/>
                </a:lnTo>
                <a:lnTo>
                  <a:pt x="3066" y="640"/>
                </a:lnTo>
                <a:lnTo>
                  <a:pt x="3069" y="644"/>
                </a:lnTo>
                <a:lnTo>
                  <a:pt x="3071" y="651"/>
                </a:lnTo>
                <a:lnTo>
                  <a:pt x="3073" y="659"/>
                </a:lnTo>
                <a:lnTo>
                  <a:pt x="3075" y="667"/>
                </a:lnTo>
                <a:lnTo>
                  <a:pt x="3077" y="676"/>
                </a:lnTo>
                <a:lnTo>
                  <a:pt x="3080" y="684"/>
                </a:lnTo>
                <a:lnTo>
                  <a:pt x="3081" y="692"/>
                </a:lnTo>
                <a:lnTo>
                  <a:pt x="3083" y="699"/>
                </a:lnTo>
                <a:lnTo>
                  <a:pt x="3086" y="705"/>
                </a:lnTo>
                <a:lnTo>
                  <a:pt x="3088" y="711"/>
                </a:lnTo>
                <a:lnTo>
                  <a:pt x="3090" y="715"/>
                </a:lnTo>
                <a:lnTo>
                  <a:pt x="3092" y="719"/>
                </a:lnTo>
                <a:lnTo>
                  <a:pt x="3094" y="722"/>
                </a:lnTo>
                <a:lnTo>
                  <a:pt x="3097" y="723"/>
                </a:lnTo>
                <a:lnTo>
                  <a:pt x="3099" y="725"/>
                </a:lnTo>
                <a:lnTo>
                  <a:pt x="3101" y="727"/>
                </a:lnTo>
                <a:lnTo>
                  <a:pt x="3102" y="728"/>
                </a:lnTo>
                <a:lnTo>
                  <a:pt x="3105" y="729"/>
                </a:lnTo>
                <a:lnTo>
                  <a:pt x="3107" y="730"/>
                </a:lnTo>
                <a:lnTo>
                  <a:pt x="3109" y="730"/>
                </a:lnTo>
                <a:lnTo>
                  <a:pt x="3111" y="731"/>
                </a:lnTo>
                <a:lnTo>
                  <a:pt x="3113" y="731"/>
                </a:lnTo>
                <a:lnTo>
                  <a:pt x="3116" y="732"/>
                </a:lnTo>
                <a:lnTo>
                  <a:pt x="3118" y="733"/>
                </a:lnTo>
                <a:lnTo>
                  <a:pt x="3120" y="733"/>
                </a:lnTo>
                <a:lnTo>
                  <a:pt x="3122" y="734"/>
                </a:lnTo>
                <a:lnTo>
                  <a:pt x="3124" y="734"/>
                </a:lnTo>
                <a:lnTo>
                  <a:pt x="3126" y="734"/>
                </a:lnTo>
                <a:lnTo>
                  <a:pt x="3128" y="734"/>
                </a:lnTo>
                <a:lnTo>
                  <a:pt x="3130" y="734"/>
                </a:lnTo>
                <a:lnTo>
                  <a:pt x="3133" y="734"/>
                </a:lnTo>
                <a:lnTo>
                  <a:pt x="3137" y="734"/>
                </a:lnTo>
                <a:lnTo>
                  <a:pt x="3139" y="734"/>
                </a:lnTo>
                <a:lnTo>
                  <a:pt x="3141" y="735"/>
                </a:lnTo>
                <a:lnTo>
                  <a:pt x="3144" y="735"/>
                </a:lnTo>
                <a:lnTo>
                  <a:pt x="3145" y="735"/>
                </a:lnTo>
                <a:lnTo>
                  <a:pt x="3147" y="735"/>
                </a:lnTo>
                <a:lnTo>
                  <a:pt x="3149" y="734"/>
                </a:lnTo>
                <a:lnTo>
                  <a:pt x="3152" y="734"/>
                </a:lnTo>
                <a:lnTo>
                  <a:pt x="3154" y="734"/>
                </a:lnTo>
                <a:lnTo>
                  <a:pt x="3156" y="734"/>
                </a:lnTo>
                <a:lnTo>
                  <a:pt x="3158" y="734"/>
                </a:lnTo>
                <a:lnTo>
                  <a:pt x="3160" y="734"/>
                </a:lnTo>
                <a:lnTo>
                  <a:pt x="3163" y="734"/>
                </a:lnTo>
                <a:lnTo>
                  <a:pt x="3165" y="734"/>
                </a:lnTo>
                <a:lnTo>
                  <a:pt x="3166" y="734"/>
                </a:lnTo>
                <a:lnTo>
                  <a:pt x="3169" y="734"/>
                </a:lnTo>
                <a:lnTo>
                  <a:pt x="3171" y="734"/>
                </a:lnTo>
                <a:lnTo>
                  <a:pt x="3173" y="733"/>
                </a:lnTo>
                <a:lnTo>
                  <a:pt x="3175" y="733"/>
                </a:lnTo>
                <a:lnTo>
                  <a:pt x="3177" y="733"/>
                </a:lnTo>
                <a:lnTo>
                  <a:pt x="3180" y="733"/>
                </a:lnTo>
                <a:lnTo>
                  <a:pt x="3182" y="734"/>
                </a:lnTo>
                <a:lnTo>
                  <a:pt x="3184" y="734"/>
                </a:lnTo>
                <a:lnTo>
                  <a:pt x="3186" y="734"/>
                </a:lnTo>
                <a:lnTo>
                  <a:pt x="3188" y="734"/>
                </a:lnTo>
                <a:lnTo>
                  <a:pt x="3190" y="735"/>
                </a:lnTo>
                <a:lnTo>
                  <a:pt x="3192" y="735"/>
                </a:lnTo>
                <a:lnTo>
                  <a:pt x="3194" y="736"/>
                </a:lnTo>
                <a:lnTo>
                  <a:pt x="3196" y="736"/>
                </a:lnTo>
                <a:lnTo>
                  <a:pt x="3199" y="736"/>
                </a:lnTo>
                <a:lnTo>
                  <a:pt x="3201" y="736"/>
                </a:lnTo>
                <a:lnTo>
                  <a:pt x="3203" y="737"/>
                </a:lnTo>
                <a:lnTo>
                  <a:pt x="3205" y="737"/>
                </a:lnTo>
                <a:lnTo>
                  <a:pt x="3208" y="737"/>
                </a:lnTo>
                <a:lnTo>
                  <a:pt x="3210" y="737"/>
                </a:lnTo>
                <a:lnTo>
                  <a:pt x="3211" y="737"/>
                </a:lnTo>
                <a:lnTo>
                  <a:pt x="3213" y="737"/>
                </a:lnTo>
                <a:lnTo>
                  <a:pt x="3216" y="736"/>
                </a:lnTo>
                <a:lnTo>
                  <a:pt x="3218" y="736"/>
                </a:lnTo>
                <a:lnTo>
                  <a:pt x="3220" y="736"/>
                </a:lnTo>
                <a:lnTo>
                  <a:pt x="3222" y="736"/>
                </a:lnTo>
                <a:lnTo>
                  <a:pt x="3227" y="736"/>
                </a:lnTo>
                <a:lnTo>
                  <a:pt x="3229" y="736"/>
                </a:lnTo>
                <a:lnTo>
                  <a:pt x="3231" y="736"/>
                </a:lnTo>
                <a:lnTo>
                  <a:pt x="3233" y="736"/>
                </a:lnTo>
                <a:lnTo>
                  <a:pt x="3235" y="736"/>
                </a:lnTo>
                <a:lnTo>
                  <a:pt x="3237" y="735"/>
                </a:lnTo>
                <a:lnTo>
                  <a:pt x="3239" y="734"/>
                </a:lnTo>
                <a:lnTo>
                  <a:pt x="3241" y="734"/>
                </a:lnTo>
                <a:lnTo>
                  <a:pt x="3244" y="734"/>
                </a:lnTo>
                <a:lnTo>
                  <a:pt x="3246" y="734"/>
                </a:lnTo>
                <a:lnTo>
                  <a:pt x="3248" y="733"/>
                </a:lnTo>
                <a:lnTo>
                  <a:pt x="3252" y="733"/>
                </a:lnTo>
                <a:lnTo>
                  <a:pt x="3254" y="733"/>
                </a:lnTo>
                <a:lnTo>
                  <a:pt x="3256" y="734"/>
                </a:lnTo>
                <a:lnTo>
                  <a:pt x="3258" y="734"/>
                </a:lnTo>
                <a:lnTo>
                  <a:pt x="3260" y="734"/>
                </a:lnTo>
                <a:lnTo>
                  <a:pt x="3263" y="735"/>
                </a:lnTo>
                <a:lnTo>
                  <a:pt x="3265" y="736"/>
                </a:lnTo>
                <a:lnTo>
                  <a:pt x="3267" y="736"/>
                </a:lnTo>
                <a:lnTo>
                  <a:pt x="3269" y="736"/>
                </a:lnTo>
                <a:lnTo>
                  <a:pt x="3271" y="736"/>
                </a:lnTo>
                <a:lnTo>
                  <a:pt x="3274" y="736"/>
                </a:lnTo>
                <a:lnTo>
                  <a:pt x="3275" y="736"/>
                </a:lnTo>
                <a:lnTo>
                  <a:pt x="3277" y="735"/>
                </a:lnTo>
                <a:lnTo>
                  <a:pt x="3280" y="735"/>
                </a:lnTo>
                <a:lnTo>
                  <a:pt x="3282" y="734"/>
                </a:lnTo>
                <a:lnTo>
                  <a:pt x="3284" y="734"/>
                </a:lnTo>
                <a:lnTo>
                  <a:pt x="3286" y="734"/>
                </a:lnTo>
                <a:lnTo>
                  <a:pt x="3288" y="734"/>
                </a:lnTo>
                <a:lnTo>
                  <a:pt x="3291" y="733"/>
                </a:lnTo>
                <a:lnTo>
                  <a:pt x="3293" y="733"/>
                </a:lnTo>
                <a:lnTo>
                  <a:pt x="3295" y="733"/>
                </a:lnTo>
                <a:lnTo>
                  <a:pt x="3296" y="733"/>
                </a:lnTo>
                <a:lnTo>
                  <a:pt x="3299" y="733"/>
                </a:lnTo>
                <a:lnTo>
                  <a:pt x="3301" y="734"/>
                </a:lnTo>
                <a:lnTo>
                  <a:pt x="3303" y="734"/>
                </a:lnTo>
                <a:lnTo>
                  <a:pt x="3305" y="734"/>
                </a:lnTo>
                <a:lnTo>
                  <a:pt x="3307" y="735"/>
                </a:lnTo>
                <a:lnTo>
                  <a:pt x="3310" y="735"/>
                </a:lnTo>
                <a:lnTo>
                  <a:pt x="3312" y="735"/>
                </a:lnTo>
                <a:lnTo>
                  <a:pt x="3316" y="735"/>
                </a:lnTo>
                <a:lnTo>
                  <a:pt x="3318" y="735"/>
                </a:lnTo>
                <a:lnTo>
                  <a:pt x="3320" y="734"/>
                </a:lnTo>
                <a:lnTo>
                  <a:pt x="3322" y="734"/>
                </a:lnTo>
                <a:lnTo>
                  <a:pt x="3324" y="734"/>
                </a:lnTo>
                <a:lnTo>
                  <a:pt x="3327" y="734"/>
                </a:lnTo>
                <a:lnTo>
                  <a:pt x="3329" y="734"/>
                </a:lnTo>
                <a:lnTo>
                  <a:pt x="3331" y="734"/>
                </a:lnTo>
                <a:lnTo>
                  <a:pt x="3333" y="733"/>
                </a:lnTo>
                <a:lnTo>
                  <a:pt x="3335" y="733"/>
                </a:lnTo>
                <a:lnTo>
                  <a:pt x="3338" y="733"/>
                </a:lnTo>
                <a:lnTo>
                  <a:pt x="3341" y="733"/>
                </a:lnTo>
                <a:lnTo>
                  <a:pt x="3343" y="733"/>
                </a:lnTo>
                <a:lnTo>
                  <a:pt x="3346" y="734"/>
                </a:lnTo>
                <a:lnTo>
                  <a:pt x="3348" y="734"/>
                </a:lnTo>
                <a:lnTo>
                  <a:pt x="3350" y="734"/>
                </a:lnTo>
                <a:lnTo>
                  <a:pt x="3352" y="735"/>
                </a:lnTo>
                <a:lnTo>
                  <a:pt x="3355" y="735"/>
                </a:lnTo>
                <a:lnTo>
                  <a:pt x="3357" y="736"/>
                </a:lnTo>
                <a:lnTo>
                  <a:pt x="3359" y="736"/>
                </a:lnTo>
                <a:lnTo>
                  <a:pt x="3361" y="737"/>
                </a:lnTo>
                <a:lnTo>
                  <a:pt x="3363" y="737"/>
                </a:lnTo>
                <a:lnTo>
                  <a:pt x="3365" y="738"/>
                </a:lnTo>
                <a:lnTo>
                  <a:pt x="3367" y="738"/>
                </a:lnTo>
                <a:lnTo>
                  <a:pt x="3369" y="738"/>
                </a:lnTo>
                <a:lnTo>
                  <a:pt x="3371" y="739"/>
                </a:lnTo>
                <a:lnTo>
                  <a:pt x="3374" y="739"/>
                </a:lnTo>
                <a:lnTo>
                  <a:pt x="3376" y="739"/>
                </a:lnTo>
                <a:lnTo>
                  <a:pt x="3380" y="739"/>
                </a:lnTo>
                <a:lnTo>
                  <a:pt x="3382" y="739"/>
                </a:lnTo>
                <a:lnTo>
                  <a:pt x="3384" y="738"/>
                </a:lnTo>
                <a:lnTo>
                  <a:pt x="3386" y="738"/>
                </a:lnTo>
                <a:lnTo>
                  <a:pt x="3388" y="738"/>
                </a:lnTo>
                <a:lnTo>
                  <a:pt x="3391" y="737"/>
                </a:lnTo>
                <a:lnTo>
                  <a:pt x="3393" y="736"/>
                </a:lnTo>
                <a:lnTo>
                  <a:pt x="3395" y="736"/>
                </a:lnTo>
                <a:lnTo>
                  <a:pt x="3397" y="735"/>
                </a:lnTo>
                <a:lnTo>
                  <a:pt x="3399" y="735"/>
                </a:lnTo>
                <a:lnTo>
                  <a:pt x="3402" y="734"/>
                </a:lnTo>
                <a:lnTo>
                  <a:pt x="3404" y="734"/>
                </a:lnTo>
                <a:lnTo>
                  <a:pt x="3405" y="734"/>
                </a:lnTo>
                <a:lnTo>
                  <a:pt x="3407" y="734"/>
                </a:lnTo>
                <a:lnTo>
                  <a:pt x="3410" y="734"/>
                </a:lnTo>
                <a:lnTo>
                  <a:pt x="3412" y="734"/>
                </a:lnTo>
                <a:lnTo>
                  <a:pt x="3414" y="734"/>
                </a:lnTo>
                <a:lnTo>
                  <a:pt x="3416" y="735"/>
                </a:lnTo>
                <a:lnTo>
                  <a:pt x="3418" y="736"/>
                </a:lnTo>
                <a:lnTo>
                  <a:pt x="3421" y="736"/>
                </a:lnTo>
                <a:lnTo>
                  <a:pt x="3423" y="737"/>
                </a:lnTo>
                <a:lnTo>
                  <a:pt x="3425" y="737"/>
                </a:lnTo>
                <a:lnTo>
                  <a:pt x="3427" y="738"/>
                </a:lnTo>
                <a:lnTo>
                  <a:pt x="3429" y="738"/>
                </a:lnTo>
                <a:lnTo>
                  <a:pt x="3431" y="738"/>
                </a:lnTo>
                <a:lnTo>
                  <a:pt x="3433" y="738"/>
                </a:lnTo>
                <a:lnTo>
                  <a:pt x="3435" y="739"/>
                </a:lnTo>
                <a:lnTo>
                  <a:pt x="3438" y="740"/>
                </a:lnTo>
                <a:lnTo>
                  <a:pt x="3440" y="740"/>
                </a:lnTo>
                <a:lnTo>
                  <a:pt x="3442" y="740"/>
                </a:lnTo>
                <a:lnTo>
                  <a:pt x="3444" y="740"/>
                </a:lnTo>
                <a:lnTo>
                  <a:pt x="3446" y="740"/>
                </a:lnTo>
                <a:lnTo>
                  <a:pt x="3448" y="740"/>
                </a:lnTo>
                <a:lnTo>
                  <a:pt x="3450" y="740"/>
                </a:lnTo>
                <a:lnTo>
                  <a:pt x="3452" y="740"/>
                </a:lnTo>
                <a:lnTo>
                  <a:pt x="3454" y="739"/>
                </a:lnTo>
                <a:lnTo>
                  <a:pt x="3457" y="739"/>
                </a:lnTo>
                <a:lnTo>
                  <a:pt x="3459" y="738"/>
                </a:lnTo>
                <a:lnTo>
                  <a:pt x="3461" y="738"/>
                </a:lnTo>
                <a:lnTo>
                  <a:pt x="3463" y="738"/>
                </a:lnTo>
                <a:lnTo>
                  <a:pt x="3465" y="737"/>
                </a:lnTo>
                <a:lnTo>
                  <a:pt x="3468" y="737"/>
                </a:lnTo>
                <a:lnTo>
                  <a:pt x="3470" y="736"/>
                </a:lnTo>
                <a:lnTo>
                  <a:pt x="3471" y="736"/>
                </a:lnTo>
                <a:lnTo>
                  <a:pt x="3474" y="736"/>
                </a:lnTo>
                <a:lnTo>
                  <a:pt x="3476" y="736"/>
                </a:lnTo>
                <a:lnTo>
                  <a:pt x="3480" y="736"/>
                </a:lnTo>
                <a:lnTo>
                  <a:pt x="3482" y="736"/>
                </a:lnTo>
                <a:lnTo>
                  <a:pt x="3485" y="736"/>
                </a:lnTo>
                <a:lnTo>
                  <a:pt x="3487" y="737"/>
                </a:lnTo>
                <a:lnTo>
                  <a:pt x="3489" y="737"/>
                </a:lnTo>
                <a:lnTo>
                  <a:pt x="3493" y="737"/>
                </a:lnTo>
                <a:lnTo>
                  <a:pt x="3495" y="737"/>
                </a:lnTo>
                <a:lnTo>
                  <a:pt x="3497" y="736"/>
                </a:lnTo>
                <a:lnTo>
                  <a:pt x="3499" y="736"/>
                </a:lnTo>
                <a:lnTo>
                  <a:pt x="3501" y="735"/>
                </a:lnTo>
                <a:lnTo>
                  <a:pt x="3504" y="734"/>
                </a:lnTo>
                <a:lnTo>
                  <a:pt x="3506" y="733"/>
                </a:lnTo>
                <a:lnTo>
                  <a:pt x="3508" y="732"/>
                </a:lnTo>
                <a:lnTo>
                  <a:pt x="3510" y="731"/>
                </a:lnTo>
                <a:lnTo>
                  <a:pt x="3513" y="729"/>
                </a:lnTo>
                <a:lnTo>
                  <a:pt x="3514" y="727"/>
                </a:lnTo>
                <a:lnTo>
                  <a:pt x="3516" y="727"/>
                </a:lnTo>
                <a:lnTo>
                  <a:pt x="3518" y="725"/>
                </a:lnTo>
                <a:lnTo>
                  <a:pt x="3521" y="725"/>
                </a:lnTo>
                <a:lnTo>
                  <a:pt x="3523" y="725"/>
                </a:lnTo>
                <a:lnTo>
                  <a:pt x="3525" y="725"/>
                </a:lnTo>
                <a:lnTo>
                  <a:pt x="3527" y="726"/>
                </a:lnTo>
                <a:lnTo>
                  <a:pt x="3529" y="727"/>
                </a:lnTo>
                <a:lnTo>
                  <a:pt x="3532" y="727"/>
                </a:lnTo>
                <a:lnTo>
                  <a:pt x="3534" y="729"/>
                </a:lnTo>
                <a:lnTo>
                  <a:pt x="3535" y="730"/>
                </a:lnTo>
                <a:lnTo>
                  <a:pt x="3538" y="731"/>
                </a:lnTo>
                <a:lnTo>
                  <a:pt x="3540" y="733"/>
                </a:lnTo>
                <a:lnTo>
                  <a:pt x="3542" y="734"/>
                </a:lnTo>
                <a:lnTo>
                  <a:pt x="3544" y="735"/>
                </a:lnTo>
                <a:lnTo>
                  <a:pt x="3546" y="736"/>
                </a:lnTo>
                <a:lnTo>
                  <a:pt x="3549" y="738"/>
                </a:lnTo>
                <a:lnTo>
                  <a:pt x="3551" y="738"/>
                </a:lnTo>
                <a:lnTo>
                  <a:pt x="3553" y="739"/>
                </a:lnTo>
                <a:lnTo>
                  <a:pt x="3555" y="740"/>
                </a:lnTo>
                <a:lnTo>
                  <a:pt x="3557" y="740"/>
                </a:lnTo>
                <a:lnTo>
                  <a:pt x="3559" y="740"/>
                </a:lnTo>
                <a:lnTo>
                  <a:pt x="3561" y="740"/>
                </a:lnTo>
                <a:lnTo>
                  <a:pt x="3563" y="741"/>
                </a:lnTo>
                <a:lnTo>
                  <a:pt x="3565" y="741"/>
                </a:lnTo>
                <a:lnTo>
                  <a:pt x="3568" y="740"/>
                </a:lnTo>
                <a:lnTo>
                  <a:pt x="3570" y="740"/>
                </a:lnTo>
                <a:lnTo>
                  <a:pt x="3572" y="740"/>
                </a:lnTo>
                <a:lnTo>
                  <a:pt x="3574" y="740"/>
                </a:lnTo>
                <a:lnTo>
                  <a:pt x="3576" y="740"/>
                </a:lnTo>
                <a:lnTo>
                  <a:pt x="3578" y="740"/>
                </a:lnTo>
                <a:lnTo>
                  <a:pt x="3582" y="740"/>
                </a:lnTo>
                <a:lnTo>
                  <a:pt x="3585" y="740"/>
                </a:lnTo>
                <a:lnTo>
                  <a:pt x="3587" y="739"/>
                </a:lnTo>
                <a:lnTo>
                  <a:pt x="3589" y="738"/>
                </a:lnTo>
                <a:lnTo>
                  <a:pt x="3591" y="738"/>
                </a:lnTo>
                <a:lnTo>
                  <a:pt x="3593" y="738"/>
                </a:lnTo>
                <a:lnTo>
                  <a:pt x="3596" y="737"/>
                </a:lnTo>
                <a:lnTo>
                  <a:pt x="3598" y="737"/>
                </a:lnTo>
                <a:lnTo>
                  <a:pt x="3600" y="737"/>
                </a:lnTo>
                <a:lnTo>
                  <a:pt x="3601" y="737"/>
                </a:lnTo>
                <a:lnTo>
                  <a:pt x="3604" y="736"/>
                </a:lnTo>
                <a:lnTo>
                  <a:pt x="3606" y="736"/>
                </a:lnTo>
                <a:lnTo>
                  <a:pt x="3608" y="736"/>
                </a:lnTo>
                <a:lnTo>
                  <a:pt x="3610" y="736"/>
                </a:lnTo>
                <a:lnTo>
                  <a:pt x="3612" y="735"/>
                </a:lnTo>
                <a:lnTo>
                  <a:pt x="3615" y="734"/>
                </a:lnTo>
                <a:lnTo>
                  <a:pt x="3617" y="733"/>
                </a:lnTo>
                <a:lnTo>
                  <a:pt x="3619" y="733"/>
                </a:lnTo>
                <a:lnTo>
                  <a:pt x="3621" y="732"/>
                </a:lnTo>
                <a:lnTo>
                  <a:pt x="3623" y="731"/>
                </a:lnTo>
                <a:lnTo>
                  <a:pt x="3625" y="731"/>
                </a:lnTo>
                <a:lnTo>
                  <a:pt x="3627" y="731"/>
                </a:lnTo>
                <a:lnTo>
                  <a:pt x="3629" y="730"/>
                </a:lnTo>
                <a:lnTo>
                  <a:pt x="3632" y="730"/>
                </a:lnTo>
                <a:lnTo>
                  <a:pt x="3634" y="730"/>
                </a:lnTo>
                <a:lnTo>
                  <a:pt x="3636" y="730"/>
                </a:lnTo>
                <a:lnTo>
                  <a:pt x="3638" y="731"/>
                </a:lnTo>
                <a:lnTo>
                  <a:pt x="3640" y="731"/>
                </a:lnTo>
                <a:lnTo>
                  <a:pt x="3643" y="731"/>
                </a:lnTo>
                <a:lnTo>
                  <a:pt x="3644" y="732"/>
                </a:lnTo>
                <a:lnTo>
                  <a:pt x="3646" y="732"/>
                </a:lnTo>
                <a:lnTo>
                  <a:pt x="3648" y="733"/>
                </a:lnTo>
                <a:lnTo>
                  <a:pt x="3651" y="733"/>
                </a:lnTo>
                <a:lnTo>
                  <a:pt x="3653" y="734"/>
                </a:lnTo>
                <a:lnTo>
                  <a:pt x="3655" y="734"/>
                </a:lnTo>
                <a:lnTo>
                  <a:pt x="3657" y="734"/>
                </a:lnTo>
                <a:lnTo>
                  <a:pt x="3660" y="734"/>
                </a:lnTo>
                <a:lnTo>
                  <a:pt x="3662" y="734"/>
                </a:lnTo>
                <a:lnTo>
                  <a:pt x="3664" y="734"/>
                </a:lnTo>
                <a:lnTo>
                  <a:pt x="3665" y="734"/>
                </a:lnTo>
                <a:lnTo>
                  <a:pt x="3668" y="734"/>
                </a:lnTo>
                <a:lnTo>
                  <a:pt x="3670" y="734"/>
                </a:lnTo>
                <a:lnTo>
                  <a:pt x="3672" y="734"/>
                </a:lnTo>
                <a:lnTo>
                  <a:pt x="3674" y="734"/>
                </a:lnTo>
                <a:lnTo>
                  <a:pt x="3676" y="735"/>
                </a:lnTo>
                <a:lnTo>
                  <a:pt x="3679" y="735"/>
                </a:lnTo>
                <a:lnTo>
                  <a:pt x="3681" y="735"/>
                </a:lnTo>
                <a:lnTo>
                  <a:pt x="3683" y="735"/>
                </a:lnTo>
                <a:lnTo>
                  <a:pt x="3685" y="736"/>
                </a:lnTo>
                <a:lnTo>
                  <a:pt x="3687" y="736"/>
                </a:lnTo>
                <a:lnTo>
                  <a:pt x="3689" y="737"/>
                </a:lnTo>
                <a:lnTo>
                  <a:pt x="3691" y="737"/>
                </a:lnTo>
                <a:lnTo>
                  <a:pt x="3693" y="738"/>
                </a:lnTo>
                <a:lnTo>
                  <a:pt x="3696" y="738"/>
                </a:lnTo>
                <a:lnTo>
                  <a:pt x="3698" y="738"/>
                </a:lnTo>
                <a:lnTo>
                  <a:pt x="3700" y="737"/>
                </a:lnTo>
                <a:lnTo>
                  <a:pt x="3702" y="737"/>
                </a:lnTo>
                <a:lnTo>
                  <a:pt x="3704" y="736"/>
                </a:lnTo>
                <a:lnTo>
                  <a:pt x="3707" y="735"/>
                </a:lnTo>
                <a:lnTo>
                  <a:pt x="3708" y="735"/>
                </a:lnTo>
                <a:lnTo>
                  <a:pt x="3710" y="734"/>
                </a:lnTo>
                <a:lnTo>
                  <a:pt x="3712" y="733"/>
                </a:lnTo>
                <a:lnTo>
                  <a:pt x="3715" y="732"/>
                </a:lnTo>
                <a:lnTo>
                  <a:pt x="3717" y="731"/>
                </a:lnTo>
                <a:lnTo>
                  <a:pt x="3719" y="730"/>
                </a:lnTo>
                <a:lnTo>
                  <a:pt x="3721" y="730"/>
                </a:lnTo>
                <a:lnTo>
                  <a:pt x="3723" y="729"/>
                </a:lnTo>
                <a:lnTo>
                  <a:pt x="3726" y="729"/>
                </a:lnTo>
                <a:lnTo>
                  <a:pt x="3728" y="729"/>
                </a:lnTo>
                <a:lnTo>
                  <a:pt x="3730" y="730"/>
                </a:lnTo>
                <a:lnTo>
                  <a:pt x="3732" y="731"/>
                </a:lnTo>
                <a:lnTo>
                  <a:pt x="3734" y="731"/>
                </a:lnTo>
                <a:lnTo>
                  <a:pt x="3736" y="732"/>
                </a:lnTo>
                <a:lnTo>
                  <a:pt x="3738" y="733"/>
                </a:lnTo>
                <a:lnTo>
                  <a:pt x="3740" y="734"/>
                </a:lnTo>
                <a:lnTo>
                  <a:pt x="3743" y="734"/>
                </a:lnTo>
                <a:lnTo>
                  <a:pt x="3745" y="736"/>
                </a:lnTo>
                <a:lnTo>
                  <a:pt x="3747" y="736"/>
                </a:lnTo>
                <a:lnTo>
                  <a:pt x="3749" y="737"/>
                </a:lnTo>
                <a:lnTo>
                  <a:pt x="3751" y="738"/>
                </a:lnTo>
                <a:lnTo>
                  <a:pt x="3753" y="738"/>
                </a:lnTo>
                <a:lnTo>
                  <a:pt x="3755" y="739"/>
                </a:lnTo>
                <a:lnTo>
                  <a:pt x="3757" y="740"/>
                </a:lnTo>
                <a:lnTo>
                  <a:pt x="3759" y="740"/>
                </a:lnTo>
                <a:lnTo>
                  <a:pt x="3762" y="740"/>
                </a:lnTo>
                <a:lnTo>
                  <a:pt x="3764" y="741"/>
                </a:lnTo>
                <a:lnTo>
                  <a:pt x="3766" y="741"/>
                </a:lnTo>
                <a:lnTo>
                  <a:pt x="3768" y="741"/>
                </a:lnTo>
                <a:lnTo>
                  <a:pt x="3770" y="741"/>
                </a:lnTo>
                <a:lnTo>
                  <a:pt x="3773" y="742"/>
                </a:lnTo>
                <a:lnTo>
                  <a:pt x="3774" y="742"/>
                </a:lnTo>
                <a:lnTo>
                  <a:pt x="3776" y="742"/>
                </a:lnTo>
                <a:lnTo>
                  <a:pt x="3779" y="742"/>
                </a:lnTo>
                <a:lnTo>
                  <a:pt x="3781" y="742"/>
                </a:lnTo>
                <a:lnTo>
                  <a:pt x="3783" y="742"/>
                </a:lnTo>
                <a:lnTo>
                  <a:pt x="3785" y="742"/>
                </a:lnTo>
                <a:lnTo>
                  <a:pt x="3787" y="742"/>
                </a:lnTo>
                <a:lnTo>
                  <a:pt x="3790" y="742"/>
                </a:lnTo>
                <a:lnTo>
                  <a:pt x="3792" y="741"/>
                </a:lnTo>
                <a:lnTo>
                  <a:pt x="3794" y="741"/>
                </a:lnTo>
                <a:lnTo>
                  <a:pt x="3795" y="741"/>
                </a:lnTo>
                <a:lnTo>
                  <a:pt x="3798" y="740"/>
                </a:lnTo>
                <a:lnTo>
                  <a:pt x="3800" y="740"/>
                </a:lnTo>
                <a:lnTo>
                  <a:pt x="3802" y="740"/>
                </a:lnTo>
                <a:lnTo>
                  <a:pt x="3804" y="739"/>
                </a:lnTo>
                <a:lnTo>
                  <a:pt x="3806" y="739"/>
                </a:lnTo>
                <a:lnTo>
                  <a:pt x="3809" y="739"/>
                </a:lnTo>
                <a:lnTo>
                  <a:pt x="3813" y="739"/>
                </a:lnTo>
                <a:lnTo>
                  <a:pt x="3815" y="739"/>
                </a:lnTo>
                <a:lnTo>
                  <a:pt x="3817" y="739"/>
                </a:lnTo>
                <a:lnTo>
                  <a:pt x="3819" y="739"/>
                </a:lnTo>
                <a:lnTo>
                  <a:pt x="3821" y="739"/>
                </a:lnTo>
                <a:lnTo>
                  <a:pt x="3826" y="739"/>
                </a:lnTo>
                <a:lnTo>
                  <a:pt x="3828" y="739"/>
                </a:lnTo>
                <a:lnTo>
                  <a:pt x="3830" y="739"/>
                </a:lnTo>
                <a:lnTo>
                  <a:pt x="3832" y="739"/>
                </a:lnTo>
                <a:lnTo>
                  <a:pt x="3834" y="739"/>
                </a:lnTo>
                <a:lnTo>
                  <a:pt x="3837" y="738"/>
                </a:lnTo>
                <a:lnTo>
                  <a:pt x="3839" y="738"/>
                </a:lnTo>
                <a:lnTo>
                  <a:pt x="3840" y="738"/>
                </a:lnTo>
                <a:lnTo>
                  <a:pt x="3843" y="737"/>
                </a:lnTo>
                <a:lnTo>
                  <a:pt x="3845" y="737"/>
                </a:lnTo>
                <a:lnTo>
                  <a:pt x="3847" y="737"/>
                </a:lnTo>
                <a:lnTo>
                  <a:pt x="3851" y="737"/>
                </a:lnTo>
                <a:lnTo>
                  <a:pt x="3854" y="737"/>
                </a:lnTo>
                <a:lnTo>
                  <a:pt x="3856" y="737"/>
                </a:lnTo>
                <a:lnTo>
                  <a:pt x="3858" y="738"/>
                </a:lnTo>
                <a:lnTo>
                  <a:pt x="3860" y="738"/>
                </a:lnTo>
                <a:lnTo>
                  <a:pt x="3862" y="739"/>
                </a:lnTo>
                <a:lnTo>
                  <a:pt x="3864" y="739"/>
                </a:lnTo>
                <a:lnTo>
                  <a:pt x="3866" y="739"/>
                </a:lnTo>
                <a:lnTo>
                  <a:pt x="3868" y="739"/>
                </a:lnTo>
                <a:lnTo>
                  <a:pt x="3870" y="740"/>
                </a:lnTo>
                <a:lnTo>
                  <a:pt x="3873" y="740"/>
                </a:lnTo>
                <a:lnTo>
                  <a:pt x="3875" y="740"/>
                </a:lnTo>
                <a:lnTo>
                  <a:pt x="3877" y="740"/>
                </a:lnTo>
                <a:lnTo>
                  <a:pt x="3879" y="741"/>
                </a:lnTo>
                <a:lnTo>
                  <a:pt x="3881" y="741"/>
                </a:lnTo>
                <a:lnTo>
                  <a:pt x="3883" y="741"/>
                </a:lnTo>
                <a:lnTo>
                  <a:pt x="3885" y="741"/>
                </a:lnTo>
                <a:lnTo>
                  <a:pt x="3890" y="740"/>
                </a:lnTo>
                <a:lnTo>
                  <a:pt x="3892" y="740"/>
                </a:lnTo>
                <a:lnTo>
                  <a:pt x="3894" y="740"/>
                </a:lnTo>
                <a:lnTo>
                  <a:pt x="3896" y="740"/>
                </a:lnTo>
                <a:lnTo>
                  <a:pt x="3898" y="740"/>
                </a:lnTo>
                <a:lnTo>
                  <a:pt x="3901" y="739"/>
                </a:lnTo>
                <a:lnTo>
                  <a:pt x="3903" y="739"/>
                </a:lnTo>
                <a:lnTo>
                  <a:pt x="3904" y="738"/>
                </a:lnTo>
                <a:lnTo>
                  <a:pt x="3906" y="738"/>
                </a:lnTo>
                <a:lnTo>
                  <a:pt x="3909" y="738"/>
                </a:lnTo>
                <a:lnTo>
                  <a:pt x="3911" y="738"/>
                </a:lnTo>
                <a:lnTo>
                  <a:pt x="3913" y="737"/>
                </a:lnTo>
                <a:lnTo>
                  <a:pt x="3915" y="737"/>
                </a:lnTo>
                <a:lnTo>
                  <a:pt x="3917" y="737"/>
                </a:lnTo>
                <a:lnTo>
                  <a:pt x="3920" y="737"/>
                </a:lnTo>
                <a:lnTo>
                  <a:pt x="3922" y="737"/>
                </a:lnTo>
                <a:lnTo>
                  <a:pt x="3924" y="738"/>
                </a:lnTo>
                <a:lnTo>
                  <a:pt x="3928" y="738"/>
                </a:lnTo>
                <a:lnTo>
                  <a:pt x="3930" y="738"/>
                </a:lnTo>
                <a:lnTo>
                  <a:pt x="3932" y="738"/>
                </a:lnTo>
                <a:lnTo>
                  <a:pt x="3934" y="737"/>
                </a:lnTo>
                <a:lnTo>
                  <a:pt x="3937" y="737"/>
                </a:lnTo>
                <a:lnTo>
                  <a:pt x="3939" y="736"/>
                </a:lnTo>
                <a:lnTo>
                  <a:pt x="3941" y="736"/>
                </a:lnTo>
                <a:lnTo>
                  <a:pt x="3943" y="735"/>
                </a:lnTo>
                <a:lnTo>
                  <a:pt x="3945" y="734"/>
                </a:lnTo>
                <a:lnTo>
                  <a:pt x="3947" y="732"/>
                </a:lnTo>
                <a:lnTo>
                  <a:pt x="3949" y="731"/>
                </a:lnTo>
                <a:lnTo>
                  <a:pt x="3951" y="730"/>
                </a:lnTo>
                <a:lnTo>
                  <a:pt x="3953" y="729"/>
                </a:lnTo>
                <a:lnTo>
                  <a:pt x="3956" y="727"/>
                </a:lnTo>
                <a:lnTo>
                  <a:pt x="3958" y="726"/>
                </a:lnTo>
                <a:lnTo>
                  <a:pt x="3960" y="725"/>
                </a:lnTo>
                <a:lnTo>
                  <a:pt x="3962" y="724"/>
                </a:lnTo>
                <a:lnTo>
                  <a:pt x="3965" y="724"/>
                </a:lnTo>
                <a:lnTo>
                  <a:pt x="3967" y="724"/>
                </a:lnTo>
                <a:lnTo>
                  <a:pt x="3969" y="724"/>
                </a:lnTo>
                <a:lnTo>
                  <a:pt x="3970" y="725"/>
                </a:lnTo>
                <a:lnTo>
                  <a:pt x="3973" y="725"/>
                </a:lnTo>
                <a:lnTo>
                  <a:pt x="3975" y="726"/>
                </a:lnTo>
                <a:lnTo>
                  <a:pt x="3977" y="727"/>
                </a:lnTo>
                <a:lnTo>
                  <a:pt x="3979" y="729"/>
                </a:lnTo>
                <a:lnTo>
                  <a:pt x="3981" y="731"/>
                </a:lnTo>
                <a:lnTo>
                  <a:pt x="3984" y="732"/>
                </a:lnTo>
                <a:lnTo>
                  <a:pt x="3986" y="734"/>
                </a:lnTo>
                <a:lnTo>
                  <a:pt x="3988" y="736"/>
                </a:lnTo>
                <a:lnTo>
                  <a:pt x="3990" y="737"/>
                </a:lnTo>
                <a:lnTo>
                  <a:pt x="3992" y="738"/>
                </a:lnTo>
                <a:lnTo>
                  <a:pt x="3994" y="740"/>
                </a:lnTo>
                <a:lnTo>
                  <a:pt x="3996" y="740"/>
                </a:lnTo>
                <a:lnTo>
                  <a:pt x="3998" y="740"/>
                </a:lnTo>
                <a:lnTo>
                  <a:pt x="4001" y="741"/>
                </a:lnTo>
                <a:lnTo>
                  <a:pt x="4003" y="741"/>
                </a:lnTo>
                <a:lnTo>
                  <a:pt x="4005" y="742"/>
                </a:lnTo>
                <a:lnTo>
                  <a:pt x="4007" y="742"/>
                </a:lnTo>
                <a:lnTo>
                  <a:pt x="4009" y="742"/>
                </a:lnTo>
                <a:lnTo>
                  <a:pt x="4012" y="742"/>
                </a:lnTo>
                <a:lnTo>
                  <a:pt x="4013" y="742"/>
                </a:lnTo>
                <a:lnTo>
                  <a:pt x="4015" y="742"/>
                </a:lnTo>
                <a:lnTo>
                  <a:pt x="4017" y="742"/>
                </a:lnTo>
                <a:lnTo>
                  <a:pt x="4020" y="742"/>
                </a:lnTo>
                <a:lnTo>
                  <a:pt x="4022" y="742"/>
                </a:lnTo>
                <a:lnTo>
                  <a:pt x="4024" y="741"/>
                </a:lnTo>
                <a:lnTo>
                  <a:pt x="4026" y="741"/>
                </a:lnTo>
                <a:lnTo>
                  <a:pt x="4028" y="741"/>
                </a:lnTo>
                <a:lnTo>
                  <a:pt x="4031" y="741"/>
                </a:lnTo>
                <a:lnTo>
                  <a:pt x="4033" y="741"/>
                </a:lnTo>
                <a:lnTo>
                  <a:pt x="4034" y="741"/>
                </a:lnTo>
                <a:lnTo>
                  <a:pt x="4037" y="741"/>
                </a:lnTo>
                <a:lnTo>
                  <a:pt x="4039" y="741"/>
                </a:lnTo>
                <a:lnTo>
                  <a:pt x="4041" y="742"/>
                </a:lnTo>
                <a:lnTo>
                  <a:pt x="4043" y="742"/>
                </a:lnTo>
                <a:lnTo>
                  <a:pt x="4045" y="742"/>
                </a:lnTo>
                <a:lnTo>
                  <a:pt x="4048" y="742"/>
                </a:lnTo>
                <a:lnTo>
                  <a:pt x="4050" y="742"/>
                </a:lnTo>
                <a:lnTo>
                  <a:pt x="4052" y="742"/>
                </a:lnTo>
                <a:lnTo>
                  <a:pt x="4054" y="742"/>
                </a:lnTo>
                <a:lnTo>
                  <a:pt x="4056" y="742"/>
                </a:lnTo>
                <a:lnTo>
                  <a:pt x="4058" y="742"/>
                </a:lnTo>
                <a:lnTo>
                  <a:pt x="4060" y="742"/>
                </a:lnTo>
                <a:lnTo>
                  <a:pt x="4062" y="742"/>
                </a:lnTo>
                <a:lnTo>
                  <a:pt x="4064" y="742"/>
                </a:lnTo>
                <a:lnTo>
                  <a:pt x="4067" y="743"/>
                </a:lnTo>
                <a:lnTo>
                  <a:pt x="4069" y="743"/>
                </a:lnTo>
                <a:lnTo>
                  <a:pt x="4071" y="743"/>
                </a:lnTo>
                <a:lnTo>
                  <a:pt x="4073" y="743"/>
                </a:lnTo>
                <a:lnTo>
                  <a:pt x="4075" y="743"/>
                </a:lnTo>
                <a:lnTo>
                  <a:pt x="4077" y="743"/>
                </a:lnTo>
                <a:lnTo>
                  <a:pt x="4081" y="742"/>
                </a:lnTo>
                <a:lnTo>
                  <a:pt x="4084" y="742"/>
                </a:lnTo>
                <a:lnTo>
                  <a:pt x="4086" y="742"/>
                </a:lnTo>
                <a:lnTo>
                  <a:pt x="4088" y="742"/>
                </a:lnTo>
                <a:lnTo>
                  <a:pt x="4090" y="742"/>
                </a:lnTo>
                <a:lnTo>
                  <a:pt x="4092" y="742"/>
                </a:lnTo>
                <a:lnTo>
                  <a:pt x="4095" y="742"/>
                </a:lnTo>
                <a:lnTo>
                  <a:pt x="4097" y="742"/>
                </a:lnTo>
                <a:lnTo>
                  <a:pt x="4099" y="742"/>
                </a:lnTo>
                <a:lnTo>
                  <a:pt x="4100" y="742"/>
                </a:lnTo>
                <a:lnTo>
                  <a:pt x="4103" y="742"/>
                </a:lnTo>
                <a:lnTo>
                  <a:pt x="4107" y="742"/>
                </a:lnTo>
                <a:lnTo>
                  <a:pt x="4109" y="742"/>
                </a:lnTo>
                <a:lnTo>
                  <a:pt x="4111" y="742"/>
                </a:lnTo>
                <a:lnTo>
                  <a:pt x="4114" y="741"/>
                </a:lnTo>
                <a:lnTo>
                  <a:pt x="4116" y="741"/>
                </a:lnTo>
                <a:lnTo>
                  <a:pt x="4118" y="741"/>
                </a:lnTo>
                <a:lnTo>
                  <a:pt x="4120" y="741"/>
                </a:lnTo>
                <a:lnTo>
                  <a:pt x="4122" y="741"/>
                </a:lnTo>
                <a:lnTo>
                  <a:pt x="4124" y="740"/>
                </a:lnTo>
                <a:lnTo>
                  <a:pt x="4126" y="740"/>
                </a:lnTo>
                <a:lnTo>
                  <a:pt x="4128" y="740"/>
                </a:lnTo>
                <a:lnTo>
                  <a:pt x="4131" y="740"/>
                </a:lnTo>
                <a:lnTo>
                  <a:pt x="4133" y="740"/>
                </a:lnTo>
                <a:lnTo>
                  <a:pt x="4135" y="739"/>
                </a:lnTo>
                <a:lnTo>
                  <a:pt x="4137" y="739"/>
                </a:lnTo>
                <a:lnTo>
                  <a:pt x="4139" y="739"/>
                </a:lnTo>
                <a:lnTo>
                  <a:pt x="4142" y="738"/>
                </a:lnTo>
                <a:lnTo>
                  <a:pt x="4145" y="738"/>
                </a:lnTo>
                <a:lnTo>
                  <a:pt x="4148" y="738"/>
                </a:lnTo>
                <a:lnTo>
                  <a:pt x="4150" y="738"/>
                </a:lnTo>
                <a:lnTo>
                  <a:pt x="4152" y="738"/>
                </a:lnTo>
                <a:lnTo>
                  <a:pt x="4154" y="737"/>
                </a:lnTo>
                <a:lnTo>
                  <a:pt x="4156" y="737"/>
                </a:lnTo>
                <a:lnTo>
                  <a:pt x="4159" y="737"/>
                </a:lnTo>
                <a:lnTo>
                  <a:pt x="4161" y="738"/>
                </a:lnTo>
                <a:lnTo>
                  <a:pt x="4163" y="738"/>
                </a:lnTo>
                <a:lnTo>
                  <a:pt x="4164" y="738"/>
                </a:lnTo>
                <a:lnTo>
                  <a:pt x="4167" y="738"/>
                </a:lnTo>
                <a:lnTo>
                  <a:pt x="4169" y="738"/>
                </a:lnTo>
                <a:lnTo>
                  <a:pt x="4171" y="738"/>
                </a:lnTo>
                <a:lnTo>
                  <a:pt x="4173" y="738"/>
                </a:lnTo>
                <a:lnTo>
                  <a:pt x="4175" y="738"/>
                </a:lnTo>
                <a:lnTo>
                  <a:pt x="4178" y="738"/>
                </a:lnTo>
                <a:lnTo>
                  <a:pt x="4180" y="738"/>
                </a:lnTo>
                <a:lnTo>
                  <a:pt x="4182" y="738"/>
                </a:lnTo>
                <a:lnTo>
                  <a:pt x="4184" y="738"/>
                </a:lnTo>
                <a:lnTo>
                  <a:pt x="4186" y="739"/>
                </a:lnTo>
                <a:lnTo>
                  <a:pt x="4188" y="739"/>
                </a:lnTo>
                <a:lnTo>
                  <a:pt x="4190" y="740"/>
                </a:lnTo>
                <a:lnTo>
                  <a:pt x="4192" y="740"/>
                </a:lnTo>
                <a:lnTo>
                  <a:pt x="4195" y="740"/>
                </a:lnTo>
                <a:lnTo>
                  <a:pt x="4197" y="741"/>
                </a:lnTo>
                <a:lnTo>
                  <a:pt x="4199" y="741"/>
                </a:lnTo>
                <a:lnTo>
                  <a:pt x="4201" y="742"/>
                </a:lnTo>
                <a:lnTo>
                  <a:pt x="4203" y="742"/>
                </a:lnTo>
                <a:lnTo>
                  <a:pt x="4206" y="742"/>
                </a:lnTo>
                <a:lnTo>
                  <a:pt x="4209" y="742"/>
                </a:lnTo>
                <a:lnTo>
                  <a:pt x="4211" y="742"/>
                </a:lnTo>
                <a:lnTo>
                  <a:pt x="4214" y="742"/>
                </a:lnTo>
                <a:lnTo>
                  <a:pt x="4216" y="742"/>
                </a:lnTo>
                <a:lnTo>
                  <a:pt x="4218" y="742"/>
                </a:lnTo>
                <a:lnTo>
                  <a:pt x="4220" y="742"/>
                </a:lnTo>
                <a:lnTo>
                  <a:pt x="4222" y="742"/>
                </a:lnTo>
                <a:lnTo>
                  <a:pt x="4225" y="742"/>
                </a:lnTo>
                <a:lnTo>
                  <a:pt x="4227" y="742"/>
                </a:lnTo>
                <a:lnTo>
                  <a:pt x="4229" y="742"/>
                </a:lnTo>
                <a:lnTo>
                  <a:pt x="4231" y="742"/>
                </a:lnTo>
                <a:lnTo>
                  <a:pt x="4233" y="742"/>
                </a:lnTo>
                <a:lnTo>
                  <a:pt x="4235" y="743"/>
                </a:lnTo>
                <a:lnTo>
                  <a:pt x="4237" y="743"/>
                </a:lnTo>
                <a:lnTo>
                  <a:pt x="4239" y="743"/>
                </a:lnTo>
                <a:lnTo>
                  <a:pt x="4242" y="743"/>
                </a:lnTo>
                <a:lnTo>
                  <a:pt x="4244" y="743"/>
                </a:lnTo>
                <a:lnTo>
                  <a:pt x="4248" y="743"/>
                </a:lnTo>
                <a:lnTo>
                  <a:pt x="4250" y="743"/>
                </a:lnTo>
                <a:lnTo>
                  <a:pt x="4252" y="743"/>
                </a:lnTo>
                <a:lnTo>
                  <a:pt x="4254" y="742"/>
                </a:lnTo>
                <a:lnTo>
                  <a:pt x="4256" y="741"/>
                </a:lnTo>
                <a:lnTo>
                  <a:pt x="4258" y="740"/>
                </a:lnTo>
                <a:lnTo>
                  <a:pt x="4261" y="739"/>
                </a:lnTo>
                <a:lnTo>
                  <a:pt x="4263" y="737"/>
                </a:lnTo>
                <a:lnTo>
                  <a:pt x="4265" y="735"/>
                </a:lnTo>
                <a:lnTo>
                  <a:pt x="4267" y="733"/>
                </a:lnTo>
                <a:lnTo>
                  <a:pt x="4270" y="731"/>
                </a:lnTo>
                <a:lnTo>
                  <a:pt x="4272" y="727"/>
                </a:lnTo>
                <a:lnTo>
                  <a:pt x="4273" y="724"/>
                </a:lnTo>
                <a:lnTo>
                  <a:pt x="4275" y="721"/>
                </a:lnTo>
                <a:lnTo>
                  <a:pt x="4278" y="718"/>
                </a:lnTo>
                <a:lnTo>
                  <a:pt x="4280" y="716"/>
                </a:lnTo>
                <a:lnTo>
                  <a:pt x="4282" y="714"/>
                </a:lnTo>
                <a:lnTo>
                  <a:pt x="4284" y="713"/>
                </a:lnTo>
                <a:lnTo>
                  <a:pt x="4286" y="713"/>
                </a:lnTo>
                <a:lnTo>
                  <a:pt x="4289" y="713"/>
                </a:lnTo>
                <a:lnTo>
                  <a:pt x="4291" y="714"/>
                </a:lnTo>
                <a:lnTo>
                  <a:pt x="4293" y="716"/>
                </a:lnTo>
                <a:lnTo>
                  <a:pt x="4294" y="718"/>
                </a:lnTo>
                <a:lnTo>
                  <a:pt x="4297" y="721"/>
                </a:lnTo>
                <a:lnTo>
                  <a:pt x="4299" y="723"/>
                </a:lnTo>
                <a:lnTo>
                  <a:pt x="4301" y="726"/>
                </a:lnTo>
                <a:lnTo>
                  <a:pt x="4303" y="729"/>
                </a:lnTo>
                <a:lnTo>
                  <a:pt x="4306" y="731"/>
                </a:lnTo>
                <a:lnTo>
                  <a:pt x="4308" y="733"/>
                </a:lnTo>
                <a:lnTo>
                  <a:pt x="4310" y="735"/>
                </a:lnTo>
                <a:lnTo>
                  <a:pt x="4312" y="737"/>
                </a:lnTo>
                <a:lnTo>
                  <a:pt x="4314" y="738"/>
                </a:lnTo>
                <a:lnTo>
                  <a:pt x="4316" y="740"/>
                </a:lnTo>
                <a:lnTo>
                  <a:pt x="4318" y="740"/>
                </a:lnTo>
                <a:lnTo>
                  <a:pt x="4320" y="741"/>
                </a:lnTo>
                <a:lnTo>
                  <a:pt x="4322" y="742"/>
                </a:lnTo>
                <a:lnTo>
                  <a:pt x="4325" y="742"/>
                </a:lnTo>
                <a:lnTo>
                  <a:pt x="4327" y="743"/>
                </a:lnTo>
                <a:lnTo>
                  <a:pt x="4329" y="743"/>
                </a:lnTo>
                <a:lnTo>
                  <a:pt x="4331" y="744"/>
                </a:lnTo>
                <a:lnTo>
                  <a:pt x="4333" y="744"/>
                </a:lnTo>
                <a:lnTo>
                  <a:pt x="4336" y="744"/>
                </a:lnTo>
                <a:lnTo>
                  <a:pt x="4337" y="744"/>
                </a:lnTo>
                <a:lnTo>
                  <a:pt x="4339" y="744"/>
                </a:lnTo>
                <a:lnTo>
                  <a:pt x="4342" y="744"/>
                </a:lnTo>
                <a:lnTo>
                  <a:pt x="4344" y="744"/>
                </a:lnTo>
                <a:lnTo>
                  <a:pt x="4346" y="745"/>
                </a:lnTo>
                <a:lnTo>
                  <a:pt x="4348" y="745"/>
                </a:lnTo>
                <a:lnTo>
                  <a:pt x="4350" y="745"/>
                </a:lnTo>
                <a:lnTo>
                  <a:pt x="4353" y="744"/>
                </a:lnTo>
                <a:lnTo>
                  <a:pt x="4355" y="744"/>
                </a:lnTo>
                <a:lnTo>
                  <a:pt x="4357" y="744"/>
                </a:lnTo>
                <a:lnTo>
                  <a:pt x="4359" y="744"/>
                </a:lnTo>
                <a:lnTo>
                  <a:pt x="4361" y="744"/>
                </a:lnTo>
                <a:lnTo>
                  <a:pt x="4363" y="744"/>
                </a:lnTo>
                <a:lnTo>
                  <a:pt x="4365" y="744"/>
                </a:lnTo>
                <a:lnTo>
                  <a:pt x="4367" y="744"/>
                </a:lnTo>
                <a:lnTo>
                  <a:pt x="4369" y="744"/>
                </a:lnTo>
                <a:lnTo>
                  <a:pt x="4372" y="744"/>
                </a:lnTo>
                <a:lnTo>
                  <a:pt x="4374" y="744"/>
                </a:lnTo>
                <a:lnTo>
                  <a:pt x="4376" y="744"/>
                </a:lnTo>
                <a:lnTo>
                  <a:pt x="4378" y="744"/>
                </a:lnTo>
                <a:lnTo>
                  <a:pt x="4380" y="743"/>
                </a:lnTo>
                <a:lnTo>
                  <a:pt x="4382" y="743"/>
                </a:lnTo>
                <a:lnTo>
                  <a:pt x="4384" y="743"/>
                </a:lnTo>
                <a:lnTo>
                  <a:pt x="4386" y="743"/>
                </a:lnTo>
                <a:lnTo>
                  <a:pt x="4389" y="742"/>
                </a:lnTo>
                <a:lnTo>
                  <a:pt x="4391" y="742"/>
                </a:lnTo>
                <a:lnTo>
                  <a:pt x="4393" y="742"/>
                </a:lnTo>
                <a:lnTo>
                  <a:pt x="4395" y="742"/>
                </a:lnTo>
                <a:lnTo>
                  <a:pt x="4397" y="741"/>
                </a:lnTo>
                <a:lnTo>
                  <a:pt x="4400" y="741"/>
                </a:lnTo>
                <a:lnTo>
                  <a:pt x="4402" y="740"/>
                </a:lnTo>
                <a:lnTo>
                  <a:pt x="4403" y="740"/>
                </a:lnTo>
                <a:lnTo>
                  <a:pt x="4405" y="740"/>
                </a:lnTo>
                <a:lnTo>
                  <a:pt x="4408" y="740"/>
                </a:lnTo>
                <a:lnTo>
                  <a:pt x="4410" y="740"/>
                </a:lnTo>
                <a:lnTo>
                  <a:pt x="4412" y="740"/>
                </a:lnTo>
                <a:lnTo>
                  <a:pt x="4414" y="740"/>
                </a:lnTo>
                <a:lnTo>
                  <a:pt x="4416" y="740"/>
                </a:lnTo>
                <a:lnTo>
                  <a:pt x="4419" y="740"/>
                </a:lnTo>
                <a:lnTo>
                  <a:pt x="4421" y="740"/>
                </a:lnTo>
                <a:lnTo>
                  <a:pt x="4423" y="740"/>
                </a:lnTo>
                <a:lnTo>
                  <a:pt x="4425" y="741"/>
                </a:lnTo>
                <a:lnTo>
                  <a:pt x="4427" y="742"/>
                </a:lnTo>
                <a:lnTo>
                  <a:pt x="4429" y="742"/>
                </a:lnTo>
                <a:lnTo>
                  <a:pt x="4431" y="742"/>
                </a:lnTo>
                <a:lnTo>
                  <a:pt x="4433" y="742"/>
                </a:lnTo>
                <a:lnTo>
                  <a:pt x="4438" y="742"/>
                </a:lnTo>
                <a:lnTo>
                  <a:pt x="4440" y="742"/>
                </a:lnTo>
                <a:lnTo>
                  <a:pt x="4442" y="741"/>
                </a:lnTo>
                <a:lnTo>
                  <a:pt x="4444" y="740"/>
                </a:lnTo>
                <a:lnTo>
                  <a:pt x="4446" y="740"/>
                </a:lnTo>
                <a:lnTo>
                  <a:pt x="4448" y="739"/>
                </a:lnTo>
                <a:lnTo>
                  <a:pt x="4450" y="738"/>
                </a:lnTo>
                <a:lnTo>
                  <a:pt x="4453" y="738"/>
                </a:lnTo>
                <a:lnTo>
                  <a:pt x="4455" y="737"/>
                </a:lnTo>
                <a:lnTo>
                  <a:pt x="4457" y="737"/>
                </a:lnTo>
                <a:lnTo>
                  <a:pt x="4459" y="737"/>
                </a:lnTo>
                <a:lnTo>
                  <a:pt x="4461" y="736"/>
                </a:lnTo>
                <a:lnTo>
                  <a:pt x="4464" y="736"/>
                </a:lnTo>
                <a:lnTo>
                  <a:pt x="4466" y="736"/>
                </a:lnTo>
                <a:lnTo>
                  <a:pt x="4467" y="736"/>
                </a:lnTo>
                <a:lnTo>
                  <a:pt x="4469" y="736"/>
                </a:lnTo>
                <a:lnTo>
                  <a:pt x="4472" y="737"/>
                </a:lnTo>
                <a:lnTo>
                  <a:pt x="4474" y="737"/>
                </a:lnTo>
                <a:lnTo>
                  <a:pt x="4476" y="737"/>
                </a:lnTo>
                <a:lnTo>
                  <a:pt x="4478" y="737"/>
                </a:lnTo>
                <a:lnTo>
                  <a:pt x="4480" y="737"/>
                </a:lnTo>
                <a:lnTo>
                  <a:pt x="4483" y="737"/>
                </a:lnTo>
                <a:lnTo>
                  <a:pt x="4485" y="738"/>
                </a:lnTo>
                <a:lnTo>
                  <a:pt x="4487" y="738"/>
                </a:lnTo>
                <a:lnTo>
                  <a:pt x="4489" y="738"/>
                </a:lnTo>
                <a:lnTo>
                  <a:pt x="4491" y="739"/>
                </a:lnTo>
                <a:lnTo>
                  <a:pt x="4493" y="739"/>
                </a:lnTo>
                <a:lnTo>
                  <a:pt x="4495" y="740"/>
                </a:lnTo>
                <a:lnTo>
                  <a:pt x="4497" y="740"/>
                </a:lnTo>
                <a:lnTo>
                  <a:pt x="4500" y="740"/>
                </a:lnTo>
                <a:lnTo>
                  <a:pt x="4502" y="741"/>
                </a:lnTo>
                <a:lnTo>
                  <a:pt x="4504" y="741"/>
                </a:lnTo>
                <a:lnTo>
                  <a:pt x="4506" y="742"/>
                </a:lnTo>
                <a:lnTo>
                  <a:pt x="4508" y="742"/>
                </a:lnTo>
                <a:lnTo>
                  <a:pt x="4511" y="743"/>
                </a:lnTo>
                <a:lnTo>
                  <a:pt x="4512" y="743"/>
                </a:lnTo>
                <a:lnTo>
                  <a:pt x="4514" y="743"/>
                </a:lnTo>
                <a:lnTo>
                  <a:pt x="4516" y="744"/>
                </a:lnTo>
                <a:lnTo>
                  <a:pt x="4519" y="744"/>
                </a:lnTo>
                <a:lnTo>
                  <a:pt x="4521" y="744"/>
                </a:lnTo>
                <a:lnTo>
                  <a:pt x="4523" y="745"/>
                </a:lnTo>
                <a:lnTo>
                  <a:pt x="4525" y="745"/>
                </a:lnTo>
                <a:lnTo>
                  <a:pt x="4527" y="745"/>
                </a:lnTo>
                <a:lnTo>
                  <a:pt x="4530" y="745"/>
                </a:lnTo>
                <a:lnTo>
                  <a:pt x="4532" y="746"/>
                </a:lnTo>
                <a:lnTo>
                  <a:pt x="4533" y="746"/>
                </a:lnTo>
                <a:lnTo>
                  <a:pt x="4536" y="746"/>
                </a:lnTo>
                <a:lnTo>
                  <a:pt x="4538" y="746"/>
                </a:lnTo>
                <a:lnTo>
                  <a:pt x="4540" y="747"/>
                </a:lnTo>
                <a:lnTo>
                  <a:pt x="4542" y="747"/>
                </a:lnTo>
                <a:lnTo>
                  <a:pt x="4544" y="747"/>
                </a:lnTo>
                <a:lnTo>
                  <a:pt x="4547" y="747"/>
                </a:lnTo>
                <a:lnTo>
                  <a:pt x="4549" y="746"/>
                </a:lnTo>
                <a:lnTo>
                  <a:pt x="4551" y="746"/>
                </a:lnTo>
                <a:lnTo>
                  <a:pt x="4553" y="746"/>
                </a:lnTo>
                <a:lnTo>
                  <a:pt x="4555" y="745"/>
                </a:lnTo>
                <a:lnTo>
                  <a:pt x="4557" y="745"/>
                </a:lnTo>
                <a:lnTo>
                  <a:pt x="4559" y="745"/>
                </a:lnTo>
                <a:lnTo>
                  <a:pt x="4561" y="745"/>
                </a:lnTo>
                <a:lnTo>
                  <a:pt x="4566" y="745"/>
                </a:lnTo>
                <a:lnTo>
                  <a:pt x="4568" y="745"/>
                </a:lnTo>
                <a:lnTo>
                  <a:pt x="4570" y="744"/>
                </a:lnTo>
                <a:lnTo>
                  <a:pt x="4572" y="744"/>
                </a:lnTo>
                <a:lnTo>
                  <a:pt x="4575" y="744"/>
                </a:lnTo>
                <a:lnTo>
                  <a:pt x="4578" y="743"/>
                </a:lnTo>
                <a:lnTo>
                  <a:pt x="4580" y="743"/>
                </a:lnTo>
                <a:lnTo>
                  <a:pt x="4583" y="743"/>
                </a:lnTo>
                <a:lnTo>
                  <a:pt x="4585" y="742"/>
                </a:lnTo>
                <a:lnTo>
                  <a:pt x="4587" y="742"/>
                </a:lnTo>
                <a:lnTo>
                  <a:pt x="4589" y="742"/>
                </a:lnTo>
                <a:lnTo>
                  <a:pt x="4591" y="742"/>
                </a:lnTo>
                <a:lnTo>
                  <a:pt x="4594" y="742"/>
                </a:lnTo>
                <a:lnTo>
                  <a:pt x="4596" y="742"/>
                </a:lnTo>
                <a:lnTo>
                  <a:pt x="4597" y="742"/>
                </a:lnTo>
                <a:lnTo>
                  <a:pt x="4599" y="742"/>
                </a:lnTo>
                <a:lnTo>
                  <a:pt x="4604" y="742"/>
                </a:lnTo>
                <a:lnTo>
                  <a:pt x="4606" y="742"/>
                </a:lnTo>
                <a:lnTo>
                  <a:pt x="4608" y="742"/>
                </a:lnTo>
                <a:lnTo>
                  <a:pt x="4611" y="742"/>
                </a:lnTo>
                <a:lnTo>
                  <a:pt x="4613" y="742"/>
                </a:lnTo>
                <a:lnTo>
                  <a:pt x="4615" y="743"/>
                </a:lnTo>
                <a:lnTo>
                  <a:pt x="4617" y="743"/>
                </a:lnTo>
                <a:lnTo>
                  <a:pt x="4619" y="743"/>
                </a:lnTo>
                <a:lnTo>
                  <a:pt x="4621" y="744"/>
                </a:lnTo>
                <a:lnTo>
                  <a:pt x="4623" y="744"/>
                </a:lnTo>
                <a:lnTo>
                  <a:pt x="4625" y="744"/>
                </a:lnTo>
                <a:lnTo>
                  <a:pt x="4627" y="744"/>
                </a:lnTo>
                <a:lnTo>
                  <a:pt x="4630" y="744"/>
                </a:lnTo>
                <a:lnTo>
                  <a:pt x="4632" y="745"/>
                </a:lnTo>
                <a:lnTo>
                  <a:pt x="4634" y="745"/>
                </a:lnTo>
                <a:lnTo>
                  <a:pt x="4636" y="745"/>
                </a:lnTo>
                <a:lnTo>
                  <a:pt x="4638" y="745"/>
                </a:lnTo>
                <a:lnTo>
                  <a:pt x="4641" y="745"/>
                </a:lnTo>
                <a:lnTo>
                  <a:pt x="4642" y="745"/>
                </a:lnTo>
                <a:lnTo>
                  <a:pt x="4644" y="745"/>
                </a:lnTo>
                <a:lnTo>
                  <a:pt x="4647" y="745"/>
                </a:lnTo>
                <a:lnTo>
                  <a:pt x="4649" y="745"/>
                </a:lnTo>
                <a:lnTo>
                  <a:pt x="4651" y="745"/>
                </a:lnTo>
                <a:lnTo>
                  <a:pt x="4653" y="744"/>
                </a:lnTo>
                <a:lnTo>
                  <a:pt x="4655" y="744"/>
                </a:lnTo>
                <a:lnTo>
                  <a:pt x="4658" y="744"/>
                </a:lnTo>
                <a:lnTo>
                  <a:pt x="4660" y="744"/>
                </a:lnTo>
                <a:lnTo>
                  <a:pt x="4662" y="743"/>
                </a:lnTo>
                <a:lnTo>
                  <a:pt x="4663" y="743"/>
                </a:lnTo>
                <a:lnTo>
                  <a:pt x="4666" y="742"/>
                </a:lnTo>
                <a:lnTo>
                  <a:pt x="4668" y="742"/>
                </a:lnTo>
                <a:lnTo>
                  <a:pt x="4670" y="742"/>
                </a:lnTo>
                <a:lnTo>
                  <a:pt x="4672" y="742"/>
                </a:lnTo>
                <a:lnTo>
                  <a:pt x="4674" y="742"/>
                </a:lnTo>
                <a:lnTo>
                  <a:pt x="4677" y="742"/>
                </a:lnTo>
                <a:lnTo>
                  <a:pt x="4681" y="742"/>
                </a:lnTo>
                <a:lnTo>
                  <a:pt x="4683" y="742"/>
                </a:lnTo>
                <a:lnTo>
                  <a:pt x="4685" y="742"/>
                </a:lnTo>
                <a:lnTo>
                  <a:pt x="4687" y="742"/>
                </a:lnTo>
                <a:lnTo>
                  <a:pt x="4689" y="742"/>
                </a:lnTo>
                <a:lnTo>
                  <a:pt x="4691" y="742"/>
                </a:lnTo>
                <a:lnTo>
                  <a:pt x="4694" y="742"/>
                </a:lnTo>
                <a:lnTo>
                  <a:pt x="4696" y="742"/>
                </a:lnTo>
                <a:lnTo>
                  <a:pt x="4698" y="743"/>
                </a:lnTo>
                <a:lnTo>
                  <a:pt x="4700" y="743"/>
                </a:lnTo>
                <a:lnTo>
                  <a:pt x="4702" y="744"/>
                </a:lnTo>
                <a:lnTo>
                  <a:pt x="4705" y="744"/>
                </a:lnTo>
                <a:lnTo>
                  <a:pt x="4706" y="744"/>
                </a:lnTo>
                <a:lnTo>
                  <a:pt x="4708" y="745"/>
                </a:lnTo>
                <a:lnTo>
                  <a:pt x="4710" y="745"/>
                </a:lnTo>
                <a:lnTo>
                  <a:pt x="4713" y="745"/>
                </a:lnTo>
                <a:lnTo>
                  <a:pt x="4715" y="746"/>
                </a:lnTo>
                <a:lnTo>
                  <a:pt x="4717" y="746"/>
                </a:lnTo>
                <a:lnTo>
                  <a:pt x="4719" y="746"/>
                </a:lnTo>
                <a:lnTo>
                  <a:pt x="4721" y="747"/>
                </a:lnTo>
                <a:lnTo>
                  <a:pt x="4724" y="747"/>
                </a:lnTo>
                <a:lnTo>
                  <a:pt x="4726" y="746"/>
                </a:lnTo>
                <a:lnTo>
                  <a:pt x="4727" y="746"/>
                </a:lnTo>
                <a:lnTo>
                  <a:pt x="4732" y="746"/>
                </a:lnTo>
                <a:lnTo>
                  <a:pt x="4734" y="746"/>
                </a:lnTo>
                <a:lnTo>
                  <a:pt x="4736" y="747"/>
                </a:lnTo>
                <a:lnTo>
                  <a:pt x="4738" y="747"/>
                </a:lnTo>
                <a:lnTo>
                  <a:pt x="4741" y="746"/>
                </a:lnTo>
                <a:lnTo>
                  <a:pt x="4743" y="746"/>
                </a:lnTo>
                <a:lnTo>
                  <a:pt x="4745" y="746"/>
                </a:lnTo>
                <a:lnTo>
                  <a:pt x="4747" y="746"/>
                </a:lnTo>
                <a:lnTo>
                  <a:pt x="4749" y="745"/>
                </a:lnTo>
                <a:lnTo>
                  <a:pt x="4751" y="745"/>
                </a:lnTo>
                <a:lnTo>
                  <a:pt x="4753" y="745"/>
                </a:lnTo>
                <a:lnTo>
                  <a:pt x="4758" y="746"/>
                </a:lnTo>
                <a:lnTo>
                  <a:pt x="4760" y="746"/>
                </a:lnTo>
                <a:lnTo>
                  <a:pt x="4762" y="746"/>
                </a:lnTo>
                <a:lnTo>
                  <a:pt x="4764" y="746"/>
                </a:lnTo>
                <a:lnTo>
                  <a:pt x="4766" y="746"/>
                </a:lnTo>
                <a:lnTo>
                  <a:pt x="4771" y="746"/>
                </a:lnTo>
                <a:lnTo>
                  <a:pt x="4772" y="746"/>
                </a:lnTo>
                <a:lnTo>
                  <a:pt x="4774" y="746"/>
                </a:lnTo>
                <a:lnTo>
                  <a:pt x="4777" y="745"/>
                </a:lnTo>
                <a:lnTo>
                  <a:pt x="4779" y="745"/>
                </a:lnTo>
                <a:lnTo>
                  <a:pt x="4783" y="745"/>
                </a:lnTo>
                <a:lnTo>
                  <a:pt x="4785" y="745"/>
                </a:lnTo>
                <a:lnTo>
                  <a:pt x="4788" y="745"/>
                </a:lnTo>
                <a:lnTo>
                  <a:pt x="4790" y="745"/>
                </a:lnTo>
                <a:lnTo>
                  <a:pt x="4792" y="745"/>
                </a:lnTo>
                <a:lnTo>
                  <a:pt x="4794" y="745"/>
                </a:lnTo>
                <a:lnTo>
                  <a:pt x="4796" y="745"/>
                </a:lnTo>
                <a:lnTo>
                  <a:pt x="4798" y="744"/>
                </a:lnTo>
                <a:lnTo>
                  <a:pt x="4800" y="744"/>
                </a:lnTo>
                <a:lnTo>
                  <a:pt x="4802" y="744"/>
                </a:lnTo>
                <a:lnTo>
                  <a:pt x="4805" y="744"/>
                </a:lnTo>
                <a:lnTo>
                  <a:pt x="4809" y="744"/>
                </a:lnTo>
                <a:lnTo>
                  <a:pt x="4811" y="744"/>
                </a:lnTo>
                <a:lnTo>
                  <a:pt x="4813" y="745"/>
                </a:lnTo>
                <a:lnTo>
                  <a:pt x="4815" y="745"/>
                </a:lnTo>
                <a:lnTo>
                  <a:pt x="4817" y="745"/>
                </a:lnTo>
                <a:lnTo>
                  <a:pt x="4819" y="745"/>
                </a:lnTo>
                <a:lnTo>
                  <a:pt x="4821" y="745"/>
                </a:lnTo>
                <a:lnTo>
                  <a:pt x="4824" y="745"/>
                </a:lnTo>
                <a:lnTo>
                  <a:pt x="4826" y="745"/>
                </a:lnTo>
                <a:lnTo>
                  <a:pt x="4828" y="745"/>
                </a:lnTo>
                <a:lnTo>
                  <a:pt x="4830" y="745"/>
                </a:lnTo>
                <a:lnTo>
                  <a:pt x="4835" y="745"/>
                </a:lnTo>
                <a:lnTo>
                  <a:pt x="4836" y="745"/>
                </a:lnTo>
                <a:lnTo>
                  <a:pt x="4838" y="745"/>
                </a:lnTo>
                <a:lnTo>
                  <a:pt x="4841" y="745"/>
                </a:lnTo>
                <a:lnTo>
                  <a:pt x="4843" y="745"/>
                </a:lnTo>
                <a:lnTo>
                  <a:pt x="4847" y="745"/>
                </a:lnTo>
                <a:lnTo>
                  <a:pt x="4849" y="745"/>
                </a:lnTo>
                <a:lnTo>
                  <a:pt x="4852" y="745"/>
                </a:lnTo>
                <a:lnTo>
                  <a:pt x="4854" y="745"/>
                </a:lnTo>
                <a:lnTo>
                  <a:pt x="4856" y="745"/>
                </a:lnTo>
                <a:lnTo>
                  <a:pt x="4857" y="745"/>
                </a:lnTo>
                <a:lnTo>
                  <a:pt x="4860" y="745"/>
                </a:lnTo>
                <a:lnTo>
                  <a:pt x="4862" y="745"/>
                </a:lnTo>
                <a:lnTo>
                  <a:pt x="4864" y="745"/>
                </a:lnTo>
                <a:lnTo>
                  <a:pt x="4866" y="745"/>
                </a:lnTo>
                <a:lnTo>
                  <a:pt x="4868" y="745"/>
                </a:lnTo>
                <a:lnTo>
                  <a:pt x="4871" y="745"/>
                </a:lnTo>
                <a:lnTo>
                  <a:pt x="4873" y="745"/>
                </a:lnTo>
                <a:lnTo>
                  <a:pt x="4875" y="745"/>
                </a:lnTo>
                <a:lnTo>
                  <a:pt x="4877" y="746"/>
                </a:lnTo>
                <a:lnTo>
                  <a:pt x="4880" y="746"/>
                </a:lnTo>
                <a:lnTo>
                  <a:pt x="4881" y="746"/>
                </a:lnTo>
                <a:lnTo>
                  <a:pt x="4883" y="746"/>
                </a:lnTo>
                <a:lnTo>
                  <a:pt x="4885" y="747"/>
                </a:lnTo>
                <a:lnTo>
                  <a:pt x="4888" y="747"/>
                </a:lnTo>
                <a:lnTo>
                  <a:pt x="4890" y="747"/>
                </a:lnTo>
                <a:lnTo>
                  <a:pt x="4892" y="747"/>
                </a:lnTo>
                <a:lnTo>
                  <a:pt x="4894" y="747"/>
                </a:lnTo>
                <a:lnTo>
                  <a:pt x="4899" y="747"/>
                </a:lnTo>
                <a:lnTo>
                  <a:pt x="4901" y="747"/>
                </a:lnTo>
                <a:lnTo>
                  <a:pt x="4902" y="747"/>
                </a:lnTo>
                <a:lnTo>
                  <a:pt x="4904" y="746"/>
                </a:lnTo>
                <a:lnTo>
                  <a:pt x="4907" y="746"/>
                </a:lnTo>
                <a:lnTo>
                  <a:pt x="4911" y="746"/>
                </a:lnTo>
                <a:lnTo>
                  <a:pt x="4913" y="746"/>
                </a:lnTo>
                <a:lnTo>
                  <a:pt x="4916" y="745"/>
                </a:lnTo>
                <a:lnTo>
                  <a:pt x="4918" y="745"/>
                </a:lnTo>
                <a:lnTo>
                  <a:pt x="4920" y="745"/>
                </a:lnTo>
                <a:lnTo>
                  <a:pt x="4924" y="746"/>
                </a:lnTo>
                <a:lnTo>
                  <a:pt x="4926" y="746"/>
                </a:lnTo>
                <a:lnTo>
                  <a:pt x="4928" y="746"/>
                </a:lnTo>
                <a:lnTo>
                  <a:pt x="4930" y="746"/>
                </a:lnTo>
                <a:lnTo>
                  <a:pt x="4932" y="746"/>
                </a:lnTo>
                <a:lnTo>
                  <a:pt x="4935" y="746"/>
                </a:lnTo>
                <a:lnTo>
                  <a:pt x="4937" y="745"/>
                </a:lnTo>
                <a:lnTo>
                  <a:pt x="4939" y="745"/>
                </a:lnTo>
                <a:lnTo>
                  <a:pt x="4941" y="745"/>
                </a:lnTo>
                <a:lnTo>
                  <a:pt x="4943" y="745"/>
                </a:lnTo>
                <a:lnTo>
                  <a:pt x="4945" y="745"/>
                </a:lnTo>
                <a:lnTo>
                  <a:pt x="4949" y="745"/>
                </a:lnTo>
                <a:lnTo>
                  <a:pt x="4952" y="745"/>
                </a:lnTo>
                <a:lnTo>
                  <a:pt x="4954" y="745"/>
                </a:lnTo>
                <a:lnTo>
                  <a:pt x="4956" y="745"/>
                </a:lnTo>
                <a:lnTo>
                  <a:pt x="4958" y="745"/>
                </a:lnTo>
                <a:lnTo>
                  <a:pt x="4963" y="745"/>
                </a:lnTo>
                <a:lnTo>
                  <a:pt x="4965" y="745"/>
                </a:lnTo>
                <a:lnTo>
                  <a:pt x="4966" y="745"/>
                </a:lnTo>
                <a:lnTo>
                  <a:pt x="4968" y="745"/>
                </a:lnTo>
                <a:lnTo>
                  <a:pt x="4971" y="745"/>
                </a:lnTo>
                <a:lnTo>
                  <a:pt x="4975" y="745"/>
                </a:lnTo>
                <a:lnTo>
                  <a:pt x="4977" y="745"/>
                </a:lnTo>
                <a:lnTo>
                  <a:pt x="4979" y="745"/>
                </a:lnTo>
                <a:lnTo>
                  <a:pt x="4982" y="745"/>
                </a:lnTo>
                <a:lnTo>
                  <a:pt x="4984" y="745"/>
                </a:lnTo>
                <a:lnTo>
                  <a:pt x="4988" y="746"/>
                </a:lnTo>
                <a:lnTo>
                  <a:pt x="4990" y="746"/>
                </a:lnTo>
                <a:lnTo>
                  <a:pt x="4992" y="746"/>
                </a:lnTo>
                <a:lnTo>
                  <a:pt x="4994" y="746"/>
                </a:lnTo>
                <a:lnTo>
                  <a:pt x="4996" y="746"/>
                </a:lnTo>
                <a:lnTo>
                  <a:pt x="5001" y="746"/>
                </a:lnTo>
                <a:lnTo>
                  <a:pt x="5003" y="746"/>
                </a:lnTo>
                <a:lnTo>
                  <a:pt x="5005" y="746"/>
                </a:lnTo>
                <a:lnTo>
                  <a:pt x="5007" y="746"/>
                </a:lnTo>
                <a:lnTo>
                  <a:pt x="5010" y="746"/>
                </a:lnTo>
                <a:lnTo>
                  <a:pt x="5013" y="746"/>
                </a:lnTo>
                <a:lnTo>
                  <a:pt x="5015" y="746"/>
                </a:lnTo>
                <a:lnTo>
                  <a:pt x="5018" y="746"/>
                </a:lnTo>
                <a:lnTo>
                  <a:pt x="5020" y="746"/>
                </a:lnTo>
                <a:lnTo>
                  <a:pt x="5022" y="746"/>
                </a:lnTo>
                <a:lnTo>
                  <a:pt x="5026" y="746"/>
                </a:lnTo>
                <a:lnTo>
                  <a:pt x="5029" y="746"/>
                </a:lnTo>
                <a:lnTo>
                  <a:pt x="5031" y="746"/>
                </a:lnTo>
                <a:lnTo>
                  <a:pt x="5032" y="745"/>
                </a:lnTo>
                <a:lnTo>
                  <a:pt x="5035" y="745"/>
                </a:lnTo>
                <a:lnTo>
                  <a:pt x="5037" y="746"/>
                </a:lnTo>
                <a:lnTo>
                  <a:pt x="5039" y="746"/>
                </a:lnTo>
                <a:lnTo>
                  <a:pt x="5041" y="747"/>
                </a:lnTo>
                <a:lnTo>
                  <a:pt x="5043" y="747"/>
                </a:lnTo>
                <a:lnTo>
                  <a:pt x="5046" y="747"/>
                </a:lnTo>
                <a:lnTo>
                  <a:pt x="5048" y="747"/>
                </a:lnTo>
                <a:lnTo>
                  <a:pt x="5050" y="747"/>
                </a:lnTo>
                <a:lnTo>
                  <a:pt x="5052" y="748"/>
                </a:lnTo>
                <a:lnTo>
                  <a:pt x="5054" y="748"/>
                </a:lnTo>
                <a:lnTo>
                  <a:pt x="5056" y="748"/>
                </a:lnTo>
                <a:lnTo>
                  <a:pt x="5058" y="748"/>
                </a:lnTo>
                <a:lnTo>
                  <a:pt x="5060" y="748"/>
                </a:lnTo>
                <a:lnTo>
                  <a:pt x="5065" y="748"/>
                </a:lnTo>
                <a:lnTo>
                  <a:pt x="5067" y="748"/>
                </a:lnTo>
                <a:lnTo>
                  <a:pt x="5069" y="748"/>
                </a:lnTo>
                <a:lnTo>
                  <a:pt x="5071" y="748"/>
                </a:lnTo>
                <a:lnTo>
                  <a:pt x="5074" y="748"/>
                </a:lnTo>
                <a:lnTo>
                  <a:pt x="5075" y="747"/>
                </a:lnTo>
                <a:lnTo>
                  <a:pt x="5077" y="747"/>
                </a:lnTo>
                <a:lnTo>
                  <a:pt x="5079" y="747"/>
                </a:lnTo>
                <a:lnTo>
                  <a:pt x="5082" y="747"/>
                </a:lnTo>
                <a:lnTo>
                  <a:pt x="5084" y="747"/>
                </a:lnTo>
                <a:lnTo>
                  <a:pt x="5086" y="747"/>
                </a:lnTo>
                <a:lnTo>
                  <a:pt x="5090" y="747"/>
                </a:lnTo>
                <a:lnTo>
                  <a:pt x="5093" y="747"/>
                </a:lnTo>
                <a:lnTo>
                  <a:pt x="5095" y="747"/>
                </a:lnTo>
                <a:lnTo>
                  <a:pt x="5096" y="747"/>
                </a:lnTo>
                <a:lnTo>
                  <a:pt x="5099" y="747"/>
                </a:lnTo>
                <a:lnTo>
                  <a:pt x="5103" y="747"/>
                </a:lnTo>
                <a:lnTo>
                  <a:pt x="5105" y="747"/>
                </a:lnTo>
                <a:lnTo>
                  <a:pt x="5107" y="747"/>
                </a:lnTo>
                <a:lnTo>
                  <a:pt x="5110" y="747"/>
                </a:lnTo>
                <a:lnTo>
                  <a:pt x="5112" y="746"/>
                </a:lnTo>
                <a:lnTo>
                  <a:pt x="5114" y="746"/>
                </a:lnTo>
                <a:lnTo>
                  <a:pt x="5116" y="746"/>
                </a:lnTo>
                <a:lnTo>
                  <a:pt x="5118" y="746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/>
          </a:p>
        </p:txBody>
      </p:sp>
      <p:sp>
        <p:nvSpPr>
          <p:cNvPr id="71" name="Rectangle 755"/>
          <p:cNvSpPr>
            <a:spLocks noChangeArrowheads="1"/>
          </p:cNvSpPr>
          <p:nvPr/>
        </p:nvSpPr>
        <p:spPr bwMode="auto">
          <a:xfrm>
            <a:off x="4288231" y="3785902"/>
            <a:ext cx="472886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inutes</a:t>
            </a:r>
            <a:endParaRPr kumimoji="0" lang="en-US" altLang="en-US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2" name="Line 756"/>
          <p:cNvSpPr>
            <a:spLocks noChangeShapeType="1"/>
          </p:cNvSpPr>
          <p:nvPr/>
        </p:nvSpPr>
        <p:spPr bwMode="auto">
          <a:xfrm>
            <a:off x="674769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57"/>
          <p:cNvSpPr>
            <a:spLocks noChangeArrowheads="1"/>
          </p:cNvSpPr>
          <p:nvPr/>
        </p:nvSpPr>
        <p:spPr bwMode="auto">
          <a:xfrm>
            <a:off x="504906" y="3533446"/>
            <a:ext cx="262892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4" name="Line 758"/>
          <p:cNvSpPr>
            <a:spLocks noChangeShapeType="1"/>
          </p:cNvSpPr>
          <p:nvPr/>
        </p:nvSpPr>
        <p:spPr bwMode="auto">
          <a:xfrm>
            <a:off x="8779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Line 759"/>
          <p:cNvSpPr>
            <a:spLocks noChangeShapeType="1"/>
          </p:cNvSpPr>
          <p:nvPr/>
        </p:nvSpPr>
        <p:spPr bwMode="auto">
          <a:xfrm>
            <a:off x="10811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Line 760"/>
          <p:cNvSpPr>
            <a:spLocks noChangeShapeType="1"/>
          </p:cNvSpPr>
          <p:nvPr/>
        </p:nvSpPr>
        <p:spPr bwMode="auto">
          <a:xfrm>
            <a:off x="12843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Line 761"/>
          <p:cNvSpPr>
            <a:spLocks noChangeShapeType="1"/>
          </p:cNvSpPr>
          <p:nvPr/>
        </p:nvSpPr>
        <p:spPr bwMode="auto">
          <a:xfrm>
            <a:off x="1487569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62"/>
          <p:cNvSpPr>
            <a:spLocks noChangeArrowheads="1"/>
          </p:cNvSpPr>
          <p:nvPr/>
        </p:nvSpPr>
        <p:spPr bwMode="auto">
          <a:xfrm>
            <a:off x="1317706" y="3533446"/>
            <a:ext cx="262892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9" name="Line 763"/>
          <p:cNvSpPr>
            <a:spLocks noChangeShapeType="1"/>
          </p:cNvSpPr>
          <p:nvPr/>
        </p:nvSpPr>
        <p:spPr bwMode="auto">
          <a:xfrm>
            <a:off x="16907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Line 764"/>
          <p:cNvSpPr>
            <a:spLocks noChangeShapeType="1"/>
          </p:cNvSpPr>
          <p:nvPr/>
        </p:nvSpPr>
        <p:spPr bwMode="auto">
          <a:xfrm>
            <a:off x="18939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Line 765"/>
          <p:cNvSpPr>
            <a:spLocks noChangeShapeType="1"/>
          </p:cNvSpPr>
          <p:nvPr/>
        </p:nvSpPr>
        <p:spPr bwMode="auto">
          <a:xfrm>
            <a:off x="20955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Line 766"/>
          <p:cNvSpPr>
            <a:spLocks noChangeShapeType="1"/>
          </p:cNvSpPr>
          <p:nvPr/>
        </p:nvSpPr>
        <p:spPr bwMode="auto">
          <a:xfrm>
            <a:off x="2298781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767"/>
          <p:cNvSpPr>
            <a:spLocks noChangeArrowheads="1"/>
          </p:cNvSpPr>
          <p:nvPr/>
        </p:nvSpPr>
        <p:spPr bwMode="auto">
          <a:xfrm>
            <a:off x="2128919" y="3533446"/>
            <a:ext cx="262892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4" name="Line 768"/>
          <p:cNvSpPr>
            <a:spLocks noChangeShapeType="1"/>
          </p:cNvSpPr>
          <p:nvPr/>
        </p:nvSpPr>
        <p:spPr bwMode="auto">
          <a:xfrm>
            <a:off x="25019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Line 769"/>
          <p:cNvSpPr>
            <a:spLocks noChangeShapeType="1"/>
          </p:cNvSpPr>
          <p:nvPr/>
        </p:nvSpPr>
        <p:spPr bwMode="auto">
          <a:xfrm>
            <a:off x="27067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Line 770"/>
          <p:cNvSpPr>
            <a:spLocks noChangeShapeType="1"/>
          </p:cNvSpPr>
          <p:nvPr/>
        </p:nvSpPr>
        <p:spPr bwMode="auto">
          <a:xfrm>
            <a:off x="2909969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Line 771"/>
          <p:cNvSpPr>
            <a:spLocks noChangeShapeType="1"/>
          </p:cNvSpPr>
          <p:nvPr/>
        </p:nvSpPr>
        <p:spPr bwMode="auto">
          <a:xfrm>
            <a:off x="3113169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772"/>
          <p:cNvSpPr>
            <a:spLocks noChangeArrowheads="1"/>
          </p:cNvSpPr>
          <p:nvPr/>
        </p:nvSpPr>
        <p:spPr bwMode="auto">
          <a:xfrm>
            <a:off x="2943306" y="3533446"/>
            <a:ext cx="262892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.00</a:t>
            </a:r>
            <a:endParaRPr kumimoji="0" lang="en-US" altLang="en-US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9" name="Line 773"/>
          <p:cNvSpPr>
            <a:spLocks noChangeShapeType="1"/>
          </p:cNvSpPr>
          <p:nvPr/>
        </p:nvSpPr>
        <p:spPr bwMode="auto">
          <a:xfrm>
            <a:off x="33147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Line 774"/>
          <p:cNvSpPr>
            <a:spLocks noChangeShapeType="1"/>
          </p:cNvSpPr>
          <p:nvPr/>
        </p:nvSpPr>
        <p:spPr bwMode="auto">
          <a:xfrm>
            <a:off x="35179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Line 775"/>
          <p:cNvSpPr>
            <a:spLocks noChangeShapeType="1"/>
          </p:cNvSpPr>
          <p:nvPr/>
        </p:nvSpPr>
        <p:spPr bwMode="auto">
          <a:xfrm>
            <a:off x="37211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776"/>
          <p:cNvSpPr>
            <a:spLocks noChangeShapeType="1"/>
          </p:cNvSpPr>
          <p:nvPr/>
        </p:nvSpPr>
        <p:spPr bwMode="auto">
          <a:xfrm>
            <a:off x="3924381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777"/>
          <p:cNvSpPr>
            <a:spLocks noChangeArrowheads="1"/>
          </p:cNvSpPr>
          <p:nvPr/>
        </p:nvSpPr>
        <p:spPr bwMode="auto">
          <a:xfrm>
            <a:off x="3714831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4" name="Line 778"/>
          <p:cNvSpPr>
            <a:spLocks noChangeShapeType="1"/>
          </p:cNvSpPr>
          <p:nvPr/>
        </p:nvSpPr>
        <p:spPr bwMode="auto">
          <a:xfrm>
            <a:off x="41275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Line 779"/>
          <p:cNvSpPr>
            <a:spLocks noChangeShapeType="1"/>
          </p:cNvSpPr>
          <p:nvPr/>
        </p:nvSpPr>
        <p:spPr bwMode="auto">
          <a:xfrm>
            <a:off x="43307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Line 780"/>
          <p:cNvSpPr>
            <a:spLocks noChangeShapeType="1"/>
          </p:cNvSpPr>
          <p:nvPr/>
        </p:nvSpPr>
        <p:spPr bwMode="auto">
          <a:xfrm>
            <a:off x="45339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Line 781"/>
          <p:cNvSpPr>
            <a:spLocks noChangeShapeType="1"/>
          </p:cNvSpPr>
          <p:nvPr/>
        </p:nvSpPr>
        <p:spPr bwMode="auto">
          <a:xfrm>
            <a:off x="4737181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782"/>
          <p:cNvSpPr>
            <a:spLocks noChangeArrowheads="1"/>
          </p:cNvSpPr>
          <p:nvPr/>
        </p:nvSpPr>
        <p:spPr bwMode="auto">
          <a:xfrm>
            <a:off x="4527631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2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9" name="Line 783"/>
          <p:cNvSpPr>
            <a:spLocks noChangeShapeType="1"/>
          </p:cNvSpPr>
          <p:nvPr/>
        </p:nvSpPr>
        <p:spPr bwMode="auto">
          <a:xfrm>
            <a:off x="49403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Line 784"/>
          <p:cNvSpPr>
            <a:spLocks noChangeShapeType="1"/>
          </p:cNvSpPr>
          <p:nvPr/>
        </p:nvSpPr>
        <p:spPr bwMode="auto">
          <a:xfrm>
            <a:off x="51435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Line 785"/>
          <p:cNvSpPr>
            <a:spLocks noChangeShapeType="1"/>
          </p:cNvSpPr>
          <p:nvPr/>
        </p:nvSpPr>
        <p:spPr bwMode="auto">
          <a:xfrm>
            <a:off x="53467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Line 786"/>
          <p:cNvSpPr>
            <a:spLocks noChangeShapeType="1"/>
          </p:cNvSpPr>
          <p:nvPr/>
        </p:nvSpPr>
        <p:spPr bwMode="auto">
          <a:xfrm>
            <a:off x="5549981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787"/>
          <p:cNvSpPr>
            <a:spLocks noChangeArrowheads="1"/>
          </p:cNvSpPr>
          <p:nvPr/>
        </p:nvSpPr>
        <p:spPr bwMode="auto">
          <a:xfrm>
            <a:off x="5340431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" name="Line 788"/>
          <p:cNvSpPr>
            <a:spLocks noChangeShapeType="1"/>
          </p:cNvSpPr>
          <p:nvPr/>
        </p:nvSpPr>
        <p:spPr bwMode="auto">
          <a:xfrm>
            <a:off x="57531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Line 789"/>
          <p:cNvSpPr>
            <a:spLocks noChangeShapeType="1"/>
          </p:cNvSpPr>
          <p:nvPr/>
        </p:nvSpPr>
        <p:spPr bwMode="auto">
          <a:xfrm>
            <a:off x="59563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Line 790"/>
          <p:cNvSpPr>
            <a:spLocks noChangeShapeType="1"/>
          </p:cNvSpPr>
          <p:nvPr/>
        </p:nvSpPr>
        <p:spPr bwMode="auto">
          <a:xfrm>
            <a:off x="61579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Line 791"/>
          <p:cNvSpPr>
            <a:spLocks noChangeShapeType="1"/>
          </p:cNvSpPr>
          <p:nvPr/>
        </p:nvSpPr>
        <p:spPr bwMode="auto">
          <a:xfrm>
            <a:off x="6361194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792"/>
          <p:cNvSpPr>
            <a:spLocks noChangeArrowheads="1"/>
          </p:cNvSpPr>
          <p:nvPr/>
        </p:nvSpPr>
        <p:spPr bwMode="auto">
          <a:xfrm>
            <a:off x="6151644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9" name="Line 793"/>
          <p:cNvSpPr>
            <a:spLocks noChangeShapeType="1"/>
          </p:cNvSpPr>
          <p:nvPr/>
        </p:nvSpPr>
        <p:spPr bwMode="auto">
          <a:xfrm>
            <a:off x="65643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Line 794"/>
          <p:cNvSpPr>
            <a:spLocks noChangeShapeType="1"/>
          </p:cNvSpPr>
          <p:nvPr/>
        </p:nvSpPr>
        <p:spPr bwMode="auto">
          <a:xfrm>
            <a:off x="67691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Line 795"/>
          <p:cNvSpPr>
            <a:spLocks noChangeShapeType="1"/>
          </p:cNvSpPr>
          <p:nvPr/>
        </p:nvSpPr>
        <p:spPr bwMode="auto">
          <a:xfrm>
            <a:off x="6972381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Line 796"/>
          <p:cNvSpPr>
            <a:spLocks noChangeShapeType="1"/>
          </p:cNvSpPr>
          <p:nvPr/>
        </p:nvSpPr>
        <p:spPr bwMode="auto">
          <a:xfrm>
            <a:off x="7175581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797"/>
          <p:cNvSpPr>
            <a:spLocks noChangeArrowheads="1"/>
          </p:cNvSpPr>
          <p:nvPr/>
        </p:nvSpPr>
        <p:spPr bwMode="auto">
          <a:xfrm>
            <a:off x="6966031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8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4" name="Line 798"/>
          <p:cNvSpPr>
            <a:spLocks noChangeShapeType="1"/>
          </p:cNvSpPr>
          <p:nvPr/>
        </p:nvSpPr>
        <p:spPr bwMode="auto">
          <a:xfrm>
            <a:off x="73771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Line 799"/>
          <p:cNvSpPr>
            <a:spLocks noChangeShapeType="1"/>
          </p:cNvSpPr>
          <p:nvPr/>
        </p:nvSpPr>
        <p:spPr bwMode="auto">
          <a:xfrm>
            <a:off x="75803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Line 800"/>
          <p:cNvSpPr>
            <a:spLocks noChangeShapeType="1"/>
          </p:cNvSpPr>
          <p:nvPr/>
        </p:nvSpPr>
        <p:spPr bwMode="auto">
          <a:xfrm>
            <a:off x="77835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Line 801"/>
          <p:cNvSpPr>
            <a:spLocks noChangeShapeType="1"/>
          </p:cNvSpPr>
          <p:nvPr/>
        </p:nvSpPr>
        <p:spPr bwMode="auto">
          <a:xfrm>
            <a:off x="7986794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Rectangle 802"/>
          <p:cNvSpPr>
            <a:spLocks noChangeArrowheads="1"/>
          </p:cNvSpPr>
          <p:nvPr/>
        </p:nvSpPr>
        <p:spPr bwMode="auto">
          <a:xfrm>
            <a:off x="7777244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9" name="Line 803"/>
          <p:cNvSpPr>
            <a:spLocks noChangeShapeType="1"/>
          </p:cNvSpPr>
          <p:nvPr/>
        </p:nvSpPr>
        <p:spPr bwMode="auto">
          <a:xfrm>
            <a:off x="81899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Line 804"/>
          <p:cNvSpPr>
            <a:spLocks noChangeShapeType="1"/>
          </p:cNvSpPr>
          <p:nvPr/>
        </p:nvSpPr>
        <p:spPr bwMode="auto">
          <a:xfrm>
            <a:off x="83931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Line 805"/>
          <p:cNvSpPr>
            <a:spLocks noChangeShapeType="1"/>
          </p:cNvSpPr>
          <p:nvPr/>
        </p:nvSpPr>
        <p:spPr bwMode="auto">
          <a:xfrm>
            <a:off x="8596394" y="3458834"/>
            <a:ext cx="0" cy="1746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Line 806"/>
          <p:cNvSpPr>
            <a:spLocks noChangeShapeType="1"/>
          </p:cNvSpPr>
          <p:nvPr/>
        </p:nvSpPr>
        <p:spPr bwMode="auto">
          <a:xfrm>
            <a:off x="8799594" y="3458834"/>
            <a:ext cx="0" cy="3651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807"/>
          <p:cNvSpPr>
            <a:spLocks noChangeArrowheads="1"/>
          </p:cNvSpPr>
          <p:nvPr/>
        </p:nvSpPr>
        <p:spPr bwMode="auto">
          <a:xfrm>
            <a:off x="8590044" y="3533446"/>
            <a:ext cx="33823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2.00</a:t>
            </a:r>
            <a:endParaRPr kumimoji="0" lang="en-US" altLang="en-US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124" name="Straight Connector 123"/>
          <p:cNvCxnSpPr/>
          <p:nvPr/>
        </p:nvCxnSpPr>
        <p:spPr>
          <a:xfrm>
            <a:off x="684294" y="3458834"/>
            <a:ext cx="81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>
            <a:off x="5350669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>
          <a:xfrm>
            <a:off x="5504579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>
            <a:off x="5691663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/>
          <p:nvPr/>
        </p:nvCxnSpPr>
        <p:spPr>
          <a:xfrm>
            <a:off x="5789454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/>
          <p:nvPr/>
        </p:nvCxnSpPr>
        <p:spPr>
          <a:xfrm>
            <a:off x="5892959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/>
          <p:cNvCxnSpPr/>
          <p:nvPr/>
        </p:nvCxnSpPr>
        <p:spPr>
          <a:xfrm>
            <a:off x="6048747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/>
          <p:cNvCxnSpPr/>
          <p:nvPr/>
        </p:nvCxnSpPr>
        <p:spPr>
          <a:xfrm>
            <a:off x="6171882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6361035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>
            <a:off x="6532706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>
          <a:xfrm>
            <a:off x="6695998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/>
          <p:cNvSpPr txBox="1"/>
          <p:nvPr/>
        </p:nvSpPr>
        <p:spPr>
          <a:xfrm rot="16200000">
            <a:off x="781709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 rot="16200000">
            <a:off x="949191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 rot="16200000">
            <a:off x="1590608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6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 rot="16200000">
            <a:off x="1161417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 rot="16200000">
            <a:off x="1334485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4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 rot="16200000">
            <a:off x="1446825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5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 rot="16200000">
            <a:off x="1784283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7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 rot="16200000">
            <a:off x="1981928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8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 rot="16200000">
            <a:off x="2155670" y="2581896"/>
            <a:ext cx="35907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9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 rot="16200000">
            <a:off x="2321421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0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rot="16200000">
            <a:off x="2645230" y="2538872"/>
            <a:ext cx="44512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1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 rot="16200000">
            <a:off x="2858232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2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 rot="16200000">
            <a:off x="3020919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3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 rot="16200000">
            <a:off x="3193274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4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 rot="16200000">
            <a:off x="3370263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5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 rot="16200000">
            <a:off x="3936681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8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 rot="16200000">
            <a:off x="4339842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0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 rot="16200000">
            <a:off x="4792738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2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5191333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4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 rot="16200000">
            <a:off x="5470403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6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 rot="16200000">
            <a:off x="5853036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9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 rot="16200000">
            <a:off x="6216489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1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 rot="16200000">
            <a:off x="6380181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2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 rot="16200000">
            <a:off x="3555423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6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 rot="16200000">
            <a:off x="3757055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7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 rot="16200000">
            <a:off x="4180362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19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 rot="16200000">
            <a:off x="4533994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1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 rot="16200000">
            <a:off x="5036157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3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 rot="16200000">
            <a:off x="5315227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5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 rot="16200000">
            <a:off x="5584776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7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 rot="16200000">
            <a:off x="5721596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28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 rot="16200000">
            <a:off x="6020046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0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Straight Connector 208"/>
          <p:cNvCxnSpPr/>
          <p:nvPr/>
        </p:nvCxnSpPr>
        <p:spPr>
          <a:xfrm>
            <a:off x="883733" y="1817433"/>
            <a:ext cx="0" cy="504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/>
          <p:cNvCxnSpPr/>
          <p:nvPr/>
        </p:nvCxnSpPr>
        <p:spPr>
          <a:xfrm>
            <a:off x="1457691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/>
          <p:cNvCxnSpPr/>
          <p:nvPr/>
        </p:nvCxnSpPr>
        <p:spPr>
          <a:xfrm>
            <a:off x="1835719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>
            <a:off x="2054432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/>
          <p:cNvCxnSpPr/>
          <p:nvPr/>
        </p:nvCxnSpPr>
        <p:spPr>
          <a:xfrm>
            <a:off x="2234882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/>
          <p:cNvCxnSpPr/>
          <p:nvPr/>
        </p:nvCxnSpPr>
        <p:spPr>
          <a:xfrm>
            <a:off x="2359571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Connector 214"/>
          <p:cNvCxnSpPr/>
          <p:nvPr/>
        </p:nvCxnSpPr>
        <p:spPr>
          <a:xfrm>
            <a:off x="2703008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/>
          <p:cNvCxnSpPr/>
          <p:nvPr/>
        </p:nvCxnSpPr>
        <p:spPr>
          <a:xfrm>
            <a:off x="3163460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Connector 216"/>
          <p:cNvCxnSpPr/>
          <p:nvPr/>
        </p:nvCxnSpPr>
        <p:spPr>
          <a:xfrm>
            <a:off x="3353356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/>
          <p:nvPr/>
        </p:nvCxnSpPr>
        <p:spPr>
          <a:xfrm>
            <a:off x="3448340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Connector 218"/>
          <p:cNvCxnSpPr/>
          <p:nvPr/>
        </p:nvCxnSpPr>
        <p:spPr>
          <a:xfrm>
            <a:off x="3694402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219"/>
          <p:cNvCxnSpPr/>
          <p:nvPr/>
        </p:nvCxnSpPr>
        <p:spPr>
          <a:xfrm>
            <a:off x="3869026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Connector 220"/>
          <p:cNvCxnSpPr/>
          <p:nvPr/>
        </p:nvCxnSpPr>
        <p:spPr>
          <a:xfrm>
            <a:off x="4082545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>
          <a:xfrm>
            <a:off x="4296065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/>
          <p:cNvCxnSpPr/>
          <p:nvPr/>
        </p:nvCxnSpPr>
        <p:spPr>
          <a:xfrm>
            <a:off x="4506408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/>
          <p:cNvCxnSpPr/>
          <p:nvPr/>
        </p:nvCxnSpPr>
        <p:spPr>
          <a:xfrm>
            <a:off x="4621502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Connector 224"/>
          <p:cNvCxnSpPr/>
          <p:nvPr/>
        </p:nvCxnSpPr>
        <p:spPr>
          <a:xfrm>
            <a:off x="4881108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Straight Connector 225"/>
          <p:cNvCxnSpPr/>
          <p:nvPr/>
        </p:nvCxnSpPr>
        <p:spPr>
          <a:xfrm>
            <a:off x="5202954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Connector 226"/>
          <p:cNvCxnSpPr/>
          <p:nvPr/>
        </p:nvCxnSpPr>
        <p:spPr>
          <a:xfrm>
            <a:off x="1077408" y="1889433"/>
            <a:ext cx="0" cy="43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Connector 227"/>
          <p:cNvCxnSpPr/>
          <p:nvPr/>
        </p:nvCxnSpPr>
        <p:spPr>
          <a:xfrm>
            <a:off x="1281402" y="1889433"/>
            <a:ext cx="0" cy="43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Connector 228"/>
          <p:cNvCxnSpPr/>
          <p:nvPr/>
        </p:nvCxnSpPr>
        <p:spPr>
          <a:xfrm>
            <a:off x="1544907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Connector 229"/>
          <p:cNvCxnSpPr/>
          <p:nvPr/>
        </p:nvCxnSpPr>
        <p:spPr>
          <a:xfrm>
            <a:off x="1682246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Connector 230"/>
          <p:cNvCxnSpPr/>
          <p:nvPr/>
        </p:nvCxnSpPr>
        <p:spPr>
          <a:xfrm>
            <a:off x="3015746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TextBox 234"/>
          <p:cNvSpPr txBox="1"/>
          <p:nvPr/>
        </p:nvSpPr>
        <p:spPr>
          <a:xfrm>
            <a:off x="96614" y="509336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2838" y="5279987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  <a:endParaRPr lang="en-US" sz="12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TextBox 237"/>
          <p:cNvSpPr txBox="1"/>
          <p:nvPr/>
        </p:nvSpPr>
        <p:spPr>
          <a:xfrm>
            <a:off x="579653" y="4883459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eF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951126" y="4826563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igo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1426589" y="488345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/>
          <p:cNvSpPr txBox="1"/>
          <p:nvPr/>
        </p:nvSpPr>
        <p:spPr>
          <a:xfrm>
            <a:off x="5841045" y="4883459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2438024" y="4883459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242"/>
          <p:cNvSpPr txBox="1"/>
          <p:nvPr/>
        </p:nvSpPr>
        <p:spPr>
          <a:xfrm>
            <a:off x="2762087" y="4883459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3090726" y="4883459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3392126" y="4883459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/>
          <p:cNvSpPr txBox="1"/>
          <p:nvPr/>
        </p:nvSpPr>
        <p:spPr>
          <a:xfrm>
            <a:off x="3781053" y="4883459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4134190" y="4883459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4488857" y="4883459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4801070" y="4883459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6232483" y="4883459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6528871" y="4883459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6840772" y="4883459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5110138" y="4883459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7579267" y="4883459"/>
            <a:ext cx="2792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5516940" y="4883459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8404490" y="80000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8122361" y="1704884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/>
          <p:cNvSpPr txBox="1"/>
          <p:nvPr/>
        </p:nvSpPr>
        <p:spPr>
          <a:xfrm>
            <a:off x="6984105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7159114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7347789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7582789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7768991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7945175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8144447" y="40329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556508" y="2938092"/>
            <a:ext cx="8649200" cy="444457"/>
            <a:chOff x="556508" y="47754"/>
            <a:chExt cx="8649200" cy="444457"/>
          </a:xfrm>
        </p:grpSpPr>
        <p:sp>
          <p:nvSpPr>
            <p:cNvPr id="263" name="Line 633"/>
            <p:cNvSpPr>
              <a:spLocks noChangeShapeType="1"/>
            </p:cNvSpPr>
            <p:nvPr/>
          </p:nvSpPr>
          <p:spPr bwMode="auto">
            <a:xfrm>
              <a:off x="896368" y="191039"/>
              <a:ext cx="0" cy="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/>
            </a:p>
          </p:txBody>
        </p:sp>
        <p:sp>
          <p:nvSpPr>
            <p:cNvPr id="264" name="Line 635"/>
            <p:cNvSpPr>
              <a:spLocks noChangeShapeType="1"/>
            </p:cNvSpPr>
            <p:nvPr/>
          </p:nvSpPr>
          <p:spPr bwMode="auto">
            <a:xfrm>
              <a:off x="1401193" y="191039"/>
              <a:ext cx="0" cy="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/>
            </a:p>
          </p:txBody>
        </p:sp>
        <p:sp>
          <p:nvSpPr>
            <p:cNvPr id="265" name="Line 637"/>
            <p:cNvSpPr>
              <a:spLocks noChangeShapeType="1"/>
            </p:cNvSpPr>
            <p:nvPr/>
          </p:nvSpPr>
          <p:spPr bwMode="auto">
            <a:xfrm>
              <a:off x="2064768" y="191039"/>
              <a:ext cx="0" cy="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/>
            </a:p>
          </p:txBody>
        </p:sp>
        <p:sp>
          <p:nvSpPr>
            <p:cNvPr id="266" name="Line 639"/>
            <p:cNvSpPr>
              <a:spLocks noChangeShapeType="1"/>
            </p:cNvSpPr>
            <p:nvPr/>
          </p:nvSpPr>
          <p:spPr bwMode="auto">
            <a:xfrm>
              <a:off x="2844230" y="191039"/>
              <a:ext cx="0" cy="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/>
            </a:p>
          </p:txBody>
        </p:sp>
        <p:sp>
          <p:nvSpPr>
            <p:cNvPr id="267" name="Line 641"/>
            <p:cNvSpPr>
              <a:spLocks noChangeShapeType="1"/>
            </p:cNvSpPr>
            <p:nvPr/>
          </p:nvSpPr>
          <p:spPr bwMode="auto">
            <a:xfrm>
              <a:off x="3677668" y="191039"/>
              <a:ext cx="0" cy="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/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1933111" y="12287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2748918" y="12287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300"/>
            <p:cNvSpPr txBox="1"/>
            <p:nvPr/>
          </p:nvSpPr>
          <p:spPr>
            <a:xfrm>
              <a:off x="3491951" y="12287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TextBox 301"/>
            <p:cNvSpPr txBox="1"/>
            <p:nvPr/>
          </p:nvSpPr>
          <p:spPr>
            <a:xfrm>
              <a:off x="4364397" y="12287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TextBox 302"/>
            <p:cNvSpPr txBox="1"/>
            <p:nvPr/>
          </p:nvSpPr>
          <p:spPr>
            <a:xfrm>
              <a:off x="7859338" y="12287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5899201" y="122879"/>
              <a:ext cx="4240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TextBox 304"/>
            <p:cNvSpPr txBox="1"/>
            <p:nvPr/>
          </p:nvSpPr>
          <p:spPr>
            <a:xfrm>
              <a:off x="6652786" y="12287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TextBox 305"/>
            <p:cNvSpPr txBox="1"/>
            <p:nvPr/>
          </p:nvSpPr>
          <p:spPr>
            <a:xfrm>
              <a:off x="7268047" y="12287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TextBox 306"/>
            <p:cNvSpPr txBox="1"/>
            <p:nvPr/>
          </p:nvSpPr>
          <p:spPr>
            <a:xfrm>
              <a:off x="8380712" y="12287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TextBox 307"/>
            <p:cNvSpPr txBox="1"/>
            <p:nvPr/>
          </p:nvSpPr>
          <p:spPr>
            <a:xfrm>
              <a:off x="5078127" y="12287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9" name="Straight Connector 308"/>
            <p:cNvCxnSpPr/>
            <p:nvPr/>
          </p:nvCxnSpPr>
          <p:spPr>
            <a:xfrm>
              <a:off x="891606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>
            <a:xfrm>
              <a:off x="1411986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Straight Connector 310"/>
            <p:cNvCxnSpPr/>
            <p:nvPr/>
          </p:nvCxnSpPr>
          <p:spPr>
            <a:xfrm>
              <a:off x="2853317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Straight Connector 311"/>
            <p:cNvCxnSpPr/>
            <p:nvPr/>
          </p:nvCxnSpPr>
          <p:spPr>
            <a:xfrm>
              <a:off x="3689517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Straight Connector 312"/>
            <p:cNvCxnSpPr/>
            <p:nvPr/>
          </p:nvCxnSpPr>
          <p:spPr>
            <a:xfrm>
              <a:off x="4532097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/>
            <p:cNvCxnSpPr/>
            <p:nvPr/>
          </p:nvCxnSpPr>
          <p:spPr>
            <a:xfrm>
              <a:off x="5341346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Straight Connector 314"/>
            <p:cNvCxnSpPr/>
            <p:nvPr/>
          </p:nvCxnSpPr>
          <p:spPr>
            <a:xfrm>
              <a:off x="6104956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Straight Connector 315"/>
            <p:cNvCxnSpPr/>
            <p:nvPr/>
          </p:nvCxnSpPr>
          <p:spPr>
            <a:xfrm>
              <a:off x="6815362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Straight Connector 316"/>
            <p:cNvCxnSpPr/>
            <p:nvPr/>
          </p:nvCxnSpPr>
          <p:spPr>
            <a:xfrm>
              <a:off x="7491019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Straight Connector 317"/>
            <p:cNvCxnSpPr/>
            <p:nvPr/>
          </p:nvCxnSpPr>
          <p:spPr>
            <a:xfrm>
              <a:off x="8091830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 flipV="1">
              <a:off x="556508" y="47754"/>
              <a:ext cx="8420370" cy="156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0" name="Rectangle 3420"/>
            <p:cNvSpPr>
              <a:spLocks noChangeArrowheads="1"/>
            </p:cNvSpPr>
            <p:nvPr/>
          </p:nvSpPr>
          <p:spPr bwMode="auto">
            <a:xfrm>
              <a:off x="8897931" y="170495"/>
              <a:ext cx="30777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U</a:t>
              </a:r>
              <a:endParaRPr kumimoji="0" lang="en-US" altLang="en-US" sz="6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321" name="Straight Connector 320"/>
            <p:cNvCxnSpPr/>
            <p:nvPr/>
          </p:nvCxnSpPr>
          <p:spPr>
            <a:xfrm>
              <a:off x="2078701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>
              <a:off x="8655891" y="50730"/>
              <a:ext cx="0" cy="1403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3" name="TextBox 322"/>
            <p:cNvSpPr txBox="1"/>
            <p:nvPr/>
          </p:nvSpPr>
          <p:spPr>
            <a:xfrm>
              <a:off x="1244636" y="12287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TextBox 323"/>
            <p:cNvSpPr txBox="1"/>
            <p:nvPr/>
          </p:nvSpPr>
          <p:spPr>
            <a:xfrm>
              <a:off x="730270" y="12287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25" name="Straight Connector 324"/>
          <p:cNvCxnSpPr/>
          <p:nvPr/>
        </p:nvCxnSpPr>
        <p:spPr>
          <a:xfrm>
            <a:off x="6848398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6" name="Straight Connector 325"/>
          <p:cNvCxnSpPr/>
          <p:nvPr/>
        </p:nvCxnSpPr>
        <p:spPr>
          <a:xfrm>
            <a:off x="7021818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Straight Connector 326"/>
          <p:cNvCxnSpPr/>
          <p:nvPr/>
        </p:nvCxnSpPr>
        <p:spPr>
          <a:xfrm>
            <a:off x="7377194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Straight Connector 327"/>
          <p:cNvCxnSpPr/>
          <p:nvPr/>
        </p:nvCxnSpPr>
        <p:spPr>
          <a:xfrm>
            <a:off x="7580394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Straight Connector 328"/>
          <p:cNvCxnSpPr/>
          <p:nvPr/>
        </p:nvCxnSpPr>
        <p:spPr>
          <a:xfrm>
            <a:off x="7867029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Straight Connector 329"/>
          <p:cNvCxnSpPr/>
          <p:nvPr/>
        </p:nvCxnSpPr>
        <p:spPr>
          <a:xfrm>
            <a:off x="7997340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Straight Connector 330"/>
          <p:cNvCxnSpPr/>
          <p:nvPr/>
        </p:nvCxnSpPr>
        <p:spPr>
          <a:xfrm>
            <a:off x="8144447" y="2069433"/>
            <a:ext cx="0" cy="252000"/>
          </a:xfrm>
          <a:prstGeom prst="line">
            <a:avLst/>
          </a:prstGeom>
          <a:ln w="190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2" name="TextBox 331"/>
          <p:cNvSpPr txBox="1"/>
          <p:nvPr/>
        </p:nvSpPr>
        <p:spPr>
          <a:xfrm rot="16200000">
            <a:off x="6542572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3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332"/>
          <p:cNvSpPr txBox="1"/>
          <p:nvPr/>
        </p:nvSpPr>
        <p:spPr>
          <a:xfrm rot="16200000">
            <a:off x="6733300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4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TextBox 333"/>
          <p:cNvSpPr txBox="1"/>
          <p:nvPr/>
        </p:nvSpPr>
        <p:spPr>
          <a:xfrm rot="16200000">
            <a:off x="6994014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5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334"/>
          <p:cNvSpPr txBox="1"/>
          <p:nvPr/>
        </p:nvSpPr>
        <p:spPr>
          <a:xfrm rot="16200000">
            <a:off x="7278708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6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/>
          <p:cNvSpPr txBox="1"/>
          <p:nvPr/>
        </p:nvSpPr>
        <p:spPr>
          <a:xfrm rot="16200000">
            <a:off x="7530867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7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336"/>
          <p:cNvSpPr txBox="1"/>
          <p:nvPr/>
        </p:nvSpPr>
        <p:spPr>
          <a:xfrm rot="16200000">
            <a:off x="7718075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8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337"/>
          <p:cNvSpPr txBox="1"/>
          <p:nvPr/>
        </p:nvSpPr>
        <p:spPr>
          <a:xfrm rot="16200000">
            <a:off x="7871523" y="2532203"/>
            <a:ext cx="45845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IE" sz="1400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39</a:t>
            </a:r>
            <a:endParaRPr lang="en-IE" sz="14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815396" y="42691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chemeClr val="bg1"/>
                </a:solidFill>
              </a:rPr>
              <a:t>*</a:t>
            </a:r>
            <a:endParaRPr lang="en-IE" dirty="0">
              <a:solidFill>
                <a:schemeClr val="bg1"/>
              </a:solidFill>
            </a:endParaRPr>
          </a:p>
        </p:txBody>
      </p:sp>
      <p:sp>
        <p:nvSpPr>
          <p:cNvPr id="339" name="TextBox 338"/>
          <p:cNvSpPr txBox="1"/>
          <p:nvPr/>
        </p:nvSpPr>
        <p:spPr>
          <a:xfrm>
            <a:off x="8157520" y="427487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chemeClr val="bg1"/>
                </a:solidFill>
              </a:rPr>
              <a:t>*</a:t>
            </a:r>
            <a:endParaRPr lang="en-IE" dirty="0">
              <a:solidFill>
                <a:schemeClr val="bg1"/>
              </a:solidFill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1644151" y="4883459"/>
            <a:ext cx="4283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>
            <a:off x="1877435" y="4801715"/>
            <a:ext cx="8082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c+OAF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0727" y="5110759"/>
            <a:ext cx="7106302" cy="428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28439" y="5073007"/>
            <a:ext cx="1166899" cy="9067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9" name="TextBox 268"/>
          <p:cNvSpPr txBox="1"/>
          <p:nvPr/>
        </p:nvSpPr>
        <p:spPr>
          <a:xfrm>
            <a:off x="7175581" y="4883459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/>
          <p:cNvSpPr txBox="1"/>
          <p:nvPr/>
        </p:nvSpPr>
        <p:spPr>
          <a:xfrm>
            <a:off x="7204435" y="505652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chemeClr val="bg1"/>
                </a:solidFill>
              </a:rPr>
              <a:t>*</a:t>
            </a:r>
            <a:endParaRPr lang="en-IE" dirty="0">
              <a:solidFill>
                <a:schemeClr val="bg1"/>
              </a:solidFill>
            </a:endParaRP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4881" y="6119732"/>
            <a:ext cx="4351714" cy="372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581878" y="5682644"/>
            <a:ext cx="1295400" cy="1143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3" name="Rectangle 252"/>
          <p:cNvSpPr/>
          <p:nvPr/>
        </p:nvSpPr>
        <p:spPr>
          <a:xfrm>
            <a:off x="-32325" y="-2026"/>
            <a:ext cx="160024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A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Rectangle 270"/>
          <p:cNvSpPr/>
          <p:nvPr/>
        </p:nvSpPr>
        <p:spPr>
          <a:xfrm>
            <a:off x="-18441" y="3663515"/>
            <a:ext cx="160973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B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5740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7513925"/>
              </p:ext>
            </p:extLst>
          </p:nvPr>
        </p:nvGraphicFramePr>
        <p:xfrm>
          <a:off x="1073369" y="1219201"/>
          <a:ext cx="6672755" cy="39308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ight Brace 4"/>
          <p:cNvSpPr/>
          <p:nvPr/>
        </p:nvSpPr>
        <p:spPr>
          <a:xfrm rot="16200000">
            <a:off x="2703909" y="1417830"/>
            <a:ext cx="74906" cy="1643296"/>
          </a:xfrm>
          <a:prstGeom prst="rightBrac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33"/>
          <p:cNvSpPr txBox="1"/>
          <p:nvPr/>
        </p:nvSpPr>
        <p:spPr>
          <a:xfrm>
            <a:off x="2559261" y="191965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ight Brace 6"/>
          <p:cNvSpPr/>
          <p:nvPr/>
        </p:nvSpPr>
        <p:spPr>
          <a:xfrm rot="16200000">
            <a:off x="5813905" y="1912501"/>
            <a:ext cx="74905" cy="1561345"/>
          </a:xfrm>
          <a:prstGeom prst="rightBrac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33"/>
          <p:cNvSpPr txBox="1"/>
          <p:nvPr/>
        </p:nvSpPr>
        <p:spPr>
          <a:xfrm>
            <a:off x="5510183" y="2361296"/>
            <a:ext cx="371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ight Brace 8"/>
          <p:cNvSpPr/>
          <p:nvPr/>
        </p:nvSpPr>
        <p:spPr>
          <a:xfrm rot="16200000">
            <a:off x="6180165" y="1090822"/>
            <a:ext cx="125650" cy="1594812"/>
          </a:xfrm>
          <a:prstGeom prst="rightBrac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33"/>
          <p:cNvSpPr txBox="1"/>
          <p:nvPr/>
        </p:nvSpPr>
        <p:spPr>
          <a:xfrm>
            <a:off x="6060889" y="1568911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03622" y="48081"/>
            <a:ext cx="1423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93896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97806" y="758430"/>
            <a:ext cx="7985993" cy="3409043"/>
            <a:chOff x="14127294" y="25428512"/>
            <a:chExt cx="7985993" cy="3409043"/>
          </a:xfrm>
        </p:grpSpPr>
        <p:sp>
          <p:nvSpPr>
            <p:cNvPr id="3" name="Rectangle 400"/>
            <p:cNvSpPr>
              <a:spLocks noChangeArrowheads="1"/>
            </p:cNvSpPr>
            <p:nvPr/>
          </p:nvSpPr>
          <p:spPr bwMode="auto">
            <a:xfrm>
              <a:off x="14127294" y="25976852"/>
              <a:ext cx="1262274" cy="1050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</a:p>
            <a:p>
              <a:pPr algn="just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  <a:p>
              <a:pPr algn="just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-cadherin</a:t>
              </a:r>
            </a:p>
            <a:p>
              <a:pPr algn="just"/>
              <a:r>
                <a:rPr lang="el-GR" sz="1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en-I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ectangle 400"/>
            <p:cNvSpPr>
              <a:spLocks noChangeArrowheads="1"/>
            </p:cNvSpPr>
            <p:nvPr/>
          </p:nvSpPr>
          <p:spPr bwMode="auto">
            <a:xfrm>
              <a:off x="14127294" y="27772932"/>
              <a:ext cx="1262274" cy="1050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</a:p>
            <a:p>
              <a:pPr algn="just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  <a:p>
              <a:pPr algn="just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-cadherin</a:t>
              </a:r>
            </a:p>
            <a:p>
              <a:pPr algn="just"/>
              <a:r>
                <a:rPr lang="el-GR" sz="1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en-I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400"/>
            <p:cNvSpPr>
              <a:spLocks noChangeArrowheads="1"/>
            </p:cNvSpPr>
            <p:nvPr/>
          </p:nvSpPr>
          <p:spPr bwMode="auto">
            <a:xfrm>
              <a:off x="15651056" y="25824896"/>
              <a:ext cx="1149284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T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446805" y="26091762"/>
              <a:ext cx="1499492" cy="92042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017238" y="26087742"/>
              <a:ext cx="1493396" cy="938706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446806" y="27839197"/>
              <a:ext cx="1528791" cy="932499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8031751" y="27867564"/>
              <a:ext cx="1518255" cy="931894"/>
            </a:xfrm>
            <a:prstGeom prst="rect">
              <a:avLst/>
            </a:prstGeom>
          </p:spPr>
        </p:pic>
        <p:sp>
          <p:nvSpPr>
            <p:cNvPr id="10" name="Rectangle 400"/>
            <p:cNvSpPr>
              <a:spLocks noChangeArrowheads="1"/>
            </p:cNvSpPr>
            <p:nvPr/>
          </p:nvSpPr>
          <p:spPr bwMode="auto">
            <a:xfrm>
              <a:off x="18247331" y="25832510"/>
              <a:ext cx="1149284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T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400"/>
            <p:cNvSpPr>
              <a:spLocks noChangeArrowheads="1"/>
            </p:cNvSpPr>
            <p:nvPr/>
          </p:nvSpPr>
          <p:spPr bwMode="auto">
            <a:xfrm>
              <a:off x="15631925" y="27553573"/>
              <a:ext cx="1149284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T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400"/>
            <p:cNvSpPr>
              <a:spLocks noChangeArrowheads="1"/>
            </p:cNvSpPr>
            <p:nvPr/>
          </p:nvSpPr>
          <p:spPr bwMode="auto">
            <a:xfrm>
              <a:off x="18218369" y="27553573"/>
              <a:ext cx="1149284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T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18041463" y="27853889"/>
              <a:ext cx="1508542" cy="924440"/>
              <a:chOff x="27926128" y="23278850"/>
              <a:chExt cx="1508542" cy="924440"/>
            </a:xfrm>
          </p:grpSpPr>
          <p:sp>
            <p:nvSpPr>
              <p:cNvPr id="51" name="Rectangle 50"/>
              <p:cNvSpPr/>
              <p:nvPr/>
            </p:nvSpPr>
            <p:spPr bwMode="auto">
              <a:xfrm>
                <a:off x="27926128" y="23278850"/>
                <a:ext cx="1508542" cy="924440"/>
              </a:xfrm>
              <a:prstGeom prst="rect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defTabSz="4173538"/>
                <a:endParaRPr lang="en-US" sz="8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Straight Connector 51"/>
              <p:cNvCxnSpPr>
                <a:stCxn id="51" idx="0"/>
                <a:endCxn id="51" idx="2"/>
              </p:cNvCxnSpPr>
              <p:nvPr/>
            </p:nvCxnSpPr>
            <p:spPr bwMode="auto">
              <a:xfrm>
                <a:off x="28680399" y="23278850"/>
                <a:ext cx="0" cy="924440"/>
              </a:xfrm>
              <a:prstGeom prst="line">
                <a:avLst/>
              </a:prstGeom>
              <a:gradFill rotWithShape="1">
                <a:gsLst>
                  <a:gs pos="0">
                    <a:srgbClr val="FFFFFF"/>
                  </a:gs>
                  <a:gs pos="100000">
                    <a:srgbClr val="800000"/>
                  </a:gs>
                </a:gsLst>
                <a:path path="rect">
                  <a:fillToRect l="50000" t="50000" r="50000" b="50000"/>
                </a:path>
              </a:gra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14" name="Group 13"/>
            <p:cNvGrpSpPr/>
            <p:nvPr/>
          </p:nvGrpSpPr>
          <p:grpSpPr>
            <a:xfrm>
              <a:off x="18008362" y="26107592"/>
              <a:ext cx="1508542" cy="924440"/>
              <a:chOff x="27926128" y="23278850"/>
              <a:chExt cx="1508542" cy="924440"/>
            </a:xfrm>
          </p:grpSpPr>
          <p:sp>
            <p:nvSpPr>
              <p:cNvPr id="49" name="Rectangle 48"/>
              <p:cNvSpPr/>
              <p:nvPr/>
            </p:nvSpPr>
            <p:spPr bwMode="auto">
              <a:xfrm>
                <a:off x="27926128" y="23278850"/>
                <a:ext cx="1508542" cy="924440"/>
              </a:xfrm>
              <a:prstGeom prst="rect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defTabSz="4173538"/>
                <a:endParaRPr lang="en-US" sz="8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Straight Connector 49"/>
              <p:cNvCxnSpPr>
                <a:stCxn id="49" idx="0"/>
                <a:endCxn id="49" idx="2"/>
              </p:cNvCxnSpPr>
              <p:nvPr/>
            </p:nvCxnSpPr>
            <p:spPr bwMode="auto">
              <a:xfrm>
                <a:off x="28680399" y="23278850"/>
                <a:ext cx="0" cy="924440"/>
              </a:xfrm>
              <a:prstGeom prst="line">
                <a:avLst/>
              </a:prstGeom>
              <a:gradFill rotWithShape="1">
                <a:gsLst>
                  <a:gs pos="0">
                    <a:srgbClr val="FFFFFF"/>
                  </a:gs>
                  <a:gs pos="100000">
                    <a:srgbClr val="800000"/>
                  </a:gs>
                </a:gsLst>
                <a:path path="rect">
                  <a:fillToRect l="50000" t="50000" r="50000" b="50000"/>
                </a:path>
              </a:gra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15" name="Group 14"/>
            <p:cNvGrpSpPr/>
            <p:nvPr/>
          </p:nvGrpSpPr>
          <p:grpSpPr>
            <a:xfrm>
              <a:off x="15458687" y="27847256"/>
              <a:ext cx="1508542" cy="924440"/>
              <a:chOff x="27926128" y="23278850"/>
              <a:chExt cx="1508542" cy="924440"/>
            </a:xfrm>
          </p:grpSpPr>
          <p:sp>
            <p:nvSpPr>
              <p:cNvPr id="47" name="Rectangle 46"/>
              <p:cNvSpPr/>
              <p:nvPr/>
            </p:nvSpPr>
            <p:spPr bwMode="auto">
              <a:xfrm>
                <a:off x="27926128" y="23278850"/>
                <a:ext cx="1508542" cy="924440"/>
              </a:xfrm>
              <a:prstGeom prst="rect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defTabSz="4173538"/>
                <a:endParaRPr lang="en-US" sz="8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Straight Connector 47"/>
              <p:cNvCxnSpPr>
                <a:stCxn id="47" idx="0"/>
                <a:endCxn id="47" idx="2"/>
              </p:cNvCxnSpPr>
              <p:nvPr/>
            </p:nvCxnSpPr>
            <p:spPr bwMode="auto">
              <a:xfrm>
                <a:off x="28680399" y="23278850"/>
                <a:ext cx="0" cy="924440"/>
              </a:xfrm>
              <a:prstGeom prst="line">
                <a:avLst/>
              </a:prstGeom>
              <a:gradFill rotWithShape="1">
                <a:gsLst>
                  <a:gs pos="0">
                    <a:srgbClr val="FFFFFF"/>
                  </a:gs>
                  <a:gs pos="100000">
                    <a:srgbClr val="800000"/>
                  </a:gs>
                </a:gsLst>
                <a:path path="rect">
                  <a:fillToRect l="50000" t="50000" r="50000" b="50000"/>
                </a:path>
              </a:gra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16" name="Group 15"/>
            <p:cNvGrpSpPr/>
            <p:nvPr/>
          </p:nvGrpSpPr>
          <p:grpSpPr>
            <a:xfrm>
              <a:off x="15437412" y="26109450"/>
              <a:ext cx="1508542" cy="924440"/>
              <a:chOff x="27926128" y="23278850"/>
              <a:chExt cx="1508542" cy="924440"/>
            </a:xfrm>
          </p:grpSpPr>
          <p:sp>
            <p:nvSpPr>
              <p:cNvPr id="45" name="Rectangle 44"/>
              <p:cNvSpPr/>
              <p:nvPr/>
            </p:nvSpPr>
            <p:spPr bwMode="auto">
              <a:xfrm>
                <a:off x="27926128" y="23278850"/>
                <a:ext cx="1508542" cy="924440"/>
              </a:xfrm>
              <a:prstGeom prst="rect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defTabSz="4173538"/>
                <a:endParaRPr lang="en-US" sz="8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" name="Straight Connector 45"/>
              <p:cNvCxnSpPr>
                <a:stCxn id="45" idx="0"/>
                <a:endCxn id="45" idx="2"/>
              </p:cNvCxnSpPr>
              <p:nvPr/>
            </p:nvCxnSpPr>
            <p:spPr bwMode="auto">
              <a:xfrm>
                <a:off x="28680399" y="23278850"/>
                <a:ext cx="0" cy="924440"/>
              </a:xfrm>
              <a:prstGeom prst="line">
                <a:avLst/>
              </a:prstGeom>
              <a:gradFill rotWithShape="1">
                <a:gsLst>
                  <a:gs pos="0">
                    <a:srgbClr val="FFFFFF"/>
                  </a:gs>
                  <a:gs pos="100000">
                    <a:srgbClr val="800000"/>
                  </a:gs>
                </a:gsLst>
                <a:path path="rect">
                  <a:fillToRect l="50000" t="50000" r="50000" b="50000"/>
                </a:path>
              </a:gra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17" name="Group 16"/>
            <p:cNvGrpSpPr/>
            <p:nvPr/>
          </p:nvGrpSpPr>
          <p:grpSpPr>
            <a:xfrm>
              <a:off x="20604745" y="26077744"/>
              <a:ext cx="1508542" cy="956146"/>
              <a:chOff x="526720" y="861455"/>
              <a:chExt cx="6296102" cy="5122291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26721" y="861455"/>
                <a:ext cx="6296101" cy="1168400"/>
              </a:xfrm>
              <a:prstGeom prst="rect">
                <a:avLst/>
              </a:prstGeom>
            </p:spPr>
          </p:pic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26720" y="2170180"/>
                <a:ext cx="6296101" cy="1384300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26720" y="3681926"/>
                <a:ext cx="6296101" cy="885825"/>
              </a:xfrm>
              <a:prstGeom prst="rect">
                <a:avLst/>
              </a:prstGeom>
            </p:spPr>
          </p:pic>
          <p:pic>
            <p:nvPicPr>
              <p:cNvPr id="44" name="Picture 43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26720" y="4669439"/>
                <a:ext cx="6296101" cy="1314307"/>
              </a:xfrm>
              <a:prstGeom prst="rect">
                <a:avLst/>
              </a:prstGeom>
            </p:spPr>
          </p:pic>
        </p:grpSp>
        <p:grpSp>
          <p:nvGrpSpPr>
            <p:cNvPr id="18" name="Group 17"/>
            <p:cNvGrpSpPr/>
            <p:nvPr/>
          </p:nvGrpSpPr>
          <p:grpSpPr>
            <a:xfrm>
              <a:off x="20604745" y="26087742"/>
              <a:ext cx="1508542" cy="924440"/>
              <a:chOff x="27926128" y="23278850"/>
              <a:chExt cx="1508542" cy="924440"/>
            </a:xfrm>
          </p:grpSpPr>
          <p:sp>
            <p:nvSpPr>
              <p:cNvPr id="39" name="Rectangle 38"/>
              <p:cNvSpPr/>
              <p:nvPr/>
            </p:nvSpPr>
            <p:spPr bwMode="auto">
              <a:xfrm>
                <a:off x="27926128" y="23278850"/>
                <a:ext cx="1508542" cy="924440"/>
              </a:xfrm>
              <a:prstGeom prst="rect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defTabSz="4173538"/>
                <a:endParaRPr lang="en-US" sz="8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Straight Connector 39"/>
              <p:cNvCxnSpPr>
                <a:stCxn id="39" idx="0"/>
                <a:endCxn id="39" idx="2"/>
              </p:cNvCxnSpPr>
              <p:nvPr/>
            </p:nvCxnSpPr>
            <p:spPr bwMode="auto">
              <a:xfrm>
                <a:off x="28680399" y="23278850"/>
                <a:ext cx="0" cy="924440"/>
              </a:xfrm>
              <a:prstGeom prst="line">
                <a:avLst/>
              </a:prstGeom>
              <a:gradFill rotWithShape="1">
                <a:gsLst>
                  <a:gs pos="0">
                    <a:srgbClr val="FFFFFF"/>
                  </a:gs>
                  <a:gs pos="100000">
                    <a:srgbClr val="800000"/>
                  </a:gs>
                </a:gsLst>
                <a:path path="rect">
                  <a:fillToRect l="50000" t="50000" r="50000" b="50000"/>
                </a:path>
              </a:gra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19" name="Group 18"/>
            <p:cNvGrpSpPr/>
            <p:nvPr/>
          </p:nvGrpSpPr>
          <p:grpSpPr>
            <a:xfrm>
              <a:off x="20562640" y="27873806"/>
              <a:ext cx="1533814" cy="963749"/>
              <a:chOff x="289058" y="823933"/>
              <a:chExt cx="7311601" cy="4594137"/>
            </a:xfrm>
          </p:grpSpPr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14445" y="823933"/>
                <a:ext cx="7260826" cy="1206500"/>
              </a:xfrm>
              <a:prstGeom prst="rect">
                <a:avLst/>
              </a:prstGeom>
            </p:spPr>
          </p:pic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89058" y="2111328"/>
                <a:ext cx="7311601" cy="952500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89058" y="3193199"/>
                <a:ext cx="7311601" cy="1079500"/>
              </a:xfrm>
              <a:prstGeom prst="rect">
                <a:avLst/>
              </a:prstGeom>
            </p:spPr>
          </p:pic>
          <p:pic>
            <p:nvPicPr>
              <p:cNvPr id="38" name="Picture 37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289058" y="4402070"/>
                <a:ext cx="7311601" cy="1016000"/>
              </a:xfrm>
              <a:prstGeom prst="rect">
                <a:avLst/>
              </a:prstGeom>
            </p:spPr>
          </p:pic>
        </p:grpSp>
        <p:grpSp>
          <p:nvGrpSpPr>
            <p:cNvPr id="20" name="Group 19"/>
            <p:cNvGrpSpPr/>
            <p:nvPr/>
          </p:nvGrpSpPr>
          <p:grpSpPr>
            <a:xfrm>
              <a:off x="20579751" y="27898600"/>
              <a:ext cx="1508542" cy="924440"/>
              <a:chOff x="27926128" y="23278850"/>
              <a:chExt cx="1508542" cy="924440"/>
            </a:xfrm>
          </p:grpSpPr>
          <p:sp>
            <p:nvSpPr>
              <p:cNvPr id="33" name="Rectangle 32"/>
              <p:cNvSpPr/>
              <p:nvPr/>
            </p:nvSpPr>
            <p:spPr bwMode="auto">
              <a:xfrm>
                <a:off x="27926128" y="23278850"/>
                <a:ext cx="1508542" cy="924440"/>
              </a:xfrm>
              <a:prstGeom prst="rect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defTabSz="4173538"/>
                <a:endParaRPr lang="en-US" sz="8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Straight Connector 33"/>
              <p:cNvCxnSpPr>
                <a:stCxn id="33" idx="0"/>
                <a:endCxn id="33" idx="2"/>
              </p:cNvCxnSpPr>
              <p:nvPr/>
            </p:nvCxnSpPr>
            <p:spPr bwMode="auto">
              <a:xfrm>
                <a:off x="28680399" y="23278850"/>
                <a:ext cx="0" cy="924440"/>
              </a:xfrm>
              <a:prstGeom prst="line">
                <a:avLst/>
              </a:prstGeom>
              <a:gradFill rotWithShape="1">
                <a:gsLst>
                  <a:gs pos="0">
                    <a:srgbClr val="FFFFFF"/>
                  </a:gs>
                  <a:gs pos="100000">
                    <a:srgbClr val="800000"/>
                  </a:gs>
                </a:gsLst>
                <a:path path="rect">
                  <a:fillToRect l="50000" t="50000" r="50000" b="50000"/>
                </a:path>
              </a:gra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sp>
          <p:nvSpPr>
            <p:cNvPr id="21" name="Rectangle 20"/>
            <p:cNvSpPr/>
            <p:nvPr/>
          </p:nvSpPr>
          <p:spPr bwMode="auto">
            <a:xfrm>
              <a:off x="15433786" y="25428512"/>
              <a:ext cx="6679124" cy="31269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none" lIns="91440" tIns="45720" rIns="91440" bIns="45720" numCol="1" rtlCol="0" anchor="ctr" anchorCtr="0" compatLnSpc="1">
              <a:prstTxWarp prst="textNoShape">
                <a:avLst/>
              </a:prstTxWarp>
            </a:bodyPr>
            <a:lstStyle/>
            <a:p>
              <a:pPr defTabSz="4173538"/>
              <a:endParaRPr lang="en-US" sz="8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400"/>
            <p:cNvSpPr>
              <a:spLocks noChangeArrowheads="1"/>
            </p:cNvSpPr>
            <p:nvPr/>
          </p:nvSpPr>
          <p:spPr bwMode="auto">
            <a:xfrm>
              <a:off x="20686940" y="25445768"/>
              <a:ext cx="1315860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DA-MB-231</a:t>
              </a:r>
              <a:endParaRPr lang="en-I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400"/>
            <p:cNvSpPr>
              <a:spLocks noChangeArrowheads="1"/>
            </p:cNvSpPr>
            <p:nvPr/>
          </p:nvSpPr>
          <p:spPr bwMode="auto">
            <a:xfrm>
              <a:off x="15860504" y="25445768"/>
              <a:ext cx="746611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2780</a:t>
              </a:r>
              <a:endParaRPr lang="en-I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400"/>
            <p:cNvSpPr>
              <a:spLocks noChangeArrowheads="1"/>
            </p:cNvSpPr>
            <p:nvPr/>
          </p:nvSpPr>
          <p:spPr bwMode="auto">
            <a:xfrm>
              <a:off x="18448854" y="25445768"/>
              <a:ext cx="1162118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2780cis</a:t>
              </a:r>
              <a:endParaRPr lang="en-I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/>
            <p:cNvSpPr/>
            <p:nvPr/>
          </p:nvSpPr>
          <p:spPr bwMode="auto">
            <a:xfrm>
              <a:off x="15425843" y="27179484"/>
              <a:ext cx="6662451" cy="30443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none" lIns="91440" tIns="45720" rIns="91440" bIns="45720" numCol="1" rtlCol="0" anchor="ctr" anchorCtr="0" compatLnSpc="1">
              <a:prstTxWarp prst="textNoShape">
                <a:avLst/>
              </a:prstTxWarp>
            </a:bodyPr>
            <a:lstStyle/>
            <a:p>
              <a:pPr defTabSz="4173538"/>
              <a:endParaRPr lang="en-US" sz="8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400"/>
            <p:cNvSpPr>
              <a:spLocks noChangeArrowheads="1"/>
            </p:cNvSpPr>
            <p:nvPr/>
          </p:nvSpPr>
          <p:spPr bwMode="auto">
            <a:xfrm>
              <a:off x="20678996" y="27196739"/>
              <a:ext cx="1315860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DA-MB-436</a:t>
              </a:r>
              <a:endParaRPr lang="en-I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400"/>
            <p:cNvSpPr>
              <a:spLocks noChangeArrowheads="1"/>
            </p:cNvSpPr>
            <p:nvPr/>
          </p:nvSpPr>
          <p:spPr bwMode="auto">
            <a:xfrm>
              <a:off x="15852560" y="27196739"/>
              <a:ext cx="746611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EO1</a:t>
              </a:r>
              <a:endParaRPr lang="en-I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400"/>
            <p:cNvSpPr>
              <a:spLocks noChangeArrowheads="1"/>
            </p:cNvSpPr>
            <p:nvPr/>
          </p:nvSpPr>
          <p:spPr bwMode="auto">
            <a:xfrm>
              <a:off x="18440910" y="27196739"/>
              <a:ext cx="1162118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EO4</a:t>
              </a:r>
              <a:endParaRPr lang="en-I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400"/>
            <p:cNvSpPr>
              <a:spLocks noChangeArrowheads="1"/>
            </p:cNvSpPr>
            <p:nvPr/>
          </p:nvSpPr>
          <p:spPr bwMode="auto">
            <a:xfrm>
              <a:off x="20828593" y="25838782"/>
              <a:ext cx="1149284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T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400"/>
            <p:cNvSpPr>
              <a:spLocks noChangeArrowheads="1"/>
            </p:cNvSpPr>
            <p:nvPr/>
          </p:nvSpPr>
          <p:spPr bwMode="auto">
            <a:xfrm>
              <a:off x="20799631" y="27553573"/>
              <a:ext cx="1149284" cy="280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64588" tIns="32296" rIns="64588" bIns="32296">
              <a:spAutoFit/>
            </a:bodyPr>
            <a:lstStyle/>
            <a:p>
              <a:pPr algn="just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T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Down Arrow 30"/>
            <p:cNvSpPr/>
            <p:nvPr/>
          </p:nvSpPr>
          <p:spPr bwMode="auto">
            <a:xfrm rot="10800000">
              <a:off x="17075151" y="26322037"/>
              <a:ext cx="372479" cy="447539"/>
            </a:xfrm>
            <a:prstGeom prst="downArrow">
              <a:avLst/>
            </a:prstGeom>
            <a:gradFill rotWithShape="1">
              <a:gsLst>
                <a:gs pos="2000">
                  <a:srgbClr val="FFFFFF"/>
                </a:gs>
                <a:gs pos="100000">
                  <a:srgbClr val="800000"/>
                </a:gs>
              </a:gsLst>
              <a:path path="rect">
                <a:fillToRect l="50000" t="50000" r="50000" b="50000"/>
              </a:path>
            </a:gra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none" lIns="91440" tIns="45720" rIns="91440" bIns="45720" numCol="1" rtlCol="0" anchor="ctr" anchorCtr="0" compatLnSpc="1">
              <a:prstTxWarp prst="textNoShape">
                <a:avLst/>
              </a:prstTxWarp>
            </a:bodyPr>
            <a:lstStyle/>
            <a:p>
              <a:pPr defTabSz="4173538"/>
              <a:endParaRPr lang="en-US" sz="8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Down Arrow 31"/>
            <p:cNvSpPr/>
            <p:nvPr/>
          </p:nvSpPr>
          <p:spPr bwMode="auto">
            <a:xfrm rot="10800000">
              <a:off x="17097803" y="28029843"/>
              <a:ext cx="372479" cy="447539"/>
            </a:xfrm>
            <a:prstGeom prst="downArrow">
              <a:avLst/>
            </a:prstGeom>
            <a:gradFill rotWithShape="1">
              <a:gsLst>
                <a:gs pos="2000">
                  <a:srgbClr val="FFFFFF"/>
                </a:gs>
                <a:gs pos="100000">
                  <a:srgbClr val="800000"/>
                </a:gs>
              </a:gsLst>
              <a:path path="rect">
                <a:fillToRect l="50000" t="50000" r="50000" b="50000"/>
              </a:path>
            </a:gra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none" lIns="91440" tIns="45720" rIns="91440" bIns="45720" numCol="1" rtlCol="0" anchor="ctr" anchorCtr="0" compatLnSpc="1">
              <a:prstTxWarp prst="textNoShape">
                <a:avLst/>
              </a:prstTxWarp>
            </a:bodyPr>
            <a:lstStyle/>
            <a:p>
              <a:pPr defTabSz="4173538"/>
              <a:endParaRPr lang="en-US" sz="8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8466035" y="1368898"/>
            <a:ext cx="1061509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I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4/57kDa</a:t>
            </a:r>
          </a:p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I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8441314" y="3164157"/>
            <a:ext cx="1061509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I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4/57kDa</a:t>
            </a:r>
          </a:p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I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03622" y="48081"/>
            <a:ext cx="1423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865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000" y="918549"/>
            <a:ext cx="2707046" cy="2675554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724" y="929512"/>
            <a:ext cx="2707046" cy="2675554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006" y="918550"/>
            <a:ext cx="2707046" cy="267555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-287839" y="573561"/>
            <a:ext cx="360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hr </a:t>
            </a:r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994885" y="567104"/>
            <a:ext cx="360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hr </a:t>
            </a:r>
            <a:r>
              <a:rPr lang="en-IE" dirty="0" err="1">
                <a:latin typeface="Arial" panose="020B0604020202020204" pitchFamily="34" charset="0"/>
                <a:cs typeface="Arial" panose="020B0604020202020204" pitchFamily="34" charset="0"/>
              </a:rPr>
              <a:t>UnT</a:t>
            </a:r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306000" y="567104"/>
            <a:ext cx="360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hr </a:t>
            </a:r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IE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IE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3520470"/>
              </p:ext>
            </p:extLst>
          </p:nvPr>
        </p:nvGraphicFramePr>
        <p:xfrm>
          <a:off x="1033330" y="4039350"/>
          <a:ext cx="3761555" cy="2750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2032042"/>
              </p:ext>
            </p:extLst>
          </p:nvPr>
        </p:nvGraphicFramePr>
        <p:xfrm>
          <a:off x="5131871" y="4039349"/>
          <a:ext cx="4242099" cy="2750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" name="Rectangle 10"/>
          <p:cNvSpPr/>
          <p:nvPr/>
        </p:nvSpPr>
        <p:spPr>
          <a:xfrm>
            <a:off x="103622" y="48081"/>
            <a:ext cx="1423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54212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446865" y="886658"/>
            <a:ext cx="5957888" cy="1763712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762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38040" y="2145545"/>
            <a:ext cx="406400" cy="193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13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23753" y="1926470"/>
            <a:ext cx="420687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84065" y="1667708"/>
            <a:ext cx="47625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12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34865" y="1404183"/>
            <a:ext cx="409575" cy="198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08" b="10899"/>
          <a:stretch>
            <a:fillRect/>
          </a:stretch>
        </p:blipFill>
        <p:spPr bwMode="auto">
          <a:xfrm>
            <a:off x="2456390" y="1161295"/>
            <a:ext cx="900113" cy="223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2"/>
          <p:cNvSpPr txBox="1">
            <a:spLocks noChangeArrowheads="1"/>
          </p:cNvSpPr>
          <p:nvPr/>
        </p:nvSpPr>
        <p:spPr bwMode="auto">
          <a:xfrm>
            <a:off x="2359553" y="578683"/>
            <a:ext cx="15319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200">
                <a:latin typeface="Arial" panose="020B0604020202020204" pitchFamily="34" charset="0"/>
                <a:cs typeface="Arial" panose="020B0604020202020204" pitchFamily="34" charset="0"/>
              </a:rPr>
              <a:t>UT T   UT T   UT T</a:t>
            </a:r>
          </a:p>
        </p:txBody>
      </p:sp>
      <p:pic>
        <p:nvPicPr>
          <p:cNvPr id="9" name="Picture 11"/>
          <p:cNvPicPr>
            <a:picLocks noChangeAspect="1"/>
          </p:cNvPicPr>
          <p:nvPr/>
        </p:nvPicPr>
        <p:blipFill>
          <a:blip r:embed="rId8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03" t="42746" r="56653" b="53249"/>
          <a:stretch>
            <a:fillRect/>
          </a:stretch>
        </p:blipFill>
        <p:spPr bwMode="auto">
          <a:xfrm>
            <a:off x="3288240" y="1159708"/>
            <a:ext cx="441325" cy="223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12"/>
          <p:cNvSpPr txBox="1">
            <a:spLocks noChangeArrowheads="1"/>
          </p:cNvSpPr>
          <p:nvPr/>
        </p:nvSpPr>
        <p:spPr bwMode="auto">
          <a:xfrm>
            <a:off x="2500840" y="326270"/>
            <a:ext cx="12382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IE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16</a:t>
            </a:r>
          </a:p>
        </p:txBody>
      </p:sp>
      <p:pic>
        <p:nvPicPr>
          <p:cNvPr id="11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65" t="41789" r="11993" b="51563"/>
          <a:stretch>
            <a:fillRect/>
          </a:stretch>
        </p:blipFill>
        <p:spPr bwMode="auto">
          <a:xfrm>
            <a:off x="2456390" y="905708"/>
            <a:ext cx="847725" cy="23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32" t="59047" r="49911" b="33273"/>
          <a:stretch>
            <a:fillRect/>
          </a:stretch>
        </p:blipFill>
        <p:spPr bwMode="auto">
          <a:xfrm>
            <a:off x="4045478" y="1445458"/>
            <a:ext cx="831850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36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73" t="46497" r="8070" b="46053"/>
          <a:stretch>
            <a:fillRect/>
          </a:stretch>
        </p:blipFill>
        <p:spPr bwMode="auto">
          <a:xfrm>
            <a:off x="2423053" y="1421645"/>
            <a:ext cx="874712" cy="227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37"/>
          <p:cNvPicPr>
            <a:picLocks noChangeAspect="1"/>
          </p:cNvPicPr>
          <p:nvPr/>
        </p:nvPicPr>
        <p:blipFill>
          <a:blip r:embed="rId1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61" t="33954" r="31633" b="63148"/>
          <a:stretch>
            <a:fillRect/>
          </a:stretch>
        </p:blipFill>
        <p:spPr bwMode="auto">
          <a:xfrm>
            <a:off x="3296178" y="1420058"/>
            <a:ext cx="42227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9"/>
          <p:cNvPicPr>
            <a:picLocks noChangeAspect="1"/>
          </p:cNvPicPr>
          <p:nvPr/>
        </p:nvPicPr>
        <p:blipFill>
          <a:blip r:embed="rId1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06" t="80928" r="47682" b="15974"/>
          <a:stretch>
            <a:fillRect/>
          </a:stretch>
        </p:blipFill>
        <p:spPr bwMode="auto">
          <a:xfrm>
            <a:off x="2912003" y="1674058"/>
            <a:ext cx="403225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Picture 40"/>
          <p:cNvSpPr>
            <a:spLocks noChangeAspect="1"/>
          </p:cNvSpPr>
          <p:nvPr/>
        </p:nvSpPr>
        <p:spPr bwMode="auto">
          <a:xfrm rot="16200000">
            <a:off x="3393809" y="1582777"/>
            <a:ext cx="222250" cy="404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2000">
              <a:latin typeface="Arial" panose="020B0604020202020204" pitchFamily="34" charset="0"/>
            </a:endParaRPr>
          </a:p>
        </p:txBody>
      </p:sp>
      <p:pic>
        <p:nvPicPr>
          <p:cNvPr id="17" name="Picture 41"/>
          <p:cNvPicPr>
            <a:picLocks noChangeAspect="1"/>
          </p:cNvPicPr>
          <p:nvPr/>
        </p:nvPicPr>
        <p:blipFill>
          <a:blip r:embed="rId1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4" t="75116" r="49788" b="21359"/>
          <a:stretch>
            <a:fillRect/>
          </a:stretch>
        </p:blipFill>
        <p:spPr bwMode="auto">
          <a:xfrm>
            <a:off x="2456390" y="1923295"/>
            <a:ext cx="881063" cy="192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42"/>
          <p:cNvPicPr>
            <a:picLocks noChangeAspect="1"/>
          </p:cNvPicPr>
          <p:nvPr/>
        </p:nvPicPr>
        <p:blipFill>
          <a:blip r:embed="rId1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26" t="75287" r="33279" b="21359"/>
          <a:stretch>
            <a:fillRect/>
          </a:stretch>
        </p:blipFill>
        <p:spPr bwMode="auto">
          <a:xfrm>
            <a:off x="3302528" y="1923295"/>
            <a:ext cx="425450" cy="192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43"/>
          <p:cNvPicPr>
            <a:picLocks noChangeAspect="1"/>
          </p:cNvPicPr>
          <p:nvPr/>
        </p:nvPicPr>
        <p:blipFill>
          <a:blip r:embed="rId1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91" t="28186" r="22842" b="70180"/>
          <a:stretch>
            <a:fillRect/>
          </a:stretch>
        </p:blipFill>
        <p:spPr bwMode="auto">
          <a:xfrm>
            <a:off x="2432578" y="2139195"/>
            <a:ext cx="1295400" cy="193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58"/>
          <p:cNvSpPr txBox="1">
            <a:spLocks noChangeArrowheads="1"/>
          </p:cNvSpPr>
          <p:nvPr/>
        </p:nvSpPr>
        <p:spPr bwMode="auto">
          <a:xfrm>
            <a:off x="4015315" y="326270"/>
            <a:ext cx="12382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IE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pic>
        <p:nvPicPr>
          <p:cNvPr id="21" name="Picture 82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5" t="58557" r="42542" b="33586"/>
          <a:stretch>
            <a:fillRect/>
          </a:stretch>
        </p:blipFill>
        <p:spPr bwMode="auto">
          <a:xfrm>
            <a:off x="4035953" y="904120"/>
            <a:ext cx="849312" cy="223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86"/>
          <p:cNvPicPr>
            <a:picLocks noChangeAspect="1"/>
          </p:cNvPicPr>
          <p:nvPr/>
        </p:nvPicPr>
        <p:blipFill>
          <a:blip r:embed="rId1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04" t="87553" r="46562" b="8559"/>
          <a:stretch>
            <a:fillRect/>
          </a:stretch>
        </p:blipFill>
        <p:spPr bwMode="auto">
          <a:xfrm>
            <a:off x="4875740" y="1445458"/>
            <a:ext cx="463550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87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70" t="20949" r="23241" b="26630"/>
          <a:stretch>
            <a:fillRect/>
          </a:stretch>
        </p:blipFill>
        <p:spPr bwMode="auto">
          <a:xfrm>
            <a:off x="4474103" y="1159708"/>
            <a:ext cx="40005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88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38" t="19710" r="28775" b="26630"/>
          <a:stretch>
            <a:fillRect/>
          </a:stretch>
        </p:blipFill>
        <p:spPr bwMode="auto">
          <a:xfrm>
            <a:off x="3999440" y="1156533"/>
            <a:ext cx="428625" cy="25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15"/>
          <p:cNvPicPr>
            <a:picLocks noChangeAspect="1"/>
          </p:cNvPicPr>
          <p:nvPr/>
        </p:nvPicPr>
        <p:blipFill>
          <a:blip r:embed="rId19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30" t="43233" r="70226" b="53539"/>
          <a:stretch>
            <a:fillRect/>
          </a:stretch>
        </p:blipFill>
        <p:spPr bwMode="auto">
          <a:xfrm>
            <a:off x="3304115" y="905708"/>
            <a:ext cx="404813" cy="234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89"/>
          <p:cNvPicPr>
            <a:picLocks noChangeAspect="1"/>
          </p:cNvPicPr>
          <p:nvPr/>
        </p:nvPicPr>
        <p:blipFill>
          <a:blip r:embed="rId20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40" t="21678" r="44135" b="74590"/>
          <a:stretch>
            <a:fillRect/>
          </a:stretch>
        </p:blipFill>
        <p:spPr bwMode="auto">
          <a:xfrm flipH="1">
            <a:off x="4875740" y="1156533"/>
            <a:ext cx="434975" cy="263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90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7703" y="1712158"/>
            <a:ext cx="809625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91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7803" y="1712158"/>
            <a:ext cx="442912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92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7703" y="1945520"/>
            <a:ext cx="809625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93"/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70" r="11182" b="2"/>
          <a:stretch>
            <a:fillRect/>
          </a:stretch>
        </p:blipFill>
        <p:spPr bwMode="auto">
          <a:xfrm>
            <a:off x="4861453" y="1945520"/>
            <a:ext cx="457200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94"/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7703" y="2164595"/>
            <a:ext cx="803275" cy="21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95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9865" y="2164595"/>
            <a:ext cx="458788" cy="207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118"/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55390" y="1173995"/>
            <a:ext cx="874713" cy="195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119"/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6665" y="902533"/>
            <a:ext cx="823913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120"/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9"/>
          <a:stretch>
            <a:fillRect/>
          </a:stretch>
        </p:blipFill>
        <p:spPr bwMode="auto">
          <a:xfrm>
            <a:off x="7195078" y="1404183"/>
            <a:ext cx="8763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121"/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6190" y="1662945"/>
            <a:ext cx="823913" cy="242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122"/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20578" y="1173995"/>
            <a:ext cx="423862" cy="195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123"/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5815" y="902533"/>
            <a:ext cx="409575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124"/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8890" y="1926470"/>
            <a:ext cx="820738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126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4603" y="2139195"/>
            <a:ext cx="8350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TextBox 133"/>
          <p:cNvSpPr txBox="1">
            <a:spLocks noChangeArrowheads="1"/>
          </p:cNvSpPr>
          <p:nvPr/>
        </p:nvSpPr>
        <p:spPr bwMode="auto">
          <a:xfrm>
            <a:off x="7150628" y="326270"/>
            <a:ext cx="12382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IE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</a:p>
        </p:txBody>
      </p:sp>
      <p:pic>
        <p:nvPicPr>
          <p:cNvPr id="42" name="Picture 6"/>
          <p:cNvPicPr>
            <a:picLocks noChangeAspect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4628" y="899358"/>
            <a:ext cx="457200" cy="219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8"/>
          <p:cNvPicPr>
            <a:picLocks noChangeAspect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1740" y="2380495"/>
            <a:ext cx="129857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13"/>
          <p:cNvPicPr>
            <a:picLocks noChangeAspect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5478" y="2401133"/>
            <a:ext cx="12827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16"/>
          <p:cNvPicPr>
            <a:picLocks noChangeAspect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8453" y="2364620"/>
            <a:ext cx="1254125" cy="220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" name="TextBox 135"/>
          <p:cNvSpPr txBox="1">
            <a:spLocks noChangeArrowheads="1"/>
          </p:cNvSpPr>
          <p:nvPr/>
        </p:nvSpPr>
        <p:spPr bwMode="auto">
          <a:xfrm>
            <a:off x="7129990" y="588208"/>
            <a:ext cx="15097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200">
                <a:latin typeface="Arial" panose="020B0604020202020204" pitchFamily="34" charset="0"/>
                <a:cs typeface="Arial" panose="020B0604020202020204" pitchFamily="34" charset="0"/>
              </a:rPr>
              <a:t>UT T  UT T  UT T</a:t>
            </a:r>
          </a:p>
        </p:txBody>
      </p:sp>
      <p:sp>
        <p:nvSpPr>
          <p:cNvPr id="47" name="TextBox 136"/>
          <p:cNvSpPr txBox="1">
            <a:spLocks noChangeArrowheads="1"/>
          </p:cNvSpPr>
          <p:nvPr/>
        </p:nvSpPr>
        <p:spPr bwMode="auto">
          <a:xfrm>
            <a:off x="4001028" y="588208"/>
            <a:ext cx="14112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200">
                <a:latin typeface="Arial" panose="020B0604020202020204" pitchFamily="34" charset="0"/>
                <a:cs typeface="Arial" panose="020B0604020202020204" pitchFamily="34" charset="0"/>
              </a:rPr>
              <a:t>UT T  UT T  UT T</a:t>
            </a:r>
          </a:p>
        </p:txBody>
      </p:sp>
      <p:sp>
        <p:nvSpPr>
          <p:cNvPr id="48" name="TextBox 137"/>
          <p:cNvSpPr txBox="1">
            <a:spLocks noChangeArrowheads="1"/>
          </p:cNvSpPr>
          <p:nvPr/>
        </p:nvSpPr>
        <p:spPr bwMode="auto">
          <a:xfrm>
            <a:off x="5539315" y="594558"/>
            <a:ext cx="15605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200">
                <a:latin typeface="Arial" panose="020B0604020202020204" pitchFamily="34" charset="0"/>
                <a:cs typeface="Arial" panose="020B0604020202020204" pitchFamily="34" charset="0"/>
              </a:rPr>
              <a:t>UT T   UT T   UT T</a:t>
            </a:r>
          </a:p>
        </p:txBody>
      </p:sp>
      <p:sp>
        <p:nvSpPr>
          <p:cNvPr id="49" name="Rectangle 48"/>
          <p:cNvSpPr/>
          <p:nvPr/>
        </p:nvSpPr>
        <p:spPr>
          <a:xfrm>
            <a:off x="2434165" y="907295"/>
            <a:ext cx="1284288" cy="1724025"/>
          </a:xfrm>
          <a:prstGeom prst="rect">
            <a:avLst/>
          </a:prstGeom>
          <a:noFill/>
          <a:ln w="762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7214128" y="902533"/>
            <a:ext cx="1249362" cy="1727200"/>
          </a:xfrm>
          <a:prstGeom prst="rect">
            <a:avLst/>
          </a:prstGeom>
          <a:noFill/>
          <a:ln w="762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3988328" y="945395"/>
            <a:ext cx="1290637" cy="1695450"/>
          </a:xfrm>
          <a:prstGeom prst="rect">
            <a:avLst/>
          </a:prstGeom>
          <a:noFill/>
          <a:ln w="762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3789890" y="870783"/>
            <a:ext cx="234950" cy="1724025"/>
          </a:xfrm>
          <a:prstGeom prst="rect">
            <a:avLst/>
          </a:prstGeom>
          <a:solidFill>
            <a:schemeClr val="bg1"/>
          </a:solidFill>
          <a:ln w="762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6949015" y="861258"/>
            <a:ext cx="234950" cy="1724025"/>
          </a:xfrm>
          <a:prstGeom prst="rect">
            <a:avLst/>
          </a:prstGeom>
          <a:solidFill>
            <a:schemeClr val="bg1"/>
          </a:solidFill>
          <a:ln w="762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10"/>
          <p:cNvSpPr>
            <a:spLocks noChangeArrowheads="1"/>
          </p:cNvSpPr>
          <p:nvPr/>
        </p:nvSpPr>
        <p:spPr bwMode="auto">
          <a:xfrm>
            <a:off x="895084" y="2096333"/>
            <a:ext cx="1816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436</a:t>
            </a:r>
            <a:endParaRPr lang="en-IE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Picture 38"/>
          <p:cNvPicPr>
            <a:picLocks noChangeAspect="1"/>
          </p:cNvPicPr>
          <p:nvPr/>
        </p:nvPicPr>
        <p:blipFill>
          <a:blip r:embed="rId1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64" t="48683" r="39857" b="48421"/>
          <a:stretch>
            <a:fillRect/>
          </a:stretch>
        </p:blipFill>
        <p:spPr bwMode="auto">
          <a:xfrm>
            <a:off x="2464328" y="1674058"/>
            <a:ext cx="449262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9" name="Rectangle 156"/>
          <p:cNvSpPr>
            <a:spLocks noChangeArrowheads="1"/>
          </p:cNvSpPr>
          <p:nvPr/>
        </p:nvSpPr>
        <p:spPr bwMode="auto">
          <a:xfrm>
            <a:off x="513857" y="3043645"/>
            <a:ext cx="16986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5-AZA treated</a:t>
            </a:r>
            <a:endParaRPr lang="en-IE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99"/>
          <p:cNvPicPr>
            <a:picLocks noChangeAspect="1"/>
          </p:cNvPicPr>
          <p:nvPr/>
        </p:nvPicPr>
        <p:blipFill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178" y="1650245"/>
            <a:ext cx="455612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" name="Rectangle 60"/>
          <p:cNvSpPr/>
          <p:nvPr/>
        </p:nvSpPr>
        <p:spPr>
          <a:xfrm>
            <a:off x="5339290" y="870783"/>
            <a:ext cx="234950" cy="1724025"/>
          </a:xfrm>
          <a:prstGeom prst="rect">
            <a:avLst/>
          </a:prstGeom>
          <a:solidFill>
            <a:schemeClr val="bg1"/>
          </a:solidFill>
          <a:ln w="762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IE" sz="1400" dirty="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149"/>
          <p:cNvSpPr txBox="1">
            <a:spLocks noChangeArrowheads="1"/>
          </p:cNvSpPr>
          <p:nvPr/>
        </p:nvSpPr>
        <p:spPr bwMode="auto">
          <a:xfrm>
            <a:off x="5544078" y="326270"/>
            <a:ext cx="13684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IE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</a:p>
        </p:txBody>
      </p:sp>
      <p:pic>
        <p:nvPicPr>
          <p:cNvPr id="64" name="Picture 3"/>
          <p:cNvPicPr>
            <a:picLocks noChangeAspect="1"/>
          </p:cNvPicPr>
          <p:nvPr/>
        </p:nvPicPr>
        <p:blipFill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0428" y="839033"/>
            <a:ext cx="1377950" cy="182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5" name="Straight Connector 64"/>
          <p:cNvCxnSpPr/>
          <p:nvPr/>
        </p:nvCxnSpPr>
        <p:spPr>
          <a:xfrm flipV="1">
            <a:off x="1072090" y="1142245"/>
            <a:ext cx="7448550" cy="4763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V="1">
            <a:off x="1095903" y="1413708"/>
            <a:ext cx="7448550" cy="476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flipV="1">
            <a:off x="1072090" y="2137608"/>
            <a:ext cx="7448550" cy="476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flipV="1">
            <a:off x="1072090" y="2363033"/>
            <a:ext cx="7448550" cy="476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1053040" y="1677233"/>
            <a:ext cx="7448550" cy="476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 flipV="1">
            <a:off x="1049865" y="1907420"/>
            <a:ext cx="7448550" cy="4763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flipV="1">
            <a:off x="1224490" y="2647195"/>
            <a:ext cx="7448550" cy="476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3"/>
          <p:cNvSpPr txBox="1">
            <a:spLocks noChangeArrowheads="1"/>
          </p:cNvSpPr>
          <p:nvPr/>
        </p:nvSpPr>
        <p:spPr bwMode="auto">
          <a:xfrm>
            <a:off x="894290" y="775533"/>
            <a:ext cx="11636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80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</a:p>
        </p:txBody>
      </p:sp>
      <p:sp>
        <p:nvSpPr>
          <p:cNvPr id="73" name="TextBox 4"/>
          <p:cNvSpPr txBox="1">
            <a:spLocks noChangeArrowheads="1"/>
          </p:cNvSpPr>
          <p:nvPr/>
        </p:nvSpPr>
        <p:spPr bwMode="auto">
          <a:xfrm>
            <a:off x="894290" y="1046995"/>
            <a:ext cx="15954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800"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</a:p>
        </p:txBody>
      </p:sp>
      <p:sp>
        <p:nvSpPr>
          <p:cNvPr id="74" name="TextBox 5"/>
          <p:cNvSpPr txBox="1">
            <a:spLocks noChangeArrowheads="1"/>
          </p:cNvSpPr>
          <p:nvPr/>
        </p:nvSpPr>
        <p:spPr bwMode="auto">
          <a:xfrm>
            <a:off x="894290" y="1327983"/>
            <a:ext cx="11636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800">
                <a:latin typeface="Arial" panose="020B0604020202020204" pitchFamily="34" charset="0"/>
                <a:cs typeface="Arial" panose="020B0604020202020204" pitchFamily="34" charset="0"/>
              </a:rPr>
              <a:t>PEO1</a:t>
            </a:r>
          </a:p>
        </p:txBody>
      </p:sp>
      <p:sp>
        <p:nvSpPr>
          <p:cNvPr id="75" name="Rectangle 9"/>
          <p:cNvSpPr>
            <a:spLocks noChangeArrowheads="1"/>
          </p:cNvSpPr>
          <p:nvPr/>
        </p:nvSpPr>
        <p:spPr bwMode="auto">
          <a:xfrm>
            <a:off x="894290" y="1859795"/>
            <a:ext cx="17081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IE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98"/>
          <p:cNvSpPr>
            <a:spLocks noChangeArrowheads="1"/>
          </p:cNvSpPr>
          <p:nvPr/>
        </p:nvSpPr>
        <p:spPr bwMode="auto">
          <a:xfrm>
            <a:off x="894290" y="2316995"/>
            <a:ext cx="16160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l-GR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IE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"/>
          <p:cNvSpPr txBox="1">
            <a:spLocks noChangeArrowheads="1"/>
          </p:cNvSpPr>
          <p:nvPr/>
        </p:nvSpPr>
        <p:spPr bwMode="auto">
          <a:xfrm>
            <a:off x="894290" y="1605795"/>
            <a:ext cx="11636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IE" altLang="en-US" sz="1800">
                <a:latin typeface="Arial" panose="020B0604020202020204" pitchFamily="34" charset="0"/>
                <a:cs typeface="Arial" panose="020B0604020202020204" pitchFamily="34" charset="0"/>
              </a:rPr>
              <a:t>PEO4</a:t>
            </a:r>
          </a:p>
        </p:txBody>
      </p:sp>
      <p:sp>
        <p:nvSpPr>
          <p:cNvPr id="82" name="Rectangle 81"/>
          <p:cNvSpPr/>
          <p:nvPr/>
        </p:nvSpPr>
        <p:spPr>
          <a:xfrm>
            <a:off x="5665636" y="2586032"/>
            <a:ext cx="122020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b-105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4076845" y="2586032"/>
            <a:ext cx="120898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21-21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2464780" y="2586032"/>
            <a:ext cx="120898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16-16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3312437" y="598181"/>
            <a:ext cx="487362" cy="20621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v</a:t>
            </a:r>
            <a:endParaRPr lang="en-US" dirty="0"/>
          </a:p>
        </p:txBody>
      </p:sp>
      <p:sp>
        <p:nvSpPr>
          <p:cNvPr id="88" name="Rectangle 87"/>
          <p:cNvSpPr/>
          <p:nvPr/>
        </p:nvSpPr>
        <p:spPr>
          <a:xfrm>
            <a:off x="4898636" y="565460"/>
            <a:ext cx="487362" cy="20621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v</a:t>
            </a:r>
            <a:endParaRPr lang="en-US" dirty="0"/>
          </a:p>
        </p:txBody>
      </p:sp>
      <p:sp>
        <p:nvSpPr>
          <p:cNvPr id="89" name="Rectangle 88"/>
          <p:cNvSpPr/>
          <p:nvPr/>
        </p:nvSpPr>
        <p:spPr>
          <a:xfrm>
            <a:off x="6456891" y="543652"/>
            <a:ext cx="487362" cy="20621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v</a:t>
            </a:r>
            <a:endParaRPr lang="en-US" dirty="0"/>
          </a:p>
        </p:txBody>
      </p:sp>
      <p:sp>
        <p:nvSpPr>
          <p:cNvPr id="90" name="Rectangle 89"/>
          <p:cNvSpPr/>
          <p:nvPr/>
        </p:nvSpPr>
        <p:spPr>
          <a:xfrm>
            <a:off x="8025458" y="607012"/>
            <a:ext cx="487362" cy="20621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v</a:t>
            </a:r>
            <a:endParaRPr lang="en-US" dirty="0"/>
          </a:p>
        </p:txBody>
      </p:sp>
      <p:sp>
        <p:nvSpPr>
          <p:cNvPr id="85" name="Rectangle 84"/>
          <p:cNvSpPr/>
          <p:nvPr/>
        </p:nvSpPr>
        <p:spPr>
          <a:xfrm>
            <a:off x="8089959" y="2316579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7030412" y="2586032"/>
            <a:ext cx="176997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ARP-116/89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/>
          <p:cNvSpPr/>
          <p:nvPr/>
        </p:nvSpPr>
        <p:spPr>
          <a:xfrm>
            <a:off x="103622" y="48081"/>
            <a:ext cx="1423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3853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905" y="1217973"/>
            <a:ext cx="4286679" cy="1814594"/>
          </a:xfrm>
          <a:prstGeom prst="rect">
            <a:avLst/>
          </a:prstGeom>
          <a:noFill/>
        </p:spPr>
      </p:pic>
      <p:pic>
        <p:nvPicPr>
          <p:cNvPr id="3" name="Picture 2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904" y="3325966"/>
            <a:ext cx="4330446" cy="1911920"/>
          </a:xfrm>
          <a:prstGeom prst="rect">
            <a:avLst/>
          </a:prstGeom>
          <a:noFill/>
        </p:spPr>
      </p:pic>
      <p:pic>
        <p:nvPicPr>
          <p:cNvPr id="4" name="Picture 3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0589" y="1217973"/>
            <a:ext cx="4330447" cy="1918237"/>
          </a:xfrm>
          <a:prstGeom prst="rect">
            <a:avLst/>
          </a:prstGeom>
          <a:noFill/>
        </p:spPr>
      </p:pic>
      <p:pic>
        <p:nvPicPr>
          <p:cNvPr id="5" name="Picture 4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0589" y="3325966"/>
            <a:ext cx="4434503" cy="1976640"/>
          </a:xfrm>
          <a:prstGeom prst="rect">
            <a:avLst/>
          </a:prstGeom>
          <a:noFill/>
        </p:spPr>
      </p:pic>
      <p:sp>
        <p:nvSpPr>
          <p:cNvPr id="7" name="Rectangle 6"/>
          <p:cNvSpPr/>
          <p:nvPr/>
        </p:nvSpPr>
        <p:spPr>
          <a:xfrm>
            <a:off x="-11575" y="2694013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-11576" y="2364850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9685" y="2039483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8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9685" y="1692438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-21211" y="4834702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-21212" y="4505539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9" y="4180172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8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9" y="3833127"/>
            <a:ext cx="7761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85kDa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401453" y="1458410"/>
            <a:ext cx="1140401" cy="38441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15" name="Rectangle 14"/>
          <p:cNvSpPr/>
          <p:nvPr/>
        </p:nvSpPr>
        <p:spPr>
          <a:xfrm>
            <a:off x="7086609" y="1334420"/>
            <a:ext cx="1216833" cy="39830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16" name="Rectangle 15"/>
          <p:cNvSpPr/>
          <p:nvPr/>
        </p:nvSpPr>
        <p:spPr>
          <a:xfrm>
            <a:off x="2507021" y="1682095"/>
            <a:ext cx="87633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GAT5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299400" y="2020649"/>
            <a:ext cx="1083951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T3GAL4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557548" y="2394068"/>
            <a:ext cx="825803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408404" y="2694013"/>
            <a:ext cx="974947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408404" y="1093246"/>
            <a:ext cx="776175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295133" y="3228024"/>
            <a:ext cx="1026243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7220167" y="1113288"/>
            <a:ext cx="73129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EO1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7249752" y="3252657"/>
            <a:ext cx="73129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EO4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2607176" y="3826556"/>
            <a:ext cx="87633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GAT5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2399555" y="4165110"/>
            <a:ext cx="1083951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T3GAL4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2657703" y="4538529"/>
            <a:ext cx="825803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2508559" y="4884774"/>
            <a:ext cx="974947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7294230" y="1682095"/>
            <a:ext cx="87633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GAT5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7086609" y="2020649"/>
            <a:ext cx="1083951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T3GAL4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7344757" y="2394068"/>
            <a:ext cx="825803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TA3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7195613" y="2694013"/>
            <a:ext cx="974947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7303212" y="3887414"/>
            <a:ext cx="87633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GAT5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7095591" y="4225968"/>
            <a:ext cx="1083951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T3GAL4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7353739" y="4599387"/>
            <a:ext cx="825803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TA3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7204595" y="4945632"/>
            <a:ext cx="974947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I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I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-1890" y="868101"/>
            <a:ext cx="5175773" cy="4699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38" name="Rectangle 37"/>
          <p:cNvSpPr/>
          <p:nvPr/>
        </p:nvSpPr>
        <p:spPr>
          <a:xfrm>
            <a:off x="5178707" y="868101"/>
            <a:ext cx="4715718" cy="4699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cxnSp>
        <p:nvCxnSpPr>
          <p:cNvPr id="40" name="Straight Connector 39"/>
          <p:cNvCxnSpPr>
            <a:stCxn id="37" idx="1"/>
            <a:endCxn id="38" idx="3"/>
          </p:cNvCxnSpPr>
          <p:nvPr/>
        </p:nvCxnSpPr>
        <p:spPr>
          <a:xfrm>
            <a:off x="-1890" y="3217762"/>
            <a:ext cx="98963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103622" y="48081"/>
            <a:ext cx="1423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I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I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 </a:t>
            </a:r>
            <a:endParaRPr lang="en-I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9325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90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45</TotalTime>
  <Words>352</Words>
  <Application>Microsoft Office PowerPoint</Application>
  <PresentationFormat>A4 Paper (210x297 mm)</PresentationFormat>
  <Paragraphs>25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ka Fahey</dc:creator>
  <cp:lastModifiedBy>Radka Fahey</cp:lastModifiedBy>
  <cp:revision>295</cp:revision>
  <cp:lastPrinted>2019-06-24T15:41:27Z</cp:lastPrinted>
  <dcterms:created xsi:type="dcterms:W3CDTF">2019-04-26T09:52:04Z</dcterms:created>
  <dcterms:modified xsi:type="dcterms:W3CDTF">2021-02-01T10:45:12Z</dcterms:modified>
</cp:coreProperties>
</file>